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4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5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6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notesSlides/notesSlide2.xml" ContentType="application/vnd.openxmlformats-officedocument.presentationml.notesSlide+xml"/>
  <Override PartName="/ppt/charts/chart7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8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notesSlides/notesSlide3.xml" ContentType="application/vnd.openxmlformats-officedocument.presentationml.notesSlide+xml"/>
  <Override PartName="/ppt/charts/chart9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notesSlides/notesSlide4.xml" ContentType="application/vnd.openxmlformats-officedocument.presentationml.notesSlide+xml"/>
  <Override PartName="/ppt/charts/chart10.xml" ContentType="application/vnd.openxmlformats-officedocument.drawingml.chart+xml"/>
  <Override PartName="/ppt/charts/chart11.xml" ContentType="application/vnd.openxmlformats-officedocument.drawingml.chart+xml"/>
  <Override PartName="/ppt/charts/chart12.xml" ContentType="application/vnd.openxmlformats-officedocument.drawingml.chart+xml"/>
  <Override PartName="/ppt/charts/chart13.xml" ContentType="application/vnd.openxmlformats-officedocument.drawingml.chart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17"/>
  </p:notesMasterIdLst>
  <p:sldIdLst>
    <p:sldId id="257" r:id="rId2"/>
    <p:sldId id="258" r:id="rId3"/>
    <p:sldId id="260" r:id="rId4"/>
    <p:sldId id="263" r:id="rId5"/>
    <p:sldId id="267" r:id="rId6"/>
    <p:sldId id="262" r:id="rId7"/>
    <p:sldId id="264" r:id="rId8"/>
    <p:sldId id="273" r:id="rId9"/>
    <p:sldId id="283" r:id="rId10"/>
    <p:sldId id="277" r:id="rId11"/>
    <p:sldId id="284" r:id="rId12"/>
    <p:sldId id="279" r:id="rId13"/>
    <p:sldId id="288" r:id="rId14"/>
    <p:sldId id="290" r:id="rId15"/>
    <p:sldId id="286" r:id="rId16"/>
  </p:sldIdLst>
  <p:sldSz cx="6858000" cy="9906000" type="A4"/>
  <p:notesSz cx="7023100" cy="93091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934BC9"/>
    <a:srgbClr val="3967B9"/>
    <a:srgbClr val="FF99CC"/>
    <a:srgbClr val="99663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216" autoAdjust="0"/>
    <p:restoredTop sz="94618" autoAdjust="0"/>
  </p:normalViewPr>
  <p:slideViewPr>
    <p:cSldViewPr snapToGrid="0">
      <p:cViewPr varScale="1">
        <p:scale>
          <a:sx n="74" d="100"/>
          <a:sy n="74" d="100"/>
        </p:scale>
        <p:origin x="3564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40" d="100"/>
        <a:sy n="140" d="100"/>
      </p:scale>
      <p:origin x="0" y="-2412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presProps" Target="presProps.xml"/><Relationship Id="rId3" Type="http://schemas.openxmlformats.org/officeDocument/2006/relationships/slide" Target="slides/slide2.xml"/><Relationship Id="rId21" Type="http://schemas.openxmlformats.org/officeDocument/2006/relationships/tableStyles" Target="tableStyle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jy488\Dropbox\My%20PC%20(DESKTOP-8VBNTHM)\Desktop\Somers%20lab%202020\TOC1phospho%20hypocotyl\Luc%20imaging\c349t1%20l4-8%2035-4-1%20Analysis_3%20trials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10.xml.rels><?xml version="1.0" encoding="UTF-8" standalone="yes"?>
<Relationships xmlns="http://schemas.openxmlformats.org/package/2006/relationships"><Relationship Id="rId1" Type="http://schemas.openxmlformats.org/officeDocument/2006/relationships/oleObject" Target="https://d.docs.live.net/d8e9bd0bebfa4803/Somers%20lab%202020/Gene%20exp/2022-10-26%20fhy3%201%20normalize.xls" TargetMode="External"/></Relationships>
</file>

<file path=ppt/charts/_rels/chart11.xml.rels><?xml version="1.0" encoding="UTF-8" standalone="yes"?>
<Relationships xmlns="http://schemas.openxmlformats.org/package/2006/relationships"><Relationship Id="rId1" Type="http://schemas.openxmlformats.org/officeDocument/2006/relationships/oleObject" Target="https://d.docs.live.net/d8e9bd0bebfa4803/Somers%20lab%202020/Gene%20exp/2022-10-26%20fhy3%201%20normalize.xls" TargetMode="External"/></Relationships>
</file>

<file path=ppt/charts/_rels/chart12.xml.rels><?xml version="1.0" encoding="UTF-8" standalone="yes"?>
<Relationships xmlns="http://schemas.openxmlformats.org/package/2006/relationships"><Relationship Id="rId1" Type="http://schemas.openxmlformats.org/officeDocument/2006/relationships/oleObject" Target="https://d.docs.live.net/d8e9bd0bebfa4803/Somers%20lab%202020/Gene%20exp/2022-10-26%20fhy3%201%20normalize.xls" TargetMode="External"/></Relationships>
</file>

<file path=ppt/charts/_rels/chart13.xml.rels><?xml version="1.0" encoding="UTF-8" standalone="yes"?>
<Relationships xmlns="http://schemas.openxmlformats.org/package/2006/relationships"><Relationship Id="rId1" Type="http://schemas.openxmlformats.org/officeDocument/2006/relationships/oleObject" Target="https://d.docs.live.net/d8e9bd0bebfa4803/Somers%20lab%202020/Gene%20exp/2022-10-26%20fhy3%201%20normalize.xls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jy488\Dropbox\My%20PC%20(DESKTOP-8VBNTHM)\Desktop\Somers%20lab%202020\TOC1%20phospho%20clock\Data\CCA1-LUC\trace.xls" TargetMode="Externa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jy488\Dropbox\My%20PC%20(DESKTOP-8VBNTHM)\Desktop\Somers%20lab%202020\TOC1%20phospho%20clock\Data\western\L4-8%2035-4-1%20135A%20175A_LD%2010d_2%20trials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jy488\Dropbox\My%20PC%20(DESKTOP-8VBNTHM)\Desktop\Somers%20lab%202020\TOC1%20phospho%20clock\Data\western\L4-8%2035-4-1%20c349_LD%2010d_2%20trials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jy488\Dropbox\My%20PC%20(DESKTOP-8VBNTHM)\Desktop\Somers%20lab%202020\Western%20blot\2021-11-3%20LWD1%20TCP20%20TCP22_TOC1%205X\2021-10-28%20quantify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jy488\Dropbox\My%20PC%20(DESKTOP-8VBNTHM)\Desktop\Somers%20lab%202020\Western%20blot\2022-1-30%20CHE%20TCP20%20TCP22_TOC1%205X%20135A%20175A\2022-1-30%20quantify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jy488\Dropbox\My%20PC%20(DESKTOP-8VBNTHM)\Desktop\Somers%20lab%202020\TOC1%20phospho%20clock\Data\ChIP\TOC1%205X_CCA1%20LHY_3%20trials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jy488\Dropbox\My%20PC%20(DESKTOP-8VBNTHM)\Desktop\Somers%20lab%202020\ChIP\2022-1-10%207.12%20SD%203d%20pif345t1%20CCA1%202nd%20trial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jy488\Dropbox\My%20PC%20(DESKTOP-8VBNTHM)\Desktop\Somers%20lab%202020\ChIP\CHEMI_10092022_184637\CHEMI_10092022_184637.xlsx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sz="1200"/>
              <a:t>Scatter plot of period vs RAE </a:t>
            </a:r>
          </a:p>
        </c:rich>
      </c:tx>
      <c:layout>
        <c:manualLayout>
          <c:xMode val="edge"/>
          <c:yMode val="edge"/>
          <c:x val="0.22379280391526177"/>
          <c:y val="1.7188657235092688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9.2330878911554143E-2"/>
          <c:y val="8.2878660928124834E-2"/>
          <c:w val="0.65516805694926228"/>
          <c:h val="0.76938689743681554"/>
        </c:manualLayout>
      </c:layout>
      <c:scatterChart>
        <c:scatterStyle val="lineMarker"/>
        <c:varyColors val="0"/>
        <c:ser>
          <c:idx val="0"/>
          <c:order val="0"/>
          <c:tx>
            <c:strRef>
              <c:f>'Scatter plot'!$B$2</c:f>
              <c:strCache>
                <c:ptCount val="1"/>
                <c:pt idx="0">
                  <c:v>Col-0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noFill/>
              <a:ln w="12700">
                <a:solidFill>
                  <a:schemeClr val="accent1"/>
                </a:solidFill>
              </a:ln>
              <a:effectLst/>
            </c:spPr>
          </c:marker>
          <c:xVal>
            <c:numRef>
              <c:f>'Scatter plot'!$B$3:$B$47</c:f>
              <c:numCache>
                <c:formatCode>General</c:formatCode>
                <c:ptCount val="45"/>
                <c:pt idx="0">
                  <c:v>24.2</c:v>
                </c:pt>
                <c:pt idx="1">
                  <c:v>23.84</c:v>
                </c:pt>
                <c:pt idx="2">
                  <c:v>24.18</c:v>
                </c:pt>
                <c:pt idx="3">
                  <c:v>23.71</c:v>
                </c:pt>
                <c:pt idx="4">
                  <c:v>24.31</c:v>
                </c:pt>
                <c:pt idx="5">
                  <c:v>23.3</c:v>
                </c:pt>
                <c:pt idx="6">
                  <c:v>24.17</c:v>
                </c:pt>
                <c:pt idx="7">
                  <c:v>24.4</c:v>
                </c:pt>
                <c:pt idx="8">
                  <c:v>24.2</c:v>
                </c:pt>
                <c:pt idx="9">
                  <c:v>24.2</c:v>
                </c:pt>
                <c:pt idx="10">
                  <c:v>23.79</c:v>
                </c:pt>
                <c:pt idx="11">
                  <c:v>23.94</c:v>
                </c:pt>
                <c:pt idx="12">
                  <c:v>23.37</c:v>
                </c:pt>
                <c:pt idx="13">
                  <c:v>24.34</c:v>
                </c:pt>
                <c:pt idx="14">
                  <c:v>24.04</c:v>
                </c:pt>
                <c:pt idx="15">
                  <c:v>24.56</c:v>
                </c:pt>
                <c:pt idx="16">
                  <c:v>24.34</c:v>
                </c:pt>
                <c:pt idx="17">
                  <c:v>24.7</c:v>
                </c:pt>
                <c:pt idx="18">
                  <c:v>24.38</c:v>
                </c:pt>
                <c:pt idx="19">
                  <c:v>24.35</c:v>
                </c:pt>
                <c:pt idx="20">
                  <c:v>25.08</c:v>
                </c:pt>
                <c:pt idx="21">
                  <c:v>24</c:v>
                </c:pt>
                <c:pt idx="22">
                  <c:v>25.51</c:v>
                </c:pt>
                <c:pt idx="23">
                  <c:v>24.94</c:v>
                </c:pt>
                <c:pt idx="24">
                  <c:v>24.77</c:v>
                </c:pt>
                <c:pt idx="25">
                  <c:v>24.72</c:v>
                </c:pt>
                <c:pt idx="26">
                  <c:v>24.22</c:v>
                </c:pt>
                <c:pt idx="27">
                  <c:v>25.03</c:v>
                </c:pt>
                <c:pt idx="28">
                  <c:v>24.31</c:v>
                </c:pt>
                <c:pt idx="29">
                  <c:v>24.51</c:v>
                </c:pt>
                <c:pt idx="30">
                  <c:v>23.88</c:v>
                </c:pt>
                <c:pt idx="31">
                  <c:v>23.49</c:v>
                </c:pt>
                <c:pt idx="32">
                  <c:v>24.03</c:v>
                </c:pt>
                <c:pt idx="33">
                  <c:v>23.99</c:v>
                </c:pt>
                <c:pt idx="34">
                  <c:v>23.37</c:v>
                </c:pt>
                <c:pt idx="35">
                  <c:v>24.02</c:v>
                </c:pt>
                <c:pt idx="36">
                  <c:v>24.26</c:v>
                </c:pt>
                <c:pt idx="37">
                  <c:v>24.22</c:v>
                </c:pt>
                <c:pt idx="38">
                  <c:v>24.57</c:v>
                </c:pt>
                <c:pt idx="39">
                  <c:v>23.66</c:v>
                </c:pt>
                <c:pt idx="40">
                  <c:v>24.16</c:v>
                </c:pt>
                <c:pt idx="41">
                  <c:v>24.02</c:v>
                </c:pt>
                <c:pt idx="42">
                  <c:v>23.97</c:v>
                </c:pt>
                <c:pt idx="43">
                  <c:v>24.09</c:v>
                </c:pt>
                <c:pt idx="44">
                  <c:v>24.31</c:v>
                </c:pt>
              </c:numCache>
            </c:numRef>
          </c:xVal>
          <c:yVal>
            <c:numRef>
              <c:f>'Scatter plot'!$Z$3:$Z$47</c:f>
              <c:numCache>
                <c:formatCode>General</c:formatCode>
                <c:ptCount val="45"/>
                <c:pt idx="0">
                  <c:v>0.309</c:v>
                </c:pt>
                <c:pt idx="1">
                  <c:v>0.255</c:v>
                </c:pt>
                <c:pt idx="2">
                  <c:v>0.307</c:v>
                </c:pt>
                <c:pt idx="3">
                  <c:v>0.17499999999999999</c:v>
                </c:pt>
                <c:pt idx="4">
                  <c:v>0.27500000000000002</c:v>
                </c:pt>
                <c:pt idx="5">
                  <c:v>0.21</c:v>
                </c:pt>
                <c:pt idx="6">
                  <c:v>0.159</c:v>
                </c:pt>
                <c:pt idx="7">
                  <c:v>0.215</c:v>
                </c:pt>
                <c:pt idx="8">
                  <c:v>0.23899999999999999</c:v>
                </c:pt>
                <c:pt idx="9">
                  <c:v>0.25600000000000001</c:v>
                </c:pt>
                <c:pt idx="10">
                  <c:v>0.216</c:v>
                </c:pt>
                <c:pt idx="11">
                  <c:v>0.245</c:v>
                </c:pt>
                <c:pt idx="12">
                  <c:v>0.27900000000000003</c:v>
                </c:pt>
                <c:pt idx="13">
                  <c:v>0.28599999999999998</c:v>
                </c:pt>
                <c:pt idx="14">
                  <c:v>0.25700000000000001</c:v>
                </c:pt>
                <c:pt idx="15">
                  <c:v>0.23400000000000001</c:v>
                </c:pt>
                <c:pt idx="16">
                  <c:v>0.249</c:v>
                </c:pt>
                <c:pt idx="17">
                  <c:v>0.29099999999999998</c:v>
                </c:pt>
                <c:pt idx="18">
                  <c:v>0.27800000000000002</c:v>
                </c:pt>
                <c:pt idx="19">
                  <c:v>0.27800000000000002</c:v>
                </c:pt>
                <c:pt idx="20">
                  <c:v>0.17799999999999999</c:v>
                </c:pt>
                <c:pt idx="21">
                  <c:v>0.29399999999999998</c:v>
                </c:pt>
                <c:pt idx="22">
                  <c:v>0.24299999999999999</c:v>
                </c:pt>
                <c:pt idx="23">
                  <c:v>0.27900000000000003</c:v>
                </c:pt>
                <c:pt idx="24">
                  <c:v>0.28599999999999998</c:v>
                </c:pt>
                <c:pt idx="25">
                  <c:v>0.26500000000000001</c:v>
                </c:pt>
                <c:pt idx="26">
                  <c:v>0.19900000000000001</c:v>
                </c:pt>
                <c:pt idx="27">
                  <c:v>0.187</c:v>
                </c:pt>
                <c:pt idx="28">
                  <c:v>0.20799999999999999</c:v>
                </c:pt>
                <c:pt idx="29">
                  <c:v>0.27400000000000002</c:v>
                </c:pt>
                <c:pt idx="30">
                  <c:v>0.30199999999999999</c:v>
                </c:pt>
                <c:pt idx="31">
                  <c:v>0.26600000000000001</c:v>
                </c:pt>
                <c:pt idx="32">
                  <c:v>0.36899999999999999</c:v>
                </c:pt>
                <c:pt idx="33">
                  <c:v>0.26600000000000001</c:v>
                </c:pt>
                <c:pt idx="34">
                  <c:v>0.30199999999999999</c:v>
                </c:pt>
                <c:pt idx="35">
                  <c:v>0.29599999999999999</c:v>
                </c:pt>
                <c:pt idx="36">
                  <c:v>0.34</c:v>
                </c:pt>
                <c:pt idx="37">
                  <c:v>0.28699999999999998</c:v>
                </c:pt>
                <c:pt idx="38">
                  <c:v>0.28899999999999998</c:v>
                </c:pt>
                <c:pt idx="39">
                  <c:v>0.218</c:v>
                </c:pt>
                <c:pt idx="40">
                  <c:v>0.224</c:v>
                </c:pt>
                <c:pt idx="41">
                  <c:v>0.25700000000000001</c:v>
                </c:pt>
                <c:pt idx="42">
                  <c:v>0.26700000000000002</c:v>
                </c:pt>
                <c:pt idx="43">
                  <c:v>0.254</c:v>
                </c:pt>
                <c:pt idx="44">
                  <c:v>0.2740000000000000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589A-4C89-A868-B8198A727E81}"/>
            </c:ext>
          </c:extLst>
        </c:ser>
        <c:ser>
          <c:idx val="1"/>
          <c:order val="1"/>
          <c:tx>
            <c:strRef>
              <c:f>'Scatter plot'!$C$2</c:f>
              <c:strCache>
                <c:ptCount val="1"/>
                <c:pt idx="0">
                  <c:v>toc1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noFill/>
              <a:ln w="12700">
                <a:solidFill>
                  <a:schemeClr val="accent2"/>
                </a:solidFill>
              </a:ln>
              <a:effectLst/>
            </c:spPr>
          </c:marker>
          <c:xVal>
            <c:numRef>
              <c:f>'Scatter plot'!$C$3:$C$47</c:f>
              <c:numCache>
                <c:formatCode>General</c:formatCode>
                <c:ptCount val="45"/>
                <c:pt idx="0">
                  <c:v>19.52</c:v>
                </c:pt>
                <c:pt idx="1">
                  <c:v>24.23</c:v>
                </c:pt>
                <c:pt idx="2">
                  <c:v>19.420000000000002</c:v>
                </c:pt>
                <c:pt idx="3">
                  <c:v>19.18</c:v>
                </c:pt>
                <c:pt idx="4">
                  <c:v>20.54</c:v>
                </c:pt>
                <c:pt idx="5">
                  <c:v>19.23</c:v>
                </c:pt>
                <c:pt idx="6">
                  <c:v>19.41</c:v>
                </c:pt>
                <c:pt idx="7">
                  <c:v>19.5</c:v>
                </c:pt>
                <c:pt idx="8">
                  <c:v>19.55</c:v>
                </c:pt>
                <c:pt idx="9">
                  <c:v>19.52</c:v>
                </c:pt>
                <c:pt idx="10">
                  <c:v>23.97</c:v>
                </c:pt>
                <c:pt idx="11">
                  <c:v>19.57</c:v>
                </c:pt>
                <c:pt idx="12">
                  <c:v>20.29</c:v>
                </c:pt>
                <c:pt idx="13">
                  <c:v>23.22</c:v>
                </c:pt>
                <c:pt idx="14">
                  <c:v>24.09</c:v>
                </c:pt>
                <c:pt idx="15">
                  <c:v>20.04</c:v>
                </c:pt>
                <c:pt idx="16">
                  <c:v>19.559999999999999</c:v>
                </c:pt>
                <c:pt idx="17">
                  <c:v>20.16</c:v>
                </c:pt>
                <c:pt idx="18">
                  <c:v>19.27</c:v>
                </c:pt>
                <c:pt idx="19">
                  <c:v>19.64</c:v>
                </c:pt>
                <c:pt idx="20">
                  <c:v>19.18</c:v>
                </c:pt>
                <c:pt idx="21">
                  <c:v>20.94</c:v>
                </c:pt>
                <c:pt idx="22">
                  <c:v>19.63</c:v>
                </c:pt>
                <c:pt idx="23">
                  <c:v>19.12</c:v>
                </c:pt>
                <c:pt idx="24">
                  <c:v>20.170000000000002</c:v>
                </c:pt>
                <c:pt idx="25">
                  <c:v>23.71</c:v>
                </c:pt>
                <c:pt idx="26">
                  <c:v>19.3</c:v>
                </c:pt>
                <c:pt idx="27">
                  <c:v>19.39</c:v>
                </c:pt>
                <c:pt idx="28">
                  <c:v>21.27</c:v>
                </c:pt>
                <c:pt idx="29">
                  <c:v>18.8</c:v>
                </c:pt>
                <c:pt idx="30">
                  <c:v>19.309999999999999</c:v>
                </c:pt>
                <c:pt idx="31">
                  <c:v>19.36</c:v>
                </c:pt>
                <c:pt idx="32">
                  <c:v>20.14</c:v>
                </c:pt>
                <c:pt idx="33">
                  <c:v>19.440000000000001</c:v>
                </c:pt>
                <c:pt idx="34">
                  <c:v>19.260000000000002</c:v>
                </c:pt>
                <c:pt idx="35">
                  <c:v>20.34</c:v>
                </c:pt>
                <c:pt idx="36">
                  <c:v>19.350000000000001</c:v>
                </c:pt>
                <c:pt idx="37">
                  <c:v>19.47</c:v>
                </c:pt>
                <c:pt idx="38">
                  <c:v>19.52</c:v>
                </c:pt>
                <c:pt idx="39">
                  <c:v>19.850000000000001</c:v>
                </c:pt>
                <c:pt idx="40">
                  <c:v>19.27</c:v>
                </c:pt>
                <c:pt idx="41">
                  <c:v>19.420000000000002</c:v>
                </c:pt>
                <c:pt idx="42">
                  <c:v>19</c:v>
                </c:pt>
                <c:pt idx="43">
                  <c:v>19.559999999999999</c:v>
                </c:pt>
                <c:pt idx="44">
                  <c:v>20.53</c:v>
                </c:pt>
              </c:numCache>
            </c:numRef>
          </c:xVal>
          <c:yVal>
            <c:numRef>
              <c:f>'Scatter plot'!$AA$3:$AA$47</c:f>
              <c:numCache>
                <c:formatCode>General</c:formatCode>
                <c:ptCount val="45"/>
                <c:pt idx="0">
                  <c:v>0.34499999999999997</c:v>
                </c:pt>
                <c:pt idx="1">
                  <c:v>0.40200000000000002</c:v>
                </c:pt>
                <c:pt idx="2">
                  <c:v>0.25900000000000001</c:v>
                </c:pt>
                <c:pt idx="3">
                  <c:v>0.33400000000000002</c:v>
                </c:pt>
                <c:pt idx="4">
                  <c:v>0.28100000000000003</c:v>
                </c:pt>
                <c:pt idx="5">
                  <c:v>0.41799999999999998</c:v>
                </c:pt>
                <c:pt idx="6">
                  <c:v>0.28000000000000003</c:v>
                </c:pt>
                <c:pt idx="7">
                  <c:v>0.255</c:v>
                </c:pt>
                <c:pt idx="8">
                  <c:v>0.315</c:v>
                </c:pt>
                <c:pt idx="9">
                  <c:v>0.17599999999999999</c:v>
                </c:pt>
                <c:pt idx="10">
                  <c:v>0.39300000000000002</c:v>
                </c:pt>
                <c:pt idx="11">
                  <c:v>0.24099999999999999</c:v>
                </c:pt>
                <c:pt idx="12">
                  <c:v>0.32</c:v>
                </c:pt>
                <c:pt idx="13">
                  <c:v>0.26</c:v>
                </c:pt>
                <c:pt idx="14">
                  <c:v>0.41499999999999998</c:v>
                </c:pt>
                <c:pt idx="15">
                  <c:v>0.33500000000000002</c:v>
                </c:pt>
                <c:pt idx="16">
                  <c:v>0.23899999999999999</c:v>
                </c:pt>
                <c:pt idx="17">
                  <c:v>0.27700000000000002</c:v>
                </c:pt>
                <c:pt idx="18">
                  <c:v>0.20100000000000001</c:v>
                </c:pt>
                <c:pt idx="19">
                  <c:v>0.20899999999999999</c:v>
                </c:pt>
                <c:pt idx="20">
                  <c:v>0.23200000000000001</c:v>
                </c:pt>
                <c:pt idx="21">
                  <c:v>0.36199999999999999</c:v>
                </c:pt>
                <c:pt idx="22">
                  <c:v>0.33600000000000002</c:v>
                </c:pt>
                <c:pt idx="23">
                  <c:v>0.33400000000000002</c:v>
                </c:pt>
                <c:pt idx="24">
                  <c:v>0.26300000000000001</c:v>
                </c:pt>
                <c:pt idx="25">
                  <c:v>0.48699999999999999</c:v>
                </c:pt>
                <c:pt idx="26">
                  <c:v>0.29799999999999999</c:v>
                </c:pt>
                <c:pt idx="27">
                  <c:v>0.25700000000000001</c:v>
                </c:pt>
                <c:pt idx="28">
                  <c:v>0.248</c:v>
                </c:pt>
                <c:pt idx="29">
                  <c:v>0.17199999999999999</c:v>
                </c:pt>
                <c:pt idx="30">
                  <c:v>0.21099999999999999</c:v>
                </c:pt>
                <c:pt idx="31">
                  <c:v>0.24</c:v>
                </c:pt>
                <c:pt idx="32">
                  <c:v>0.25</c:v>
                </c:pt>
                <c:pt idx="33">
                  <c:v>0.20100000000000001</c:v>
                </c:pt>
                <c:pt idx="34">
                  <c:v>0.183</c:v>
                </c:pt>
                <c:pt idx="35">
                  <c:v>0.24399999999999999</c:v>
                </c:pt>
                <c:pt idx="36">
                  <c:v>0.27700000000000002</c:v>
                </c:pt>
                <c:pt idx="37">
                  <c:v>0.21299999999999999</c:v>
                </c:pt>
                <c:pt idx="38">
                  <c:v>0.223</c:v>
                </c:pt>
                <c:pt idx="39">
                  <c:v>0.222</c:v>
                </c:pt>
                <c:pt idx="40">
                  <c:v>0.161</c:v>
                </c:pt>
                <c:pt idx="41">
                  <c:v>0.17499999999999999</c:v>
                </c:pt>
                <c:pt idx="42">
                  <c:v>0.21</c:v>
                </c:pt>
                <c:pt idx="43">
                  <c:v>0.20300000000000001</c:v>
                </c:pt>
                <c:pt idx="44">
                  <c:v>0.1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589A-4C89-A868-B8198A727E81}"/>
            </c:ext>
          </c:extLst>
        </c:ser>
        <c:ser>
          <c:idx val="4"/>
          <c:order val="2"/>
          <c:tx>
            <c:strRef>
              <c:f>'Scatter plot'!$E$2</c:f>
              <c:strCache>
                <c:ptCount val="1"/>
                <c:pt idx="0">
                  <c:v>pTOC1:TOC1-GFP/t1 #2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square"/>
            <c:size val="5"/>
            <c:spPr>
              <a:noFill/>
              <a:ln w="12700">
                <a:solidFill>
                  <a:srgbClr val="FF99CC"/>
                </a:solidFill>
              </a:ln>
              <a:effectLst/>
            </c:spPr>
          </c:marker>
          <c:xVal>
            <c:numRef>
              <c:f>'Scatter plot'!$E$3:$E$47</c:f>
              <c:numCache>
                <c:formatCode>General</c:formatCode>
                <c:ptCount val="45"/>
                <c:pt idx="0">
                  <c:v>25.09</c:v>
                </c:pt>
                <c:pt idx="1">
                  <c:v>25.71</c:v>
                </c:pt>
                <c:pt idx="2">
                  <c:v>25.17</c:v>
                </c:pt>
                <c:pt idx="3">
                  <c:v>27</c:v>
                </c:pt>
                <c:pt idx="4">
                  <c:v>24.21</c:v>
                </c:pt>
                <c:pt idx="5">
                  <c:v>24.97</c:v>
                </c:pt>
                <c:pt idx="6">
                  <c:v>25.28</c:v>
                </c:pt>
                <c:pt idx="7">
                  <c:v>24.59</c:v>
                </c:pt>
                <c:pt idx="8">
                  <c:v>24.29</c:v>
                </c:pt>
                <c:pt idx="9">
                  <c:v>25.47</c:v>
                </c:pt>
                <c:pt idx="10">
                  <c:v>26.26</c:v>
                </c:pt>
                <c:pt idx="11">
                  <c:v>26.08</c:v>
                </c:pt>
                <c:pt idx="12">
                  <c:v>24.83</c:v>
                </c:pt>
                <c:pt idx="13">
                  <c:v>25.39</c:v>
                </c:pt>
                <c:pt idx="14">
                  <c:v>26.3</c:v>
                </c:pt>
                <c:pt idx="15">
                  <c:v>25.09</c:v>
                </c:pt>
                <c:pt idx="16">
                  <c:v>25.87</c:v>
                </c:pt>
                <c:pt idx="17">
                  <c:v>26.48</c:v>
                </c:pt>
                <c:pt idx="18">
                  <c:v>26.67</c:v>
                </c:pt>
                <c:pt idx="19">
                  <c:v>25.97</c:v>
                </c:pt>
                <c:pt idx="20">
                  <c:v>21.68</c:v>
                </c:pt>
                <c:pt idx="21">
                  <c:v>26.84</c:v>
                </c:pt>
                <c:pt idx="22">
                  <c:v>26.95</c:v>
                </c:pt>
                <c:pt idx="23">
                  <c:v>25.31</c:v>
                </c:pt>
                <c:pt idx="24">
                  <c:v>26.1</c:v>
                </c:pt>
                <c:pt idx="25">
                  <c:v>26.1</c:v>
                </c:pt>
                <c:pt idx="26">
                  <c:v>26.43</c:v>
                </c:pt>
                <c:pt idx="27">
                  <c:v>26.16</c:v>
                </c:pt>
                <c:pt idx="28">
                  <c:v>27.05</c:v>
                </c:pt>
                <c:pt idx="29">
                  <c:v>26.62</c:v>
                </c:pt>
                <c:pt idx="30">
                  <c:v>24.06</c:v>
                </c:pt>
                <c:pt idx="31">
                  <c:v>24.34</c:v>
                </c:pt>
                <c:pt idx="32">
                  <c:v>24.65</c:v>
                </c:pt>
                <c:pt idx="33">
                  <c:v>25.02</c:v>
                </c:pt>
                <c:pt idx="34">
                  <c:v>24.45</c:v>
                </c:pt>
                <c:pt idx="35">
                  <c:v>24.66</c:v>
                </c:pt>
                <c:pt idx="36">
                  <c:v>24.69</c:v>
                </c:pt>
                <c:pt idx="37">
                  <c:v>23.51</c:v>
                </c:pt>
                <c:pt idx="38">
                  <c:v>24.46</c:v>
                </c:pt>
                <c:pt idx="39">
                  <c:v>24.05</c:v>
                </c:pt>
                <c:pt idx="40">
                  <c:v>24.36</c:v>
                </c:pt>
                <c:pt idx="41">
                  <c:v>25.42</c:v>
                </c:pt>
                <c:pt idx="42">
                  <c:v>24.34</c:v>
                </c:pt>
                <c:pt idx="43">
                  <c:v>24.29</c:v>
                </c:pt>
                <c:pt idx="44">
                  <c:v>24.85</c:v>
                </c:pt>
              </c:numCache>
            </c:numRef>
          </c:xVal>
          <c:yVal>
            <c:numRef>
              <c:f>'Scatter plot'!$AC$3:$AC$47</c:f>
              <c:numCache>
                <c:formatCode>General</c:formatCode>
                <c:ptCount val="45"/>
                <c:pt idx="0">
                  <c:v>0.47799999999999998</c:v>
                </c:pt>
                <c:pt idx="1">
                  <c:v>0.21299999999999999</c:v>
                </c:pt>
                <c:pt idx="2">
                  <c:v>0.29799999999999999</c:v>
                </c:pt>
                <c:pt idx="3">
                  <c:v>0.38500000000000001</c:v>
                </c:pt>
                <c:pt idx="4">
                  <c:v>0.44400000000000001</c:v>
                </c:pt>
                <c:pt idx="5">
                  <c:v>0.36899999999999999</c:v>
                </c:pt>
                <c:pt idx="6">
                  <c:v>0.39</c:v>
                </c:pt>
                <c:pt idx="7">
                  <c:v>0.309</c:v>
                </c:pt>
                <c:pt idx="8">
                  <c:v>0.377</c:v>
                </c:pt>
                <c:pt idx="9">
                  <c:v>0.34399999999999997</c:v>
                </c:pt>
                <c:pt idx="10">
                  <c:v>0.34799999999999998</c:v>
                </c:pt>
                <c:pt idx="11">
                  <c:v>0.44400000000000001</c:v>
                </c:pt>
                <c:pt idx="12">
                  <c:v>0.41099999999999998</c:v>
                </c:pt>
                <c:pt idx="13">
                  <c:v>0.38</c:v>
                </c:pt>
                <c:pt idx="14">
                  <c:v>0.41499999999999998</c:v>
                </c:pt>
                <c:pt idx="15">
                  <c:v>0.27300000000000002</c:v>
                </c:pt>
                <c:pt idx="16">
                  <c:v>0.39100000000000001</c:v>
                </c:pt>
                <c:pt idx="17">
                  <c:v>0.56899999999999995</c:v>
                </c:pt>
                <c:pt idx="18">
                  <c:v>0.28799999999999998</c:v>
                </c:pt>
                <c:pt idx="19">
                  <c:v>0.308</c:v>
                </c:pt>
                <c:pt idx="20">
                  <c:v>0.43</c:v>
                </c:pt>
                <c:pt idx="21">
                  <c:v>0.41299999999999998</c:v>
                </c:pt>
                <c:pt idx="22">
                  <c:v>0.51300000000000001</c:v>
                </c:pt>
                <c:pt idx="23">
                  <c:v>0.311</c:v>
                </c:pt>
                <c:pt idx="24">
                  <c:v>0.34</c:v>
                </c:pt>
                <c:pt idx="25">
                  <c:v>0.49099999999999999</c:v>
                </c:pt>
                <c:pt idx="26">
                  <c:v>0.35799999999999998</c:v>
                </c:pt>
                <c:pt idx="27">
                  <c:v>0.23200000000000001</c:v>
                </c:pt>
                <c:pt idx="28">
                  <c:v>0.26700000000000002</c:v>
                </c:pt>
                <c:pt idx="29">
                  <c:v>0.41299999999999998</c:v>
                </c:pt>
                <c:pt idx="30">
                  <c:v>0.27900000000000003</c:v>
                </c:pt>
                <c:pt idx="31">
                  <c:v>0.21</c:v>
                </c:pt>
                <c:pt idx="32">
                  <c:v>0.19900000000000001</c:v>
                </c:pt>
                <c:pt idx="33">
                  <c:v>0.187</c:v>
                </c:pt>
                <c:pt idx="34">
                  <c:v>0.22800000000000001</c:v>
                </c:pt>
                <c:pt idx="35">
                  <c:v>0.19700000000000001</c:v>
                </c:pt>
                <c:pt idx="36">
                  <c:v>0.33900000000000002</c:v>
                </c:pt>
                <c:pt idx="37">
                  <c:v>0.28000000000000003</c:v>
                </c:pt>
                <c:pt idx="38">
                  <c:v>0.249</c:v>
                </c:pt>
                <c:pt idx="39">
                  <c:v>0.222</c:v>
                </c:pt>
                <c:pt idx="40">
                  <c:v>0.24199999999999999</c:v>
                </c:pt>
                <c:pt idx="41">
                  <c:v>0.20599999999999999</c:v>
                </c:pt>
                <c:pt idx="42">
                  <c:v>0.25700000000000001</c:v>
                </c:pt>
                <c:pt idx="43">
                  <c:v>0.252</c:v>
                </c:pt>
                <c:pt idx="44">
                  <c:v>0.2730000000000000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589A-4C89-A868-B8198A727E81}"/>
            </c:ext>
          </c:extLst>
        </c:ser>
        <c:ser>
          <c:idx val="5"/>
          <c:order val="3"/>
          <c:tx>
            <c:strRef>
              <c:f>'Scatter plot'!$G$2</c:f>
              <c:strCache>
                <c:ptCount val="1"/>
                <c:pt idx="0">
                  <c:v>pTOC1:5X-GFP/t1 #2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triangle"/>
            <c:size val="6"/>
            <c:spPr>
              <a:noFill/>
              <a:ln w="12700">
                <a:solidFill>
                  <a:srgbClr val="C00000"/>
                </a:solidFill>
              </a:ln>
              <a:effectLst/>
            </c:spPr>
          </c:marker>
          <c:xVal>
            <c:numRef>
              <c:f>'Scatter plot'!$G$3:$G$47</c:f>
              <c:numCache>
                <c:formatCode>General</c:formatCode>
                <c:ptCount val="45"/>
                <c:pt idx="0">
                  <c:v>22.75</c:v>
                </c:pt>
                <c:pt idx="1">
                  <c:v>22.57</c:v>
                </c:pt>
                <c:pt idx="2">
                  <c:v>22.79</c:v>
                </c:pt>
                <c:pt idx="3">
                  <c:v>22.53</c:v>
                </c:pt>
                <c:pt idx="4">
                  <c:v>22.33</c:v>
                </c:pt>
                <c:pt idx="5">
                  <c:v>21.53</c:v>
                </c:pt>
                <c:pt idx="6">
                  <c:v>22.52</c:v>
                </c:pt>
                <c:pt idx="7">
                  <c:v>22.76</c:v>
                </c:pt>
                <c:pt idx="8">
                  <c:v>22.34</c:v>
                </c:pt>
                <c:pt idx="9">
                  <c:v>22.66</c:v>
                </c:pt>
                <c:pt idx="10">
                  <c:v>22.05</c:v>
                </c:pt>
                <c:pt idx="11">
                  <c:v>21.98</c:v>
                </c:pt>
                <c:pt idx="12">
                  <c:v>21.55</c:v>
                </c:pt>
                <c:pt idx="13">
                  <c:v>21.96</c:v>
                </c:pt>
                <c:pt idx="14">
                  <c:v>22.9</c:v>
                </c:pt>
                <c:pt idx="15">
                  <c:v>22.86</c:v>
                </c:pt>
                <c:pt idx="16">
                  <c:v>22.26</c:v>
                </c:pt>
                <c:pt idx="17">
                  <c:v>22.23</c:v>
                </c:pt>
                <c:pt idx="18">
                  <c:v>22.18</c:v>
                </c:pt>
                <c:pt idx="19">
                  <c:v>22.86</c:v>
                </c:pt>
                <c:pt idx="20">
                  <c:v>22.2</c:v>
                </c:pt>
                <c:pt idx="21">
                  <c:v>22.85</c:v>
                </c:pt>
                <c:pt idx="22">
                  <c:v>21.97</c:v>
                </c:pt>
                <c:pt idx="23">
                  <c:v>22.31</c:v>
                </c:pt>
                <c:pt idx="24">
                  <c:v>22.59</c:v>
                </c:pt>
                <c:pt idx="25">
                  <c:v>22.68</c:v>
                </c:pt>
                <c:pt idx="26">
                  <c:v>22.09</c:v>
                </c:pt>
                <c:pt idx="27">
                  <c:v>22.4</c:v>
                </c:pt>
                <c:pt idx="28">
                  <c:v>22.17</c:v>
                </c:pt>
                <c:pt idx="29">
                  <c:v>22.56</c:v>
                </c:pt>
                <c:pt idx="30">
                  <c:v>22.92</c:v>
                </c:pt>
                <c:pt idx="31">
                  <c:v>22.65</c:v>
                </c:pt>
                <c:pt idx="32">
                  <c:v>22.13</c:v>
                </c:pt>
                <c:pt idx="33">
                  <c:v>22.61</c:v>
                </c:pt>
                <c:pt idx="34">
                  <c:v>22.41</c:v>
                </c:pt>
                <c:pt idx="35">
                  <c:v>22.27</c:v>
                </c:pt>
                <c:pt idx="36">
                  <c:v>22.71</c:v>
                </c:pt>
                <c:pt idx="37">
                  <c:v>22.56</c:v>
                </c:pt>
                <c:pt idx="38">
                  <c:v>22.16</c:v>
                </c:pt>
                <c:pt idx="39">
                  <c:v>22.24</c:v>
                </c:pt>
                <c:pt idx="40">
                  <c:v>22.77</c:v>
                </c:pt>
                <c:pt idx="41">
                  <c:v>22.62</c:v>
                </c:pt>
                <c:pt idx="42">
                  <c:v>22.12</c:v>
                </c:pt>
                <c:pt idx="43">
                  <c:v>22.6</c:v>
                </c:pt>
                <c:pt idx="44">
                  <c:v>23.11</c:v>
                </c:pt>
              </c:numCache>
            </c:numRef>
          </c:xVal>
          <c:yVal>
            <c:numRef>
              <c:f>'Scatter plot'!$AE$3:$AE$47</c:f>
              <c:numCache>
                <c:formatCode>General</c:formatCode>
                <c:ptCount val="45"/>
                <c:pt idx="0">
                  <c:v>0.19800000000000001</c:v>
                </c:pt>
                <c:pt idx="1">
                  <c:v>0.152</c:v>
                </c:pt>
                <c:pt idx="2">
                  <c:v>0.19700000000000001</c:v>
                </c:pt>
                <c:pt idx="3">
                  <c:v>0.112</c:v>
                </c:pt>
                <c:pt idx="4">
                  <c:v>0.40200000000000002</c:v>
                </c:pt>
                <c:pt idx="5">
                  <c:v>0.377</c:v>
                </c:pt>
                <c:pt idx="6">
                  <c:v>0.221</c:v>
                </c:pt>
                <c:pt idx="7">
                  <c:v>0.22600000000000001</c:v>
                </c:pt>
                <c:pt idx="8">
                  <c:v>0.16700000000000001</c:v>
                </c:pt>
                <c:pt idx="9">
                  <c:v>0.28799999999999998</c:v>
                </c:pt>
                <c:pt idx="10">
                  <c:v>0.191</c:v>
                </c:pt>
                <c:pt idx="11">
                  <c:v>0.28000000000000003</c:v>
                </c:pt>
                <c:pt idx="12">
                  <c:v>0.311</c:v>
                </c:pt>
                <c:pt idx="13">
                  <c:v>0.29599999999999999</c:v>
                </c:pt>
                <c:pt idx="14">
                  <c:v>0.24399999999999999</c:v>
                </c:pt>
                <c:pt idx="15">
                  <c:v>0.223</c:v>
                </c:pt>
                <c:pt idx="16">
                  <c:v>0.17499999999999999</c:v>
                </c:pt>
                <c:pt idx="17">
                  <c:v>0.21099999999999999</c:v>
                </c:pt>
                <c:pt idx="18">
                  <c:v>0.221</c:v>
                </c:pt>
                <c:pt idx="19">
                  <c:v>0.26500000000000001</c:v>
                </c:pt>
                <c:pt idx="20">
                  <c:v>0.27</c:v>
                </c:pt>
                <c:pt idx="21">
                  <c:v>0.26800000000000002</c:v>
                </c:pt>
                <c:pt idx="22">
                  <c:v>0.308</c:v>
                </c:pt>
                <c:pt idx="23">
                  <c:v>0.20599999999999999</c:v>
                </c:pt>
                <c:pt idx="24">
                  <c:v>0.248</c:v>
                </c:pt>
                <c:pt idx="25">
                  <c:v>0.22700000000000001</c:v>
                </c:pt>
                <c:pt idx="26">
                  <c:v>0.26900000000000002</c:v>
                </c:pt>
                <c:pt idx="27">
                  <c:v>0.28999999999999998</c:v>
                </c:pt>
                <c:pt idx="28">
                  <c:v>0.314</c:v>
                </c:pt>
                <c:pt idx="29">
                  <c:v>0.20599999999999999</c:v>
                </c:pt>
                <c:pt idx="30">
                  <c:v>0.23499999999999999</c:v>
                </c:pt>
                <c:pt idx="31">
                  <c:v>0.187</c:v>
                </c:pt>
                <c:pt idx="32">
                  <c:v>0.23200000000000001</c:v>
                </c:pt>
                <c:pt idx="33">
                  <c:v>0.35499999999999998</c:v>
                </c:pt>
                <c:pt idx="34">
                  <c:v>0.24199999999999999</c:v>
                </c:pt>
                <c:pt idx="35">
                  <c:v>0.27</c:v>
                </c:pt>
                <c:pt idx="36">
                  <c:v>0.26900000000000002</c:v>
                </c:pt>
                <c:pt idx="37">
                  <c:v>0.23799999999999999</c:v>
                </c:pt>
                <c:pt idx="38">
                  <c:v>0.254</c:v>
                </c:pt>
                <c:pt idx="39">
                  <c:v>0.27800000000000002</c:v>
                </c:pt>
                <c:pt idx="40">
                  <c:v>0.23300000000000001</c:v>
                </c:pt>
                <c:pt idx="41">
                  <c:v>0.22600000000000001</c:v>
                </c:pt>
                <c:pt idx="42">
                  <c:v>0.28000000000000003</c:v>
                </c:pt>
                <c:pt idx="43">
                  <c:v>0.31</c:v>
                </c:pt>
                <c:pt idx="44">
                  <c:v>0.2379999999999999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589A-4C89-A868-B8198A727E8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124547135"/>
        <c:axId val="541556943"/>
        <c:extLst/>
      </c:scatterChart>
      <c:valAx>
        <c:axId val="1124547135"/>
        <c:scaling>
          <c:orientation val="minMax"/>
          <c:min val="18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Period (hr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41556943"/>
        <c:crosses val="autoZero"/>
        <c:crossBetween val="midCat"/>
        <c:majorUnit val="1"/>
      </c:valAx>
      <c:valAx>
        <c:axId val="541556943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000"/>
                  <a:t>RAE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124547135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r"/>
      <c:legendEntry>
        <c:idx val="0"/>
        <c:txPr>
          <a:bodyPr rot="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</c:legendEntry>
      <c:legendEntry>
        <c:idx val="1"/>
        <c:txPr>
          <a:bodyPr rot="0" spcFirstLastPara="1" vertOverflow="ellipsis" vert="horz" wrap="square" anchor="ctr" anchorCtr="1"/>
          <a:lstStyle/>
          <a:p>
            <a:pPr>
              <a:defRPr sz="900" b="0" i="1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</c:legendEntry>
      <c:layout>
        <c:manualLayout>
          <c:xMode val="edge"/>
          <c:yMode val="edge"/>
          <c:x val="0.70332647019736172"/>
          <c:y val="0.26007034326942802"/>
          <c:w val="0.29667349266274423"/>
          <c:h val="0.28478695561174716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1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solidFill>
            <a:sysClr val="windowText" lastClr="000000"/>
          </a:solidFill>
        </a:defRPr>
      </a:pPr>
      <a:endParaRPr lang="en-US"/>
    </a:p>
  </c:txPr>
  <c:externalData r:id="rId3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60" b="0" i="1" u="none" strike="noStrike" baseline="0">
                <a:solidFill>
                  <a:srgbClr val="000000"/>
                </a:solidFill>
                <a:latin typeface="Calibri"/>
                <a:ea typeface="Calibri"/>
                <a:cs typeface="Calibri"/>
              </a:defRPr>
            </a:pPr>
            <a:r>
              <a:rPr lang="en-US" altLang="zh-CN" i="1" dirty="0"/>
              <a:t>CCA1 </a:t>
            </a:r>
          </a:p>
        </c:rich>
      </c:tx>
      <c:layout>
        <c:manualLayout>
          <c:xMode val="edge"/>
          <c:yMode val="edge"/>
          <c:x val="0.44829181615168973"/>
          <c:y val="4.674370585572267E-2"/>
        </c:manualLayout>
      </c:layout>
      <c:overlay val="0"/>
      <c:spPr>
        <a:noFill/>
        <a:ln w="25400">
          <a:noFill/>
        </a:ln>
      </c:spPr>
    </c:title>
    <c:autoTitleDeleted val="0"/>
    <c:plotArea>
      <c:layout>
        <c:manualLayout>
          <c:layoutTarget val="inner"/>
          <c:xMode val="edge"/>
          <c:yMode val="edge"/>
          <c:x val="7.5724405964996522E-2"/>
          <c:y val="0.13682516954495177"/>
          <c:w val="0.87304360136793291"/>
          <c:h val="0.68253885639271572"/>
        </c:manualLayout>
      </c:layout>
      <c:lineChart>
        <c:grouping val="standard"/>
        <c:varyColors val="0"/>
        <c:ser>
          <c:idx val="0"/>
          <c:order val="0"/>
          <c:tx>
            <c:strRef>
              <c:f>'[2022-10-26 fhy3 1 normalize.xls]Sheet1'!$A$3</c:f>
              <c:strCache>
                <c:ptCount val="1"/>
                <c:pt idx="0">
                  <c:v>Col-0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noFill/>
              <a:ln w="12700">
                <a:solidFill>
                  <a:schemeClr val="accent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('https://d.docs.live.net/d8e9bd0bebfa4803/Somers%20lab%202020/Gene%20exp/[2022-5-20 LD 50umol zt1_4.xls]Sheet1'!$I$2,'https://d.docs.live.net/d8e9bd0bebfa4803/Somers%20lab%202020/Gene%20exp/[2022-5-20 LD 50umol zt1_4.xls]Sheet1'!$I$14,'https://d.docs.live.net/d8e9bd0bebfa4803/Somers%20lab%202020/Gene%20exp/[2022-5-20 LD 50umol zt1_4.xls]Sheet1'!$I$26,'https://d.docs.live.net/d8e9bd0bebfa4803/Somers%20lab%202020/Gene%20exp/[2022-5-20 LD 50umol zt1_4.xls]Sheet1'!$I$38,'https://d.docs.live.net/d8e9bd0bebfa4803/Somers%20lab%202020/Gene%20exp/[2022-5-20 LD 50umol zt1_4.xls]Sheet1'!$I$50,'https://d.docs.live.net/d8e9bd0bebfa4803/Somers%20lab%202020/Gene%20exp/[2022-5-20 LD 50umol zt1_4.xls]Sheet1'!$I$62,'https://d.docs.live.net/d8e9bd0bebfa4803/Somers%20lab%202020/Gene%20exp/[2022-5-20 LD 50umol zt1_4.xls]Sheet1'!$I$74,'https://d.docs.live.net/d8e9bd0bebfa4803/Somers%20lab%202020/Gene%20exp/[2022-5-20 LD 50umol zt1_4.xls]Sheet1'!$I$86)</c:f>
                <c:numCache>
                  <c:formatCode>General</c:formatCode>
                  <c:ptCount val="8"/>
                  <c:pt idx="0">
                    <c:v>3.9954191964042041E-2</c:v>
                  </c:pt>
                  <c:pt idx="1">
                    <c:v>2.1702121285376574E-2</c:v>
                  </c:pt>
                  <c:pt idx="2">
                    <c:v>3.0672177638113932E-3</c:v>
                  </c:pt>
                  <c:pt idx="3">
                    <c:v>1.1288837044739708E-4</c:v>
                  </c:pt>
                  <c:pt idx="4">
                    <c:v>1.7778717529663463E-4</c:v>
                  </c:pt>
                  <c:pt idx="5">
                    <c:v>9.4991907416536536E-5</c:v>
                  </c:pt>
                  <c:pt idx="6">
                    <c:v>3.4706044305174324E-3</c:v>
                  </c:pt>
                  <c:pt idx="7">
                    <c:v>3.54969011438237E-2</c:v>
                  </c:pt>
                </c:numCache>
              </c:numRef>
            </c:plus>
            <c:minus>
              <c:numRef>
                <c:f>('https://d.docs.live.net/d8e9bd0bebfa4803/Somers%20lab%202020/Gene%20exp/[2022-5-20 LD 50umol zt1_4.xls]Sheet1'!$I$2,'https://d.docs.live.net/d8e9bd0bebfa4803/Somers%20lab%202020/Gene%20exp/[2022-5-20 LD 50umol zt1_4.xls]Sheet1'!$I$14,'https://d.docs.live.net/d8e9bd0bebfa4803/Somers%20lab%202020/Gene%20exp/[2022-5-20 LD 50umol zt1_4.xls]Sheet1'!$I$26,'https://d.docs.live.net/d8e9bd0bebfa4803/Somers%20lab%202020/Gene%20exp/[2022-5-20 LD 50umol zt1_4.xls]Sheet1'!$I$38,'https://d.docs.live.net/d8e9bd0bebfa4803/Somers%20lab%202020/Gene%20exp/[2022-5-20 LD 50umol zt1_4.xls]Sheet1'!$I$50,'https://d.docs.live.net/d8e9bd0bebfa4803/Somers%20lab%202020/Gene%20exp/[2022-5-20 LD 50umol zt1_4.xls]Sheet1'!$I$62,'https://d.docs.live.net/d8e9bd0bebfa4803/Somers%20lab%202020/Gene%20exp/[2022-5-20 LD 50umol zt1_4.xls]Sheet1'!$I$74,'https://d.docs.live.net/d8e9bd0bebfa4803/Somers%20lab%202020/Gene%20exp/[2022-5-20 LD 50umol zt1_4.xls]Sheet1'!$I$86)</c:f>
                <c:numCache>
                  <c:formatCode>General</c:formatCode>
                  <c:ptCount val="8"/>
                  <c:pt idx="0">
                    <c:v>3.9954191964042041E-2</c:v>
                  </c:pt>
                  <c:pt idx="1">
                    <c:v>2.1702121285376574E-2</c:v>
                  </c:pt>
                  <c:pt idx="2">
                    <c:v>3.0672177638113932E-3</c:v>
                  </c:pt>
                  <c:pt idx="3">
                    <c:v>1.1288837044739708E-4</c:v>
                  </c:pt>
                  <c:pt idx="4">
                    <c:v>1.7778717529663463E-4</c:v>
                  </c:pt>
                  <c:pt idx="5">
                    <c:v>9.4991907416536536E-5</c:v>
                  </c:pt>
                  <c:pt idx="6">
                    <c:v>3.4706044305174324E-3</c:v>
                  </c:pt>
                  <c:pt idx="7">
                    <c:v>3.54969011438237E-2</c:v>
                  </c:pt>
                </c:numCache>
              </c:numRef>
            </c:minus>
            <c:spPr>
              <a:ln w="3175">
                <a:solidFill>
                  <a:srgbClr val="666699"/>
                </a:solidFill>
                <a:prstDash val="solid"/>
              </a:ln>
            </c:spPr>
          </c:errBars>
          <c:cat>
            <c:numRef>
              <c:f>'[2022-10-26 fhy3 1 normalize.xls]Sheet1'!$A$2,'[2022-10-26 fhy3 1 normalize.xls]Sheet1'!$A$14,'[2022-10-26 fhy3 1 normalize.xls]Sheet1'!$A$26,'[2022-10-26 fhy3 1 normalize.xls]Sheet1'!$A$38,'[2022-10-26 fhy3 1 normalize.xls]Sheet1'!$A$50,'[2022-10-26 fhy3 1 normalize.xls]Sheet1'!$A$62,'[2022-10-26 fhy3 1 normalize.xls]Sheet1'!$A$74,'[2022-10-26 fhy3 1 normalize.xls]Sheet1'!$A$86</c:f>
              <c:numCache>
                <c:formatCode>General</c:formatCode>
                <c:ptCount val="8"/>
                <c:pt idx="0">
                  <c:v>1</c:v>
                </c:pt>
                <c:pt idx="1">
                  <c:v>4</c:v>
                </c:pt>
                <c:pt idx="2">
                  <c:v>7</c:v>
                </c:pt>
                <c:pt idx="3">
                  <c:v>10</c:v>
                </c:pt>
                <c:pt idx="4">
                  <c:v>13</c:v>
                </c:pt>
                <c:pt idx="5">
                  <c:v>16</c:v>
                </c:pt>
                <c:pt idx="6">
                  <c:v>19</c:v>
                </c:pt>
                <c:pt idx="7">
                  <c:v>22</c:v>
                </c:pt>
              </c:numCache>
            </c:numRef>
          </c:cat>
          <c:val>
            <c:numRef>
              <c:f>'[2022-10-26 fhy3 1 normalize.xls]Sheet1'!$H$2,'[2022-10-26 fhy3 1 normalize.xls]Sheet1'!$H$14,'[2022-10-26 fhy3 1 normalize.xls]Sheet1'!$H$26,'[2022-10-26 fhy3 1 normalize.xls]Sheet1'!$H$38,'[2022-10-26 fhy3 1 normalize.xls]Sheet1'!$H$50,'[2022-10-26 fhy3 1 normalize.xls]Sheet1'!$H$62,'[2022-10-26 fhy3 1 normalize.xls]Sheet1'!$H$74,'[2022-10-26 fhy3 1 normalize.xls]Sheet1'!$H$86</c:f>
              <c:numCache>
                <c:formatCode>#,##0.000000000000000</c:formatCode>
                <c:ptCount val="8"/>
                <c:pt idx="0">
                  <c:v>0.99999999999999989</c:v>
                </c:pt>
                <c:pt idx="1">
                  <c:v>0.22480718342455486</c:v>
                </c:pt>
                <c:pt idx="2">
                  <c:v>2.7845236546072467E-2</c:v>
                </c:pt>
                <c:pt idx="3">
                  <c:v>1.8292904691172283E-3</c:v>
                </c:pt>
                <c:pt idx="4">
                  <c:v>2.1278658610696596E-3</c:v>
                </c:pt>
                <c:pt idx="5">
                  <c:v>5.67527332349314E-3</c:v>
                </c:pt>
                <c:pt idx="6">
                  <c:v>0.14796484458646683</c:v>
                </c:pt>
                <c:pt idx="7">
                  <c:v>1.52763324235189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2679-554B-9151-BCA11AA99AAC}"/>
            </c:ext>
          </c:extLst>
        </c:ser>
        <c:ser>
          <c:idx val="1"/>
          <c:order val="1"/>
          <c:tx>
            <c:strRef>
              <c:f>'[2022-10-26 fhy3 1 normalize.xls]Sheet1'!$A$4</c:f>
              <c:strCache>
                <c:ptCount val="1"/>
                <c:pt idx="0">
                  <c:v>fhy3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square"/>
            <c:size val="5"/>
            <c:spPr>
              <a:noFill/>
              <a:ln w="12700">
                <a:solidFill>
                  <a:schemeClr val="accent2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('https://d.docs.live.net/d8e9bd0bebfa4803/Somers%20lab%202020/Gene%20exp/[2022-5-20 LD 50umol zt1_4.xls]Sheet1'!$I$4,'https://d.docs.live.net/d8e9bd0bebfa4803/Somers%20lab%202020/Gene%20exp/[2022-5-20 LD 50umol zt1_4.xls]Sheet1'!$I$16,'https://d.docs.live.net/d8e9bd0bebfa4803/Somers%20lab%202020/Gene%20exp/[2022-5-20 LD 50umol zt1_4.xls]Sheet1'!$I$28,'https://d.docs.live.net/d8e9bd0bebfa4803/Somers%20lab%202020/Gene%20exp/[2022-5-20 LD 50umol zt1_4.xls]Sheet1'!$I$40,'https://d.docs.live.net/d8e9bd0bebfa4803/Somers%20lab%202020/Gene%20exp/[2022-5-20 LD 50umol zt1_4.xls]Sheet1'!$I$52,'https://d.docs.live.net/d8e9bd0bebfa4803/Somers%20lab%202020/Gene%20exp/[2022-5-20 LD 50umol zt1_4.xls]Sheet1'!$I$64,'https://d.docs.live.net/d8e9bd0bebfa4803/Somers%20lab%202020/Gene%20exp/[2022-5-20 LD 50umol zt1_4.xls]Sheet1'!$I$76,'https://d.docs.live.net/d8e9bd0bebfa4803/Somers%20lab%202020/Gene%20exp/[2022-5-20 LD 50umol zt1_4.xls]Sheet1'!$I$88)</c:f>
                <c:numCache>
                  <c:formatCode>General</c:formatCode>
                  <c:ptCount val="8"/>
                  <c:pt idx="0">
                    <c:v>5.3002158208558248E-3</c:v>
                  </c:pt>
                  <c:pt idx="1">
                    <c:v>5.0666417937232219E-3</c:v>
                  </c:pt>
                  <c:pt idx="2">
                    <c:v>7.781011339731414E-4</c:v>
                  </c:pt>
                  <c:pt idx="3">
                    <c:v>9.2626951066538394E-5</c:v>
                  </c:pt>
                  <c:pt idx="4">
                    <c:v>2.584520005966429E-4</c:v>
                  </c:pt>
                  <c:pt idx="5">
                    <c:v>5.5862603209442738E-5</c:v>
                  </c:pt>
                  <c:pt idx="6">
                    <c:v>1.4218722040180626E-2</c:v>
                  </c:pt>
                  <c:pt idx="7">
                    <c:v>7.9081334943453818E-4</c:v>
                  </c:pt>
                </c:numCache>
              </c:numRef>
            </c:plus>
            <c:minus>
              <c:numRef>
                <c:f>('https://d.docs.live.net/d8e9bd0bebfa4803/Somers%20lab%202020/Gene%20exp/[2022-5-20 LD 50umol zt1_4.xls]Sheet1'!$I$4,'https://d.docs.live.net/d8e9bd0bebfa4803/Somers%20lab%202020/Gene%20exp/[2022-5-20 LD 50umol zt1_4.xls]Sheet1'!$I$16,'https://d.docs.live.net/d8e9bd0bebfa4803/Somers%20lab%202020/Gene%20exp/[2022-5-20 LD 50umol zt1_4.xls]Sheet1'!$I$28,'https://d.docs.live.net/d8e9bd0bebfa4803/Somers%20lab%202020/Gene%20exp/[2022-5-20 LD 50umol zt1_4.xls]Sheet1'!$I$40,'https://d.docs.live.net/d8e9bd0bebfa4803/Somers%20lab%202020/Gene%20exp/[2022-5-20 LD 50umol zt1_4.xls]Sheet1'!$I$52,'https://d.docs.live.net/d8e9bd0bebfa4803/Somers%20lab%202020/Gene%20exp/[2022-5-20 LD 50umol zt1_4.xls]Sheet1'!$I$64,'https://d.docs.live.net/d8e9bd0bebfa4803/Somers%20lab%202020/Gene%20exp/[2022-5-20 LD 50umol zt1_4.xls]Sheet1'!$I$76,'https://d.docs.live.net/d8e9bd0bebfa4803/Somers%20lab%202020/Gene%20exp/[2022-5-20 LD 50umol zt1_4.xls]Sheet1'!$I$88)</c:f>
                <c:numCache>
                  <c:formatCode>General</c:formatCode>
                  <c:ptCount val="8"/>
                  <c:pt idx="0">
                    <c:v>5.3002158208558248E-3</c:v>
                  </c:pt>
                  <c:pt idx="1">
                    <c:v>5.0666417937232219E-3</c:v>
                  </c:pt>
                  <c:pt idx="2">
                    <c:v>7.781011339731414E-4</c:v>
                  </c:pt>
                  <c:pt idx="3">
                    <c:v>9.2626951066538394E-5</c:v>
                  </c:pt>
                  <c:pt idx="4">
                    <c:v>2.584520005966429E-4</c:v>
                  </c:pt>
                  <c:pt idx="5">
                    <c:v>5.5862603209442738E-5</c:v>
                  </c:pt>
                  <c:pt idx="6">
                    <c:v>1.4218722040180626E-2</c:v>
                  </c:pt>
                  <c:pt idx="7">
                    <c:v>7.9081334943453818E-4</c:v>
                  </c:pt>
                </c:numCache>
              </c:numRef>
            </c:minus>
            <c:spPr>
              <a:ln w="3175">
                <a:solidFill>
                  <a:srgbClr val="FF6600"/>
                </a:solidFill>
                <a:prstDash val="solid"/>
              </a:ln>
            </c:spPr>
          </c:errBars>
          <c:cat>
            <c:numRef>
              <c:f>'[2022-10-26 fhy3 1 normalize.xls]Sheet1'!$A$2,'[2022-10-26 fhy3 1 normalize.xls]Sheet1'!$A$14,'[2022-10-26 fhy3 1 normalize.xls]Sheet1'!$A$26,'[2022-10-26 fhy3 1 normalize.xls]Sheet1'!$A$38,'[2022-10-26 fhy3 1 normalize.xls]Sheet1'!$A$50,'[2022-10-26 fhy3 1 normalize.xls]Sheet1'!$A$62,'[2022-10-26 fhy3 1 normalize.xls]Sheet1'!$A$74,'[2022-10-26 fhy3 1 normalize.xls]Sheet1'!$A$86</c:f>
              <c:numCache>
                <c:formatCode>General</c:formatCode>
                <c:ptCount val="8"/>
                <c:pt idx="0">
                  <c:v>1</c:v>
                </c:pt>
                <c:pt idx="1">
                  <c:v>4</c:v>
                </c:pt>
                <c:pt idx="2">
                  <c:v>7</c:v>
                </c:pt>
                <c:pt idx="3">
                  <c:v>10</c:v>
                </c:pt>
                <c:pt idx="4">
                  <c:v>13</c:v>
                </c:pt>
                <c:pt idx="5">
                  <c:v>16</c:v>
                </c:pt>
                <c:pt idx="6">
                  <c:v>19</c:v>
                </c:pt>
                <c:pt idx="7">
                  <c:v>22</c:v>
                </c:pt>
              </c:numCache>
            </c:numRef>
          </c:cat>
          <c:val>
            <c:numRef>
              <c:f>'[2022-10-26 fhy3 1 normalize.xls]Sheet1'!$H$4,'[2022-10-26 fhy3 1 normalize.xls]Sheet1'!$H$16,'[2022-10-26 fhy3 1 normalize.xls]Sheet1'!$H$28,'[2022-10-26 fhy3 1 normalize.xls]Sheet1'!$H$40,'[2022-10-26 fhy3 1 normalize.xls]Sheet1'!$H$52,'[2022-10-26 fhy3 1 normalize.xls]Sheet1'!$H$64,'[2022-10-26 fhy3 1 normalize.xls]Sheet1'!$H$76,'[2022-10-26 fhy3 1 normalize.xls]Sheet1'!$H$88</c:f>
              <c:numCache>
                <c:formatCode>#,##0.000000000000000</c:formatCode>
                <c:ptCount val="8"/>
                <c:pt idx="0">
                  <c:v>0.30590754423509348</c:v>
                </c:pt>
                <c:pt idx="1">
                  <c:v>0.23217813146218214</c:v>
                </c:pt>
                <c:pt idx="2">
                  <c:v>5.0937877313759088E-2</c:v>
                </c:pt>
                <c:pt idx="3">
                  <c:v>6.810940598415427E-2</c:v>
                </c:pt>
                <c:pt idx="4">
                  <c:v>0.10234418626433654</c:v>
                </c:pt>
                <c:pt idx="5">
                  <c:v>0.15865142915028149</c:v>
                </c:pt>
                <c:pt idx="6">
                  <c:v>0.22266759195025299</c:v>
                </c:pt>
                <c:pt idx="7">
                  <c:v>0.9120079053478451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2679-554B-9151-BCA11AA99AAC}"/>
            </c:ext>
          </c:extLst>
        </c:ser>
        <c:ser>
          <c:idx val="2"/>
          <c:order val="2"/>
          <c:tx>
            <c:strRef>
              <c:f>'[2022-10-26 fhy3 1 normalize.xls]Sheet1'!$A$5</c:f>
              <c:strCache>
                <c:ptCount val="1"/>
                <c:pt idx="0">
                  <c:v>fhy3toc1</c:v>
                </c:pt>
              </c:strCache>
            </c:strRef>
          </c:tx>
          <c:spPr>
            <a:ln>
              <a:solidFill>
                <a:srgbClr val="7030A0"/>
              </a:solidFill>
            </a:ln>
          </c:spPr>
          <c:marker>
            <c:symbol val="square"/>
            <c:size val="5"/>
            <c:spPr>
              <a:noFill/>
              <a:ln w="12700">
                <a:solidFill>
                  <a:srgbClr val="7030A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('https://d.docs.live.net/d8e9bd0bebfa4803/Somers%20lab%202020/Gene%20exp/[2022-5-20 LD 50umol zt1_4.xls]Sheet1'!$I$6,'https://d.docs.live.net/d8e9bd0bebfa4803/Somers%20lab%202020/Gene%20exp/[2022-5-20 LD 50umol zt1_4.xls]Sheet1'!$I$18,'https://d.docs.live.net/d8e9bd0bebfa4803/Somers%20lab%202020/Gene%20exp/[2022-5-20 LD 50umol zt1_4.xls]Sheet1'!$I$30,'https://d.docs.live.net/d8e9bd0bebfa4803/Somers%20lab%202020/Gene%20exp/[2022-5-20 LD 50umol zt1_4.xls]Sheet1'!$I$42,'https://d.docs.live.net/d8e9bd0bebfa4803/Somers%20lab%202020/Gene%20exp/[2022-5-20 LD 50umol zt1_4.xls]Sheet1'!$I$54,'https://d.docs.live.net/d8e9bd0bebfa4803/Somers%20lab%202020/Gene%20exp/[2022-5-20 LD 50umol zt1_4.xls]Sheet1'!$I$66,'https://d.docs.live.net/d8e9bd0bebfa4803/Somers%20lab%202020/Gene%20exp/[2022-5-20 LD 50umol zt1_4.xls]Sheet1'!$I$78,'https://d.docs.live.net/d8e9bd0bebfa4803/Somers%20lab%202020/Gene%20exp/[2022-5-20 LD 50umol zt1_4.xls]Sheet1'!$I$90)</c:f>
                <c:numCache>
                  <c:formatCode>General</c:formatCode>
                  <c:ptCount val="8"/>
                  <c:pt idx="0">
                    <c:v>1.8365318686981433E-3</c:v>
                  </c:pt>
                  <c:pt idx="1">
                    <c:v>1.3437811421488366E-3</c:v>
                  </c:pt>
                  <c:pt idx="2">
                    <c:v>3.8835657568042459E-3</c:v>
                  </c:pt>
                  <c:pt idx="3">
                    <c:v>3.0060249602618353E-4</c:v>
                  </c:pt>
                  <c:pt idx="4">
                    <c:v>4.5366529944570457E-4</c:v>
                  </c:pt>
                  <c:pt idx="5">
                    <c:v>7.9612554656568338E-5</c:v>
                  </c:pt>
                  <c:pt idx="6">
                    <c:v>6.575284696106222E-4</c:v>
                  </c:pt>
                  <c:pt idx="7">
                    <c:v>1.1129487956969913E-2</c:v>
                  </c:pt>
                </c:numCache>
              </c:numRef>
            </c:plus>
            <c:minus>
              <c:numRef>
                <c:f>('https://d.docs.live.net/d8e9bd0bebfa4803/Somers%20lab%202020/Gene%20exp/[2022-5-20 LD 50umol zt1_4.xls]Sheet1'!$I$6,'https://d.docs.live.net/d8e9bd0bebfa4803/Somers%20lab%202020/Gene%20exp/[2022-5-20 LD 50umol zt1_4.xls]Sheet1'!$I$18,'https://d.docs.live.net/d8e9bd0bebfa4803/Somers%20lab%202020/Gene%20exp/[2022-5-20 LD 50umol zt1_4.xls]Sheet1'!$I$30,'https://d.docs.live.net/d8e9bd0bebfa4803/Somers%20lab%202020/Gene%20exp/[2022-5-20 LD 50umol zt1_4.xls]Sheet1'!$I$42,'https://d.docs.live.net/d8e9bd0bebfa4803/Somers%20lab%202020/Gene%20exp/[2022-5-20 LD 50umol zt1_4.xls]Sheet1'!$I$54,'https://d.docs.live.net/d8e9bd0bebfa4803/Somers%20lab%202020/Gene%20exp/[2022-5-20 LD 50umol zt1_4.xls]Sheet1'!$I$66,'https://d.docs.live.net/d8e9bd0bebfa4803/Somers%20lab%202020/Gene%20exp/[2022-5-20 LD 50umol zt1_4.xls]Sheet1'!$I$78,'https://d.docs.live.net/d8e9bd0bebfa4803/Somers%20lab%202020/Gene%20exp/[2022-5-20 LD 50umol zt1_4.xls]Sheet1'!$I$90)</c:f>
                <c:numCache>
                  <c:formatCode>General</c:formatCode>
                  <c:ptCount val="8"/>
                  <c:pt idx="0">
                    <c:v>1.8365318686981433E-3</c:v>
                  </c:pt>
                  <c:pt idx="1">
                    <c:v>1.3437811421488366E-3</c:v>
                  </c:pt>
                  <c:pt idx="2">
                    <c:v>3.8835657568042459E-3</c:v>
                  </c:pt>
                  <c:pt idx="3">
                    <c:v>3.0060249602618353E-4</c:v>
                  </c:pt>
                  <c:pt idx="4">
                    <c:v>4.5366529944570457E-4</c:v>
                  </c:pt>
                  <c:pt idx="5">
                    <c:v>7.9612554656568338E-5</c:v>
                  </c:pt>
                  <c:pt idx="6">
                    <c:v>6.575284696106222E-4</c:v>
                  </c:pt>
                  <c:pt idx="7">
                    <c:v>1.1129487956969913E-2</c:v>
                  </c:pt>
                </c:numCache>
              </c:numRef>
            </c:minus>
            <c:spPr>
              <a:ln w="3175">
                <a:solidFill>
                  <a:srgbClr val="808080"/>
                </a:solidFill>
                <a:prstDash val="solid"/>
              </a:ln>
            </c:spPr>
          </c:errBars>
          <c:cat>
            <c:numRef>
              <c:f>'[2022-10-26 fhy3 1 normalize.xls]Sheet1'!$A$2,'[2022-10-26 fhy3 1 normalize.xls]Sheet1'!$A$14,'[2022-10-26 fhy3 1 normalize.xls]Sheet1'!$A$26,'[2022-10-26 fhy3 1 normalize.xls]Sheet1'!$A$38,'[2022-10-26 fhy3 1 normalize.xls]Sheet1'!$A$50,'[2022-10-26 fhy3 1 normalize.xls]Sheet1'!$A$62,'[2022-10-26 fhy3 1 normalize.xls]Sheet1'!$A$74,'[2022-10-26 fhy3 1 normalize.xls]Sheet1'!$A$86</c:f>
              <c:numCache>
                <c:formatCode>General</c:formatCode>
                <c:ptCount val="8"/>
                <c:pt idx="0">
                  <c:v>1</c:v>
                </c:pt>
                <c:pt idx="1">
                  <c:v>4</c:v>
                </c:pt>
                <c:pt idx="2">
                  <c:v>7</c:v>
                </c:pt>
                <c:pt idx="3">
                  <c:v>10</c:v>
                </c:pt>
                <c:pt idx="4">
                  <c:v>13</c:v>
                </c:pt>
                <c:pt idx="5">
                  <c:v>16</c:v>
                </c:pt>
                <c:pt idx="6">
                  <c:v>19</c:v>
                </c:pt>
                <c:pt idx="7">
                  <c:v>22</c:v>
                </c:pt>
              </c:numCache>
            </c:numRef>
          </c:cat>
          <c:val>
            <c:numRef>
              <c:f>'[2022-10-26 fhy3 1 normalize.xls]Sheet1'!$H$6,'[2022-10-26 fhy3 1 normalize.xls]Sheet1'!$H$18,'[2022-10-26 fhy3 1 normalize.xls]Sheet1'!$H$30,'[2022-10-26 fhy3 1 normalize.xls]Sheet1'!$H$42,'[2022-10-26 fhy3 1 normalize.xls]Sheet1'!$H$54,'[2022-10-26 fhy3 1 normalize.xls]Sheet1'!$H$66,'[2022-10-26 fhy3 1 normalize.xls]Sheet1'!$H$78,'[2022-10-26 fhy3 1 normalize.xls]Sheet1'!$H$90</c:f>
              <c:numCache>
                <c:formatCode>#,##0.000000000000000</c:formatCode>
                <c:ptCount val="8"/>
                <c:pt idx="0">
                  <c:v>0.60241335435579468</c:v>
                </c:pt>
                <c:pt idx="1">
                  <c:v>9.1986164207628812E-2</c:v>
                </c:pt>
                <c:pt idx="2">
                  <c:v>9.5768036454736416E-3</c:v>
                </c:pt>
                <c:pt idx="3">
                  <c:v>8.0765491193178929E-3</c:v>
                </c:pt>
                <c:pt idx="4">
                  <c:v>2.314842618779327E-2</c:v>
                </c:pt>
                <c:pt idx="5">
                  <c:v>9.0746068635177868E-2</c:v>
                </c:pt>
                <c:pt idx="6">
                  <c:v>0.42366794590064455</c:v>
                </c:pt>
                <c:pt idx="7">
                  <c:v>0.8295406698654479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2679-554B-9151-BCA11AA99AAC}"/>
            </c:ext>
          </c:extLst>
        </c:ser>
        <c:ser>
          <c:idx val="3"/>
          <c:order val="3"/>
          <c:tx>
            <c:strRef>
              <c:f>'[2022-10-26 fhy3 1 normalize.xls]Sheet1'!$A$6</c:f>
              <c:strCache>
                <c:ptCount val="1"/>
                <c:pt idx="0">
                  <c:v>pTOC1:TOC1-GFP/fhy3toc1</c:v>
                </c:pt>
              </c:strCache>
            </c:strRef>
          </c:tx>
          <c:marker>
            <c:symbol val="triangle"/>
            <c:size val="5"/>
            <c:spPr>
              <a:noFill/>
              <a:ln w="12700">
                <a:solidFill>
                  <a:schemeClr val="accent4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('https://d.docs.live.net/d8e9bd0bebfa4803/Somers%20lab%202020/Gene%20exp/[2022-5-20 LD 50umol zt1_4.xls]Sheet1'!$I$8,'https://d.docs.live.net/d8e9bd0bebfa4803/Somers%20lab%202020/Gene%20exp/[2022-5-20 LD 50umol zt1_4.xls]Sheet1'!$I$20,'https://d.docs.live.net/d8e9bd0bebfa4803/Somers%20lab%202020/Gene%20exp/[2022-5-20 LD 50umol zt1_4.xls]Sheet1'!$I$32,'https://d.docs.live.net/d8e9bd0bebfa4803/Somers%20lab%202020/Gene%20exp/[2022-5-20 LD 50umol zt1_4.xls]Sheet1'!$I$44,'https://d.docs.live.net/d8e9bd0bebfa4803/Somers%20lab%202020/Gene%20exp/[2022-5-20 LD 50umol zt1_4.xls]Sheet1'!$I$56,'https://d.docs.live.net/d8e9bd0bebfa4803/Somers%20lab%202020/Gene%20exp/[2022-5-20 LD 50umol zt1_4.xls]Sheet1'!$I$68,'https://d.docs.live.net/d8e9bd0bebfa4803/Somers%20lab%202020/Gene%20exp/[2022-5-20 LD 50umol zt1_4.xls]Sheet1'!$I$80,'https://d.docs.live.net/d8e9bd0bebfa4803/Somers%20lab%202020/Gene%20exp/[2022-5-20 LD 50umol zt1_4.xls]Sheet1'!$I$92)</c:f>
                <c:numCache>
                  <c:formatCode>General</c:formatCode>
                  <c:ptCount val="8"/>
                  <c:pt idx="0">
                    <c:v>3.117952473660035E-3</c:v>
                  </c:pt>
                  <c:pt idx="1">
                    <c:v>1.4328321478133674E-3</c:v>
                  </c:pt>
                  <c:pt idx="2">
                    <c:v>1.0057425196796225E-3</c:v>
                  </c:pt>
                  <c:pt idx="3">
                    <c:v>3.3321351339267134E-3</c:v>
                  </c:pt>
                  <c:pt idx="4">
                    <c:v>6.6132694943958686E-3</c:v>
                  </c:pt>
                  <c:pt idx="5">
                    <c:v>9.7634884838525976E-4</c:v>
                  </c:pt>
                  <c:pt idx="6">
                    <c:v>2.8880287983773924E-3</c:v>
                  </c:pt>
                  <c:pt idx="7">
                    <c:v>1.0353398736352991E-2</c:v>
                  </c:pt>
                </c:numCache>
              </c:numRef>
            </c:plus>
            <c:minus>
              <c:numRef>
                <c:f>('https://d.docs.live.net/d8e9bd0bebfa4803/Somers%20lab%202020/Gene%20exp/[2022-5-20 LD 50umol zt1_4.xls]Sheet1'!$I$8,'https://d.docs.live.net/d8e9bd0bebfa4803/Somers%20lab%202020/Gene%20exp/[2022-5-20 LD 50umol zt1_4.xls]Sheet1'!$I$20,'https://d.docs.live.net/d8e9bd0bebfa4803/Somers%20lab%202020/Gene%20exp/[2022-5-20 LD 50umol zt1_4.xls]Sheet1'!$I$32,'https://d.docs.live.net/d8e9bd0bebfa4803/Somers%20lab%202020/Gene%20exp/[2022-5-20 LD 50umol zt1_4.xls]Sheet1'!$I$44,'https://d.docs.live.net/d8e9bd0bebfa4803/Somers%20lab%202020/Gene%20exp/[2022-5-20 LD 50umol zt1_4.xls]Sheet1'!$I$56,'https://d.docs.live.net/d8e9bd0bebfa4803/Somers%20lab%202020/Gene%20exp/[2022-5-20 LD 50umol zt1_4.xls]Sheet1'!$I$68,'https://d.docs.live.net/d8e9bd0bebfa4803/Somers%20lab%202020/Gene%20exp/[2022-5-20 LD 50umol zt1_4.xls]Sheet1'!$I$80,'https://d.docs.live.net/d8e9bd0bebfa4803/Somers%20lab%202020/Gene%20exp/[2022-5-20 LD 50umol zt1_4.xls]Sheet1'!$I$92)</c:f>
                <c:numCache>
                  <c:formatCode>General</c:formatCode>
                  <c:ptCount val="8"/>
                  <c:pt idx="0">
                    <c:v>3.117952473660035E-3</c:v>
                  </c:pt>
                  <c:pt idx="1">
                    <c:v>1.4328321478133674E-3</c:v>
                  </c:pt>
                  <c:pt idx="2">
                    <c:v>1.0057425196796225E-3</c:v>
                  </c:pt>
                  <c:pt idx="3">
                    <c:v>3.3321351339267134E-3</c:v>
                  </c:pt>
                  <c:pt idx="4">
                    <c:v>6.6132694943958686E-3</c:v>
                  </c:pt>
                  <c:pt idx="5">
                    <c:v>9.7634884838525976E-4</c:v>
                  </c:pt>
                  <c:pt idx="6">
                    <c:v>2.8880287983773924E-3</c:v>
                  </c:pt>
                  <c:pt idx="7">
                    <c:v>1.0353398736352991E-2</c:v>
                  </c:pt>
                </c:numCache>
              </c:numRef>
            </c:minus>
            <c:spPr>
              <a:ln w="3175">
                <a:solidFill>
                  <a:srgbClr val="FFCC00"/>
                </a:solidFill>
                <a:prstDash val="solid"/>
              </a:ln>
            </c:spPr>
          </c:errBars>
          <c:cat>
            <c:numRef>
              <c:f>'[2022-10-26 fhy3 1 normalize.xls]Sheet1'!$A$2,'[2022-10-26 fhy3 1 normalize.xls]Sheet1'!$A$14,'[2022-10-26 fhy3 1 normalize.xls]Sheet1'!$A$26,'[2022-10-26 fhy3 1 normalize.xls]Sheet1'!$A$38,'[2022-10-26 fhy3 1 normalize.xls]Sheet1'!$A$50,'[2022-10-26 fhy3 1 normalize.xls]Sheet1'!$A$62,'[2022-10-26 fhy3 1 normalize.xls]Sheet1'!$A$74,'[2022-10-26 fhy3 1 normalize.xls]Sheet1'!$A$86</c:f>
              <c:numCache>
                <c:formatCode>General</c:formatCode>
                <c:ptCount val="8"/>
                <c:pt idx="0">
                  <c:v>1</c:v>
                </c:pt>
                <c:pt idx="1">
                  <c:v>4</c:v>
                </c:pt>
                <c:pt idx="2">
                  <c:v>7</c:v>
                </c:pt>
                <c:pt idx="3">
                  <c:v>10</c:v>
                </c:pt>
                <c:pt idx="4">
                  <c:v>13</c:v>
                </c:pt>
                <c:pt idx="5">
                  <c:v>16</c:v>
                </c:pt>
                <c:pt idx="6">
                  <c:v>19</c:v>
                </c:pt>
                <c:pt idx="7">
                  <c:v>22</c:v>
                </c:pt>
              </c:numCache>
            </c:numRef>
          </c:cat>
          <c:val>
            <c:numRef>
              <c:f>'[2022-10-26 fhy3 1 normalize.xls]Sheet1'!$H$8,'[2022-10-26 fhy3 1 normalize.xls]Sheet1'!$H$20,'[2022-10-26 fhy3 1 normalize.xls]Sheet1'!$H$32,'[2022-10-26 fhy3 1 normalize.xls]Sheet1'!$H$44,'[2022-10-26 fhy3 1 normalize.xls]Sheet1'!$H$56,'[2022-10-26 fhy3 1 normalize.xls]Sheet1'!$H$68,'[2022-10-26 fhy3 1 normalize.xls]Sheet1'!$H$80,'[2022-10-26 fhy3 1 normalize.xls]Sheet1'!$H$92</c:f>
              <c:numCache>
                <c:formatCode>#,##0.000000000000000</c:formatCode>
                <c:ptCount val="8"/>
                <c:pt idx="0">
                  <c:v>0.51517258737634131</c:v>
                </c:pt>
                <c:pt idx="1">
                  <c:v>0.18713941195380726</c:v>
                </c:pt>
                <c:pt idx="2">
                  <c:v>2.3132233014411328E-2</c:v>
                </c:pt>
                <c:pt idx="3">
                  <c:v>2.5426553397253529E-3</c:v>
                </c:pt>
                <c:pt idx="4">
                  <c:v>2.7481384578185381E-3</c:v>
                </c:pt>
                <c:pt idx="5">
                  <c:v>6.2953017579406058E-3</c:v>
                </c:pt>
                <c:pt idx="6">
                  <c:v>0.10627421761068129</c:v>
                </c:pt>
                <c:pt idx="7">
                  <c:v>1.16603306044261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2679-554B-9151-BCA11AA99AAC}"/>
            </c:ext>
          </c:extLst>
        </c:ser>
        <c:ser>
          <c:idx val="4"/>
          <c:order val="4"/>
          <c:tx>
            <c:strRef>
              <c:f>'[2022-10-26 fhy3 1 normalize.xls]Sheet1'!$A$7</c:f>
              <c:strCache>
                <c:ptCount val="1"/>
                <c:pt idx="0">
                  <c:v>pTOC1:5X-GFP/fhy3toc1</c:v>
                </c:pt>
              </c:strCache>
            </c:strRef>
          </c:tx>
          <c:spPr>
            <a:ln>
              <a:solidFill>
                <a:schemeClr val="accent6"/>
              </a:solidFill>
            </a:ln>
          </c:spPr>
          <c:marker>
            <c:symbol val="triangle"/>
            <c:size val="5"/>
            <c:spPr>
              <a:noFill/>
              <a:ln w="12700">
                <a:solidFill>
                  <a:schemeClr val="accent6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('https://d.docs.live.net/d8e9bd0bebfa4803/Somers%20lab%202020/Gene%20exp/[2022-5-20 LD 50umol zt1_4.xls]Sheet1'!$I$10,'https://d.docs.live.net/d8e9bd0bebfa4803/Somers%20lab%202020/Gene%20exp/[2022-5-20 LD 50umol zt1_4.xls]Sheet1'!$I$22,'https://d.docs.live.net/d8e9bd0bebfa4803/Somers%20lab%202020/Gene%20exp/[2022-5-20 LD 50umol zt1_4.xls]Sheet1'!$I$34,'https://d.docs.live.net/d8e9bd0bebfa4803/Somers%20lab%202020/Gene%20exp/[2022-5-20 LD 50umol zt1_4.xls]Sheet1'!$I$46,'https://d.docs.live.net/d8e9bd0bebfa4803/Somers%20lab%202020/Gene%20exp/[2022-5-20 LD 50umol zt1_4.xls]Sheet1'!$I$58,'https://d.docs.live.net/d8e9bd0bebfa4803/Somers%20lab%202020/Gene%20exp/[2022-5-20 LD 50umol zt1_4.xls]Sheet1'!$I$70,'https://d.docs.live.net/d8e9bd0bebfa4803/Somers%20lab%202020/Gene%20exp/[2022-5-20 LD 50umol zt1_4.xls]Sheet1'!$I$82,'https://d.docs.live.net/d8e9bd0bebfa4803/Somers%20lab%202020/Gene%20exp/[2022-5-20 LD 50umol zt1_4.xls]Sheet1'!$I$94)</c:f>
                <c:numCache>
                  <c:formatCode>General</c:formatCode>
                  <c:ptCount val="8"/>
                  <c:pt idx="0">
                    <c:v>3.2316303930444157E-3</c:v>
                  </c:pt>
                  <c:pt idx="1">
                    <c:v>6.8802553007674969E-3</c:v>
                  </c:pt>
                  <c:pt idx="2">
                    <c:v>3.3614092854711494E-3</c:v>
                  </c:pt>
                  <c:pt idx="3">
                    <c:v>6.032376393059297E-5</c:v>
                  </c:pt>
                  <c:pt idx="4">
                    <c:v>1.3606318495585452E-3</c:v>
                  </c:pt>
                  <c:pt idx="5">
                    <c:v>3.0475805569661092E-4</c:v>
                  </c:pt>
                  <c:pt idx="6">
                    <c:v>8.7584831964419144E-5</c:v>
                  </c:pt>
                  <c:pt idx="7">
                    <c:v>6.3272241480005487E-3</c:v>
                  </c:pt>
                </c:numCache>
              </c:numRef>
            </c:plus>
            <c:minus>
              <c:numRef>
                <c:f>('https://d.docs.live.net/d8e9bd0bebfa4803/Somers%20lab%202020/Gene%20exp/[2022-5-20 LD 50umol zt1_4.xls]Sheet1'!$I$10,'https://d.docs.live.net/d8e9bd0bebfa4803/Somers%20lab%202020/Gene%20exp/[2022-5-20 LD 50umol zt1_4.xls]Sheet1'!$I$22,'https://d.docs.live.net/d8e9bd0bebfa4803/Somers%20lab%202020/Gene%20exp/[2022-5-20 LD 50umol zt1_4.xls]Sheet1'!$I$34,'https://d.docs.live.net/d8e9bd0bebfa4803/Somers%20lab%202020/Gene%20exp/[2022-5-20 LD 50umol zt1_4.xls]Sheet1'!$I$46,'https://d.docs.live.net/d8e9bd0bebfa4803/Somers%20lab%202020/Gene%20exp/[2022-5-20 LD 50umol zt1_4.xls]Sheet1'!$I$58,'https://d.docs.live.net/d8e9bd0bebfa4803/Somers%20lab%202020/Gene%20exp/[2022-5-20 LD 50umol zt1_4.xls]Sheet1'!$I$70,'https://d.docs.live.net/d8e9bd0bebfa4803/Somers%20lab%202020/Gene%20exp/[2022-5-20 LD 50umol zt1_4.xls]Sheet1'!$I$82,'https://d.docs.live.net/d8e9bd0bebfa4803/Somers%20lab%202020/Gene%20exp/[2022-5-20 LD 50umol zt1_4.xls]Sheet1'!$I$94)</c:f>
                <c:numCache>
                  <c:formatCode>General</c:formatCode>
                  <c:ptCount val="8"/>
                  <c:pt idx="0">
                    <c:v>3.2316303930444157E-3</c:v>
                  </c:pt>
                  <c:pt idx="1">
                    <c:v>6.8802553007674969E-3</c:v>
                  </c:pt>
                  <c:pt idx="2">
                    <c:v>3.3614092854711494E-3</c:v>
                  </c:pt>
                  <c:pt idx="3">
                    <c:v>6.032376393059297E-5</c:v>
                  </c:pt>
                  <c:pt idx="4">
                    <c:v>1.3606318495585452E-3</c:v>
                  </c:pt>
                  <c:pt idx="5">
                    <c:v>3.0475805569661092E-4</c:v>
                  </c:pt>
                  <c:pt idx="6">
                    <c:v>8.7584831964419144E-5</c:v>
                  </c:pt>
                  <c:pt idx="7">
                    <c:v>6.3272241480005487E-3</c:v>
                  </c:pt>
                </c:numCache>
              </c:numRef>
            </c:minus>
            <c:spPr>
              <a:ln w="3175">
                <a:solidFill>
                  <a:srgbClr val="666699"/>
                </a:solidFill>
                <a:prstDash val="solid"/>
              </a:ln>
            </c:spPr>
          </c:errBars>
          <c:cat>
            <c:numRef>
              <c:f>'[2022-10-26 fhy3 1 normalize.xls]Sheet1'!$A$2,'[2022-10-26 fhy3 1 normalize.xls]Sheet1'!$A$14,'[2022-10-26 fhy3 1 normalize.xls]Sheet1'!$A$26,'[2022-10-26 fhy3 1 normalize.xls]Sheet1'!$A$38,'[2022-10-26 fhy3 1 normalize.xls]Sheet1'!$A$50,'[2022-10-26 fhy3 1 normalize.xls]Sheet1'!$A$62,'[2022-10-26 fhy3 1 normalize.xls]Sheet1'!$A$74,'[2022-10-26 fhy3 1 normalize.xls]Sheet1'!$A$86</c:f>
              <c:numCache>
                <c:formatCode>General</c:formatCode>
                <c:ptCount val="8"/>
                <c:pt idx="0">
                  <c:v>1</c:v>
                </c:pt>
                <c:pt idx="1">
                  <c:v>4</c:v>
                </c:pt>
                <c:pt idx="2">
                  <c:v>7</c:v>
                </c:pt>
                <c:pt idx="3">
                  <c:v>10</c:v>
                </c:pt>
                <c:pt idx="4">
                  <c:v>13</c:v>
                </c:pt>
                <c:pt idx="5">
                  <c:v>16</c:v>
                </c:pt>
                <c:pt idx="6">
                  <c:v>19</c:v>
                </c:pt>
                <c:pt idx="7">
                  <c:v>22</c:v>
                </c:pt>
              </c:numCache>
            </c:numRef>
          </c:cat>
          <c:val>
            <c:numRef>
              <c:f>'[2022-10-26 fhy3 1 normalize.xls]Sheet1'!$H$10,'[2022-10-26 fhy3 1 normalize.xls]Sheet1'!$H$22,'[2022-10-26 fhy3 1 normalize.xls]Sheet1'!$H$34,'[2022-10-26 fhy3 1 normalize.xls]Sheet1'!$H$46,'[2022-10-26 fhy3 1 normalize.xls]Sheet1'!$H$58,'[2022-10-26 fhy3 1 normalize.xls]Sheet1'!$H$70,'[2022-10-26 fhy3 1 normalize.xls]Sheet1'!$H$82,'[2022-10-26 fhy3 1 normalize.xls]Sheet1'!$H$94</c:f>
              <c:numCache>
                <c:formatCode>#,##0.000000000000000</c:formatCode>
                <c:ptCount val="8"/>
                <c:pt idx="0">
                  <c:v>0.49184994591071429</c:v>
                </c:pt>
                <c:pt idx="1">
                  <c:v>0.32074134864545201</c:v>
                </c:pt>
                <c:pt idx="2">
                  <c:v>3.4617577497411706E-2</c:v>
                </c:pt>
                <c:pt idx="3">
                  <c:v>3.040664189230078E-2</c:v>
                </c:pt>
                <c:pt idx="4">
                  <c:v>3.8323208052838231E-2</c:v>
                </c:pt>
                <c:pt idx="5">
                  <c:v>4.5690969169295763E-2</c:v>
                </c:pt>
                <c:pt idx="6">
                  <c:v>0.23169737050990022</c:v>
                </c:pt>
                <c:pt idx="7">
                  <c:v>0.8202815156318020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2679-554B-9151-BCA11AA99AA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383097920"/>
        <c:axId val="1"/>
      </c:lineChart>
      <c:catAx>
        <c:axId val="383097920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1"/>
        <c:crosses val="autoZero"/>
        <c:auto val="1"/>
        <c:lblAlgn val="ctr"/>
        <c:lblOffset val="100"/>
        <c:noMultiLvlLbl val="0"/>
      </c:catAx>
      <c:valAx>
        <c:axId val="1"/>
        <c:scaling>
          <c:orientation val="minMax"/>
          <c:max val="1.6"/>
          <c:min val="0.4"/>
        </c:scaling>
        <c:delete val="0"/>
        <c:axPos val="l"/>
        <c:numFmt formatCode="#,##0.0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0" vert="horz"/>
          <a:lstStyle/>
          <a:p>
            <a:pPr>
              <a:defRPr sz="1050" b="0" i="0" u="none" strike="noStrike" baseline="0">
                <a:solidFill>
                  <a:srgbClr val="000000"/>
                </a:solidFill>
                <a:latin typeface="Calibri"/>
                <a:ea typeface="Calibri"/>
                <a:cs typeface="Calibri"/>
              </a:defRPr>
            </a:pPr>
            <a:endParaRPr lang="en-US"/>
          </a:p>
        </c:txPr>
        <c:crossAx val="383097920"/>
        <c:crosses val="autoZero"/>
        <c:crossBetween val="between"/>
        <c:majorUnit val="0.4"/>
      </c:valAx>
      <c:spPr>
        <a:noFill/>
        <a:ln w="25400">
          <a:noFill/>
        </a:ln>
      </c:spPr>
    </c:plotArea>
    <c:legend>
      <c:legendPos val="r"/>
      <c:legendEntry>
        <c:idx val="1"/>
        <c:txPr>
          <a:bodyPr/>
          <a:lstStyle/>
          <a:p>
            <a:pPr>
              <a:defRPr sz="885" b="0" i="1" u="none" strike="noStrike" baseline="0">
                <a:solidFill>
                  <a:srgbClr val="000000"/>
                </a:solidFill>
                <a:latin typeface="Calibri"/>
                <a:ea typeface="Calibri"/>
                <a:cs typeface="Calibri"/>
              </a:defRPr>
            </a:pPr>
            <a:endParaRPr lang="en-US"/>
          </a:p>
        </c:txPr>
      </c:legendEntry>
      <c:legendEntry>
        <c:idx val="2"/>
        <c:txPr>
          <a:bodyPr/>
          <a:lstStyle/>
          <a:p>
            <a:pPr>
              <a:defRPr sz="885" b="0" i="1" u="none" strike="noStrike" baseline="0">
                <a:solidFill>
                  <a:srgbClr val="000000"/>
                </a:solidFill>
                <a:latin typeface="Calibri"/>
                <a:ea typeface="Calibri"/>
                <a:cs typeface="Calibri"/>
              </a:defRPr>
            </a:pPr>
            <a:endParaRPr lang="en-US"/>
          </a:p>
        </c:txPr>
      </c:legendEntry>
      <c:legendEntry>
        <c:idx val="3"/>
        <c:txPr>
          <a:bodyPr/>
          <a:lstStyle/>
          <a:p>
            <a:pPr>
              <a:defRPr sz="885" b="0" i="1" u="none" strike="noStrike" baseline="0">
                <a:solidFill>
                  <a:srgbClr val="000000"/>
                </a:solidFill>
                <a:latin typeface="Calibri"/>
                <a:ea typeface="Calibri"/>
                <a:cs typeface="Calibri"/>
              </a:defRPr>
            </a:pPr>
            <a:endParaRPr lang="en-US"/>
          </a:p>
        </c:txPr>
      </c:legendEntry>
      <c:legendEntry>
        <c:idx val="4"/>
        <c:txPr>
          <a:bodyPr/>
          <a:lstStyle/>
          <a:p>
            <a:pPr>
              <a:defRPr sz="885" b="0" i="1" u="none" strike="noStrike" baseline="0">
                <a:solidFill>
                  <a:srgbClr val="000000"/>
                </a:solidFill>
                <a:latin typeface="Calibri"/>
                <a:ea typeface="Calibri"/>
                <a:cs typeface="Calibri"/>
              </a:defRPr>
            </a:pPr>
            <a:endParaRPr lang="en-US"/>
          </a:p>
        </c:txPr>
      </c:legendEntry>
      <c:layout>
        <c:manualLayout>
          <c:xMode val="edge"/>
          <c:yMode val="edge"/>
          <c:x val="0.14796299365702298"/>
          <c:y val="0.20542141107101977"/>
          <c:w val="0.80445701514722157"/>
          <c:h val="0.4999944790898595"/>
        </c:manualLayout>
      </c:layout>
      <c:overlay val="0"/>
      <c:spPr>
        <a:noFill/>
        <a:ln w="25400">
          <a:noFill/>
        </a:ln>
      </c:spPr>
      <c:txPr>
        <a:bodyPr/>
        <a:lstStyle/>
        <a:p>
          <a:pPr>
            <a:defRPr sz="885" b="0" i="0" u="none" strike="noStrike" baseline="0">
              <a:solidFill>
                <a:srgbClr val="000000"/>
              </a:solidFill>
              <a:latin typeface="Calibri"/>
              <a:ea typeface="Calibri"/>
              <a:cs typeface="Calibri"/>
            </a:defRPr>
          </a:pPr>
          <a:endParaRPr lang="en-US"/>
        </a:p>
      </c:txPr>
    </c:legend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1050" b="0" i="0" u="none" strike="noStrike" baseline="0">
          <a:solidFill>
            <a:srgbClr val="000000"/>
          </a:solidFill>
          <a:latin typeface="Calibri"/>
          <a:ea typeface="Calibri"/>
          <a:cs typeface="Calibri"/>
        </a:defRPr>
      </a:pPr>
      <a:endParaRPr lang="en-US"/>
    </a:p>
  </c:txPr>
  <c:externalData r:id="rId1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7.5724405964996522E-2"/>
          <c:y val="0.13682516954495177"/>
          <c:w val="0.87304360136793291"/>
          <c:h val="0.58938882192001518"/>
        </c:manualLayout>
      </c:layout>
      <c:lineChart>
        <c:grouping val="standard"/>
        <c:varyColors val="0"/>
        <c:ser>
          <c:idx val="0"/>
          <c:order val="0"/>
          <c:tx>
            <c:strRef>
              <c:f>'[2022-10-26 fhy3 1 normalize.xls]Sheet1'!$A$3</c:f>
              <c:strCache>
                <c:ptCount val="1"/>
                <c:pt idx="0">
                  <c:v>Col-0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noFill/>
              <a:ln w="12700">
                <a:solidFill>
                  <a:schemeClr val="accent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('https://d.docs.live.net/d8e9bd0bebfa4803/Somers%20lab%202020/Gene%20exp/[2022-5-20 LD 50umol zt1_4.xls]Sheet1'!$I$2,'https://d.docs.live.net/d8e9bd0bebfa4803/Somers%20lab%202020/Gene%20exp/[2022-5-20 LD 50umol zt1_4.xls]Sheet1'!$I$14,'https://d.docs.live.net/d8e9bd0bebfa4803/Somers%20lab%202020/Gene%20exp/[2022-5-20 LD 50umol zt1_4.xls]Sheet1'!$I$26,'https://d.docs.live.net/d8e9bd0bebfa4803/Somers%20lab%202020/Gene%20exp/[2022-5-20 LD 50umol zt1_4.xls]Sheet1'!$I$38,'https://d.docs.live.net/d8e9bd0bebfa4803/Somers%20lab%202020/Gene%20exp/[2022-5-20 LD 50umol zt1_4.xls]Sheet1'!$I$50,'https://d.docs.live.net/d8e9bd0bebfa4803/Somers%20lab%202020/Gene%20exp/[2022-5-20 LD 50umol zt1_4.xls]Sheet1'!$I$62,'https://d.docs.live.net/d8e9bd0bebfa4803/Somers%20lab%202020/Gene%20exp/[2022-5-20 LD 50umol zt1_4.xls]Sheet1'!$I$74,'https://d.docs.live.net/d8e9bd0bebfa4803/Somers%20lab%202020/Gene%20exp/[2022-5-20 LD 50umol zt1_4.xls]Sheet1'!$I$86)</c:f>
                <c:numCache>
                  <c:formatCode>General</c:formatCode>
                  <c:ptCount val="8"/>
                  <c:pt idx="0">
                    <c:v>3.9954191964042041E-2</c:v>
                  </c:pt>
                  <c:pt idx="1">
                    <c:v>2.1702121285376574E-2</c:v>
                  </c:pt>
                  <c:pt idx="2">
                    <c:v>3.0672177638113932E-3</c:v>
                  </c:pt>
                  <c:pt idx="3">
                    <c:v>1.1288837044739708E-4</c:v>
                  </c:pt>
                  <c:pt idx="4">
                    <c:v>1.7778717529663463E-4</c:v>
                  </c:pt>
                  <c:pt idx="5">
                    <c:v>9.4991907416536536E-5</c:v>
                  </c:pt>
                  <c:pt idx="6">
                    <c:v>3.4706044305174324E-3</c:v>
                  </c:pt>
                  <c:pt idx="7">
                    <c:v>3.54969011438237E-2</c:v>
                  </c:pt>
                </c:numCache>
              </c:numRef>
            </c:plus>
            <c:minus>
              <c:numRef>
                <c:f>('https://d.docs.live.net/d8e9bd0bebfa4803/Somers%20lab%202020/Gene%20exp/[2022-5-20 LD 50umol zt1_4.xls]Sheet1'!$I$2,'https://d.docs.live.net/d8e9bd0bebfa4803/Somers%20lab%202020/Gene%20exp/[2022-5-20 LD 50umol zt1_4.xls]Sheet1'!$I$14,'https://d.docs.live.net/d8e9bd0bebfa4803/Somers%20lab%202020/Gene%20exp/[2022-5-20 LD 50umol zt1_4.xls]Sheet1'!$I$26,'https://d.docs.live.net/d8e9bd0bebfa4803/Somers%20lab%202020/Gene%20exp/[2022-5-20 LD 50umol zt1_4.xls]Sheet1'!$I$38,'https://d.docs.live.net/d8e9bd0bebfa4803/Somers%20lab%202020/Gene%20exp/[2022-5-20 LD 50umol zt1_4.xls]Sheet1'!$I$50,'https://d.docs.live.net/d8e9bd0bebfa4803/Somers%20lab%202020/Gene%20exp/[2022-5-20 LD 50umol zt1_4.xls]Sheet1'!$I$62,'https://d.docs.live.net/d8e9bd0bebfa4803/Somers%20lab%202020/Gene%20exp/[2022-5-20 LD 50umol zt1_4.xls]Sheet1'!$I$74,'https://d.docs.live.net/d8e9bd0bebfa4803/Somers%20lab%202020/Gene%20exp/[2022-5-20 LD 50umol zt1_4.xls]Sheet1'!$I$86)</c:f>
                <c:numCache>
                  <c:formatCode>General</c:formatCode>
                  <c:ptCount val="8"/>
                  <c:pt idx="0">
                    <c:v>3.9954191964042041E-2</c:v>
                  </c:pt>
                  <c:pt idx="1">
                    <c:v>2.1702121285376574E-2</c:v>
                  </c:pt>
                  <c:pt idx="2">
                    <c:v>3.0672177638113932E-3</c:v>
                  </c:pt>
                  <c:pt idx="3">
                    <c:v>1.1288837044739708E-4</c:v>
                  </c:pt>
                  <c:pt idx="4">
                    <c:v>1.7778717529663463E-4</c:v>
                  </c:pt>
                  <c:pt idx="5">
                    <c:v>9.4991907416536536E-5</c:v>
                  </c:pt>
                  <c:pt idx="6">
                    <c:v>3.4706044305174324E-3</c:v>
                  </c:pt>
                  <c:pt idx="7">
                    <c:v>3.54969011438237E-2</c:v>
                  </c:pt>
                </c:numCache>
              </c:numRef>
            </c:minus>
            <c:spPr>
              <a:ln w="3175">
                <a:solidFill>
                  <a:srgbClr val="666699"/>
                </a:solidFill>
                <a:prstDash val="solid"/>
              </a:ln>
            </c:spPr>
          </c:errBars>
          <c:cat>
            <c:numRef>
              <c:f>'[2022-10-26 fhy3 1 normalize.xls]Sheet1'!$A$2,'[2022-10-26 fhy3 1 normalize.xls]Sheet1'!$A$14,'[2022-10-26 fhy3 1 normalize.xls]Sheet1'!$A$26,'[2022-10-26 fhy3 1 normalize.xls]Sheet1'!$A$38,'[2022-10-26 fhy3 1 normalize.xls]Sheet1'!$A$50,'[2022-10-26 fhy3 1 normalize.xls]Sheet1'!$A$62,'[2022-10-26 fhy3 1 normalize.xls]Sheet1'!$A$74,'[2022-10-26 fhy3 1 normalize.xls]Sheet1'!$A$86</c:f>
              <c:numCache>
                <c:formatCode>General</c:formatCode>
                <c:ptCount val="8"/>
                <c:pt idx="0">
                  <c:v>1</c:v>
                </c:pt>
                <c:pt idx="1">
                  <c:v>4</c:v>
                </c:pt>
                <c:pt idx="2">
                  <c:v>7</c:v>
                </c:pt>
                <c:pt idx="3">
                  <c:v>10</c:v>
                </c:pt>
                <c:pt idx="4">
                  <c:v>13</c:v>
                </c:pt>
                <c:pt idx="5">
                  <c:v>16</c:v>
                </c:pt>
                <c:pt idx="6">
                  <c:v>19</c:v>
                </c:pt>
                <c:pt idx="7">
                  <c:v>22</c:v>
                </c:pt>
              </c:numCache>
            </c:numRef>
          </c:cat>
          <c:val>
            <c:numRef>
              <c:f>'[2022-10-26 fhy3 1 normalize.xls]Sheet1'!$H$2,'[2022-10-26 fhy3 1 normalize.xls]Sheet1'!$H$14,'[2022-10-26 fhy3 1 normalize.xls]Sheet1'!$H$26,'[2022-10-26 fhy3 1 normalize.xls]Sheet1'!$H$38,'[2022-10-26 fhy3 1 normalize.xls]Sheet1'!$H$50,'[2022-10-26 fhy3 1 normalize.xls]Sheet1'!$H$62,'[2022-10-26 fhy3 1 normalize.xls]Sheet1'!$H$74,'[2022-10-26 fhy3 1 normalize.xls]Sheet1'!$H$86</c:f>
              <c:numCache>
                <c:formatCode>#,##0.000000000000000</c:formatCode>
                <c:ptCount val="8"/>
                <c:pt idx="0">
                  <c:v>0.99999999999999989</c:v>
                </c:pt>
                <c:pt idx="1">
                  <c:v>0.22480718342455486</c:v>
                </c:pt>
                <c:pt idx="2">
                  <c:v>2.7845236546072467E-2</c:v>
                </c:pt>
                <c:pt idx="3">
                  <c:v>1.8292904691172283E-3</c:v>
                </c:pt>
                <c:pt idx="4">
                  <c:v>2.1278658610696596E-3</c:v>
                </c:pt>
                <c:pt idx="5">
                  <c:v>5.67527332349314E-3</c:v>
                </c:pt>
                <c:pt idx="6">
                  <c:v>0.14796484458646683</c:v>
                </c:pt>
                <c:pt idx="7">
                  <c:v>1.52763324235189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3C0A-5D42-906E-E7B747A98851}"/>
            </c:ext>
          </c:extLst>
        </c:ser>
        <c:ser>
          <c:idx val="1"/>
          <c:order val="1"/>
          <c:tx>
            <c:strRef>
              <c:f>'[2022-10-26 fhy3 1 normalize.xls]Sheet1'!$A$4</c:f>
              <c:strCache>
                <c:ptCount val="1"/>
                <c:pt idx="0">
                  <c:v>fhy3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square"/>
            <c:size val="5"/>
            <c:spPr>
              <a:noFill/>
              <a:ln w="12700">
                <a:solidFill>
                  <a:schemeClr val="accent2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('https://d.docs.live.net/d8e9bd0bebfa4803/Somers%20lab%202020/Gene%20exp/[2022-5-20 LD 50umol zt1_4.xls]Sheet1'!$I$4,'https://d.docs.live.net/d8e9bd0bebfa4803/Somers%20lab%202020/Gene%20exp/[2022-5-20 LD 50umol zt1_4.xls]Sheet1'!$I$16,'https://d.docs.live.net/d8e9bd0bebfa4803/Somers%20lab%202020/Gene%20exp/[2022-5-20 LD 50umol zt1_4.xls]Sheet1'!$I$28,'https://d.docs.live.net/d8e9bd0bebfa4803/Somers%20lab%202020/Gene%20exp/[2022-5-20 LD 50umol zt1_4.xls]Sheet1'!$I$40,'https://d.docs.live.net/d8e9bd0bebfa4803/Somers%20lab%202020/Gene%20exp/[2022-5-20 LD 50umol zt1_4.xls]Sheet1'!$I$52,'https://d.docs.live.net/d8e9bd0bebfa4803/Somers%20lab%202020/Gene%20exp/[2022-5-20 LD 50umol zt1_4.xls]Sheet1'!$I$64,'https://d.docs.live.net/d8e9bd0bebfa4803/Somers%20lab%202020/Gene%20exp/[2022-5-20 LD 50umol zt1_4.xls]Sheet1'!$I$76,'https://d.docs.live.net/d8e9bd0bebfa4803/Somers%20lab%202020/Gene%20exp/[2022-5-20 LD 50umol zt1_4.xls]Sheet1'!$I$88)</c:f>
                <c:numCache>
                  <c:formatCode>General</c:formatCode>
                  <c:ptCount val="8"/>
                  <c:pt idx="0">
                    <c:v>5.3002158208558248E-3</c:v>
                  </c:pt>
                  <c:pt idx="1">
                    <c:v>5.0666417937232219E-3</c:v>
                  </c:pt>
                  <c:pt idx="2">
                    <c:v>7.781011339731414E-4</c:v>
                  </c:pt>
                  <c:pt idx="3">
                    <c:v>9.2626951066538394E-5</c:v>
                  </c:pt>
                  <c:pt idx="4">
                    <c:v>2.584520005966429E-4</c:v>
                  </c:pt>
                  <c:pt idx="5">
                    <c:v>5.5862603209442738E-5</c:v>
                  </c:pt>
                  <c:pt idx="6">
                    <c:v>1.4218722040180626E-2</c:v>
                  </c:pt>
                  <c:pt idx="7">
                    <c:v>7.9081334943453818E-4</c:v>
                  </c:pt>
                </c:numCache>
              </c:numRef>
            </c:plus>
            <c:minus>
              <c:numRef>
                <c:f>('https://d.docs.live.net/d8e9bd0bebfa4803/Somers%20lab%202020/Gene%20exp/[2022-5-20 LD 50umol zt1_4.xls]Sheet1'!$I$4,'https://d.docs.live.net/d8e9bd0bebfa4803/Somers%20lab%202020/Gene%20exp/[2022-5-20 LD 50umol zt1_4.xls]Sheet1'!$I$16,'https://d.docs.live.net/d8e9bd0bebfa4803/Somers%20lab%202020/Gene%20exp/[2022-5-20 LD 50umol zt1_4.xls]Sheet1'!$I$28,'https://d.docs.live.net/d8e9bd0bebfa4803/Somers%20lab%202020/Gene%20exp/[2022-5-20 LD 50umol zt1_4.xls]Sheet1'!$I$40,'https://d.docs.live.net/d8e9bd0bebfa4803/Somers%20lab%202020/Gene%20exp/[2022-5-20 LD 50umol zt1_4.xls]Sheet1'!$I$52,'https://d.docs.live.net/d8e9bd0bebfa4803/Somers%20lab%202020/Gene%20exp/[2022-5-20 LD 50umol zt1_4.xls]Sheet1'!$I$64,'https://d.docs.live.net/d8e9bd0bebfa4803/Somers%20lab%202020/Gene%20exp/[2022-5-20 LD 50umol zt1_4.xls]Sheet1'!$I$76,'https://d.docs.live.net/d8e9bd0bebfa4803/Somers%20lab%202020/Gene%20exp/[2022-5-20 LD 50umol zt1_4.xls]Sheet1'!$I$88)</c:f>
                <c:numCache>
                  <c:formatCode>General</c:formatCode>
                  <c:ptCount val="8"/>
                  <c:pt idx="0">
                    <c:v>5.3002158208558248E-3</c:v>
                  </c:pt>
                  <c:pt idx="1">
                    <c:v>5.0666417937232219E-3</c:v>
                  </c:pt>
                  <c:pt idx="2">
                    <c:v>7.781011339731414E-4</c:v>
                  </c:pt>
                  <c:pt idx="3">
                    <c:v>9.2626951066538394E-5</c:v>
                  </c:pt>
                  <c:pt idx="4">
                    <c:v>2.584520005966429E-4</c:v>
                  </c:pt>
                  <c:pt idx="5">
                    <c:v>5.5862603209442738E-5</c:v>
                  </c:pt>
                  <c:pt idx="6">
                    <c:v>1.4218722040180626E-2</c:v>
                  </c:pt>
                  <c:pt idx="7">
                    <c:v>7.9081334943453818E-4</c:v>
                  </c:pt>
                </c:numCache>
              </c:numRef>
            </c:minus>
            <c:spPr>
              <a:ln w="3175">
                <a:solidFill>
                  <a:srgbClr val="FF6600"/>
                </a:solidFill>
                <a:prstDash val="solid"/>
              </a:ln>
            </c:spPr>
          </c:errBars>
          <c:cat>
            <c:numRef>
              <c:f>'[2022-10-26 fhy3 1 normalize.xls]Sheet1'!$A$2,'[2022-10-26 fhy3 1 normalize.xls]Sheet1'!$A$14,'[2022-10-26 fhy3 1 normalize.xls]Sheet1'!$A$26,'[2022-10-26 fhy3 1 normalize.xls]Sheet1'!$A$38,'[2022-10-26 fhy3 1 normalize.xls]Sheet1'!$A$50,'[2022-10-26 fhy3 1 normalize.xls]Sheet1'!$A$62,'[2022-10-26 fhy3 1 normalize.xls]Sheet1'!$A$74,'[2022-10-26 fhy3 1 normalize.xls]Sheet1'!$A$86</c:f>
              <c:numCache>
                <c:formatCode>General</c:formatCode>
                <c:ptCount val="8"/>
                <c:pt idx="0">
                  <c:v>1</c:v>
                </c:pt>
                <c:pt idx="1">
                  <c:v>4</c:v>
                </c:pt>
                <c:pt idx="2">
                  <c:v>7</c:v>
                </c:pt>
                <c:pt idx="3">
                  <c:v>10</c:v>
                </c:pt>
                <c:pt idx="4">
                  <c:v>13</c:v>
                </c:pt>
                <c:pt idx="5">
                  <c:v>16</c:v>
                </c:pt>
                <c:pt idx="6">
                  <c:v>19</c:v>
                </c:pt>
                <c:pt idx="7">
                  <c:v>22</c:v>
                </c:pt>
              </c:numCache>
            </c:numRef>
          </c:cat>
          <c:val>
            <c:numRef>
              <c:f>'[2022-10-26 fhy3 1 normalize.xls]Sheet1'!$H$4,'[2022-10-26 fhy3 1 normalize.xls]Sheet1'!$H$16,'[2022-10-26 fhy3 1 normalize.xls]Sheet1'!$H$28,'[2022-10-26 fhy3 1 normalize.xls]Sheet1'!$H$40,'[2022-10-26 fhy3 1 normalize.xls]Sheet1'!$H$52,'[2022-10-26 fhy3 1 normalize.xls]Sheet1'!$H$64,'[2022-10-26 fhy3 1 normalize.xls]Sheet1'!$H$76,'[2022-10-26 fhy3 1 normalize.xls]Sheet1'!$H$88</c:f>
              <c:numCache>
                <c:formatCode>#,##0.000000000000000</c:formatCode>
                <c:ptCount val="8"/>
                <c:pt idx="0">
                  <c:v>0.30590754423509348</c:v>
                </c:pt>
                <c:pt idx="1">
                  <c:v>0.23217813146218214</c:v>
                </c:pt>
                <c:pt idx="2">
                  <c:v>5.0937877313759088E-2</c:v>
                </c:pt>
                <c:pt idx="3">
                  <c:v>6.810940598415427E-2</c:v>
                </c:pt>
                <c:pt idx="4">
                  <c:v>0.10234418626433654</c:v>
                </c:pt>
                <c:pt idx="5">
                  <c:v>0.15865142915028149</c:v>
                </c:pt>
                <c:pt idx="6">
                  <c:v>0.22266759195025299</c:v>
                </c:pt>
                <c:pt idx="7">
                  <c:v>0.9120079053478451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3C0A-5D42-906E-E7B747A98851}"/>
            </c:ext>
          </c:extLst>
        </c:ser>
        <c:ser>
          <c:idx val="2"/>
          <c:order val="2"/>
          <c:tx>
            <c:strRef>
              <c:f>'[2022-10-26 fhy3 1 normalize.xls]Sheet1'!$A$5</c:f>
              <c:strCache>
                <c:ptCount val="1"/>
                <c:pt idx="0">
                  <c:v>fhy3toc1</c:v>
                </c:pt>
              </c:strCache>
            </c:strRef>
          </c:tx>
          <c:spPr>
            <a:ln>
              <a:solidFill>
                <a:srgbClr val="7030A0"/>
              </a:solidFill>
            </a:ln>
          </c:spPr>
          <c:marker>
            <c:symbol val="square"/>
            <c:size val="5"/>
            <c:spPr>
              <a:noFill/>
              <a:ln w="12700">
                <a:solidFill>
                  <a:srgbClr val="7030A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('https://d.docs.live.net/d8e9bd0bebfa4803/Somers%20lab%202020/Gene%20exp/[2022-5-20 LD 50umol zt1_4.xls]Sheet1'!$I$6,'https://d.docs.live.net/d8e9bd0bebfa4803/Somers%20lab%202020/Gene%20exp/[2022-5-20 LD 50umol zt1_4.xls]Sheet1'!$I$18,'https://d.docs.live.net/d8e9bd0bebfa4803/Somers%20lab%202020/Gene%20exp/[2022-5-20 LD 50umol zt1_4.xls]Sheet1'!$I$30,'https://d.docs.live.net/d8e9bd0bebfa4803/Somers%20lab%202020/Gene%20exp/[2022-5-20 LD 50umol zt1_4.xls]Sheet1'!$I$42,'https://d.docs.live.net/d8e9bd0bebfa4803/Somers%20lab%202020/Gene%20exp/[2022-5-20 LD 50umol zt1_4.xls]Sheet1'!$I$54,'https://d.docs.live.net/d8e9bd0bebfa4803/Somers%20lab%202020/Gene%20exp/[2022-5-20 LD 50umol zt1_4.xls]Sheet1'!$I$66,'https://d.docs.live.net/d8e9bd0bebfa4803/Somers%20lab%202020/Gene%20exp/[2022-5-20 LD 50umol zt1_4.xls]Sheet1'!$I$78,'https://d.docs.live.net/d8e9bd0bebfa4803/Somers%20lab%202020/Gene%20exp/[2022-5-20 LD 50umol zt1_4.xls]Sheet1'!$I$90)</c:f>
                <c:numCache>
                  <c:formatCode>General</c:formatCode>
                  <c:ptCount val="8"/>
                  <c:pt idx="0">
                    <c:v>1.8365318686981433E-3</c:v>
                  </c:pt>
                  <c:pt idx="1">
                    <c:v>1.3437811421488366E-3</c:v>
                  </c:pt>
                  <c:pt idx="2">
                    <c:v>3.8835657568042459E-3</c:v>
                  </c:pt>
                  <c:pt idx="3">
                    <c:v>3.0060249602618353E-4</c:v>
                  </c:pt>
                  <c:pt idx="4">
                    <c:v>4.5366529944570457E-4</c:v>
                  </c:pt>
                  <c:pt idx="5">
                    <c:v>7.9612554656568338E-5</c:v>
                  </c:pt>
                  <c:pt idx="6">
                    <c:v>6.575284696106222E-4</c:v>
                  </c:pt>
                  <c:pt idx="7">
                    <c:v>1.1129487956969913E-2</c:v>
                  </c:pt>
                </c:numCache>
              </c:numRef>
            </c:plus>
            <c:minus>
              <c:numRef>
                <c:f>('https://d.docs.live.net/d8e9bd0bebfa4803/Somers%20lab%202020/Gene%20exp/[2022-5-20 LD 50umol zt1_4.xls]Sheet1'!$I$6,'https://d.docs.live.net/d8e9bd0bebfa4803/Somers%20lab%202020/Gene%20exp/[2022-5-20 LD 50umol zt1_4.xls]Sheet1'!$I$18,'https://d.docs.live.net/d8e9bd0bebfa4803/Somers%20lab%202020/Gene%20exp/[2022-5-20 LD 50umol zt1_4.xls]Sheet1'!$I$30,'https://d.docs.live.net/d8e9bd0bebfa4803/Somers%20lab%202020/Gene%20exp/[2022-5-20 LD 50umol zt1_4.xls]Sheet1'!$I$42,'https://d.docs.live.net/d8e9bd0bebfa4803/Somers%20lab%202020/Gene%20exp/[2022-5-20 LD 50umol zt1_4.xls]Sheet1'!$I$54,'https://d.docs.live.net/d8e9bd0bebfa4803/Somers%20lab%202020/Gene%20exp/[2022-5-20 LD 50umol zt1_4.xls]Sheet1'!$I$66,'https://d.docs.live.net/d8e9bd0bebfa4803/Somers%20lab%202020/Gene%20exp/[2022-5-20 LD 50umol zt1_4.xls]Sheet1'!$I$78,'https://d.docs.live.net/d8e9bd0bebfa4803/Somers%20lab%202020/Gene%20exp/[2022-5-20 LD 50umol zt1_4.xls]Sheet1'!$I$90)</c:f>
                <c:numCache>
                  <c:formatCode>General</c:formatCode>
                  <c:ptCount val="8"/>
                  <c:pt idx="0">
                    <c:v>1.8365318686981433E-3</c:v>
                  </c:pt>
                  <c:pt idx="1">
                    <c:v>1.3437811421488366E-3</c:v>
                  </c:pt>
                  <c:pt idx="2">
                    <c:v>3.8835657568042459E-3</c:v>
                  </c:pt>
                  <c:pt idx="3">
                    <c:v>3.0060249602618353E-4</c:v>
                  </c:pt>
                  <c:pt idx="4">
                    <c:v>4.5366529944570457E-4</c:v>
                  </c:pt>
                  <c:pt idx="5">
                    <c:v>7.9612554656568338E-5</c:v>
                  </c:pt>
                  <c:pt idx="6">
                    <c:v>6.575284696106222E-4</c:v>
                  </c:pt>
                  <c:pt idx="7">
                    <c:v>1.1129487956969913E-2</c:v>
                  </c:pt>
                </c:numCache>
              </c:numRef>
            </c:minus>
            <c:spPr>
              <a:ln w="3175">
                <a:solidFill>
                  <a:srgbClr val="808080"/>
                </a:solidFill>
                <a:prstDash val="solid"/>
              </a:ln>
            </c:spPr>
          </c:errBars>
          <c:cat>
            <c:numRef>
              <c:f>'[2022-10-26 fhy3 1 normalize.xls]Sheet1'!$A$2,'[2022-10-26 fhy3 1 normalize.xls]Sheet1'!$A$14,'[2022-10-26 fhy3 1 normalize.xls]Sheet1'!$A$26,'[2022-10-26 fhy3 1 normalize.xls]Sheet1'!$A$38,'[2022-10-26 fhy3 1 normalize.xls]Sheet1'!$A$50,'[2022-10-26 fhy3 1 normalize.xls]Sheet1'!$A$62,'[2022-10-26 fhy3 1 normalize.xls]Sheet1'!$A$74,'[2022-10-26 fhy3 1 normalize.xls]Sheet1'!$A$86</c:f>
              <c:numCache>
                <c:formatCode>General</c:formatCode>
                <c:ptCount val="8"/>
                <c:pt idx="0">
                  <c:v>1</c:v>
                </c:pt>
                <c:pt idx="1">
                  <c:v>4</c:v>
                </c:pt>
                <c:pt idx="2">
                  <c:v>7</c:v>
                </c:pt>
                <c:pt idx="3">
                  <c:v>10</c:v>
                </c:pt>
                <c:pt idx="4">
                  <c:v>13</c:v>
                </c:pt>
                <c:pt idx="5">
                  <c:v>16</c:v>
                </c:pt>
                <c:pt idx="6">
                  <c:v>19</c:v>
                </c:pt>
                <c:pt idx="7">
                  <c:v>22</c:v>
                </c:pt>
              </c:numCache>
            </c:numRef>
          </c:cat>
          <c:val>
            <c:numRef>
              <c:f>'[2022-10-26 fhy3 1 normalize.xls]Sheet1'!$H$6,'[2022-10-26 fhy3 1 normalize.xls]Sheet1'!$H$18,'[2022-10-26 fhy3 1 normalize.xls]Sheet1'!$H$30,'[2022-10-26 fhy3 1 normalize.xls]Sheet1'!$H$42,'[2022-10-26 fhy3 1 normalize.xls]Sheet1'!$H$54,'[2022-10-26 fhy3 1 normalize.xls]Sheet1'!$H$66,'[2022-10-26 fhy3 1 normalize.xls]Sheet1'!$H$78,'[2022-10-26 fhy3 1 normalize.xls]Sheet1'!$H$90</c:f>
              <c:numCache>
                <c:formatCode>#,##0.000000000000000</c:formatCode>
                <c:ptCount val="8"/>
                <c:pt idx="0">
                  <c:v>0.60241335435579468</c:v>
                </c:pt>
                <c:pt idx="1">
                  <c:v>9.1986164207628812E-2</c:v>
                </c:pt>
                <c:pt idx="2">
                  <c:v>9.5768036454736416E-3</c:v>
                </c:pt>
                <c:pt idx="3">
                  <c:v>8.0765491193178929E-3</c:v>
                </c:pt>
                <c:pt idx="4">
                  <c:v>2.314842618779327E-2</c:v>
                </c:pt>
                <c:pt idx="5">
                  <c:v>9.0746068635177868E-2</c:v>
                </c:pt>
                <c:pt idx="6">
                  <c:v>0.42366794590064455</c:v>
                </c:pt>
                <c:pt idx="7">
                  <c:v>0.8295406698654479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3C0A-5D42-906E-E7B747A98851}"/>
            </c:ext>
          </c:extLst>
        </c:ser>
        <c:ser>
          <c:idx val="3"/>
          <c:order val="3"/>
          <c:tx>
            <c:strRef>
              <c:f>'[2022-10-26 fhy3 1 normalize.xls]Sheet1'!$A$6</c:f>
              <c:strCache>
                <c:ptCount val="1"/>
                <c:pt idx="0">
                  <c:v>pTOC1:TOC1-GFP/fhy3toc1</c:v>
                </c:pt>
              </c:strCache>
            </c:strRef>
          </c:tx>
          <c:marker>
            <c:symbol val="triangle"/>
            <c:size val="5"/>
            <c:spPr>
              <a:noFill/>
              <a:ln w="12700">
                <a:solidFill>
                  <a:schemeClr val="accent4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('https://d.docs.live.net/d8e9bd0bebfa4803/Somers%20lab%202020/Gene%20exp/[2022-5-20 LD 50umol zt1_4.xls]Sheet1'!$I$8,'https://d.docs.live.net/d8e9bd0bebfa4803/Somers%20lab%202020/Gene%20exp/[2022-5-20 LD 50umol zt1_4.xls]Sheet1'!$I$20,'https://d.docs.live.net/d8e9bd0bebfa4803/Somers%20lab%202020/Gene%20exp/[2022-5-20 LD 50umol zt1_4.xls]Sheet1'!$I$32,'https://d.docs.live.net/d8e9bd0bebfa4803/Somers%20lab%202020/Gene%20exp/[2022-5-20 LD 50umol zt1_4.xls]Sheet1'!$I$44,'https://d.docs.live.net/d8e9bd0bebfa4803/Somers%20lab%202020/Gene%20exp/[2022-5-20 LD 50umol zt1_4.xls]Sheet1'!$I$56,'https://d.docs.live.net/d8e9bd0bebfa4803/Somers%20lab%202020/Gene%20exp/[2022-5-20 LD 50umol zt1_4.xls]Sheet1'!$I$68,'https://d.docs.live.net/d8e9bd0bebfa4803/Somers%20lab%202020/Gene%20exp/[2022-5-20 LD 50umol zt1_4.xls]Sheet1'!$I$80,'https://d.docs.live.net/d8e9bd0bebfa4803/Somers%20lab%202020/Gene%20exp/[2022-5-20 LD 50umol zt1_4.xls]Sheet1'!$I$92)</c:f>
                <c:numCache>
                  <c:formatCode>General</c:formatCode>
                  <c:ptCount val="8"/>
                  <c:pt idx="0">
                    <c:v>3.117952473660035E-3</c:v>
                  </c:pt>
                  <c:pt idx="1">
                    <c:v>1.4328321478133674E-3</c:v>
                  </c:pt>
                  <c:pt idx="2">
                    <c:v>1.0057425196796225E-3</c:v>
                  </c:pt>
                  <c:pt idx="3">
                    <c:v>3.3321351339267134E-3</c:v>
                  </c:pt>
                  <c:pt idx="4">
                    <c:v>6.6132694943958686E-3</c:v>
                  </c:pt>
                  <c:pt idx="5">
                    <c:v>9.7634884838525976E-4</c:v>
                  </c:pt>
                  <c:pt idx="6">
                    <c:v>2.8880287983773924E-3</c:v>
                  </c:pt>
                  <c:pt idx="7">
                    <c:v>1.0353398736352991E-2</c:v>
                  </c:pt>
                </c:numCache>
              </c:numRef>
            </c:plus>
            <c:minus>
              <c:numRef>
                <c:f>('https://d.docs.live.net/d8e9bd0bebfa4803/Somers%20lab%202020/Gene%20exp/[2022-5-20 LD 50umol zt1_4.xls]Sheet1'!$I$8,'https://d.docs.live.net/d8e9bd0bebfa4803/Somers%20lab%202020/Gene%20exp/[2022-5-20 LD 50umol zt1_4.xls]Sheet1'!$I$20,'https://d.docs.live.net/d8e9bd0bebfa4803/Somers%20lab%202020/Gene%20exp/[2022-5-20 LD 50umol zt1_4.xls]Sheet1'!$I$32,'https://d.docs.live.net/d8e9bd0bebfa4803/Somers%20lab%202020/Gene%20exp/[2022-5-20 LD 50umol zt1_4.xls]Sheet1'!$I$44,'https://d.docs.live.net/d8e9bd0bebfa4803/Somers%20lab%202020/Gene%20exp/[2022-5-20 LD 50umol zt1_4.xls]Sheet1'!$I$56,'https://d.docs.live.net/d8e9bd0bebfa4803/Somers%20lab%202020/Gene%20exp/[2022-5-20 LD 50umol zt1_4.xls]Sheet1'!$I$68,'https://d.docs.live.net/d8e9bd0bebfa4803/Somers%20lab%202020/Gene%20exp/[2022-5-20 LD 50umol zt1_4.xls]Sheet1'!$I$80,'https://d.docs.live.net/d8e9bd0bebfa4803/Somers%20lab%202020/Gene%20exp/[2022-5-20 LD 50umol zt1_4.xls]Sheet1'!$I$92)</c:f>
                <c:numCache>
                  <c:formatCode>General</c:formatCode>
                  <c:ptCount val="8"/>
                  <c:pt idx="0">
                    <c:v>3.117952473660035E-3</c:v>
                  </c:pt>
                  <c:pt idx="1">
                    <c:v>1.4328321478133674E-3</c:v>
                  </c:pt>
                  <c:pt idx="2">
                    <c:v>1.0057425196796225E-3</c:v>
                  </c:pt>
                  <c:pt idx="3">
                    <c:v>3.3321351339267134E-3</c:v>
                  </c:pt>
                  <c:pt idx="4">
                    <c:v>6.6132694943958686E-3</c:v>
                  </c:pt>
                  <c:pt idx="5">
                    <c:v>9.7634884838525976E-4</c:v>
                  </c:pt>
                  <c:pt idx="6">
                    <c:v>2.8880287983773924E-3</c:v>
                  </c:pt>
                  <c:pt idx="7">
                    <c:v>1.0353398736352991E-2</c:v>
                  </c:pt>
                </c:numCache>
              </c:numRef>
            </c:minus>
            <c:spPr>
              <a:ln w="3175">
                <a:solidFill>
                  <a:srgbClr val="FFCC00"/>
                </a:solidFill>
                <a:prstDash val="solid"/>
              </a:ln>
            </c:spPr>
          </c:errBars>
          <c:cat>
            <c:numRef>
              <c:f>'[2022-10-26 fhy3 1 normalize.xls]Sheet1'!$A$2,'[2022-10-26 fhy3 1 normalize.xls]Sheet1'!$A$14,'[2022-10-26 fhy3 1 normalize.xls]Sheet1'!$A$26,'[2022-10-26 fhy3 1 normalize.xls]Sheet1'!$A$38,'[2022-10-26 fhy3 1 normalize.xls]Sheet1'!$A$50,'[2022-10-26 fhy3 1 normalize.xls]Sheet1'!$A$62,'[2022-10-26 fhy3 1 normalize.xls]Sheet1'!$A$74,'[2022-10-26 fhy3 1 normalize.xls]Sheet1'!$A$86</c:f>
              <c:numCache>
                <c:formatCode>General</c:formatCode>
                <c:ptCount val="8"/>
                <c:pt idx="0">
                  <c:v>1</c:v>
                </c:pt>
                <c:pt idx="1">
                  <c:v>4</c:v>
                </c:pt>
                <c:pt idx="2">
                  <c:v>7</c:v>
                </c:pt>
                <c:pt idx="3">
                  <c:v>10</c:v>
                </c:pt>
                <c:pt idx="4">
                  <c:v>13</c:v>
                </c:pt>
                <c:pt idx="5">
                  <c:v>16</c:v>
                </c:pt>
                <c:pt idx="6">
                  <c:v>19</c:v>
                </c:pt>
                <c:pt idx="7">
                  <c:v>22</c:v>
                </c:pt>
              </c:numCache>
            </c:numRef>
          </c:cat>
          <c:val>
            <c:numRef>
              <c:f>'[2022-10-26 fhy3 1 normalize.xls]Sheet1'!$H$8,'[2022-10-26 fhy3 1 normalize.xls]Sheet1'!$H$20,'[2022-10-26 fhy3 1 normalize.xls]Sheet1'!$H$32,'[2022-10-26 fhy3 1 normalize.xls]Sheet1'!$H$44,'[2022-10-26 fhy3 1 normalize.xls]Sheet1'!$H$56,'[2022-10-26 fhy3 1 normalize.xls]Sheet1'!$H$68,'[2022-10-26 fhy3 1 normalize.xls]Sheet1'!$H$80,'[2022-10-26 fhy3 1 normalize.xls]Sheet1'!$H$92</c:f>
              <c:numCache>
                <c:formatCode>#,##0.000000000000000</c:formatCode>
                <c:ptCount val="8"/>
                <c:pt idx="0">
                  <c:v>0.51517258737634131</c:v>
                </c:pt>
                <c:pt idx="1">
                  <c:v>0.18713941195380726</c:v>
                </c:pt>
                <c:pt idx="2">
                  <c:v>2.3132233014411328E-2</c:v>
                </c:pt>
                <c:pt idx="3">
                  <c:v>2.5426553397253529E-3</c:v>
                </c:pt>
                <c:pt idx="4">
                  <c:v>2.7481384578185381E-3</c:v>
                </c:pt>
                <c:pt idx="5">
                  <c:v>6.2953017579406058E-3</c:v>
                </c:pt>
                <c:pt idx="6">
                  <c:v>0.10627421761068129</c:v>
                </c:pt>
                <c:pt idx="7">
                  <c:v>1.16603306044261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3C0A-5D42-906E-E7B747A98851}"/>
            </c:ext>
          </c:extLst>
        </c:ser>
        <c:ser>
          <c:idx val="4"/>
          <c:order val="4"/>
          <c:tx>
            <c:strRef>
              <c:f>'[2022-10-26 fhy3 1 normalize.xls]Sheet1'!$A$7</c:f>
              <c:strCache>
                <c:ptCount val="1"/>
                <c:pt idx="0">
                  <c:v>pTOC1:5X-GFP/fhy3toc1</c:v>
                </c:pt>
              </c:strCache>
            </c:strRef>
          </c:tx>
          <c:spPr>
            <a:ln>
              <a:solidFill>
                <a:schemeClr val="accent6"/>
              </a:solidFill>
            </a:ln>
          </c:spPr>
          <c:marker>
            <c:symbol val="triangle"/>
            <c:size val="5"/>
            <c:spPr>
              <a:noFill/>
              <a:ln w="12700">
                <a:solidFill>
                  <a:schemeClr val="accent6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('https://d.docs.live.net/d8e9bd0bebfa4803/Somers%20lab%202020/Gene%20exp/[2022-5-20 LD 50umol zt1_4.xls]Sheet1'!$I$10,'https://d.docs.live.net/d8e9bd0bebfa4803/Somers%20lab%202020/Gene%20exp/[2022-5-20 LD 50umol zt1_4.xls]Sheet1'!$I$22,'https://d.docs.live.net/d8e9bd0bebfa4803/Somers%20lab%202020/Gene%20exp/[2022-5-20 LD 50umol zt1_4.xls]Sheet1'!$I$34,'https://d.docs.live.net/d8e9bd0bebfa4803/Somers%20lab%202020/Gene%20exp/[2022-5-20 LD 50umol zt1_4.xls]Sheet1'!$I$46,'https://d.docs.live.net/d8e9bd0bebfa4803/Somers%20lab%202020/Gene%20exp/[2022-5-20 LD 50umol zt1_4.xls]Sheet1'!$I$58,'https://d.docs.live.net/d8e9bd0bebfa4803/Somers%20lab%202020/Gene%20exp/[2022-5-20 LD 50umol zt1_4.xls]Sheet1'!$I$70,'https://d.docs.live.net/d8e9bd0bebfa4803/Somers%20lab%202020/Gene%20exp/[2022-5-20 LD 50umol zt1_4.xls]Sheet1'!$I$82,'https://d.docs.live.net/d8e9bd0bebfa4803/Somers%20lab%202020/Gene%20exp/[2022-5-20 LD 50umol zt1_4.xls]Sheet1'!$I$94)</c:f>
                <c:numCache>
                  <c:formatCode>General</c:formatCode>
                  <c:ptCount val="8"/>
                  <c:pt idx="0">
                    <c:v>3.2316303930444157E-3</c:v>
                  </c:pt>
                  <c:pt idx="1">
                    <c:v>6.8802553007674969E-3</c:v>
                  </c:pt>
                  <c:pt idx="2">
                    <c:v>3.3614092854711494E-3</c:v>
                  </c:pt>
                  <c:pt idx="3">
                    <c:v>6.032376393059297E-5</c:v>
                  </c:pt>
                  <c:pt idx="4">
                    <c:v>1.3606318495585452E-3</c:v>
                  </c:pt>
                  <c:pt idx="5">
                    <c:v>3.0475805569661092E-4</c:v>
                  </c:pt>
                  <c:pt idx="6">
                    <c:v>8.7584831964419144E-5</c:v>
                  </c:pt>
                  <c:pt idx="7">
                    <c:v>6.3272241480005487E-3</c:v>
                  </c:pt>
                </c:numCache>
              </c:numRef>
            </c:plus>
            <c:minus>
              <c:numRef>
                <c:f>('https://d.docs.live.net/d8e9bd0bebfa4803/Somers%20lab%202020/Gene%20exp/[2022-5-20 LD 50umol zt1_4.xls]Sheet1'!$I$10,'https://d.docs.live.net/d8e9bd0bebfa4803/Somers%20lab%202020/Gene%20exp/[2022-5-20 LD 50umol zt1_4.xls]Sheet1'!$I$22,'https://d.docs.live.net/d8e9bd0bebfa4803/Somers%20lab%202020/Gene%20exp/[2022-5-20 LD 50umol zt1_4.xls]Sheet1'!$I$34,'https://d.docs.live.net/d8e9bd0bebfa4803/Somers%20lab%202020/Gene%20exp/[2022-5-20 LD 50umol zt1_4.xls]Sheet1'!$I$46,'https://d.docs.live.net/d8e9bd0bebfa4803/Somers%20lab%202020/Gene%20exp/[2022-5-20 LD 50umol zt1_4.xls]Sheet1'!$I$58,'https://d.docs.live.net/d8e9bd0bebfa4803/Somers%20lab%202020/Gene%20exp/[2022-5-20 LD 50umol zt1_4.xls]Sheet1'!$I$70,'https://d.docs.live.net/d8e9bd0bebfa4803/Somers%20lab%202020/Gene%20exp/[2022-5-20 LD 50umol zt1_4.xls]Sheet1'!$I$82,'https://d.docs.live.net/d8e9bd0bebfa4803/Somers%20lab%202020/Gene%20exp/[2022-5-20 LD 50umol zt1_4.xls]Sheet1'!$I$94)</c:f>
                <c:numCache>
                  <c:formatCode>General</c:formatCode>
                  <c:ptCount val="8"/>
                  <c:pt idx="0">
                    <c:v>3.2316303930444157E-3</c:v>
                  </c:pt>
                  <c:pt idx="1">
                    <c:v>6.8802553007674969E-3</c:v>
                  </c:pt>
                  <c:pt idx="2">
                    <c:v>3.3614092854711494E-3</c:v>
                  </c:pt>
                  <c:pt idx="3">
                    <c:v>6.032376393059297E-5</c:v>
                  </c:pt>
                  <c:pt idx="4">
                    <c:v>1.3606318495585452E-3</c:v>
                  </c:pt>
                  <c:pt idx="5">
                    <c:v>3.0475805569661092E-4</c:v>
                  </c:pt>
                  <c:pt idx="6">
                    <c:v>8.7584831964419144E-5</c:v>
                  </c:pt>
                  <c:pt idx="7">
                    <c:v>6.3272241480005487E-3</c:v>
                  </c:pt>
                </c:numCache>
              </c:numRef>
            </c:minus>
            <c:spPr>
              <a:ln w="3175">
                <a:solidFill>
                  <a:srgbClr val="666699"/>
                </a:solidFill>
                <a:prstDash val="solid"/>
              </a:ln>
            </c:spPr>
          </c:errBars>
          <c:cat>
            <c:numRef>
              <c:f>'[2022-10-26 fhy3 1 normalize.xls]Sheet1'!$A$2,'[2022-10-26 fhy3 1 normalize.xls]Sheet1'!$A$14,'[2022-10-26 fhy3 1 normalize.xls]Sheet1'!$A$26,'[2022-10-26 fhy3 1 normalize.xls]Sheet1'!$A$38,'[2022-10-26 fhy3 1 normalize.xls]Sheet1'!$A$50,'[2022-10-26 fhy3 1 normalize.xls]Sheet1'!$A$62,'[2022-10-26 fhy3 1 normalize.xls]Sheet1'!$A$74,'[2022-10-26 fhy3 1 normalize.xls]Sheet1'!$A$86</c:f>
              <c:numCache>
                <c:formatCode>General</c:formatCode>
                <c:ptCount val="8"/>
                <c:pt idx="0">
                  <c:v>1</c:v>
                </c:pt>
                <c:pt idx="1">
                  <c:v>4</c:v>
                </c:pt>
                <c:pt idx="2">
                  <c:v>7</c:v>
                </c:pt>
                <c:pt idx="3">
                  <c:v>10</c:v>
                </c:pt>
                <c:pt idx="4">
                  <c:v>13</c:v>
                </c:pt>
                <c:pt idx="5">
                  <c:v>16</c:v>
                </c:pt>
                <c:pt idx="6">
                  <c:v>19</c:v>
                </c:pt>
                <c:pt idx="7">
                  <c:v>22</c:v>
                </c:pt>
              </c:numCache>
            </c:numRef>
          </c:cat>
          <c:val>
            <c:numRef>
              <c:f>'[2022-10-26 fhy3 1 normalize.xls]Sheet1'!$H$10,'[2022-10-26 fhy3 1 normalize.xls]Sheet1'!$H$22,'[2022-10-26 fhy3 1 normalize.xls]Sheet1'!$H$34,'[2022-10-26 fhy3 1 normalize.xls]Sheet1'!$H$46,'[2022-10-26 fhy3 1 normalize.xls]Sheet1'!$H$58,'[2022-10-26 fhy3 1 normalize.xls]Sheet1'!$H$70,'[2022-10-26 fhy3 1 normalize.xls]Sheet1'!$H$82,'[2022-10-26 fhy3 1 normalize.xls]Sheet1'!$H$94</c:f>
              <c:numCache>
                <c:formatCode>#,##0.000000000000000</c:formatCode>
                <c:ptCount val="8"/>
                <c:pt idx="0">
                  <c:v>0.49184994591071429</c:v>
                </c:pt>
                <c:pt idx="1">
                  <c:v>0.32074134864545201</c:v>
                </c:pt>
                <c:pt idx="2">
                  <c:v>3.4617577497411706E-2</c:v>
                </c:pt>
                <c:pt idx="3">
                  <c:v>3.040664189230078E-2</c:v>
                </c:pt>
                <c:pt idx="4">
                  <c:v>3.8323208052838231E-2</c:v>
                </c:pt>
                <c:pt idx="5">
                  <c:v>4.5690969169295763E-2</c:v>
                </c:pt>
                <c:pt idx="6">
                  <c:v>0.23169737050990022</c:v>
                </c:pt>
                <c:pt idx="7">
                  <c:v>0.8202815156318020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3C0A-5D42-906E-E7B747A9885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383097920"/>
        <c:axId val="1"/>
      </c:lineChart>
      <c:catAx>
        <c:axId val="383097920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altLang="zh-CN" dirty="0"/>
                  <a:t>ZT Time</a:t>
                </a:r>
                <a:endParaRPr lang="zh-CN" altLang="en-US" dirty="0"/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0" vert="horz"/>
          <a:lstStyle/>
          <a:p>
            <a:pPr>
              <a:defRPr sz="1050" b="0" i="0" u="none" strike="noStrike" baseline="0">
                <a:solidFill>
                  <a:srgbClr val="000000"/>
                </a:solidFill>
                <a:latin typeface="Calibri"/>
                <a:ea typeface="Calibri"/>
                <a:cs typeface="Calibri"/>
              </a:defRPr>
            </a:pPr>
            <a:endParaRPr lang="en-US"/>
          </a:p>
        </c:txPr>
        <c:crossAx val="1"/>
        <c:crosses val="autoZero"/>
        <c:auto val="1"/>
        <c:lblAlgn val="ctr"/>
        <c:lblOffset val="100"/>
        <c:noMultiLvlLbl val="0"/>
      </c:catAx>
      <c:valAx>
        <c:axId val="1"/>
        <c:scaling>
          <c:orientation val="minMax"/>
          <c:max val="0.4"/>
          <c:min val="0"/>
        </c:scaling>
        <c:delete val="0"/>
        <c:axPos val="l"/>
        <c:numFmt formatCode="#,##0.0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0" vert="horz"/>
          <a:lstStyle/>
          <a:p>
            <a:pPr>
              <a:defRPr sz="1050" b="0" i="0" u="none" strike="noStrike" baseline="0">
                <a:solidFill>
                  <a:srgbClr val="000000"/>
                </a:solidFill>
                <a:latin typeface="Calibri"/>
                <a:ea typeface="Calibri"/>
                <a:cs typeface="Calibri"/>
              </a:defRPr>
            </a:pPr>
            <a:endParaRPr lang="en-US"/>
          </a:p>
        </c:txPr>
        <c:crossAx val="383097920"/>
        <c:crosses val="autoZero"/>
        <c:crossBetween val="between"/>
        <c:majorUnit val="0.2"/>
      </c:valAx>
      <c:spPr>
        <a:noFill/>
        <a:ln w="25400">
          <a:noFill/>
        </a:ln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1050" b="0" i="0" u="none" strike="noStrike" baseline="0">
          <a:solidFill>
            <a:srgbClr val="000000"/>
          </a:solidFill>
          <a:latin typeface="Calibri"/>
          <a:ea typeface="Calibri"/>
          <a:cs typeface="Calibri"/>
        </a:defRPr>
      </a:pPr>
      <a:endParaRPr lang="en-US"/>
    </a:p>
  </c:txPr>
  <c:externalData r:id="rId1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60" b="0" i="1" u="none" strike="noStrike" baseline="0">
                <a:solidFill>
                  <a:srgbClr val="000000"/>
                </a:solidFill>
                <a:latin typeface="Calibri"/>
                <a:ea typeface="Calibri"/>
                <a:cs typeface="Calibri"/>
              </a:defRPr>
            </a:pPr>
            <a:r>
              <a:rPr lang="en-US" altLang="zh-CN" i="1" dirty="0"/>
              <a:t>LHY</a:t>
            </a:r>
          </a:p>
        </c:rich>
      </c:tx>
      <c:layout>
        <c:manualLayout>
          <c:xMode val="edge"/>
          <c:yMode val="edge"/>
          <c:x val="0.47933890958558673"/>
          <c:y val="5.6716431241375306E-2"/>
        </c:manualLayout>
      </c:layout>
      <c:overlay val="0"/>
      <c:spPr>
        <a:noFill/>
        <a:ln w="25400">
          <a:noFill/>
        </a:ln>
      </c:spPr>
    </c:title>
    <c:autoTitleDeleted val="0"/>
    <c:plotArea>
      <c:layout>
        <c:manualLayout>
          <c:layoutTarget val="inner"/>
          <c:xMode val="edge"/>
          <c:yMode val="edge"/>
          <c:x val="0.10915462973897631"/>
          <c:y val="0.158830888699905"/>
          <c:w val="0.88194448581447826"/>
          <c:h val="0.73140463441507109"/>
        </c:manualLayout>
      </c:layout>
      <c:lineChart>
        <c:grouping val="standard"/>
        <c:varyColors val="0"/>
        <c:ser>
          <c:idx val="0"/>
          <c:order val="0"/>
          <c:tx>
            <c:strRef>
              <c:f>'[2022-10-26 fhy3 1 normalize.xls]Sheet1'!$A$3</c:f>
              <c:strCache>
                <c:ptCount val="1"/>
                <c:pt idx="0">
                  <c:v>Col-0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noFill/>
              <a:ln w="12700">
                <a:solidFill>
                  <a:schemeClr val="accent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('https://d.docs.live.net/d8e9bd0bebfa4803/Somers%20lab%202020/Gene%20exp/[2022-5-20 LD 50umol zt1_4.xls]Sheet1'!$R$2,'https://d.docs.live.net/d8e9bd0bebfa4803/Somers%20lab%202020/Gene%20exp/[2022-5-20 LD 50umol zt1_4.xls]Sheet1'!$R$14,'https://d.docs.live.net/d8e9bd0bebfa4803/Somers%20lab%202020/Gene%20exp/[2022-5-20 LD 50umol zt1_4.xls]Sheet1'!$R$26,'https://d.docs.live.net/d8e9bd0bebfa4803/Somers%20lab%202020/Gene%20exp/[2022-5-20 LD 50umol zt1_4.xls]Sheet1'!$R$38,'https://d.docs.live.net/d8e9bd0bebfa4803/Somers%20lab%202020/Gene%20exp/[2022-5-20 LD 50umol zt1_4.xls]Sheet1'!$R$50,'https://d.docs.live.net/d8e9bd0bebfa4803/Somers%20lab%202020/Gene%20exp/[2022-5-20 LD 50umol zt1_4.xls]Sheet1'!$R$62,'https://d.docs.live.net/d8e9bd0bebfa4803/Somers%20lab%202020/Gene%20exp/[2022-5-20 LD 50umol zt1_4.xls]Sheet1'!$R$74,'https://d.docs.live.net/d8e9bd0bebfa4803/Somers%20lab%202020/Gene%20exp/[2022-5-20 LD 50umol zt1_4.xls]Sheet1'!$R$86)</c:f>
                <c:numCache>
                  <c:formatCode>General</c:formatCode>
                  <c:ptCount val="8"/>
                  <c:pt idx="0">
                    <c:v>1.1984750978864117E-3</c:v>
                  </c:pt>
                  <c:pt idx="1">
                    <c:v>2.7225390690862027E-4</c:v>
                  </c:pt>
                  <c:pt idx="2">
                    <c:v>1.5498486049229178E-5</c:v>
                  </c:pt>
                  <c:pt idx="3">
                    <c:v>9.7521281457490131E-5</c:v>
                  </c:pt>
                  <c:pt idx="4">
                    <c:v>2.0289726358196811E-5</c:v>
                  </c:pt>
                  <c:pt idx="5">
                    <c:v>3.2967670795421987E-5</c:v>
                  </c:pt>
                  <c:pt idx="6">
                    <c:v>3.9623006470999866E-5</c:v>
                  </c:pt>
                  <c:pt idx="7">
                    <c:v>8.0455474881991121E-4</c:v>
                  </c:pt>
                </c:numCache>
              </c:numRef>
            </c:plus>
            <c:minus>
              <c:numRef>
                <c:f>('https://d.docs.live.net/d8e9bd0bebfa4803/Somers%20lab%202020/Gene%20exp/[2022-5-20 LD 50umol zt1_4.xls]Sheet1'!$R$2,'https://d.docs.live.net/d8e9bd0bebfa4803/Somers%20lab%202020/Gene%20exp/[2022-5-20 LD 50umol zt1_4.xls]Sheet1'!$R$14,'https://d.docs.live.net/d8e9bd0bebfa4803/Somers%20lab%202020/Gene%20exp/[2022-5-20 LD 50umol zt1_4.xls]Sheet1'!$R$26,'https://d.docs.live.net/d8e9bd0bebfa4803/Somers%20lab%202020/Gene%20exp/[2022-5-20 LD 50umol zt1_4.xls]Sheet1'!$R$38,'https://d.docs.live.net/d8e9bd0bebfa4803/Somers%20lab%202020/Gene%20exp/[2022-5-20 LD 50umol zt1_4.xls]Sheet1'!$R$50,'https://d.docs.live.net/d8e9bd0bebfa4803/Somers%20lab%202020/Gene%20exp/[2022-5-20 LD 50umol zt1_4.xls]Sheet1'!$R$62,'https://d.docs.live.net/d8e9bd0bebfa4803/Somers%20lab%202020/Gene%20exp/[2022-5-20 LD 50umol zt1_4.xls]Sheet1'!$R$74,'https://d.docs.live.net/d8e9bd0bebfa4803/Somers%20lab%202020/Gene%20exp/[2022-5-20 LD 50umol zt1_4.xls]Sheet1'!$R$86)</c:f>
                <c:numCache>
                  <c:formatCode>General</c:formatCode>
                  <c:ptCount val="8"/>
                  <c:pt idx="0">
                    <c:v>1.1984750978864117E-3</c:v>
                  </c:pt>
                  <c:pt idx="1">
                    <c:v>2.7225390690862027E-4</c:v>
                  </c:pt>
                  <c:pt idx="2">
                    <c:v>1.5498486049229178E-5</c:v>
                  </c:pt>
                  <c:pt idx="3">
                    <c:v>9.7521281457490131E-5</c:v>
                  </c:pt>
                  <c:pt idx="4">
                    <c:v>2.0289726358196811E-5</c:v>
                  </c:pt>
                  <c:pt idx="5">
                    <c:v>3.2967670795421987E-5</c:v>
                  </c:pt>
                  <c:pt idx="6">
                    <c:v>3.9623006470999866E-5</c:v>
                  </c:pt>
                  <c:pt idx="7">
                    <c:v>8.0455474881991121E-4</c:v>
                  </c:pt>
                </c:numCache>
              </c:numRef>
            </c:minus>
            <c:spPr>
              <a:ln w="3175">
                <a:solidFill>
                  <a:srgbClr val="666699"/>
                </a:solidFill>
                <a:prstDash val="solid"/>
              </a:ln>
            </c:spPr>
          </c:errBars>
          <c:cat>
            <c:numRef>
              <c:f>'[2022-10-26 fhy3 1 normalize.xls]Sheet1'!$A$2,'[2022-10-26 fhy3 1 normalize.xls]Sheet1'!$A$14,'[2022-10-26 fhy3 1 normalize.xls]Sheet1'!$A$26,'[2022-10-26 fhy3 1 normalize.xls]Sheet1'!$A$38,'[2022-10-26 fhy3 1 normalize.xls]Sheet1'!$A$50,'[2022-10-26 fhy3 1 normalize.xls]Sheet1'!$A$62,'[2022-10-26 fhy3 1 normalize.xls]Sheet1'!$A$74,'[2022-10-26 fhy3 1 normalize.xls]Sheet1'!$A$86</c:f>
              <c:numCache>
                <c:formatCode>General</c:formatCode>
                <c:ptCount val="8"/>
                <c:pt idx="0">
                  <c:v>1</c:v>
                </c:pt>
                <c:pt idx="1">
                  <c:v>4</c:v>
                </c:pt>
                <c:pt idx="2">
                  <c:v>7</c:v>
                </c:pt>
                <c:pt idx="3">
                  <c:v>10</c:v>
                </c:pt>
                <c:pt idx="4">
                  <c:v>13</c:v>
                </c:pt>
                <c:pt idx="5">
                  <c:v>16</c:v>
                </c:pt>
                <c:pt idx="6">
                  <c:v>19</c:v>
                </c:pt>
                <c:pt idx="7">
                  <c:v>22</c:v>
                </c:pt>
              </c:numCache>
            </c:numRef>
          </c:cat>
          <c:val>
            <c:numRef>
              <c:f>'[2022-10-26 fhy3 1 normalize.xls]Sheet1'!$Q$2,'[2022-10-26 fhy3 1 normalize.xls]Sheet1'!$Q$14,'[2022-10-26 fhy3 1 normalize.xls]Sheet1'!$Q$26,'[2022-10-26 fhy3 1 normalize.xls]Sheet1'!$Q$38,'[2022-10-26 fhy3 1 normalize.xls]Sheet1'!$Q$50,'[2022-10-26 fhy3 1 normalize.xls]Sheet1'!$Q$62,'[2022-10-26 fhy3 1 normalize.xls]Sheet1'!$Q$74,'[2022-10-26 fhy3 1 normalize.xls]Sheet1'!$Q$86</c:f>
              <c:numCache>
                <c:formatCode>#,##0.000000000000000</c:formatCode>
                <c:ptCount val="8"/>
                <c:pt idx="0">
                  <c:v>0.99999999999999978</c:v>
                </c:pt>
                <c:pt idx="1">
                  <c:v>6.2153110799117721E-2</c:v>
                </c:pt>
                <c:pt idx="2">
                  <c:v>8.3601091031872306E-3</c:v>
                </c:pt>
                <c:pt idx="3">
                  <c:v>2.2841138224417934E-3</c:v>
                </c:pt>
                <c:pt idx="4">
                  <c:v>4.2229968172506705E-3</c:v>
                </c:pt>
                <c:pt idx="5">
                  <c:v>2.7127246605896032E-2</c:v>
                </c:pt>
                <c:pt idx="6">
                  <c:v>0.44603767025788277</c:v>
                </c:pt>
                <c:pt idx="7">
                  <c:v>2.686021964173478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B924-CA41-AA4E-818E625AF543}"/>
            </c:ext>
          </c:extLst>
        </c:ser>
        <c:ser>
          <c:idx val="1"/>
          <c:order val="1"/>
          <c:tx>
            <c:strRef>
              <c:f>'[2022-10-26 fhy3 1 normalize.xls]Sheet1'!$A$4</c:f>
              <c:strCache>
                <c:ptCount val="1"/>
                <c:pt idx="0">
                  <c:v>fhy3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square"/>
            <c:size val="5"/>
            <c:spPr>
              <a:noFill/>
              <a:ln w="12700">
                <a:solidFill>
                  <a:schemeClr val="accent2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('https://d.docs.live.net/d8e9bd0bebfa4803/Somers%20lab%202020/Gene%20exp/[2022-5-20 LD 50umol zt1_4.xls]Sheet1'!$R$4,'https://d.docs.live.net/d8e9bd0bebfa4803/Somers%20lab%202020/Gene%20exp/[2022-5-20 LD 50umol zt1_4.xls]Sheet1'!$R$16,'https://d.docs.live.net/d8e9bd0bebfa4803/Somers%20lab%202020/Gene%20exp/[2022-5-20 LD 50umol zt1_4.xls]Sheet1'!$R$28,'https://d.docs.live.net/d8e9bd0bebfa4803/Somers%20lab%202020/Gene%20exp/[2022-5-20 LD 50umol zt1_4.xls]Sheet1'!$R$40,'https://d.docs.live.net/d8e9bd0bebfa4803/Somers%20lab%202020/Gene%20exp/[2022-5-20 LD 50umol zt1_4.xls]Sheet1'!$R$52,'https://d.docs.live.net/d8e9bd0bebfa4803/Somers%20lab%202020/Gene%20exp/[2022-5-20 LD 50umol zt1_4.xls]Sheet1'!$R$64,'https://d.docs.live.net/d8e9bd0bebfa4803/Somers%20lab%202020/Gene%20exp/[2022-5-20 LD 50umol zt1_4.xls]Sheet1'!$R$76,'https://d.docs.live.net/d8e9bd0bebfa4803/Somers%20lab%202020/Gene%20exp/[2022-5-20 LD 50umol zt1_4.xls]Sheet1'!$R$88)</c:f>
                <c:numCache>
                  <c:formatCode>General</c:formatCode>
                  <c:ptCount val="8"/>
                  <c:pt idx="0">
                    <c:v>2.0816157498584741E-3</c:v>
                  </c:pt>
                  <c:pt idx="1">
                    <c:v>9.4371261251063095E-5</c:v>
                  </c:pt>
                  <c:pt idx="2">
                    <c:v>7.5459654176112068E-6</c:v>
                  </c:pt>
                  <c:pt idx="3">
                    <c:v>7.269229894768513E-6</c:v>
                  </c:pt>
                  <c:pt idx="4">
                    <c:v>4.7632637712312237E-6</c:v>
                  </c:pt>
                  <c:pt idx="5">
                    <c:v>1.6551977786918946E-4</c:v>
                  </c:pt>
                  <c:pt idx="6">
                    <c:v>2.6305991397382006E-3</c:v>
                  </c:pt>
                  <c:pt idx="7">
                    <c:v>1.6221855587023879E-3</c:v>
                  </c:pt>
                </c:numCache>
              </c:numRef>
            </c:plus>
            <c:minus>
              <c:numRef>
                <c:f>('https://d.docs.live.net/d8e9bd0bebfa4803/Somers%20lab%202020/Gene%20exp/[2022-5-20 LD 50umol zt1_4.xls]Sheet1'!$R$4,'https://d.docs.live.net/d8e9bd0bebfa4803/Somers%20lab%202020/Gene%20exp/[2022-5-20 LD 50umol zt1_4.xls]Sheet1'!$R$16,'https://d.docs.live.net/d8e9bd0bebfa4803/Somers%20lab%202020/Gene%20exp/[2022-5-20 LD 50umol zt1_4.xls]Sheet1'!$R$28,'https://d.docs.live.net/d8e9bd0bebfa4803/Somers%20lab%202020/Gene%20exp/[2022-5-20 LD 50umol zt1_4.xls]Sheet1'!$R$40,'https://d.docs.live.net/d8e9bd0bebfa4803/Somers%20lab%202020/Gene%20exp/[2022-5-20 LD 50umol zt1_4.xls]Sheet1'!$R$52,'https://d.docs.live.net/d8e9bd0bebfa4803/Somers%20lab%202020/Gene%20exp/[2022-5-20 LD 50umol zt1_4.xls]Sheet1'!$R$64,'https://d.docs.live.net/d8e9bd0bebfa4803/Somers%20lab%202020/Gene%20exp/[2022-5-20 LD 50umol zt1_4.xls]Sheet1'!$R$76,'https://d.docs.live.net/d8e9bd0bebfa4803/Somers%20lab%202020/Gene%20exp/[2022-5-20 LD 50umol zt1_4.xls]Sheet1'!$R$88)</c:f>
                <c:numCache>
                  <c:formatCode>General</c:formatCode>
                  <c:ptCount val="8"/>
                  <c:pt idx="0">
                    <c:v>2.0816157498584741E-3</c:v>
                  </c:pt>
                  <c:pt idx="1">
                    <c:v>9.4371261251063095E-5</c:v>
                  </c:pt>
                  <c:pt idx="2">
                    <c:v>7.5459654176112068E-6</c:v>
                  </c:pt>
                  <c:pt idx="3">
                    <c:v>7.269229894768513E-6</c:v>
                  </c:pt>
                  <c:pt idx="4">
                    <c:v>4.7632637712312237E-6</c:v>
                  </c:pt>
                  <c:pt idx="5">
                    <c:v>1.6551977786918946E-4</c:v>
                  </c:pt>
                  <c:pt idx="6">
                    <c:v>2.6305991397382006E-3</c:v>
                  </c:pt>
                  <c:pt idx="7">
                    <c:v>1.6221855587023879E-3</c:v>
                  </c:pt>
                </c:numCache>
              </c:numRef>
            </c:minus>
            <c:spPr>
              <a:ln w="3175">
                <a:solidFill>
                  <a:srgbClr val="FF6600"/>
                </a:solidFill>
                <a:prstDash val="solid"/>
              </a:ln>
            </c:spPr>
          </c:errBars>
          <c:cat>
            <c:numRef>
              <c:f>'[2022-10-26 fhy3 1 normalize.xls]Sheet1'!$A$2,'[2022-10-26 fhy3 1 normalize.xls]Sheet1'!$A$14,'[2022-10-26 fhy3 1 normalize.xls]Sheet1'!$A$26,'[2022-10-26 fhy3 1 normalize.xls]Sheet1'!$A$38,'[2022-10-26 fhy3 1 normalize.xls]Sheet1'!$A$50,'[2022-10-26 fhy3 1 normalize.xls]Sheet1'!$A$62,'[2022-10-26 fhy3 1 normalize.xls]Sheet1'!$A$74,'[2022-10-26 fhy3 1 normalize.xls]Sheet1'!$A$86</c:f>
              <c:numCache>
                <c:formatCode>General</c:formatCode>
                <c:ptCount val="8"/>
                <c:pt idx="0">
                  <c:v>1</c:v>
                </c:pt>
                <c:pt idx="1">
                  <c:v>4</c:v>
                </c:pt>
                <c:pt idx="2">
                  <c:v>7</c:v>
                </c:pt>
                <c:pt idx="3">
                  <c:v>10</c:v>
                </c:pt>
                <c:pt idx="4">
                  <c:v>13</c:v>
                </c:pt>
                <c:pt idx="5">
                  <c:v>16</c:v>
                </c:pt>
                <c:pt idx="6">
                  <c:v>19</c:v>
                </c:pt>
                <c:pt idx="7">
                  <c:v>22</c:v>
                </c:pt>
              </c:numCache>
            </c:numRef>
          </c:cat>
          <c:val>
            <c:numRef>
              <c:f>'[2022-10-26 fhy3 1 normalize.xls]Sheet1'!$Q$4,'[2022-10-26 fhy3 1 normalize.xls]Sheet1'!$Q$16,'[2022-10-26 fhy3 1 normalize.xls]Sheet1'!$Q$28,'[2022-10-26 fhy3 1 normalize.xls]Sheet1'!$Q$40,'[2022-10-26 fhy3 1 normalize.xls]Sheet1'!$Q$52,'[2022-10-26 fhy3 1 normalize.xls]Sheet1'!$Q$64,'[2022-10-26 fhy3 1 normalize.xls]Sheet1'!$Q$76,'[2022-10-26 fhy3 1 normalize.xls]Sheet1'!$Q$88</c:f>
              <c:numCache>
                <c:formatCode>#,##0.000000000000000</c:formatCode>
                <c:ptCount val="8"/>
                <c:pt idx="0">
                  <c:v>0.77674313017504604</c:v>
                </c:pt>
                <c:pt idx="1">
                  <c:v>4.8243330733435189E-2</c:v>
                </c:pt>
                <c:pt idx="2">
                  <c:v>3.6206655799088097E-3</c:v>
                </c:pt>
                <c:pt idx="3">
                  <c:v>3.0656501377497249E-3</c:v>
                </c:pt>
                <c:pt idx="4">
                  <c:v>3.4547365592209481E-3</c:v>
                </c:pt>
                <c:pt idx="5">
                  <c:v>1.7834961226753068E-2</c:v>
                </c:pt>
                <c:pt idx="6">
                  <c:v>0.20268804317629882</c:v>
                </c:pt>
                <c:pt idx="7">
                  <c:v>2.44478341386713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B924-CA41-AA4E-818E625AF543}"/>
            </c:ext>
          </c:extLst>
        </c:ser>
        <c:ser>
          <c:idx val="2"/>
          <c:order val="2"/>
          <c:tx>
            <c:strRef>
              <c:f>'[2022-10-26 fhy3 1 normalize.xls]Sheet1'!$A$5</c:f>
              <c:strCache>
                <c:ptCount val="1"/>
                <c:pt idx="0">
                  <c:v>fhy3toc1</c:v>
                </c:pt>
              </c:strCache>
            </c:strRef>
          </c:tx>
          <c:spPr>
            <a:ln>
              <a:solidFill>
                <a:srgbClr val="7030A0"/>
              </a:solidFill>
            </a:ln>
          </c:spPr>
          <c:marker>
            <c:symbol val="square"/>
            <c:size val="5"/>
            <c:spPr>
              <a:noFill/>
              <a:ln w="12700">
                <a:solidFill>
                  <a:srgbClr val="7030A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('https://d.docs.live.net/d8e9bd0bebfa4803/Somers%20lab%202020/Gene%20exp/[2022-5-20 LD 50umol zt1_4.xls]Sheet1'!$R$6,'https://d.docs.live.net/d8e9bd0bebfa4803/Somers%20lab%202020/Gene%20exp/[2022-5-20 LD 50umol zt1_4.xls]Sheet1'!$R$18,'https://d.docs.live.net/d8e9bd0bebfa4803/Somers%20lab%202020/Gene%20exp/[2022-5-20 LD 50umol zt1_4.xls]Sheet1'!$R$30,'https://d.docs.live.net/d8e9bd0bebfa4803/Somers%20lab%202020/Gene%20exp/[2022-5-20 LD 50umol zt1_4.xls]Sheet1'!$R$42,'https://d.docs.live.net/d8e9bd0bebfa4803/Somers%20lab%202020/Gene%20exp/[2022-5-20 LD 50umol zt1_4.xls]Sheet1'!$R$54,'https://d.docs.live.net/d8e9bd0bebfa4803/Somers%20lab%202020/Gene%20exp/[2022-5-20 LD 50umol zt1_4.xls]Sheet1'!$R$66,'https://d.docs.live.net/d8e9bd0bebfa4803/Somers%20lab%202020/Gene%20exp/[2022-5-20 LD 50umol zt1_4.xls]Sheet1'!$R$78,'https://d.docs.live.net/d8e9bd0bebfa4803/Somers%20lab%202020/Gene%20exp/[2022-5-20 LD 50umol zt1_4.xls]Sheet1'!$R$90)</c:f>
                <c:numCache>
                  <c:formatCode>General</c:formatCode>
                  <c:ptCount val="8"/>
                  <c:pt idx="0">
                    <c:v>1.6711494154174956E-3</c:v>
                  </c:pt>
                  <c:pt idx="1">
                    <c:v>3.4239823222339486E-4</c:v>
                  </c:pt>
                  <c:pt idx="2">
                    <c:v>3.3453345234090786E-5</c:v>
                  </c:pt>
                  <c:pt idx="3">
                    <c:v>1.1419313349351219E-5</c:v>
                  </c:pt>
                  <c:pt idx="4">
                    <c:v>2.5922847437564695E-5</c:v>
                  </c:pt>
                  <c:pt idx="5">
                    <c:v>8.7421008766254177E-6</c:v>
                  </c:pt>
                  <c:pt idx="6">
                    <c:v>2.9557717703181104E-5</c:v>
                  </c:pt>
                  <c:pt idx="7">
                    <c:v>4.1717035631016856E-4</c:v>
                  </c:pt>
                </c:numCache>
              </c:numRef>
            </c:plus>
            <c:minus>
              <c:numRef>
                <c:f>('https://d.docs.live.net/d8e9bd0bebfa4803/Somers%20lab%202020/Gene%20exp/[2022-5-20 LD 50umol zt1_4.xls]Sheet1'!$R$6,'https://d.docs.live.net/d8e9bd0bebfa4803/Somers%20lab%202020/Gene%20exp/[2022-5-20 LD 50umol zt1_4.xls]Sheet1'!$R$18,'https://d.docs.live.net/d8e9bd0bebfa4803/Somers%20lab%202020/Gene%20exp/[2022-5-20 LD 50umol zt1_4.xls]Sheet1'!$R$30,'https://d.docs.live.net/d8e9bd0bebfa4803/Somers%20lab%202020/Gene%20exp/[2022-5-20 LD 50umol zt1_4.xls]Sheet1'!$R$42,'https://d.docs.live.net/d8e9bd0bebfa4803/Somers%20lab%202020/Gene%20exp/[2022-5-20 LD 50umol zt1_4.xls]Sheet1'!$R$54,'https://d.docs.live.net/d8e9bd0bebfa4803/Somers%20lab%202020/Gene%20exp/[2022-5-20 LD 50umol zt1_4.xls]Sheet1'!$R$66,'https://d.docs.live.net/d8e9bd0bebfa4803/Somers%20lab%202020/Gene%20exp/[2022-5-20 LD 50umol zt1_4.xls]Sheet1'!$R$78,'https://d.docs.live.net/d8e9bd0bebfa4803/Somers%20lab%202020/Gene%20exp/[2022-5-20 LD 50umol zt1_4.xls]Sheet1'!$R$90)</c:f>
                <c:numCache>
                  <c:formatCode>General</c:formatCode>
                  <c:ptCount val="8"/>
                  <c:pt idx="0">
                    <c:v>1.6711494154174956E-3</c:v>
                  </c:pt>
                  <c:pt idx="1">
                    <c:v>3.4239823222339486E-4</c:v>
                  </c:pt>
                  <c:pt idx="2">
                    <c:v>3.3453345234090786E-5</c:v>
                  </c:pt>
                  <c:pt idx="3">
                    <c:v>1.1419313349351219E-5</c:v>
                  </c:pt>
                  <c:pt idx="4">
                    <c:v>2.5922847437564695E-5</c:v>
                  </c:pt>
                  <c:pt idx="5">
                    <c:v>8.7421008766254177E-6</c:v>
                  </c:pt>
                  <c:pt idx="6">
                    <c:v>2.9557717703181104E-5</c:v>
                  </c:pt>
                  <c:pt idx="7">
                    <c:v>4.1717035631016856E-4</c:v>
                  </c:pt>
                </c:numCache>
              </c:numRef>
            </c:minus>
            <c:spPr>
              <a:ln w="3175">
                <a:solidFill>
                  <a:srgbClr val="808080"/>
                </a:solidFill>
                <a:prstDash val="solid"/>
              </a:ln>
            </c:spPr>
          </c:errBars>
          <c:cat>
            <c:numRef>
              <c:f>'[2022-10-26 fhy3 1 normalize.xls]Sheet1'!$A$2,'[2022-10-26 fhy3 1 normalize.xls]Sheet1'!$A$14,'[2022-10-26 fhy3 1 normalize.xls]Sheet1'!$A$26,'[2022-10-26 fhy3 1 normalize.xls]Sheet1'!$A$38,'[2022-10-26 fhy3 1 normalize.xls]Sheet1'!$A$50,'[2022-10-26 fhy3 1 normalize.xls]Sheet1'!$A$62,'[2022-10-26 fhy3 1 normalize.xls]Sheet1'!$A$74,'[2022-10-26 fhy3 1 normalize.xls]Sheet1'!$A$86</c:f>
              <c:numCache>
                <c:formatCode>General</c:formatCode>
                <c:ptCount val="8"/>
                <c:pt idx="0">
                  <c:v>1</c:v>
                </c:pt>
                <c:pt idx="1">
                  <c:v>4</c:v>
                </c:pt>
                <c:pt idx="2">
                  <c:v>7</c:v>
                </c:pt>
                <c:pt idx="3">
                  <c:v>10</c:v>
                </c:pt>
                <c:pt idx="4">
                  <c:v>13</c:v>
                </c:pt>
                <c:pt idx="5">
                  <c:v>16</c:v>
                </c:pt>
                <c:pt idx="6">
                  <c:v>19</c:v>
                </c:pt>
                <c:pt idx="7">
                  <c:v>22</c:v>
                </c:pt>
              </c:numCache>
            </c:numRef>
          </c:cat>
          <c:val>
            <c:numRef>
              <c:f>'[2022-10-26 fhy3 1 normalize.xls]Sheet1'!$Q$6,'[2022-10-26 fhy3 1 normalize.xls]Sheet1'!$Q$18,'[2022-10-26 fhy3 1 normalize.xls]Sheet1'!$Q$30,'[2022-10-26 fhy3 1 normalize.xls]Sheet1'!$Q$42,'[2022-10-26 fhy3 1 normalize.xls]Sheet1'!$Q$54,'[2022-10-26 fhy3 1 normalize.xls]Sheet1'!$Q$66,'[2022-10-26 fhy3 1 normalize.xls]Sheet1'!$Q$78,'[2022-10-26 fhy3 1 normalize.xls]Sheet1'!$Q$90</c:f>
              <c:numCache>
                <c:formatCode>#,##0.000000000000000</c:formatCode>
                <c:ptCount val="8"/>
                <c:pt idx="0">
                  <c:v>0.53982014002668299</c:v>
                </c:pt>
                <c:pt idx="1">
                  <c:v>1.6568870108980151E-2</c:v>
                </c:pt>
                <c:pt idx="2">
                  <c:v>1.5729700089550155E-3</c:v>
                </c:pt>
                <c:pt idx="3">
                  <c:v>2.5704058523832586E-3</c:v>
                </c:pt>
                <c:pt idx="4">
                  <c:v>6.5354502198231631E-3</c:v>
                </c:pt>
                <c:pt idx="5">
                  <c:v>5.852798973041469E-2</c:v>
                </c:pt>
                <c:pt idx="6">
                  <c:v>0.56153028388254245</c:v>
                </c:pt>
                <c:pt idx="7">
                  <c:v>1.25871357594626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B924-CA41-AA4E-818E625AF543}"/>
            </c:ext>
          </c:extLst>
        </c:ser>
        <c:ser>
          <c:idx val="3"/>
          <c:order val="3"/>
          <c:tx>
            <c:strRef>
              <c:f>'[2022-10-26 fhy3 1 normalize.xls]Sheet1'!$A$6</c:f>
              <c:strCache>
                <c:ptCount val="1"/>
                <c:pt idx="0">
                  <c:v>pTOC1:TOC1-GFP/fhy3toc1</c:v>
                </c:pt>
              </c:strCache>
            </c:strRef>
          </c:tx>
          <c:marker>
            <c:symbol val="triangle"/>
            <c:size val="5"/>
            <c:spPr>
              <a:noFill/>
              <a:ln w="12700">
                <a:solidFill>
                  <a:schemeClr val="accent4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('https://d.docs.live.net/d8e9bd0bebfa4803/Somers%20lab%202020/Gene%20exp/[2022-5-20 LD 50umol zt1_4.xls]Sheet1'!$R$8,'https://d.docs.live.net/d8e9bd0bebfa4803/Somers%20lab%202020/Gene%20exp/[2022-5-20 LD 50umol zt1_4.xls]Sheet1'!$R$20,'https://d.docs.live.net/d8e9bd0bebfa4803/Somers%20lab%202020/Gene%20exp/[2022-5-20 LD 50umol zt1_4.xls]Sheet1'!$R$32,'https://d.docs.live.net/d8e9bd0bebfa4803/Somers%20lab%202020/Gene%20exp/[2022-5-20 LD 50umol zt1_4.xls]Sheet1'!$R$44,'https://d.docs.live.net/d8e9bd0bebfa4803/Somers%20lab%202020/Gene%20exp/[2022-5-20 LD 50umol zt1_4.xls]Sheet1'!$R$56,'https://d.docs.live.net/d8e9bd0bebfa4803/Somers%20lab%202020/Gene%20exp/[2022-5-20 LD 50umol zt1_4.xls]Sheet1'!$R$68,'https://d.docs.live.net/d8e9bd0bebfa4803/Somers%20lab%202020/Gene%20exp/[2022-5-20 LD 50umol zt1_4.xls]Sheet1'!$R$80,'https://d.docs.live.net/d8e9bd0bebfa4803/Somers%20lab%202020/Gene%20exp/[2022-5-20 LD 50umol zt1_4.xls]Sheet1'!$R$92)</c:f>
                <c:numCache>
                  <c:formatCode>General</c:formatCode>
                  <c:ptCount val="8"/>
                  <c:pt idx="0">
                    <c:v>7.1368649051913719E-4</c:v>
                  </c:pt>
                  <c:pt idx="1">
                    <c:v>8.4556121959700539E-5</c:v>
                  </c:pt>
                  <c:pt idx="2">
                    <c:v>2.8724777144461998E-5</c:v>
                  </c:pt>
                  <c:pt idx="3">
                    <c:v>1.872409192152744E-5</c:v>
                  </c:pt>
                  <c:pt idx="4">
                    <c:v>3.8739722899234569E-5</c:v>
                  </c:pt>
                  <c:pt idx="5">
                    <c:v>5.4239551982321701E-5</c:v>
                  </c:pt>
                  <c:pt idx="6">
                    <c:v>3.0096859066720908E-4</c:v>
                  </c:pt>
                  <c:pt idx="7">
                    <c:v>1.795674132601503E-4</c:v>
                  </c:pt>
                </c:numCache>
              </c:numRef>
            </c:plus>
            <c:minus>
              <c:numRef>
                <c:f>('https://d.docs.live.net/d8e9bd0bebfa4803/Somers%20lab%202020/Gene%20exp/[2022-5-20 LD 50umol zt1_4.xls]Sheet1'!$R$8,'https://d.docs.live.net/d8e9bd0bebfa4803/Somers%20lab%202020/Gene%20exp/[2022-5-20 LD 50umol zt1_4.xls]Sheet1'!$R$20,'https://d.docs.live.net/d8e9bd0bebfa4803/Somers%20lab%202020/Gene%20exp/[2022-5-20 LD 50umol zt1_4.xls]Sheet1'!$R$32,'https://d.docs.live.net/d8e9bd0bebfa4803/Somers%20lab%202020/Gene%20exp/[2022-5-20 LD 50umol zt1_4.xls]Sheet1'!$R$44,'https://d.docs.live.net/d8e9bd0bebfa4803/Somers%20lab%202020/Gene%20exp/[2022-5-20 LD 50umol zt1_4.xls]Sheet1'!$R$56,'https://d.docs.live.net/d8e9bd0bebfa4803/Somers%20lab%202020/Gene%20exp/[2022-5-20 LD 50umol zt1_4.xls]Sheet1'!$R$68,'https://d.docs.live.net/d8e9bd0bebfa4803/Somers%20lab%202020/Gene%20exp/[2022-5-20 LD 50umol zt1_4.xls]Sheet1'!$R$80,'https://d.docs.live.net/d8e9bd0bebfa4803/Somers%20lab%202020/Gene%20exp/[2022-5-20 LD 50umol zt1_4.xls]Sheet1'!$R$92)</c:f>
                <c:numCache>
                  <c:formatCode>General</c:formatCode>
                  <c:ptCount val="8"/>
                  <c:pt idx="0">
                    <c:v>7.1368649051913719E-4</c:v>
                  </c:pt>
                  <c:pt idx="1">
                    <c:v>8.4556121959700539E-5</c:v>
                  </c:pt>
                  <c:pt idx="2">
                    <c:v>2.8724777144461998E-5</c:v>
                  </c:pt>
                  <c:pt idx="3">
                    <c:v>1.872409192152744E-5</c:v>
                  </c:pt>
                  <c:pt idx="4">
                    <c:v>3.8739722899234569E-5</c:v>
                  </c:pt>
                  <c:pt idx="5">
                    <c:v>5.4239551982321701E-5</c:v>
                  </c:pt>
                  <c:pt idx="6">
                    <c:v>3.0096859066720908E-4</c:v>
                  </c:pt>
                  <c:pt idx="7">
                    <c:v>1.795674132601503E-4</c:v>
                  </c:pt>
                </c:numCache>
              </c:numRef>
            </c:minus>
            <c:spPr>
              <a:ln w="3175">
                <a:solidFill>
                  <a:srgbClr val="FFCC00"/>
                </a:solidFill>
                <a:prstDash val="solid"/>
              </a:ln>
            </c:spPr>
          </c:errBars>
          <c:cat>
            <c:numRef>
              <c:f>'[2022-10-26 fhy3 1 normalize.xls]Sheet1'!$A$2,'[2022-10-26 fhy3 1 normalize.xls]Sheet1'!$A$14,'[2022-10-26 fhy3 1 normalize.xls]Sheet1'!$A$26,'[2022-10-26 fhy3 1 normalize.xls]Sheet1'!$A$38,'[2022-10-26 fhy3 1 normalize.xls]Sheet1'!$A$50,'[2022-10-26 fhy3 1 normalize.xls]Sheet1'!$A$62,'[2022-10-26 fhy3 1 normalize.xls]Sheet1'!$A$74,'[2022-10-26 fhy3 1 normalize.xls]Sheet1'!$A$86</c:f>
              <c:numCache>
                <c:formatCode>General</c:formatCode>
                <c:ptCount val="8"/>
                <c:pt idx="0">
                  <c:v>1</c:v>
                </c:pt>
                <c:pt idx="1">
                  <c:v>4</c:v>
                </c:pt>
                <c:pt idx="2">
                  <c:v>7</c:v>
                </c:pt>
                <c:pt idx="3">
                  <c:v>10</c:v>
                </c:pt>
                <c:pt idx="4">
                  <c:v>13</c:v>
                </c:pt>
                <c:pt idx="5">
                  <c:v>16</c:v>
                </c:pt>
                <c:pt idx="6">
                  <c:v>19</c:v>
                </c:pt>
                <c:pt idx="7">
                  <c:v>22</c:v>
                </c:pt>
              </c:numCache>
            </c:numRef>
          </c:cat>
          <c:val>
            <c:numRef>
              <c:f>'[2022-10-26 fhy3 1 normalize.xls]Sheet1'!$Q$8,'[2022-10-26 fhy3 1 normalize.xls]Sheet1'!$Q$20,'[2022-10-26 fhy3 1 normalize.xls]Sheet1'!$Q$32,'[2022-10-26 fhy3 1 normalize.xls]Sheet1'!$Q$44,'[2022-10-26 fhy3 1 normalize.xls]Sheet1'!$Q$56,'[2022-10-26 fhy3 1 normalize.xls]Sheet1'!$Q$68,'[2022-10-26 fhy3 1 normalize.xls]Sheet1'!$Q$80,'[2022-10-26 fhy3 1 normalize.xls]Sheet1'!$Q$92</c:f>
              <c:numCache>
                <c:formatCode>#,##0.000000000000000</c:formatCode>
                <c:ptCount val="8"/>
                <c:pt idx="0">
                  <c:v>0.68103044903694532</c:v>
                </c:pt>
                <c:pt idx="1">
                  <c:v>4.9095976355563301E-2</c:v>
                </c:pt>
                <c:pt idx="2">
                  <c:v>6.763913795635422E-3</c:v>
                </c:pt>
                <c:pt idx="3">
                  <c:v>2.0409502722689181E-3</c:v>
                </c:pt>
                <c:pt idx="4">
                  <c:v>2.832391098134374E-3</c:v>
                </c:pt>
                <c:pt idx="5">
                  <c:v>1.3228768279980842E-2</c:v>
                </c:pt>
                <c:pt idx="6">
                  <c:v>0.19014965974098785</c:v>
                </c:pt>
                <c:pt idx="7">
                  <c:v>2.061555515138253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B924-CA41-AA4E-818E625AF543}"/>
            </c:ext>
          </c:extLst>
        </c:ser>
        <c:ser>
          <c:idx val="4"/>
          <c:order val="4"/>
          <c:tx>
            <c:strRef>
              <c:f>'[2022-10-26 fhy3 1 normalize.xls]Sheet1'!$A$7</c:f>
              <c:strCache>
                <c:ptCount val="1"/>
                <c:pt idx="0">
                  <c:v>pTOC1:5X-GFP/fhy3toc1</c:v>
                </c:pt>
              </c:strCache>
            </c:strRef>
          </c:tx>
          <c:spPr>
            <a:ln>
              <a:solidFill>
                <a:schemeClr val="accent6"/>
              </a:solidFill>
            </a:ln>
          </c:spPr>
          <c:marker>
            <c:symbol val="triangle"/>
            <c:size val="5"/>
            <c:spPr>
              <a:noFill/>
              <a:ln w="12700">
                <a:solidFill>
                  <a:schemeClr val="accent6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('https://d.docs.live.net/d8e9bd0bebfa4803/Somers%20lab%202020/Gene%20exp/[2022-5-20 LD 50umol zt1_4.xls]Sheet1'!$R$10,'https://d.docs.live.net/d8e9bd0bebfa4803/Somers%20lab%202020/Gene%20exp/[2022-5-20 LD 50umol zt1_4.xls]Sheet1'!$R$22,'https://d.docs.live.net/d8e9bd0bebfa4803/Somers%20lab%202020/Gene%20exp/[2022-5-20 LD 50umol zt1_4.xls]Sheet1'!$R$34,'https://d.docs.live.net/d8e9bd0bebfa4803/Somers%20lab%202020/Gene%20exp/[2022-5-20 LD 50umol zt1_4.xls]Sheet1'!$R$46,'https://d.docs.live.net/d8e9bd0bebfa4803/Somers%20lab%202020/Gene%20exp/[2022-5-20 LD 50umol zt1_4.xls]Sheet1'!$R$58,'https://d.docs.live.net/d8e9bd0bebfa4803/Somers%20lab%202020/Gene%20exp/[2022-5-20 LD 50umol zt1_4.xls]Sheet1'!$R$70,'https://d.docs.live.net/d8e9bd0bebfa4803/Somers%20lab%202020/Gene%20exp/[2022-5-20 LD 50umol zt1_4.xls]Sheet1'!$R$82,'https://d.docs.live.net/d8e9bd0bebfa4803/Somers%20lab%202020/Gene%20exp/[2022-5-20 LD 50umol zt1_4.xls]Sheet1'!$R$94)</c:f>
                <c:numCache>
                  <c:formatCode>General</c:formatCode>
                  <c:ptCount val="8"/>
                  <c:pt idx="0">
                    <c:v>6.6269055305497027E-4</c:v>
                  </c:pt>
                  <c:pt idx="1">
                    <c:v>5.2689885566768214E-5</c:v>
                  </c:pt>
                  <c:pt idx="2">
                    <c:v>2.8692939196963771E-5</c:v>
                  </c:pt>
                  <c:pt idx="3">
                    <c:v>1.6007641066423216E-4</c:v>
                  </c:pt>
                  <c:pt idx="4">
                    <c:v>1.9351247922499531E-5</c:v>
                  </c:pt>
                  <c:pt idx="5">
                    <c:v>1.3141067385505286E-5</c:v>
                  </c:pt>
                  <c:pt idx="6">
                    <c:v>1.1331008655563954E-5</c:v>
                  </c:pt>
                  <c:pt idx="7">
                    <c:v>8.3324555156683011E-4</c:v>
                  </c:pt>
                </c:numCache>
              </c:numRef>
            </c:plus>
            <c:minus>
              <c:numRef>
                <c:f>('https://d.docs.live.net/d8e9bd0bebfa4803/Somers%20lab%202020/Gene%20exp/[2022-5-20 LD 50umol zt1_4.xls]Sheet1'!$R$10,'https://d.docs.live.net/d8e9bd0bebfa4803/Somers%20lab%202020/Gene%20exp/[2022-5-20 LD 50umol zt1_4.xls]Sheet1'!$R$22,'https://d.docs.live.net/d8e9bd0bebfa4803/Somers%20lab%202020/Gene%20exp/[2022-5-20 LD 50umol zt1_4.xls]Sheet1'!$R$34,'https://d.docs.live.net/d8e9bd0bebfa4803/Somers%20lab%202020/Gene%20exp/[2022-5-20 LD 50umol zt1_4.xls]Sheet1'!$R$46,'https://d.docs.live.net/d8e9bd0bebfa4803/Somers%20lab%202020/Gene%20exp/[2022-5-20 LD 50umol zt1_4.xls]Sheet1'!$R$58,'https://d.docs.live.net/d8e9bd0bebfa4803/Somers%20lab%202020/Gene%20exp/[2022-5-20 LD 50umol zt1_4.xls]Sheet1'!$R$70,'https://d.docs.live.net/d8e9bd0bebfa4803/Somers%20lab%202020/Gene%20exp/[2022-5-20 LD 50umol zt1_4.xls]Sheet1'!$R$82,'https://d.docs.live.net/d8e9bd0bebfa4803/Somers%20lab%202020/Gene%20exp/[2022-5-20 LD 50umol zt1_4.xls]Sheet1'!$R$94)</c:f>
                <c:numCache>
                  <c:formatCode>General</c:formatCode>
                  <c:ptCount val="8"/>
                  <c:pt idx="0">
                    <c:v>6.6269055305497027E-4</c:v>
                  </c:pt>
                  <c:pt idx="1">
                    <c:v>5.2689885566768214E-5</c:v>
                  </c:pt>
                  <c:pt idx="2">
                    <c:v>2.8692939196963771E-5</c:v>
                  </c:pt>
                  <c:pt idx="3">
                    <c:v>1.6007641066423216E-4</c:v>
                  </c:pt>
                  <c:pt idx="4">
                    <c:v>1.9351247922499531E-5</c:v>
                  </c:pt>
                  <c:pt idx="5">
                    <c:v>1.3141067385505286E-5</c:v>
                  </c:pt>
                  <c:pt idx="6">
                    <c:v>1.1331008655563954E-5</c:v>
                  </c:pt>
                  <c:pt idx="7">
                    <c:v>8.3324555156683011E-4</c:v>
                  </c:pt>
                </c:numCache>
              </c:numRef>
            </c:minus>
            <c:spPr>
              <a:ln w="3175">
                <a:solidFill>
                  <a:srgbClr val="666699"/>
                </a:solidFill>
                <a:prstDash val="solid"/>
              </a:ln>
            </c:spPr>
          </c:errBars>
          <c:cat>
            <c:numRef>
              <c:f>'[2022-10-26 fhy3 1 normalize.xls]Sheet1'!$A$2,'[2022-10-26 fhy3 1 normalize.xls]Sheet1'!$A$14,'[2022-10-26 fhy3 1 normalize.xls]Sheet1'!$A$26,'[2022-10-26 fhy3 1 normalize.xls]Sheet1'!$A$38,'[2022-10-26 fhy3 1 normalize.xls]Sheet1'!$A$50,'[2022-10-26 fhy3 1 normalize.xls]Sheet1'!$A$62,'[2022-10-26 fhy3 1 normalize.xls]Sheet1'!$A$74,'[2022-10-26 fhy3 1 normalize.xls]Sheet1'!$A$86</c:f>
              <c:numCache>
                <c:formatCode>General</c:formatCode>
                <c:ptCount val="8"/>
                <c:pt idx="0">
                  <c:v>1</c:v>
                </c:pt>
                <c:pt idx="1">
                  <c:v>4</c:v>
                </c:pt>
                <c:pt idx="2">
                  <c:v>7</c:v>
                </c:pt>
                <c:pt idx="3">
                  <c:v>10</c:v>
                </c:pt>
                <c:pt idx="4">
                  <c:v>13</c:v>
                </c:pt>
                <c:pt idx="5">
                  <c:v>16</c:v>
                </c:pt>
                <c:pt idx="6">
                  <c:v>19</c:v>
                </c:pt>
                <c:pt idx="7">
                  <c:v>22</c:v>
                </c:pt>
              </c:numCache>
            </c:numRef>
          </c:cat>
          <c:val>
            <c:numRef>
              <c:f>'[2022-10-26 fhy3 1 normalize.xls]Sheet1'!$Q$10,'[2022-10-26 fhy3 1 normalize.xls]Sheet1'!$Q$22,'[2022-10-26 fhy3 1 normalize.xls]Sheet1'!$Q$34,'[2022-10-26 fhy3 1 normalize.xls]Sheet1'!$Q$46,'[2022-10-26 fhy3 1 normalize.xls]Sheet1'!$Q$58,'[2022-10-26 fhy3 1 normalize.xls]Sheet1'!$Q$70,'[2022-10-26 fhy3 1 normalize.xls]Sheet1'!$Q$82,'[2022-10-26 fhy3 1 normalize.xls]Sheet1'!$Q$94</c:f>
              <c:numCache>
                <c:formatCode>#,##0.000000000000000</c:formatCode>
                <c:ptCount val="8"/>
                <c:pt idx="0">
                  <c:v>0.69584367010858417</c:v>
                </c:pt>
                <c:pt idx="1">
                  <c:v>3.4532819451431815E-2</c:v>
                </c:pt>
                <c:pt idx="2">
                  <c:v>2.4823780336563047E-3</c:v>
                </c:pt>
                <c:pt idx="3">
                  <c:v>2.5579521476239526E-3</c:v>
                </c:pt>
                <c:pt idx="4">
                  <c:v>3.1520420139168753E-3</c:v>
                </c:pt>
                <c:pt idx="5">
                  <c:v>2.3172971720289148E-2</c:v>
                </c:pt>
                <c:pt idx="6">
                  <c:v>0.22714570384613442</c:v>
                </c:pt>
                <c:pt idx="7">
                  <c:v>2.482541608896830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B924-CA41-AA4E-818E625AF54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888440351"/>
        <c:axId val="1"/>
      </c:lineChart>
      <c:catAx>
        <c:axId val="1888440351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1"/>
        <c:crosses val="autoZero"/>
        <c:auto val="1"/>
        <c:lblAlgn val="ctr"/>
        <c:lblOffset val="100"/>
        <c:noMultiLvlLbl val="0"/>
      </c:catAx>
      <c:valAx>
        <c:axId val="1"/>
        <c:scaling>
          <c:orientation val="minMax"/>
          <c:max val="2.8"/>
          <c:min val="0.4"/>
        </c:scaling>
        <c:delete val="0"/>
        <c:axPos val="l"/>
        <c:numFmt formatCode="#,##0.0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0" vert="horz"/>
          <a:lstStyle/>
          <a:p>
            <a:pPr>
              <a:defRPr sz="1050" b="0" i="0" u="none" strike="noStrike" baseline="0">
                <a:solidFill>
                  <a:srgbClr val="000000"/>
                </a:solidFill>
                <a:latin typeface="Calibri"/>
                <a:ea typeface="Calibri"/>
                <a:cs typeface="Calibri"/>
              </a:defRPr>
            </a:pPr>
            <a:endParaRPr lang="en-US"/>
          </a:p>
        </c:txPr>
        <c:crossAx val="1888440351"/>
        <c:crosses val="autoZero"/>
        <c:crossBetween val="between"/>
        <c:majorUnit val="0.8"/>
      </c:valAx>
      <c:spPr>
        <a:noFill/>
        <a:ln w="25400">
          <a:noFill/>
        </a:ln>
      </c:spPr>
    </c:plotArea>
    <c:legend>
      <c:legendPos val="r"/>
      <c:legendEntry>
        <c:idx val="1"/>
        <c:txPr>
          <a:bodyPr/>
          <a:lstStyle/>
          <a:p>
            <a:pPr>
              <a:defRPr sz="885" b="0" i="1" u="none" strike="noStrike" baseline="0">
                <a:solidFill>
                  <a:srgbClr val="000000"/>
                </a:solidFill>
                <a:latin typeface="Calibri"/>
                <a:ea typeface="Calibri"/>
                <a:cs typeface="Calibri"/>
              </a:defRPr>
            </a:pPr>
            <a:endParaRPr lang="en-US"/>
          </a:p>
        </c:txPr>
      </c:legendEntry>
      <c:legendEntry>
        <c:idx val="2"/>
        <c:txPr>
          <a:bodyPr/>
          <a:lstStyle/>
          <a:p>
            <a:pPr>
              <a:defRPr sz="885" b="0" i="1" u="none" strike="noStrike" baseline="0">
                <a:solidFill>
                  <a:srgbClr val="000000"/>
                </a:solidFill>
                <a:latin typeface="Calibri"/>
                <a:ea typeface="Calibri"/>
                <a:cs typeface="Calibri"/>
              </a:defRPr>
            </a:pPr>
            <a:endParaRPr lang="en-US"/>
          </a:p>
        </c:txPr>
      </c:legendEntry>
      <c:legendEntry>
        <c:idx val="3"/>
        <c:txPr>
          <a:bodyPr/>
          <a:lstStyle/>
          <a:p>
            <a:pPr>
              <a:defRPr sz="885" b="0" i="1" u="none" strike="noStrike" baseline="0">
                <a:solidFill>
                  <a:srgbClr val="000000"/>
                </a:solidFill>
                <a:latin typeface="Calibri"/>
                <a:ea typeface="Calibri"/>
                <a:cs typeface="Calibri"/>
              </a:defRPr>
            </a:pPr>
            <a:endParaRPr lang="en-US"/>
          </a:p>
        </c:txPr>
      </c:legendEntry>
      <c:legendEntry>
        <c:idx val="4"/>
        <c:txPr>
          <a:bodyPr/>
          <a:lstStyle/>
          <a:p>
            <a:pPr>
              <a:defRPr sz="885" b="0" i="1" u="none" strike="noStrike" baseline="0">
                <a:solidFill>
                  <a:srgbClr val="000000"/>
                </a:solidFill>
                <a:latin typeface="Calibri"/>
                <a:ea typeface="Calibri"/>
                <a:cs typeface="Calibri"/>
              </a:defRPr>
            </a:pPr>
            <a:endParaRPr lang="en-US"/>
          </a:p>
        </c:txPr>
      </c:legendEntry>
      <c:layout>
        <c:manualLayout>
          <c:xMode val="edge"/>
          <c:yMode val="edge"/>
          <c:x val="0.22560342915334017"/>
          <c:y val="0.21851201348434751"/>
          <c:w val="0.59955569403494535"/>
          <c:h val="0.54456131531082064"/>
        </c:manualLayout>
      </c:layout>
      <c:overlay val="0"/>
      <c:spPr>
        <a:noFill/>
        <a:ln w="25400">
          <a:noFill/>
        </a:ln>
      </c:spPr>
      <c:txPr>
        <a:bodyPr/>
        <a:lstStyle/>
        <a:p>
          <a:pPr>
            <a:defRPr sz="885" b="0" i="0" u="none" strike="noStrike" baseline="0">
              <a:solidFill>
                <a:srgbClr val="000000"/>
              </a:solidFill>
              <a:latin typeface="Calibri"/>
              <a:ea typeface="Calibri"/>
              <a:cs typeface="Calibri"/>
            </a:defRPr>
          </a:pPr>
          <a:endParaRPr lang="en-US"/>
        </a:p>
      </c:txPr>
    </c:legend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1050" b="0" i="0" u="none" strike="noStrike" baseline="0">
          <a:solidFill>
            <a:srgbClr val="000000"/>
          </a:solidFill>
          <a:latin typeface="Calibri"/>
          <a:ea typeface="Calibri"/>
          <a:cs typeface="Calibri"/>
        </a:defRPr>
      </a:pPr>
      <a:endParaRPr lang="en-US"/>
    </a:p>
  </c:txPr>
  <c:externalData r:id="rId1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0915462973897631"/>
          <c:y val="0.12642179423722386"/>
          <c:w val="0.88194448581447826"/>
          <c:h val="0.58726704938571728"/>
        </c:manualLayout>
      </c:layout>
      <c:lineChart>
        <c:grouping val="standard"/>
        <c:varyColors val="0"/>
        <c:ser>
          <c:idx val="0"/>
          <c:order val="0"/>
          <c:tx>
            <c:strRef>
              <c:f>'[2022-10-26 fhy3 1 normalize.xls]Sheet1'!$A$3</c:f>
              <c:strCache>
                <c:ptCount val="1"/>
                <c:pt idx="0">
                  <c:v>Col-0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noFill/>
              <a:ln w="12700">
                <a:solidFill>
                  <a:schemeClr val="accent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('https://d.docs.live.net/d8e9bd0bebfa4803/Somers%20lab%202020/Gene%20exp/[2022-5-20 LD 50umol zt1_4.xls]Sheet1'!$R$2,'https://d.docs.live.net/d8e9bd0bebfa4803/Somers%20lab%202020/Gene%20exp/[2022-5-20 LD 50umol zt1_4.xls]Sheet1'!$R$14,'https://d.docs.live.net/d8e9bd0bebfa4803/Somers%20lab%202020/Gene%20exp/[2022-5-20 LD 50umol zt1_4.xls]Sheet1'!$R$26,'https://d.docs.live.net/d8e9bd0bebfa4803/Somers%20lab%202020/Gene%20exp/[2022-5-20 LD 50umol zt1_4.xls]Sheet1'!$R$38,'https://d.docs.live.net/d8e9bd0bebfa4803/Somers%20lab%202020/Gene%20exp/[2022-5-20 LD 50umol zt1_4.xls]Sheet1'!$R$50,'https://d.docs.live.net/d8e9bd0bebfa4803/Somers%20lab%202020/Gene%20exp/[2022-5-20 LD 50umol zt1_4.xls]Sheet1'!$R$62,'https://d.docs.live.net/d8e9bd0bebfa4803/Somers%20lab%202020/Gene%20exp/[2022-5-20 LD 50umol zt1_4.xls]Sheet1'!$R$74,'https://d.docs.live.net/d8e9bd0bebfa4803/Somers%20lab%202020/Gene%20exp/[2022-5-20 LD 50umol zt1_4.xls]Sheet1'!$R$86)</c:f>
                <c:numCache>
                  <c:formatCode>General</c:formatCode>
                  <c:ptCount val="8"/>
                  <c:pt idx="0">
                    <c:v>1.1984750978864117E-3</c:v>
                  </c:pt>
                  <c:pt idx="1">
                    <c:v>2.7225390690862027E-4</c:v>
                  </c:pt>
                  <c:pt idx="2">
                    <c:v>1.5498486049229178E-5</c:v>
                  </c:pt>
                  <c:pt idx="3">
                    <c:v>9.7521281457490131E-5</c:v>
                  </c:pt>
                  <c:pt idx="4">
                    <c:v>2.0289726358196811E-5</c:v>
                  </c:pt>
                  <c:pt idx="5">
                    <c:v>3.2967670795421987E-5</c:v>
                  </c:pt>
                  <c:pt idx="6">
                    <c:v>3.9623006470999866E-5</c:v>
                  </c:pt>
                  <c:pt idx="7">
                    <c:v>8.0455474881991121E-4</c:v>
                  </c:pt>
                </c:numCache>
              </c:numRef>
            </c:plus>
            <c:minus>
              <c:numRef>
                <c:f>('https://d.docs.live.net/d8e9bd0bebfa4803/Somers%20lab%202020/Gene%20exp/[2022-5-20 LD 50umol zt1_4.xls]Sheet1'!$R$2,'https://d.docs.live.net/d8e9bd0bebfa4803/Somers%20lab%202020/Gene%20exp/[2022-5-20 LD 50umol zt1_4.xls]Sheet1'!$R$14,'https://d.docs.live.net/d8e9bd0bebfa4803/Somers%20lab%202020/Gene%20exp/[2022-5-20 LD 50umol zt1_4.xls]Sheet1'!$R$26,'https://d.docs.live.net/d8e9bd0bebfa4803/Somers%20lab%202020/Gene%20exp/[2022-5-20 LD 50umol zt1_4.xls]Sheet1'!$R$38,'https://d.docs.live.net/d8e9bd0bebfa4803/Somers%20lab%202020/Gene%20exp/[2022-5-20 LD 50umol zt1_4.xls]Sheet1'!$R$50,'https://d.docs.live.net/d8e9bd0bebfa4803/Somers%20lab%202020/Gene%20exp/[2022-5-20 LD 50umol zt1_4.xls]Sheet1'!$R$62,'https://d.docs.live.net/d8e9bd0bebfa4803/Somers%20lab%202020/Gene%20exp/[2022-5-20 LD 50umol zt1_4.xls]Sheet1'!$R$74,'https://d.docs.live.net/d8e9bd0bebfa4803/Somers%20lab%202020/Gene%20exp/[2022-5-20 LD 50umol zt1_4.xls]Sheet1'!$R$86)</c:f>
                <c:numCache>
                  <c:formatCode>General</c:formatCode>
                  <c:ptCount val="8"/>
                  <c:pt idx="0">
                    <c:v>1.1984750978864117E-3</c:v>
                  </c:pt>
                  <c:pt idx="1">
                    <c:v>2.7225390690862027E-4</c:v>
                  </c:pt>
                  <c:pt idx="2">
                    <c:v>1.5498486049229178E-5</c:v>
                  </c:pt>
                  <c:pt idx="3">
                    <c:v>9.7521281457490131E-5</c:v>
                  </c:pt>
                  <c:pt idx="4">
                    <c:v>2.0289726358196811E-5</c:v>
                  </c:pt>
                  <c:pt idx="5">
                    <c:v>3.2967670795421987E-5</c:v>
                  </c:pt>
                  <c:pt idx="6">
                    <c:v>3.9623006470999866E-5</c:v>
                  </c:pt>
                  <c:pt idx="7">
                    <c:v>8.0455474881991121E-4</c:v>
                  </c:pt>
                </c:numCache>
              </c:numRef>
            </c:minus>
            <c:spPr>
              <a:ln w="3175">
                <a:solidFill>
                  <a:srgbClr val="666699"/>
                </a:solidFill>
                <a:prstDash val="solid"/>
              </a:ln>
            </c:spPr>
          </c:errBars>
          <c:cat>
            <c:numRef>
              <c:f>'[2022-10-26 fhy3 1 normalize.xls]Sheet1'!$A$2,'[2022-10-26 fhy3 1 normalize.xls]Sheet1'!$A$14,'[2022-10-26 fhy3 1 normalize.xls]Sheet1'!$A$26,'[2022-10-26 fhy3 1 normalize.xls]Sheet1'!$A$38,'[2022-10-26 fhy3 1 normalize.xls]Sheet1'!$A$50,'[2022-10-26 fhy3 1 normalize.xls]Sheet1'!$A$62,'[2022-10-26 fhy3 1 normalize.xls]Sheet1'!$A$74,'[2022-10-26 fhy3 1 normalize.xls]Sheet1'!$A$86</c:f>
              <c:numCache>
                <c:formatCode>General</c:formatCode>
                <c:ptCount val="8"/>
                <c:pt idx="0">
                  <c:v>1</c:v>
                </c:pt>
                <c:pt idx="1">
                  <c:v>4</c:v>
                </c:pt>
                <c:pt idx="2">
                  <c:v>7</c:v>
                </c:pt>
                <c:pt idx="3">
                  <c:v>10</c:v>
                </c:pt>
                <c:pt idx="4">
                  <c:v>13</c:v>
                </c:pt>
                <c:pt idx="5">
                  <c:v>16</c:v>
                </c:pt>
                <c:pt idx="6">
                  <c:v>19</c:v>
                </c:pt>
                <c:pt idx="7">
                  <c:v>22</c:v>
                </c:pt>
              </c:numCache>
            </c:numRef>
          </c:cat>
          <c:val>
            <c:numRef>
              <c:f>'[2022-10-26 fhy3 1 normalize.xls]Sheet1'!$Q$2,'[2022-10-26 fhy3 1 normalize.xls]Sheet1'!$Q$14,'[2022-10-26 fhy3 1 normalize.xls]Sheet1'!$Q$26,'[2022-10-26 fhy3 1 normalize.xls]Sheet1'!$Q$38,'[2022-10-26 fhy3 1 normalize.xls]Sheet1'!$Q$50,'[2022-10-26 fhy3 1 normalize.xls]Sheet1'!$Q$62,'[2022-10-26 fhy3 1 normalize.xls]Sheet1'!$Q$74,'[2022-10-26 fhy3 1 normalize.xls]Sheet1'!$Q$86</c:f>
              <c:numCache>
                <c:formatCode>#,##0.000000000000000</c:formatCode>
                <c:ptCount val="8"/>
                <c:pt idx="0">
                  <c:v>0.99999999999999978</c:v>
                </c:pt>
                <c:pt idx="1">
                  <c:v>6.2153110799117721E-2</c:v>
                </c:pt>
                <c:pt idx="2">
                  <c:v>8.3601091031872306E-3</c:v>
                </c:pt>
                <c:pt idx="3">
                  <c:v>2.2841138224417934E-3</c:v>
                </c:pt>
                <c:pt idx="4">
                  <c:v>4.2229968172506705E-3</c:v>
                </c:pt>
                <c:pt idx="5">
                  <c:v>2.7127246605896032E-2</c:v>
                </c:pt>
                <c:pt idx="6">
                  <c:v>0.44603767025788277</c:v>
                </c:pt>
                <c:pt idx="7">
                  <c:v>2.686021964173478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293F-0F49-939D-21E14E0639B8}"/>
            </c:ext>
          </c:extLst>
        </c:ser>
        <c:ser>
          <c:idx val="1"/>
          <c:order val="1"/>
          <c:tx>
            <c:strRef>
              <c:f>'[2022-10-26 fhy3 1 normalize.xls]Sheet1'!$A$4</c:f>
              <c:strCache>
                <c:ptCount val="1"/>
                <c:pt idx="0">
                  <c:v>fhy3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square"/>
            <c:size val="5"/>
            <c:spPr>
              <a:noFill/>
              <a:ln w="12700">
                <a:solidFill>
                  <a:schemeClr val="accent2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('https://d.docs.live.net/d8e9bd0bebfa4803/Somers%20lab%202020/Gene%20exp/[2022-5-20 LD 50umol zt1_4.xls]Sheet1'!$R$4,'https://d.docs.live.net/d8e9bd0bebfa4803/Somers%20lab%202020/Gene%20exp/[2022-5-20 LD 50umol zt1_4.xls]Sheet1'!$R$16,'https://d.docs.live.net/d8e9bd0bebfa4803/Somers%20lab%202020/Gene%20exp/[2022-5-20 LD 50umol zt1_4.xls]Sheet1'!$R$28,'https://d.docs.live.net/d8e9bd0bebfa4803/Somers%20lab%202020/Gene%20exp/[2022-5-20 LD 50umol zt1_4.xls]Sheet1'!$R$40,'https://d.docs.live.net/d8e9bd0bebfa4803/Somers%20lab%202020/Gene%20exp/[2022-5-20 LD 50umol zt1_4.xls]Sheet1'!$R$52,'https://d.docs.live.net/d8e9bd0bebfa4803/Somers%20lab%202020/Gene%20exp/[2022-5-20 LD 50umol zt1_4.xls]Sheet1'!$R$64,'https://d.docs.live.net/d8e9bd0bebfa4803/Somers%20lab%202020/Gene%20exp/[2022-5-20 LD 50umol zt1_4.xls]Sheet1'!$R$76,'https://d.docs.live.net/d8e9bd0bebfa4803/Somers%20lab%202020/Gene%20exp/[2022-5-20 LD 50umol zt1_4.xls]Sheet1'!$R$88)</c:f>
                <c:numCache>
                  <c:formatCode>General</c:formatCode>
                  <c:ptCount val="8"/>
                  <c:pt idx="0">
                    <c:v>2.0816157498584741E-3</c:v>
                  </c:pt>
                  <c:pt idx="1">
                    <c:v>9.4371261251063095E-5</c:v>
                  </c:pt>
                  <c:pt idx="2">
                    <c:v>7.5459654176112068E-6</c:v>
                  </c:pt>
                  <c:pt idx="3">
                    <c:v>7.269229894768513E-6</c:v>
                  </c:pt>
                  <c:pt idx="4">
                    <c:v>4.7632637712312237E-6</c:v>
                  </c:pt>
                  <c:pt idx="5">
                    <c:v>1.6551977786918946E-4</c:v>
                  </c:pt>
                  <c:pt idx="6">
                    <c:v>2.6305991397382006E-3</c:v>
                  </c:pt>
                  <c:pt idx="7">
                    <c:v>1.6221855587023879E-3</c:v>
                  </c:pt>
                </c:numCache>
              </c:numRef>
            </c:plus>
            <c:minus>
              <c:numRef>
                <c:f>('https://d.docs.live.net/d8e9bd0bebfa4803/Somers%20lab%202020/Gene%20exp/[2022-5-20 LD 50umol zt1_4.xls]Sheet1'!$R$4,'https://d.docs.live.net/d8e9bd0bebfa4803/Somers%20lab%202020/Gene%20exp/[2022-5-20 LD 50umol zt1_4.xls]Sheet1'!$R$16,'https://d.docs.live.net/d8e9bd0bebfa4803/Somers%20lab%202020/Gene%20exp/[2022-5-20 LD 50umol zt1_4.xls]Sheet1'!$R$28,'https://d.docs.live.net/d8e9bd0bebfa4803/Somers%20lab%202020/Gene%20exp/[2022-5-20 LD 50umol zt1_4.xls]Sheet1'!$R$40,'https://d.docs.live.net/d8e9bd0bebfa4803/Somers%20lab%202020/Gene%20exp/[2022-5-20 LD 50umol zt1_4.xls]Sheet1'!$R$52,'https://d.docs.live.net/d8e9bd0bebfa4803/Somers%20lab%202020/Gene%20exp/[2022-5-20 LD 50umol zt1_4.xls]Sheet1'!$R$64,'https://d.docs.live.net/d8e9bd0bebfa4803/Somers%20lab%202020/Gene%20exp/[2022-5-20 LD 50umol zt1_4.xls]Sheet1'!$R$76,'https://d.docs.live.net/d8e9bd0bebfa4803/Somers%20lab%202020/Gene%20exp/[2022-5-20 LD 50umol zt1_4.xls]Sheet1'!$R$88)</c:f>
                <c:numCache>
                  <c:formatCode>General</c:formatCode>
                  <c:ptCount val="8"/>
                  <c:pt idx="0">
                    <c:v>2.0816157498584741E-3</c:v>
                  </c:pt>
                  <c:pt idx="1">
                    <c:v>9.4371261251063095E-5</c:v>
                  </c:pt>
                  <c:pt idx="2">
                    <c:v>7.5459654176112068E-6</c:v>
                  </c:pt>
                  <c:pt idx="3">
                    <c:v>7.269229894768513E-6</c:v>
                  </c:pt>
                  <c:pt idx="4">
                    <c:v>4.7632637712312237E-6</c:v>
                  </c:pt>
                  <c:pt idx="5">
                    <c:v>1.6551977786918946E-4</c:v>
                  </c:pt>
                  <c:pt idx="6">
                    <c:v>2.6305991397382006E-3</c:v>
                  </c:pt>
                  <c:pt idx="7">
                    <c:v>1.6221855587023879E-3</c:v>
                  </c:pt>
                </c:numCache>
              </c:numRef>
            </c:minus>
            <c:spPr>
              <a:ln w="3175">
                <a:solidFill>
                  <a:srgbClr val="FF6600"/>
                </a:solidFill>
                <a:prstDash val="solid"/>
              </a:ln>
            </c:spPr>
          </c:errBars>
          <c:cat>
            <c:numRef>
              <c:f>'[2022-10-26 fhy3 1 normalize.xls]Sheet1'!$A$2,'[2022-10-26 fhy3 1 normalize.xls]Sheet1'!$A$14,'[2022-10-26 fhy3 1 normalize.xls]Sheet1'!$A$26,'[2022-10-26 fhy3 1 normalize.xls]Sheet1'!$A$38,'[2022-10-26 fhy3 1 normalize.xls]Sheet1'!$A$50,'[2022-10-26 fhy3 1 normalize.xls]Sheet1'!$A$62,'[2022-10-26 fhy3 1 normalize.xls]Sheet1'!$A$74,'[2022-10-26 fhy3 1 normalize.xls]Sheet1'!$A$86</c:f>
              <c:numCache>
                <c:formatCode>General</c:formatCode>
                <c:ptCount val="8"/>
                <c:pt idx="0">
                  <c:v>1</c:v>
                </c:pt>
                <c:pt idx="1">
                  <c:v>4</c:v>
                </c:pt>
                <c:pt idx="2">
                  <c:v>7</c:v>
                </c:pt>
                <c:pt idx="3">
                  <c:v>10</c:v>
                </c:pt>
                <c:pt idx="4">
                  <c:v>13</c:v>
                </c:pt>
                <c:pt idx="5">
                  <c:v>16</c:v>
                </c:pt>
                <c:pt idx="6">
                  <c:v>19</c:v>
                </c:pt>
                <c:pt idx="7">
                  <c:v>22</c:v>
                </c:pt>
              </c:numCache>
            </c:numRef>
          </c:cat>
          <c:val>
            <c:numRef>
              <c:f>'[2022-10-26 fhy3 1 normalize.xls]Sheet1'!$Q$4,'[2022-10-26 fhy3 1 normalize.xls]Sheet1'!$Q$16,'[2022-10-26 fhy3 1 normalize.xls]Sheet1'!$Q$28,'[2022-10-26 fhy3 1 normalize.xls]Sheet1'!$Q$40,'[2022-10-26 fhy3 1 normalize.xls]Sheet1'!$Q$52,'[2022-10-26 fhy3 1 normalize.xls]Sheet1'!$Q$64,'[2022-10-26 fhy3 1 normalize.xls]Sheet1'!$Q$76,'[2022-10-26 fhy3 1 normalize.xls]Sheet1'!$Q$88</c:f>
              <c:numCache>
                <c:formatCode>#,##0.000000000000000</c:formatCode>
                <c:ptCount val="8"/>
                <c:pt idx="0">
                  <c:v>0.77674313017504604</c:v>
                </c:pt>
                <c:pt idx="1">
                  <c:v>4.8243330733435189E-2</c:v>
                </c:pt>
                <c:pt idx="2">
                  <c:v>3.6206655799088097E-3</c:v>
                </c:pt>
                <c:pt idx="3">
                  <c:v>3.0656501377497249E-3</c:v>
                </c:pt>
                <c:pt idx="4">
                  <c:v>3.4547365592209481E-3</c:v>
                </c:pt>
                <c:pt idx="5">
                  <c:v>1.7834961226753068E-2</c:v>
                </c:pt>
                <c:pt idx="6">
                  <c:v>0.20268804317629882</c:v>
                </c:pt>
                <c:pt idx="7">
                  <c:v>2.44478341386713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293F-0F49-939D-21E14E0639B8}"/>
            </c:ext>
          </c:extLst>
        </c:ser>
        <c:ser>
          <c:idx val="2"/>
          <c:order val="2"/>
          <c:tx>
            <c:strRef>
              <c:f>'[2022-10-26 fhy3 1 normalize.xls]Sheet1'!$A$5</c:f>
              <c:strCache>
                <c:ptCount val="1"/>
                <c:pt idx="0">
                  <c:v>fhy3toc1</c:v>
                </c:pt>
              </c:strCache>
            </c:strRef>
          </c:tx>
          <c:spPr>
            <a:ln>
              <a:solidFill>
                <a:srgbClr val="7030A0"/>
              </a:solidFill>
            </a:ln>
          </c:spPr>
          <c:marker>
            <c:symbol val="square"/>
            <c:size val="5"/>
            <c:spPr>
              <a:noFill/>
              <a:ln w="12700">
                <a:solidFill>
                  <a:srgbClr val="7030A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('https://d.docs.live.net/d8e9bd0bebfa4803/Somers%20lab%202020/Gene%20exp/[2022-5-20 LD 50umol zt1_4.xls]Sheet1'!$R$6,'https://d.docs.live.net/d8e9bd0bebfa4803/Somers%20lab%202020/Gene%20exp/[2022-5-20 LD 50umol zt1_4.xls]Sheet1'!$R$18,'https://d.docs.live.net/d8e9bd0bebfa4803/Somers%20lab%202020/Gene%20exp/[2022-5-20 LD 50umol zt1_4.xls]Sheet1'!$R$30,'https://d.docs.live.net/d8e9bd0bebfa4803/Somers%20lab%202020/Gene%20exp/[2022-5-20 LD 50umol zt1_4.xls]Sheet1'!$R$42,'https://d.docs.live.net/d8e9bd0bebfa4803/Somers%20lab%202020/Gene%20exp/[2022-5-20 LD 50umol zt1_4.xls]Sheet1'!$R$54,'https://d.docs.live.net/d8e9bd0bebfa4803/Somers%20lab%202020/Gene%20exp/[2022-5-20 LD 50umol zt1_4.xls]Sheet1'!$R$66,'https://d.docs.live.net/d8e9bd0bebfa4803/Somers%20lab%202020/Gene%20exp/[2022-5-20 LD 50umol zt1_4.xls]Sheet1'!$R$78,'https://d.docs.live.net/d8e9bd0bebfa4803/Somers%20lab%202020/Gene%20exp/[2022-5-20 LD 50umol zt1_4.xls]Sheet1'!$R$90)</c:f>
                <c:numCache>
                  <c:formatCode>General</c:formatCode>
                  <c:ptCount val="8"/>
                  <c:pt idx="0">
                    <c:v>1.6711494154174956E-3</c:v>
                  </c:pt>
                  <c:pt idx="1">
                    <c:v>3.4239823222339486E-4</c:v>
                  </c:pt>
                  <c:pt idx="2">
                    <c:v>3.3453345234090786E-5</c:v>
                  </c:pt>
                  <c:pt idx="3">
                    <c:v>1.1419313349351219E-5</c:v>
                  </c:pt>
                  <c:pt idx="4">
                    <c:v>2.5922847437564695E-5</c:v>
                  </c:pt>
                  <c:pt idx="5">
                    <c:v>8.7421008766254177E-6</c:v>
                  </c:pt>
                  <c:pt idx="6">
                    <c:v>2.9557717703181104E-5</c:v>
                  </c:pt>
                  <c:pt idx="7">
                    <c:v>4.1717035631016856E-4</c:v>
                  </c:pt>
                </c:numCache>
              </c:numRef>
            </c:plus>
            <c:minus>
              <c:numRef>
                <c:f>('https://d.docs.live.net/d8e9bd0bebfa4803/Somers%20lab%202020/Gene%20exp/[2022-5-20 LD 50umol zt1_4.xls]Sheet1'!$R$6,'https://d.docs.live.net/d8e9bd0bebfa4803/Somers%20lab%202020/Gene%20exp/[2022-5-20 LD 50umol zt1_4.xls]Sheet1'!$R$18,'https://d.docs.live.net/d8e9bd0bebfa4803/Somers%20lab%202020/Gene%20exp/[2022-5-20 LD 50umol zt1_4.xls]Sheet1'!$R$30,'https://d.docs.live.net/d8e9bd0bebfa4803/Somers%20lab%202020/Gene%20exp/[2022-5-20 LD 50umol zt1_4.xls]Sheet1'!$R$42,'https://d.docs.live.net/d8e9bd0bebfa4803/Somers%20lab%202020/Gene%20exp/[2022-5-20 LD 50umol zt1_4.xls]Sheet1'!$R$54,'https://d.docs.live.net/d8e9bd0bebfa4803/Somers%20lab%202020/Gene%20exp/[2022-5-20 LD 50umol zt1_4.xls]Sheet1'!$R$66,'https://d.docs.live.net/d8e9bd0bebfa4803/Somers%20lab%202020/Gene%20exp/[2022-5-20 LD 50umol zt1_4.xls]Sheet1'!$R$78,'https://d.docs.live.net/d8e9bd0bebfa4803/Somers%20lab%202020/Gene%20exp/[2022-5-20 LD 50umol zt1_4.xls]Sheet1'!$R$90)</c:f>
                <c:numCache>
                  <c:formatCode>General</c:formatCode>
                  <c:ptCount val="8"/>
                  <c:pt idx="0">
                    <c:v>1.6711494154174956E-3</c:v>
                  </c:pt>
                  <c:pt idx="1">
                    <c:v>3.4239823222339486E-4</c:v>
                  </c:pt>
                  <c:pt idx="2">
                    <c:v>3.3453345234090786E-5</c:v>
                  </c:pt>
                  <c:pt idx="3">
                    <c:v>1.1419313349351219E-5</c:v>
                  </c:pt>
                  <c:pt idx="4">
                    <c:v>2.5922847437564695E-5</c:v>
                  </c:pt>
                  <c:pt idx="5">
                    <c:v>8.7421008766254177E-6</c:v>
                  </c:pt>
                  <c:pt idx="6">
                    <c:v>2.9557717703181104E-5</c:v>
                  </c:pt>
                  <c:pt idx="7">
                    <c:v>4.1717035631016856E-4</c:v>
                  </c:pt>
                </c:numCache>
              </c:numRef>
            </c:minus>
            <c:spPr>
              <a:ln w="3175">
                <a:solidFill>
                  <a:srgbClr val="808080"/>
                </a:solidFill>
                <a:prstDash val="solid"/>
              </a:ln>
            </c:spPr>
          </c:errBars>
          <c:cat>
            <c:numRef>
              <c:f>'[2022-10-26 fhy3 1 normalize.xls]Sheet1'!$A$2,'[2022-10-26 fhy3 1 normalize.xls]Sheet1'!$A$14,'[2022-10-26 fhy3 1 normalize.xls]Sheet1'!$A$26,'[2022-10-26 fhy3 1 normalize.xls]Sheet1'!$A$38,'[2022-10-26 fhy3 1 normalize.xls]Sheet1'!$A$50,'[2022-10-26 fhy3 1 normalize.xls]Sheet1'!$A$62,'[2022-10-26 fhy3 1 normalize.xls]Sheet1'!$A$74,'[2022-10-26 fhy3 1 normalize.xls]Sheet1'!$A$86</c:f>
              <c:numCache>
                <c:formatCode>General</c:formatCode>
                <c:ptCount val="8"/>
                <c:pt idx="0">
                  <c:v>1</c:v>
                </c:pt>
                <c:pt idx="1">
                  <c:v>4</c:v>
                </c:pt>
                <c:pt idx="2">
                  <c:v>7</c:v>
                </c:pt>
                <c:pt idx="3">
                  <c:v>10</c:v>
                </c:pt>
                <c:pt idx="4">
                  <c:v>13</c:v>
                </c:pt>
                <c:pt idx="5">
                  <c:v>16</c:v>
                </c:pt>
                <c:pt idx="6">
                  <c:v>19</c:v>
                </c:pt>
                <c:pt idx="7">
                  <c:v>22</c:v>
                </c:pt>
              </c:numCache>
            </c:numRef>
          </c:cat>
          <c:val>
            <c:numRef>
              <c:f>'[2022-10-26 fhy3 1 normalize.xls]Sheet1'!$Q$6,'[2022-10-26 fhy3 1 normalize.xls]Sheet1'!$Q$18,'[2022-10-26 fhy3 1 normalize.xls]Sheet1'!$Q$30,'[2022-10-26 fhy3 1 normalize.xls]Sheet1'!$Q$42,'[2022-10-26 fhy3 1 normalize.xls]Sheet1'!$Q$54,'[2022-10-26 fhy3 1 normalize.xls]Sheet1'!$Q$66,'[2022-10-26 fhy3 1 normalize.xls]Sheet1'!$Q$78,'[2022-10-26 fhy3 1 normalize.xls]Sheet1'!$Q$90</c:f>
              <c:numCache>
                <c:formatCode>#,##0.000000000000000</c:formatCode>
                <c:ptCount val="8"/>
                <c:pt idx="0">
                  <c:v>0.53982014002668299</c:v>
                </c:pt>
                <c:pt idx="1">
                  <c:v>1.6568870108980151E-2</c:v>
                </c:pt>
                <c:pt idx="2">
                  <c:v>1.5729700089550155E-3</c:v>
                </c:pt>
                <c:pt idx="3">
                  <c:v>2.5704058523832586E-3</c:v>
                </c:pt>
                <c:pt idx="4">
                  <c:v>6.5354502198231631E-3</c:v>
                </c:pt>
                <c:pt idx="5">
                  <c:v>5.852798973041469E-2</c:v>
                </c:pt>
                <c:pt idx="6">
                  <c:v>0.56153028388254245</c:v>
                </c:pt>
                <c:pt idx="7">
                  <c:v>1.25871357594626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293F-0F49-939D-21E14E0639B8}"/>
            </c:ext>
          </c:extLst>
        </c:ser>
        <c:ser>
          <c:idx val="3"/>
          <c:order val="3"/>
          <c:tx>
            <c:strRef>
              <c:f>'[2022-10-26 fhy3 1 normalize.xls]Sheet1'!$A$6</c:f>
              <c:strCache>
                <c:ptCount val="1"/>
                <c:pt idx="0">
                  <c:v>pTOC1:TOC1-GFP/fhy3toc1</c:v>
                </c:pt>
              </c:strCache>
            </c:strRef>
          </c:tx>
          <c:marker>
            <c:symbol val="triangle"/>
            <c:size val="5"/>
            <c:spPr>
              <a:noFill/>
              <a:ln w="12700">
                <a:solidFill>
                  <a:schemeClr val="accent4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('https://d.docs.live.net/d8e9bd0bebfa4803/Somers%20lab%202020/Gene%20exp/[2022-5-20 LD 50umol zt1_4.xls]Sheet1'!$R$8,'https://d.docs.live.net/d8e9bd0bebfa4803/Somers%20lab%202020/Gene%20exp/[2022-5-20 LD 50umol zt1_4.xls]Sheet1'!$R$20,'https://d.docs.live.net/d8e9bd0bebfa4803/Somers%20lab%202020/Gene%20exp/[2022-5-20 LD 50umol zt1_4.xls]Sheet1'!$R$32,'https://d.docs.live.net/d8e9bd0bebfa4803/Somers%20lab%202020/Gene%20exp/[2022-5-20 LD 50umol zt1_4.xls]Sheet1'!$R$44,'https://d.docs.live.net/d8e9bd0bebfa4803/Somers%20lab%202020/Gene%20exp/[2022-5-20 LD 50umol zt1_4.xls]Sheet1'!$R$56,'https://d.docs.live.net/d8e9bd0bebfa4803/Somers%20lab%202020/Gene%20exp/[2022-5-20 LD 50umol zt1_4.xls]Sheet1'!$R$68,'https://d.docs.live.net/d8e9bd0bebfa4803/Somers%20lab%202020/Gene%20exp/[2022-5-20 LD 50umol zt1_4.xls]Sheet1'!$R$80,'https://d.docs.live.net/d8e9bd0bebfa4803/Somers%20lab%202020/Gene%20exp/[2022-5-20 LD 50umol zt1_4.xls]Sheet1'!$R$92)</c:f>
                <c:numCache>
                  <c:formatCode>General</c:formatCode>
                  <c:ptCount val="8"/>
                  <c:pt idx="0">
                    <c:v>7.1368649051913719E-4</c:v>
                  </c:pt>
                  <c:pt idx="1">
                    <c:v>8.4556121959700539E-5</c:v>
                  </c:pt>
                  <c:pt idx="2">
                    <c:v>2.8724777144461998E-5</c:v>
                  </c:pt>
                  <c:pt idx="3">
                    <c:v>1.872409192152744E-5</c:v>
                  </c:pt>
                  <c:pt idx="4">
                    <c:v>3.8739722899234569E-5</c:v>
                  </c:pt>
                  <c:pt idx="5">
                    <c:v>5.4239551982321701E-5</c:v>
                  </c:pt>
                  <c:pt idx="6">
                    <c:v>3.0096859066720908E-4</c:v>
                  </c:pt>
                  <c:pt idx="7">
                    <c:v>1.795674132601503E-4</c:v>
                  </c:pt>
                </c:numCache>
              </c:numRef>
            </c:plus>
            <c:minus>
              <c:numRef>
                <c:f>('https://d.docs.live.net/d8e9bd0bebfa4803/Somers%20lab%202020/Gene%20exp/[2022-5-20 LD 50umol zt1_4.xls]Sheet1'!$R$8,'https://d.docs.live.net/d8e9bd0bebfa4803/Somers%20lab%202020/Gene%20exp/[2022-5-20 LD 50umol zt1_4.xls]Sheet1'!$R$20,'https://d.docs.live.net/d8e9bd0bebfa4803/Somers%20lab%202020/Gene%20exp/[2022-5-20 LD 50umol zt1_4.xls]Sheet1'!$R$32,'https://d.docs.live.net/d8e9bd0bebfa4803/Somers%20lab%202020/Gene%20exp/[2022-5-20 LD 50umol zt1_4.xls]Sheet1'!$R$44,'https://d.docs.live.net/d8e9bd0bebfa4803/Somers%20lab%202020/Gene%20exp/[2022-5-20 LD 50umol zt1_4.xls]Sheet1'!$R$56,'https://d.docs.live.net/d8e9bd0bebfa4803/Somers%20lab%202020/Gene%20exp/[2022-5-20 LD 50umol zt1_4.xls]Sheet1'!$R$68,'https://d.docs.live.net/d8e9bd0bebfa4803/Somers%20lab%202020/Gene%20exp/[2022-5-20 LD 50umol zt1_4.xls]Sheet1'!$R$80,'https://d.docs.live.net/d8e9bd0bebfa4803/Somers%20lab%202020/Gene%20exp/[2022-5-20 LD 50umol zt1_4.xls]Sheet1'!$R$92)</c:f>
                <c:numCache>
                  <c:formatCode>General</c:formatCode>
                  <c:ptCount val="8"/>
                  <c:pt idx="0">
                    <c:v>7.1368649051913719E-4</c:v>
                  </c:pt>
                  <c:pt idx="1">
                    <c:v>8.4556121959700539E-5</c:v>
                  </c:pt>
                  <c:pt idx="2">
                    <c:v>2.8724777144461998E-5</c:v>
                  </c:pt>
                  <c:pt idx="3">
                    <c:v>1.872409192152744E-5</c:v>
                  </c:pt>
                  <c:pt idx="4">
                    <c:v>3.8739722899234569E-5</c:v>
                  </c:pt>
                  <c:pt idx="5">
                    <c:v>5.4239551982321701E-5</c:v>
                  </c:pt>
                  <c:pt idx="6">
                    <c:v>3.0096859066720908E-4</c:v>
                  </c:pt>
                  <c:pt idx="7">
                    <c:v>1.795674132601503E-4</c:v>
                  </c:pt>
                </c:numCache>
              </c:numRef>
            </c:minus>
            <c:spPr>
              <a:ln w="3175">
                <a:solidFill>
                  <a:srgbClr val="FFCC00"/>
                </a:solidFill>
                <a:prstDash val="solid"/>
              </a:ln>
            </c:spPr>
          </c:errBars>
          <c:cat>
            <c:numRef>
              <c:f>'[2022-10-26 fhy3 1 normalize.xls]Sheet1'!$A$2,'[2022-10-26 fhy3 1 normalize.xls]Sheet1'!$A$14,'[2022-10-26 fhy3 1 normalize.xls]Sheet1'!$A$26,'[2022-10-26 fhy3 1 normalize.xls]Sheet1'!$A$38,'[2022-10-26 fhy3 1 normalize.xls]Sheet1'!$A$50,'[2022-10-26 fhy3 1 normalize.xls]Sheet1'!$A$62,'[2022-10-26 fhy3 1 normalize.xls]Sheet1'!$A$74,'[2022-10-26 fhy3 1 normalize.xls]Sheet1'!$A$86</c:f>
              <c:numCache>
                <c:formatCode>General</c:formatCode>
                <c:ptCount val="8"/>
                <c:pt idx="0">
                  <c:v>1</c:v>
                </c:pt>
                <c:pt idx="1">
                  <c:v>4</c:v>
                </c:pt>
                <c:pt idx="2">
                  <c:v>7</c:v>
                </c:pt>
                <c:pt idx="3">
                  <c:v>10</c:v>
                </c:pt>
                <c:pt idx="4">
                  <c:v>13</c:v>
                </c:pt>
                <c:pt idx="5">
                  <c:v>16</c:v>
                </c:pt>
                <c:pt idx="6">
                  <c:v>19</c:v>
                </c:pt>
                <c:pt idx="7">
                  <c:v>22</c:v>
                </c:pt>
              </c:numCache>
            </c:numRef>
          </c:cat>
          <c:val>
            <c:numRef>
              <c:f>'[2022-10-26 fhy3 1 normalize.xls]Sheet1'!$Q$8,'[2022-10-26 fhy3 1 normalize.xls]Sheet1'!$Q$20,'[2022-10-26 fhy3 1 normalize.xls]Sheet1'!$Q$32,'[2022-10-26 fhy3 1 normalize.xls]Sheet1'!$Q$44,'[2022-10-26 fhy3 1 normalize.xls]Sheet1'!$Q$56,'[2022-10-26 fhy3 1 normalize.xls]Sheet1'!$Q$68,'[2022-10-26 fhy3 1 normalize.xls]Sheet1'!$Q$80,'[2022-10-26 fhy3 1 normalize.xls]Sheet1'!$Q$92</c:f>
              <c:numCache>
                <c:formatCode>#,##0.000000000000000</c:formatCode>
                <c:ptCount val="8"/>
                <c:pt idx="0">
                  <c:v>0.68103044903694532</c:v>
                </c:pt>
                <c:pt idx="1">
                  <c:v>4.9095976355563301E-2</c:v>
                </c:pt>
                <c:pt idx="2">
                  <c:v>6.763913795635422E-3</c:v>
                </c:pt>
                <c:pt idx="3">
                  <c:v>2.0409502722689181E-3</c:v>
                </c:pt>
                <c:pt idx="4">
                  <c:v>2.832391098134374E-3</c:v>
                </c:pt>
                <c:pt idx="5">
                  <c:v>1.3228768279980842E-2</c:v>
                </c:pt>
                <c:pt idx="6">
                  <c:v>0.19014965974098785</c:v>
                </c:pt>
                <c:pt idx="7">
                  <c:v>2.061555515138253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293F-0F49-939D-21E14E0639B8}"/>
            </c:ext>
          </c:extLst>
        </c:ser>
        <c:ser>
          <c:idx val="4"/>
          <c:order val="4"/>
          <c:tx>
            <c:strRef>
              <c:f>'[2022-10-26 fhy3 1 normalize.xls]Sheet1'!$A$7</c:f>
              <c:strCache>
                <c:ptCount val="1"/>
                <c:pt idx="0">
                  <c:v>pTOC1:5X-GFP/fhy3toc1</c:v>
                </c:pt>
              </c:strCache>
            </c:strRef>
          </c:tx>
          <c:spPr>
            <a:ln>
              <a:solidFill>
                <a:schemeClr val="accent6"/>
              </a:solidFill>
            </a:ln>
          </c:spPr>
          <c:marker>
            <c:symbol val="triangle"/>
            <c:size val="5"/>
            <c:spPr>
              <a:noFill/>
              <a:ln w="12700">
                <a:solidFill>
                  <a:schemeClr val="accent6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('https://d.docs.live.net/d8e9bd0bebfa4803/Somers%20lab%202020/Gene%20exp/[2022-5-20 LD 50umol zt1_4.xls]Sheet1'!$R$10,'https://d.docs.live.net/d8e9bd0bebfa4803/Somers%20lab%202020/Gene%20exp/[2022-5-20 LD 50umol zt1_4.xls]Sheet1'!$R$22,'https://d.docs.live.net/d8e9bd0bebfa4803/Somers%20lab%202020/Gene%20exp/[2022-5-20 LD 50umol zt1_4.xls]Sheet1'!$R$34,'https://d.docs.live.net/d8e9bd0bebfa4803/Somers%20lab%202020/Gene%20exp/[2022-5-20 LD 50umol zt1_4.xls]Sheet1'!$R$46,'https://d.docs.live.net/d8e9bd0bebfa4803/Somers%20lab%202020/Gene%20exp/[2022-5-20 LD 50umol zt1_4.xls]Sheet1'!$R$58,'https://d.docs.live.net/d8e9bd0bebfa4803/Somers%20lab%202020/Gene%20exp/[2022-5-20 LD 50umol zt1_4.xls]Sheet1'!$R$70,'https://d.docs.live.net/d8e9bd0bebfa4803/Somers%20lab%202020/Gene%20exp/[2022-5-20 LD 50umol zt1_4.xls]Sheet1'!$R$82,'https://d.docs.live.net/d8e9bd0bebfa4803/Somers%20lab%202020/Gene%20exp/[2022-5-20 LD 50umol zt1_4.xls]Sheet1'!$R$94)</c:f>
                <c:numCache>
                  <c:formatCode>General</c:formatCode>
                  <c:ptCount val="8"/>
                  <c:pt idx="0">
                    <c:v>6.6269055305497027E-4</c:v>
                  </c:pt>
                  <c:pt idx="1">
                    <c:v>5.2689885566768214E-5</c:v>
                  </c:pt>
                  <c:pt idx="2">
                    <c:v>2.8692939196963771E-5</c:v>
                  </c:pt>
                  <c:pt idx="3">
                    <c:v>1.6007641066423216E-4</c:v>
                  </c:pt>
                  <c:pt idx="4">
                    <c:v>1.9351247922499531E-5</c:v>
                  </c:pt>
                  <c:pt idx="5">
                    <c:v>1.3141067385505286E-5</c:v>
                  </c:pt>
                  <c:pt idx="6">
                    <c:v>1.1331008655563954E-5</c:v>
                  </c:pt>
                  <c:pt idx="7">
                    <c:v>8.3324555156683011E-4</c:v>
                  </c:pt>
                </c:numCache>
              </c:numRef>
            </c:plus>
            <c:minus>
              <c:numRef>
                <c:f>('https://d.docs.live.net/d8e9bd0bebfa4803/Somers%20lab%202020/Gene%20exp/[2022-5-20 LD 50umol zt1_4.xls]Sheet1'!$R$10,'https://d.docs.live.net/d8e9bd0bebfa4803/Somers%20lab%202020/Gene%20exp/[2022-5-20 LD 50umol zt1_4.xls]Sheet1'!$R$22,'https://d.docs.live.net/d8e9bd0bebfa4803/Somers%20lab%202020/Gene%20exp/[2022-5-20 LD 50umol zt1_4.xls]Sheet1'!$R$34,'https://d.docs.live.net/d8e9bd0bebfa4803/Somers%20lab%202020/Gene%20exp/[2022-5-20 LD 50umol zt1_4.xls]Sheet1'!$R$46,'https://d.docs.live.net/d8e9bd0bebfa4803/Somers%20lab%202020/Gene%20exp/[2022-5-20 LD 50umol zt1_4.xls]Sheet1'!$R$58,'https://d.docs.live.net/d8e9bd0bebfa4803/Somers%20lab%202020/Gene%20exp/[2022-5-20 LD 50umol zt1_4.xls]Sheet1'!$R$70,'https://d.docs.live.net/d8e9bd0bebfa4803/Somers%20lab%202020/Gene%20exp/[2022-5-20 LD 50umol zt1_4.xls]Sheet1'!$R$82,'https://d.docs.live.net/d8e9bd0bebfa4803/Somers%20lab%202020/Gene%20exp/[2022-5-20 LD 50umol zt1_4.xls]Sheet1'!$R$94)</c:f>
                <c:numCache>
                  <c:formatCode>General</c:formatCode>
                  <c:ptCount val="8"/>
                  <c:pt idx="0">
                    <c:v>6.6269055305497027E-4</c:v>
                  </c:pt>
                  <c:pt idx="1">
                    <c:v>5.2689885566768214E-5</c:v>
                  </c:pt>
                  <c:pt idx="2">
                    <c:v>2.8692939196963771E-5</c:v>
                  </c:pt>
                  <c:pt idx="3">
                    <c:v>1.6007641066423216E-4</c:v>
                  </c:pt>
                  <c:pt idx="4">
                    <c:v>1.9351247922499531E-5</c:v>
                  </c:pt>
                  <c:pt idx="5">
                    <c:v>1.3141067385505286E-5</c:v>
                  </c:pt>
                  <c:pt idx="6">
                    <c:v>1.1331008655563954E-5</c:v>
                  </c:pt>
                  <c:pt idx="7">
                    <c:v>8.3324555156683011E-4</c:v>
                  </c:pt>
                </c:numCache>
              </c:numRef>
            </c:minus>
            <c:spPr>
              <a:ln w="3175">
                <a:solidFill>
                  <a:srgbClr val="666699"/>
                </a:solidFill>
                <a:prstDash val="solid"/>
              </a:ln>
            </c:spPr>
          </c:errBars>
          <c:cat>
            <c:numRef>
              <c:f>'[2022-10-26 fhy3 1 normalize.xls]Sheet1'!$A$2,'[2022-10-26 fhy3 1 normalize.xls]Sheet1'!$A$14,'[2022-10-26 fhy3 1 normalize.xls]Sheet1'!$A$26,'[2022-10-26 fhy3 1 normalize.xls]Sheet1'!$A$38,'[2022-10-26 fhy3 1 normalize.xls]Sheet1'!$A$50,'[2022-10-26 fhy3 1 normalize.xls]Sheet1'!$A$62,'[2022-10-26 fhy3 1 normalize.xls]Sheet1'!$A$74,'[2022-10-26 fhy3 1 normalize.xls]Sheet1'!$A$86</c:f>
              <c:numCache>
                <c:formatCode>General</c:formatCode>
                <c:ptCount val="8"/>
                <c:pt idx="0">
                  <c:v>1</c:v>
                </c:pt>
                <c:pt idx="1">
                  <c:v>4</c:v>
                </c:pt>
                <c:pt idx="2">
                  <c:v>7</c:v>
                </c:pt>
                <c:pt idx="3">
                  <c:v>10</c:v>
                </c:pt>
                <c:pt idx="4">
                  <c:v>13</c:v>
                </c:pt>
                <c:pt idx="5">
                  <c:v>16</c:v>
                </c:pt>
                <c:pt idx="6">
                  <c:v>19</c:v>
                </c:pt>
                <c:pt idx="7">
                  <c:v>22</c:v>
                </c:pt>
              </c:numCache>
            </c:numRef>
          </c:cat>
          <c:val>
            <c:numRef>
              <c:f>'[2022-10-26 fhy3 1 normalize.xls]Sheet1'!$Q$10,'[2022-10-26 fhy3 1 normalize.xls]Sheet1'!$Q$22,'[2022-10-26 fhy3 1 normalize.xls]Sheet1'!$Q$34,'[2022-10-26 fhy3 1 normalize.xls]Sheet1'!$Q$46,'[2022-10-26 fhy3 1 normalize.xls]Sheet1'!$Q$58,'[2022-10-26 fhy3 1 normalize.xls]Sheet1'!$Q$70,'[2022-10-26 fhy3 1 normalize.xls]Sheet1'!$Q$82,'[2022-10-26 fhy3 1 normalize.xls]Sheet1'!$Q$94</c:f>
              <c:numCache>
                <c:formatCode>#,##0.000000000000000</c:formatCode>
                <c:ptCount val="8"/>
                <c:pt idx="0">
                  <c:v>0.69584367010858417</c:v>
                </c:pt>
                <c:pt idx="1">
                  <c:v>3.4532819451431815E-2</c:v>
                </c:pt>
                <c:pt idx="2">
                  <c:v>2.4823780336563047E-3</c:v>
                </c:pt>
                <c:pt idx="3">
                  <c:v>2.5579521476239526E-3</c:v>
                </c:pt>
                <c:pt idx="4">
                  <c:v>3.1520420139168753E-3</c:v>
                </c:pt>
                <c:pt idx="5">
                  <c:v>2.3172971720289148E-2</c:v>
                </c:pt>
                <c:pt idx="6">
                  <c:v>0.22714570384613442</c:v>
                </c:pt>
                <c:pt idx="7">
                  <c:v>2.482541608896830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293F-0F49-939D-21E14E0639B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888440351"/>
        <c:axId val="1"/>
      </c:lineChart>
      <c:catAx>
        <c:axId val="1888440351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altLang="zh-CN" dirty="0"/>
                  <a:t>ZT</a:t>
                </a:r>
                <a:r>
                  <a:rPr lang="en-US" altLang="zh-CN" baseline="0" dirty="0"/>
                  <a:t> Time</a:t>
                </a:r>
                <a:endParaRPr lang="zh-CN" altLang="en-US" dirty="0"/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0" vert="horz"/>
          <a:lstStyle/>
          <a:p>
            <a:pPr>
              <a:defRPr sz="1050" b="0" i="0" u="none" strike="noStrike" baseline="0">
                <a:solidFill>
                  <a:srgbClr val="000000"/>
                </a:solidFill>
                <a:latin typeface="Calibri"/>
                <a:ea typeface="Calibri"/>
                <a:cs typeface="Calibri"/>
              </a:defRPr>
            </a:pPr>
            <a:endParaRPr lang="en-US"/>
          </a:p>
        </c:txPr>
        <c:crossAx val="1"/>
        <c:crosses val="autoZero"/>
        <c:auto val="1"/>
        <c:lblAlgn val="ctr"/>
        <c:lblOffset val="100"/>
        <c:noMultiLvlLbl val="0"/>
      </c:catAx>
      <c:valAx>
        <c:axId val="1"/>
        <c:scaling>
          <c:orientation val="minMax"/>
          <c:max val="0.4"/>
          <c:min val="0"/>
        </c:scaling>
        <c:delete val="0"/>
        <c:axPos val="l"/>
        <c:numFmt formatCode="#,##0.0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0" vert="horz"/>
          <a:lstStyle/>
          <a:p>
            <a:pPr>
              <a:defRPr sz="1050" b="0" i="0" u="none" strike="noStrike" baseline="0">
                <a:solidFill>
                  <a:srgbClr val="000000"/>
                </a:solidFill>
                <a:latin typeface="Calibri"/>
                <a:ea typeface="Calibri"/>
                <a:cs typeface="Calibri"/>
              </a:defRPr>
            </a:pPr>
            <a:endParaRPr lang="en-US"/>
          </a:p>
        </c:txPr>
        <c:crossAx val="1888440351"/>
        <c:crosses val="autoZero"/>
        <c:crossBetween val="between"/>
        <c:majorUnit val="0.2"/>
      </c:valAx>
      <c:spPr>
        <a:noFill/>
        <a:ln w="25400">
          <a:noFill/>
        </a:ln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1050" b="0" i="0" u="none" strike="noStrike" baseline="0">
          <a:solidFill>
            <a:srgbClr val="000000"/>
          </a:solidFill>
          <a:latin typeface="Calibri"/>
          <a:ea typeface="Calibri"/>
          <a:cs typeface="Calibri"/>
        </a:defRPr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/>
            </a:pPr>
            <a:r>
              <a:rPr lang="en-US" sz="1200" b="0" i="1" baseline="0" dirty="0">
                <a:effectLst/>
              </a:rPr>
              <a:t>CCA1:LUC </a:t>
            </a:r>
            <a:r>
              <a:rPr lang="en-US" sz="1200" b="0" i="0" baseline="0" dirty="0">
                <a:effectLst/>
              </a:rPr>
              <a:t>bioluminescence</a:t>
            </a:r>
            <a:endParaRPr lang="en-US" sz="1200" dirty="0">
              <a:effectLst/>
            </a:endParaRPr>
          </a:p>
        </c:rich>
      </c:tx>
      <c:layout>
        <c:manualLayout>
          <c:xMode val="edge"/>
          <c:yMode val="edge"/>
          <c:x val="0.27876517997024575"/>
          <c:y val="1.9146975196491535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0694074809190443"/>
          <c:y val="8.0410766130075237E-2"/>
          <c:w val="0.6329000001794588"/>
          <c:h val="0.74083417164820276"/>
        </c:manualLayout>
      </c:layout>
      <c:lineChart>
        <c:grouping val="standard"/>
        <c:varyColors val="0"/>
        <c:ser>
          <c:idx val="0"/>
          <c:order val="0"/>
          <c:tx>
            <c:strRef>
              <c:f>'20211213WW30UMOL22_1xls'!$FI$7</c:f>
              <c:strCache>
                <c:ptCount val="1"/>
                <c:pt idx="0">
                  <c:v>Col-0</c:v>
                </c:pt>
              </c:strCache>
            </c:strRef>
          </c:tx>
          <c:spPr>
            <a:ln w="9525" cap="rnd">
              <a:solidFill>
                <a:srgbClr val="A5A5A5"/>
              </a:solidFill>
              <a:round/>
            </a:ln>
            <a:effectLst/>
          </c:spPr>
          <c:marker>
            <c:symbol val="circle"/>
            <c:size val="5"/>
            <c:spPr>
              <a:noFill/>
              <a:ln w="12700">
                <a:solidFill>
                  <a:schemeClr val="accent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1"/>
            <c:plus>
              <c:numRef>
                <c:f>'20211213WW30UMOL22_1xls'!$FJ$21:$FJ$81</c:f>
                <c:numCache>
                  <c:formatCode>General</c:formatCode>
                  <c:ptCount val="61"/>
                  <c:pt idx="0">
                    <c:v>38.073239393419378</c:v>
                  </c:pt>
                  <c:pt idx="1">
                    <c:v>46.484395505641984</c:v>
                  </c:pt>
                  <c:pt idx="2">
                    <c:v>39.732731205376837</c:v>
                  </c:pt>
                  <c:pt idx="3">
                    <c:v>25.073189580068632</c:v>
                  </c:pt>
                  <c:pt idx="4">
                    <c:v>15.549588888577698</c:v>
                  </c:pt>
                  <c:pt idx="5">
                    <c:v>13.445564435388246</c:v>
                  </c:pt>
                  <c:pt idx="6">
                    <c:v>13.810808657763834</c:v>
                  </c:pt>
                  <c:pt idx="7">
                    <c:v>13.637617395673265</c:v>
                  </c:pt>
                  <c:pt idx="8">
                    <c:v>12.516795235586889</c:v>
                  </c:pt>
                  <c:pt idx="9">
                    <c:v>10.185302641332584</c:v>
                  </c:pt>
                  <c:pt idx="10">
                    <c:v>16.769183021816005</c:v>
                  </c:pt>
                  <c:pt idx="11">
                    <c:v>35.734143392104777</c:v>
                  </c:pt>
                  <c:pt idx="12">
                    <c:v>45.965985523483454</c:v>
                  </c:pt>
                  <c:pt idx="13">
                    <c:v>42.071370350961679</c:v>
                  </c:pt>
                  <c:pt idx="14">
                    <c:v>31.236323782348055</c:v>
                  </c:pt>
                  <c:pt idx="15">
                    <c:v>22.399475563237591</c:v>
                  </c:pt>
                  <c:pt idx="16">
                    <c:v>16.100513771158482</c:v>
                  </c:pt>
                  <c:pt idx="17">
                    <c:v>13.196331606932649</c:v>
                  </c:pt>
                  <c:pt idx="18">
                    <c:v>13.638972967674503</c:v>
                  </c:pt>
                  <c:pt idx="19">
                    <c:v>14.082425212024878</c:v>
                  </c:pt>
                  <c:pt idx="20">
                    <c:v>12.43230185797937</c:v>
                  </c:pt>
                  <c:pt idx="21">
                    <c:v>13.208169709782259</c:v>
                  </c:pt>
                  <c:pt idx="22">
                    <c:v>23.038214642266237</c:v>
                  </c:pt>
                  <c:pt idx="23">
                    <c:v>33.135774764464422</c:v>
                  </c:pt>
                  <c:pt idx="24">
                    <c:v>36.276898008992021</c:v>
                  </c:pt>
                  <c:pt idx="25">
                    <c:v>34.062900489294591</c:v>
                  </c:pt>
                  <c:pt idx="26">
                    <c:v>29.656420763074596</c:v>
                  </c:pt>
                  <c:pt idx="27">
                    <c:v>23.794400264127496</c:v>
                  </c:pt>
                  <c:pt idx="28">
                    <c:v>18.163314173821217</c:v>
                  </c:pt>
                  <c:pt idx="29">
                    <c:v>14.773172333582249</c:v>
                  </c:pt>
                  <c:pt idx="30">
                    <c:v>13.424732488857403</c:v>
                  </c:pt>
                  <c:pt idx="31">
                    <c:v>13.288359738406442</c:v>
                  </c:pt>
                  <c:pt idx="32">
                    <c:v>13.39383054332872</c:v>
                  </c:pt>
                  <c:pt idx="33">
                    <c:v>17.355611173340169</c:v>
                  </c:pt>
                  <c:pt idx="34">
                    <c:v>23.343889031670116</c:v>
                  </c:pt>
                  <c:pt idx="35">
                    <c:v>26.829801154863098</c:v>
                  </c:pt>
                  <c:pt idx="36">
                    <c:v>27.728209587576625</c:v>
                  </c:pt>
                  <c:pt idx="37">
                    <c:v>27.485832057855394</c:v>
                  </c:pt>
                  <c:pt idx="38">
                    <c:v>25.593041295888053</c:v>
                  </c:pt>
                  <c:pt idx="39">
                    <c:v>21.816325547599973</c:v>
                  </c:pt>
                  <c:pt idx="40">
                    <c:v>18.118832202547882</c:v>
                  </c:pt>
                  <c:pt idx="41">
                    <c:v>15.133970018039349</c:v>
                  </c:pt>
                  <c:pt idx="42">
                    <c:v>13.623437634879506</c:v>
                  </c:pt>
                  <c:pt idx="43">
                    <c:v>13.41438342660779</c:v>
                  </c:pt>
                  <c:pt idx="44">
                    <c:v>15.198617704608544</c:v>
                  </c:pt>
                  <c:pt idx="45">
                    <c:v>18.509604139599105</c:v>
                  </c:pt>
                  <c:pt idx="46">
                    <c:v>21.17983495761737</c:v>
                  </c:pt>
                  <c:pt idx="47">
                    <c:v>23.33910648563819</c:v>
                  </c:pt>
                  <c:pt idx="48">
                    <c:v>24.835446322933489</c:v>
                  </c:pt>
                  <c:pt idx="49">
                    <c:v>24.835967139075709</c:v>
                  </c:pt>
                  <c:pt idx="50">
                    <c:v>23.876591503421352</c:v>
                  </c:pt>
                  <c:pt idx="51">
                    <c:v>22.324510103852766</c:v>
                  </c:pt>
                  <c:pt idx="52">
                    <c:v>19.702317267482897</c:v>
                  </c:pt>
                  <c:pt idx="53">
                    <c:v>16.73958406424364</c:v>
                  </c:pt>
                  <c:pt idx="54">
                    <c:v>15.127589932147714</c:v>
                  </c:pt>
                  <c:pt idx="55">
                    <c:v>14.983733045460742</c:v>
                  </c:pt>
                  <c:pt idx="56">
                    <c:v>16.294369777992628</c:v>
                  </c:pt>
                  <c:pt idx="57">
                    <c:v>17.875209450363805</c:v>
                  </c:pt>
                  <c:pt idx="58">
                    <c:v>18.980480864738485</c:v>
                  </c:pt>
                  <c:pt idx="59">
                    <c:v>20.016119465081943</c:v>
                  </c:pt>
                  <c:pt idx="60">
                    <c:v>21.769468757897126</c:v>
                  </c:pt>
                </c:numCache>
              </c:numRef>
            </c:plus>
            <c:minus>
              <c:numRef>
                <c:f>'20211213WW30UMOL22_1xls'!$FJ$21:$FJ$81</c:f>
                <c:numCache>
                  <c:formatCode>General</c:formatCode>
                  <c:ptCount val="61"/>
                  <c:pt idx="0">
                    <c:v>38.073239393419378</c:v>
                  </c:pt>
                  <c:pt idx="1">
                    <c:v>46.484395505641984</c:v>
                  </c:pt>
                  <c:pt idx="2">
                    <c:v>39.732731205376837</c:v>
                  </c:pt>
                  <c:pt idx="3">
                    <c:v>25.073189580068632</c:v>
                  </c:pt>
                  <c:pt idx="4">
                    <c:v>15.549588888577698</c:v>
                  </c:pt>
                  <c:pt idx="5">
                    <c:v>13.445564435388246</c:v>
                  </c:pt>
                  <c:pt idx="6">
                    <c:v>13.810808657763834</c:v>
                  </c:pt>
                  <c:pt idx="7">
                    <c:v>13.637617395673265</c:v>
                  </c:pt>
                  <c:pt idx="8">
                    <c:v>12.516795235586889</c:v>
                  </c:pt>
                  <c:pt idx="9">
                    <c:v>10.185302641332584</c:v>
                  </c:pt>
                  <c:pt idx="10">
                    <c:v>16.769183021816005</c:v>
                  </c:pt>
                  <c:pt idx="11">
                    <c:v>35.734143392104777</c:v>
                  </c:pt>
                  <c:pt idx="12">
                    <c:v>45.965985523483454</c:v>
                  </c:pt>
                  <c:pt idx="13">
                    <c:v>42.071370350961679</c:v>
                  </c:pt>
                  <c:pt idx="14">
                    <c:v>31.236323782348055</c:v>
                  </c:pt>
                  <c:pt idx="15">
                    <c:v>22.399475563237591</c:v>
                  </c:pt>
                  <c:pt idx="16">
                    <c:v>16.100513771158482</c:v>
                  </c:pt>
                  <c:pt idx="17">
                    <c:v>13.196331606932649</c:v>
                  </c:pt>
                  <c:pt idx="18">
                    <c:v>13.638972967674503</c:v>
                  </c:pt>
                  <c:pt idx="19">
                    <c:v>14.082425212024878</c:v>
                  </c:pt>
                  <c:pt idx="20">
                    <c:v>12.43230185797937</c:v>
                  </c:pt>
                  <c:pt idx="21">
                    <c:v>13.208169709782259</c:v>
                  </c:pt>
                  <c:pt idx="22">
                    <c:v>23.038214642266237</c:v>
                  </c:pt>
                  <c:pt idx="23">
                    <c:v>33.135774764464422</c:v>
                  </c:pt>
                  <c:pt idx="24">
                    <c:v>36.276898008992021</c:v>
                  </c:pt>
                  <c:pt idx="25">
                    <c:v>34.062900489294591</c:v>
                  </c:pt>
                  <c:pt idx="26">
                    <c:v>29.656420763074596</c:v>
                  </c:pt>
                  <c:pt idx="27">
                    <c:v>23.794400264127496</c:v>
                  </c:pt>
                  <c:pt idx="28">
                    <c:v>18.163314173821217</c:v>
                  </c:pt>
                  <c:pt idx="29">
                    <c:v>14.773172333582249</c:v>
                  </c:pt>
                  <c:pt idx="30">
                    <c:v>13.424732488857403</c:v>
                  </c:pt>
                  <c:pt idx="31">
                    <c:v>13.288359738406442</c:v>
                  </c:pt>
                  <c:pt idx="32">
                    <c:v>13.39383054332872</c:v>
                  </c:pt>
                  <c:pt idx="33">
                    <c:v>17.355611173340169</c:v>
                  </c:pt>
                  <c:pt idx="34">
                    <c:v>23.343889031670116</c:v>
                  </c:pt>
                  <c:pt idx="35">
                    <c:v>26.829801154863098</c:v>
                  </c:pt>
                  <c:pt idx="36">
                    <c:v>27.728209587576625</c:v>
                  </c:pt>
                  <c:pt idx="37">
                    <c:v>27.485832057855394</c:v>
                  </c:pt>
                  <c:pt idx="38">
                    <c:v>25.593041295888053</c:v>
                  </c:pt>
                  <c:pt idx="39">
                    <c:v>21.816325547599973</c:v>
                  </c:pt>
                  <c:pt idx="40">
                    <c:v>18.118832202547882</c:v>
                  </c:pt>
                  <c:pt idx="41">
                    <c:v>15.133970018039349</c:v>
                  </c:pt>
                  <c:pt idx="42">
                    <c:v>13.623437634879506</c:v>
                  </c:pt>
                  <c:pt idx="43">
                    <c:v>13.41438342660779</c:v>
                  </c:pt>
                  <c:pt idx="44">
                    <c:v>15.198617704608544</c:v>
                  </c:pt>
                  <c:pt idx="45">
                    <c:v>18.509604139599105</c:v>
                  </c:pt>
                  <c:pt idx="46">
                    <c:v>21.17983495761737</c:v>
                  </c:pt>
                  <c:pt idx="47">
                    <c:v>23.33910648563819</c:v>
                  </c:pt>
                  <c:pt idx="48">
                    <c:v>24.835446322933489</c:v>
                  </c:pt>
                  <c:pt idx="49">
                    <c:v>24.835967139075709</c:v>
                  </c:pt>
                  <c:pt idx="50">
                    <c:v>23.876591503421352</c:v>
                  </c:pt>
                  <c:pt idx="51">
                    <c:v>22.324510103852766</c:v>
                  </c:pt>
                  <c:pt idx="52">
                    <c:v>19.702317267482897</c:v>
                  </c:pt>
                  <c:pt idx="53">
                    <c:v>16.73958406424364</c:v>
                  </c:pt>
                  <c:pt idx="54">
                    <c:v>15.127589932147714</c:v>
                  </c:pt>
                  <c:pt idx="55">
                    <c:v>14.983733045460742</c:v>
                  </c:pt>
                  <c:pt idx="56">
                    <c:v>16.294369777992628</c:v>
                  </c:pt>
                  <c:pt idx="57">
                    <c:v>17.875209450363805</c:v>
                  </c:pt>
                  <c:pt idx="58">
                    <c:v>18.980480864738485</c:v>
                  </c:pt>
                  <c:pt idx="59">
                    <c:v>20.016119465081943</c:v>
                  </c:pt>
                  <c:pt idx="60">
                    <c:v>21.769468757897126</c:v>
                  </c:pt>
                </c:numCache>
              </c:numRef>
            </c:minus>
            <c:spPr>
              <a:ln w="12700">
                <a:solidFill>
                  <a:schemeClr val="accent1"/>
                </a:solidFill>
              </a:ln>
            </c:spPr>
          </c:errBars>
          <c:cat>
            <c:numRef>
              <c:f>'20211213WW30UMOL22_1xls'!$D$21:$D$81</c:f>
              <c:numCache>
                <c:formatCode>General</c:formatCode>
                <c:ptCount val="61"/>
                <c:pt idx="0">
                  <c:v>24</c:v>
                </c:pt>
                <c:pt idx="1">
                  <c:v>26</c:v>
                </c:pt>
                <c:pt idx="2">
                  <c:v>28</c:v>
                </c:pt>
                <c:pt idx="3">
                  <c:v>30</c:v>
                </c:pt>
                <c:pt idx="4">
                  <c:v>32</c:v>
                </c:pt>
                <c:pt idx="5">
                  <c:v>34</c:v>
                </c:pt>
                <c:pt idx="6">
                  <c:v>36</c:v>
                </c:pt>
                <c:pt idx="7">
                  <c:v>38</c:v>
                </c:pt>
                <c:pt idx="8">
                  <c:v>40</c:v>
                </c:pt>
                <c:pt idx="9">
                  <c:v>42</c:v>
                </c:pt>
                <c:pt idx="10">
                  <c:v>44</c:v>
                </c:pt>
                <c:pt idx="11">
                  <c:v>46</c:v>
                </c:pt>
                <c:pt idx="12">
                  <c:v>48</c:v>
                </c:pt>
                <c:pt idx="13">
                  <c:v>50</c:v>
                </c:pt>
                <c:pt idx="14">
                  <c:v>52</c:v>
                </c:pt>
                <c:pt idx="15">
                  <c:v>54</c:v>
                </c:pt>
                <c:pt idx="16">
                  <c:v>56</c:v>
                </c:pt>
                <c:pt idx="17">
                  <c:v>58</c:v>
                </c:pt>
                <c:pt idx="18">
                  <c:v>60</c:v>
                </c:pt>
                <c:pt idx="19">
                  <c:v>62</c:v>
                </c:pt>
                <c:pt idx="20">
                  <c:v>64</c:v>
                </c:pt>
                <c:pt idx="21">
                  <c:v>66</c:v>
                </c:pt>
                <c:pt idx="22">
                  <c:v>68</c:v>
                </c:pt>
                <c:pt idx="23">
                  <c:v>70</c:v>
                </c:pt>
                <c:pt idx="24">
                  <c:v>72</c:v>
                </c:pt>
                <c:pt idx="25">
                  <c:v>74</c:v>
                </c:pt>
                <c:pt idx="26">
                  <c:v>76</c:v>
                </c:pt>
                <c:pt idx="27">
                  <c:v>78</c:v>
                </c:pt>
                <c:pt idx="28">
                  <c:v>80</c:v>
                </c:pt>
                <c:pt idx="29">
                  <c:v>82</c:v>
                </c:pt>
                <c:pt idx="30">
                  <c:v>84</c:v>
                </c:pt>
                <c:pt idx="31">
                  <c:v>86</c:v>
                </c:pt>
                <c:pt idx="32">
                  <c:v>88</c:v>
                </c:pt>
                <c:pt idx="33">
                  <c:v>90</c:v>
                </c:pt>
                <c:pt idx="34">
                  <c:v>92</c:v>
                </c:pt>
                <c:pt idx="35">
                  <c:v>94</c:v>
                </c:pt>
                <c:pt idx="36">
                  <c:v>96</c:v>
                </c:pt>
                <c:pt idx="37">
                  <c:v>98</c:v>
                </c:pt>
                <c:pt idx="38">
                  <c:v>100</c:v>
                </c:pt>
                <c:pt idx="39">
                  <c:v>102</c:v>
                </c:pt>
                <c:pt idx="40">
                  <c:v>104</c:v>
                </c:pt>
                <c:pt idx="41">
                  <c:v>106</c:v>
                </c:pt>
                <c:pt idx="42">
                  <c:v>108</c:v>
                </c:pt>
                <c:pt idx="43">
                  <c:v>110</c:v>
                </c:pt>
                <c:pt idx="44">
                  <c:v>112</c:v>
                </c:pt>
                <c:pt idx="45">
                  <c:v>114</c:v>
                </c:pt>
                <c:pt idx="46">
                  <c:v>116</c:v>
                </c:pt>
                <c:pt idx="47">
                  <c:v>118</c:v>
                </c:pt>
                <c:pt idx="48">
                  <c:v>120</c:v>
                </c:pt>
                <c:pt idx="49">
                  <c:v>122</c:v>
                </c:pt>
                <c:pt idx="50">
                  <c:v>124</c:v>
                </c:pt>
                <c:pt idx="51">
                  <c:v>126</c:v>
                </c:pt>
                <c:pt idx="52">
                  <c:v>128</c:v>
                </c:pt>
                <c:pt idx="53">
                  <c:v>130</c:v>
                </c:pt>
                <c:pt idx="54">
                  <c:v>132</c:v>
                </c:pt>
                <c:pt idx="55">
                  <c:v>134</c:v>
                </c:pt>
                <c:pt idx="56">
                  <c:v>136</c:v>
                </c:pt>
                <c:pt idx="57">
                  <c:v>138</c:v>
                </c:pt>
                <c:pt idx="58">
                  <c:v>140</c:v>
                </c:pt>
                <c:pt idx="59">
                  <c:v>142</c:v>
                </c:pt>
                <c:pt idx="60">
                  <c:v>144</c:v>
                </c:pt>
              </c:numCache>
            </c:numRef>
          </c:cat>
          <c:val>
            <c:numRef>
              <c:f>'20211213WW30UMOL22_1xls'!$FI$21:$FI$81</c:f>
              <c:numCache>
                <c:formatCode>General</c:formatCode>
                <c:ptCount val="61"/>
                <c:pt idx="0">
                  <c:v>633.43592592592586</c:v>
                </c:pt>
                <c:pt idx="1">
                  <c:v>847.27259259259279</c:v>
                </c:pt>
                <c:pt idx="2">
                  <c:v>803.62074074074087</c:v>
                </c:pt>
                <c:pt idx="3">
                  <c:v>593.055185185185</c:v>
                </c:pt>
                <c:pt idx="4">
                  <c:v>394.43407407407403</c:v>
                </c:pt>
                <c:pt idx="5">
                  <c:v>282.61962962962963</c:v>
                </c:pt>
                <c:pt idx="6">
                  <c:v>233.02740740740742</c:v>
                </c:pt>
                <c:pt idx="7">
                  <c:v>182.4466666666666</c:v>
                </c:pt>
                <c:pt idx="8">
                  <c:v>145.31444444444443</c:v>
                </c:pt>
                <c:pt idx="9">
                  <c:v>159.79988888888889</c:v>
                </c:pt>
                <c:pt idx="10">
                  <c:v>293.81407407407409</c:v>
                </c:pt>
                <c:pt idx="11">
                  <c:v>568.03925925925921</c:v>
                </c:pt>
                <c:pt idx="12">
                  <c:v>824.9840740740741</c:v>
                </c:pt>
                <c:pt idx="13">
                  <c:v>877.57592592592573</c:v>
                </c:pt>
                <c:pt idx="14">
                  <c:v>740.24592592592603</c:v>
                </c:pt>
                <c:pt idx="15">
                  <c:v>556.11777777777763</c:v>
                </c:pt>
                <c:pt idx="16">
                  <c:v>407.91481481481486</c:v>
                </c:pt>
                <c:pt idx="17">
                  <c:v>325.76407407407413</c:v>
                </c:pt>
                <c:pt idx="18">
                  <c:v>279.05962962962968</c:v>
                </c:pt>
                <c:pt idx="19">
                  <c:v>234.26962962962963</c:v>
                </c:pt>
                <c:pt idx="20">
                  <c:v>210.23859259259262</c:v>
                </c:pt>
                <c:pt idx="21">
                  <c:v>260.82592592592596</c:v>
                </c:pt>
                <c:pt idx="22">
                  <c:v>423.67333333333335</c:v>
                </c:pt>
                <c:pt idx="23">
                  <c:v>641.7918518518519</c:v>
                </c:pt>
                <c:pt idx="24">
                  <c:v>783.13222222222203</c:v>
                </c:pt>
                <c:pt idx="25">
                  <c:v>781.85666666666668</c:v>
                </c:pt>
                <c:pt idx="26">
                  <c:v>671.36259259259259</c:v>
                </c:pt>
                <c:pt idx="27">
                  <c:v>548.30259259259265</c:v>
                </c:pt>
                <c:pt idx="28">
                  <c:v>447.74814814814812</c:v>
                </c:pt>
                <c:pt idx="29">
                  <c:v>381.59333333333336</c:v>
                </c:pt>
                <c:pt idx="30">
                  <c:v>334.66703703703706</c:v>
                </c:pt>
                <c:pt idx="31">
                  <c:v>304.13925925925918</c:v>
                </c:pt>
                <c:pt idx="32">
                  <c:v>304.88629629629622</c:v>
                </c:pt>
                <c:pt idx="33">
                  <c:v>367.47740740740738</c:v>
                </c:pt>
                <c:pt idx="34">
                  <c:v>478.65037037037035</c:v>
                </c:pt>
                <c:pt idx="35">
                  <c:v>587.19111111111124</c:v>
                </c:pt>
                <c:pt idx="36">
                  <c:v>654.18111111111114</c:v>
                </c:pt>
                <c:pt idx="37">
                  <c:v>668.76555555555547</c:v>
                </c:pt>
                <c:pt idx="38">
                  <c:v>620.3555555555555</c:v>
                </c:pt>
                <c:pt idx="39">
                  <c:v>543.94333333333327</c:v>
                </c:pt>
                <c:pt idx="40">
                  <c:v>468.78629629629626</c:v>
                </c:pt>
                <c:pt idx="41">
                  <c:v>408.83592592592589</c:v>
                </c:pt>
                <c:pt idx="42">
                  <c:v>377.31</c:v>
                </c:pt>
                <c:pt idx="43">
                  <c:v>369.14444444444445</c:v>
                </c:pt>
                <c:pt idx="44">
                  <c:v>388.83407407407418</c:v>
                </c:pt>
                <c:pt idx="45">
                  <c:v>427.00518518518516</c:v>
                </c:pt>
                <c:pt idx="46">
                  <c:v>472.67999999999995</c:v>
                </c:pt>
                <c:pt idx="47">
                  <c:v>526.30444444444447</c:v>
                </c:pt>
                <c:pt idx="48">
                  <c:v>577.62370370370354</c:v>
                </c:pt>
                <c:pt idx="49">
                  <c:v>609.23148148148152</c:v>
                </c:pt>
                <c:pt idx="50">
                  <c:v>603.15740740740739</c:v>
                </c:pt>
                <c:pt idx="51">
                  <c:v>556.84555555555539</c:v>
                </c:pt>
                <c:pt idx="52">
                  <c:v>500.83814814814821</c:v>
                </c:pt>
                <c:pt idx="53">
                  <c:v>436.28666666666663</c:v>
                </c:pt>
                <c:pt idx="54">
                  <c:v>404.21703703703707</c:v>
                </c:pt>
                <c:pt idx="55">
                  <c:v>408.84962962962959</c:v>
                </c:pt>
                <c:pt idx="56">
                  <c:v>424.88962962962967</c:v>
                </c:pt>
                <c:pt idx="57">
                  <c:v>437.80407407407409</c:v>
                </c:pt>
                <c:pt idx="58">
                  <c:v>452.35814814814813</c:v>
                </c:pt>
                <c:pt idx="59">
                  <c:v>481.52925925925928</c:v>
                </c:pt>
                <c:pt idx="60">
                  <c:v>529.0814814814813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0408-47AD-93AE-EC8B73D8B0AA}"/>
            </c:ext>
          </c:extLst>
        </c:ser>
        <c:ser>
          <c:idx val="1"/>
          <c:order val="1"/>
          <c:tx>
            <c:strRef>
              <c:f>'20211213WW30UMOL22_1xls'!$FK$7</c:f>
              <c:strCache>
                <c:ptCount val="1"/>
                <c:pt idx="0">
                  <c:v>toc1</c:v>
                </c:pt>
              </c:strCache>
            </c:strRef>
          </c:tx>
          <c:spPr>
            <a:ln w="9525" cap="rnd">
              <a:solidFill>
                <a:srgbClr val="A5A5A5"/>
              </a:solidFill>
              <a:round/>
            </a:ln>
            <a:effectLst/>
          </c:spPr>
          <c:marker>
            <c:symbol val="circle"/>
            <c:size val="5"/>
            <c:spPr>
              <a:noFill/>
              <a:ln w="12700">
                <a:solidFill>
                  <a:srgbClr val="FF781D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1"/>
            <c:plus>
              <c:numRef>
                <c:f>'20211213WW30UMOL22_1xls'!$FL$21:$FL$81</c:f>
                <c:numCache>
                  <c:formatCode>General</c:formatCode>
                  <c:ptCount val="61"/>
                  <c:pt idx="0">
                    <c:v>58.239839779928282</c:v>
                  </c:pt>
                  <c:pt idx="1">
                    <c:v>45.363856420146817</c:v>
                  </c:pt>
                  <c:pt idx="2">
                    <c:v>30.698828718477081</c:v>
                  </c:pt>
                  <c:pt idx="3">
                    <c:v>23.099168231266038</c:v>
                  </c:pt>
                  <c:pt idx="4">
                    <c:v>22.618328988995685</c:v>
                  </c:pt>
                  <c:pt idx="5">
                    <c:v>22.401202838584041</c:v>
                  </c:pt>
                  <c:pt idx="6">
                    <c:v>18.971326420518078</c:v>
                  </c:pt>
                  <c:pt idx="7">
                    <c:v>19.748060760160325</c:v>
                  </c:pt>
                  <c:pt idx="8">
                    <c:v>37.295963952523472</c:v>
                  </c:pt>
                  <c:pt idx="9">
                    <c:v>49.665120870693421</c:v>
                  </c:pt>
                  <c:pt idx="10">
                    <c:v>48.725396826798594</c:v>
                  </c:pt>
                  <c:pt idx="11">
                    <c:v>39.774946314551428</c:v>
                  </c:pt>
                  <c:pt idx="12">
                    <c:v>30.597842096245149</c:v>
                  </c:pt>
                  <c:pt idx="13">
                    <c:v>23.818477967460279</c:v>
                  </c:pt>
                  <c:pt idx="14">
                    <c:v>22.899102381312364</c:v>
                  </c:pt>
                  <c:pt idx="15">
                    <c:v>21.322126321495734</c:v>
                  </c:pt>
                  <c:pt idx="16">
                    <c:v>19.246546002276705</c:v>
                  </c:pt>
                  <c:pt idx="17">
                    <c:v>27.987503084401975</c:v>
                  </c:pt>
                  <c:pt idx="18">
                    <c:v>45.553592007253549</c:v>
                  </c:pt>
                  <c:pt idx="19">
                    <c:v>54.227530858248123</c:v>
                  </c:pt>
                  <c:pt idx="20">
                    <c:v>51.166365089339955</c:v>
                  </c:pt>
                  <c:pt idx="21">
                    <c:v>42.409673681266092</c:v>
                  </c:pt>
                  <c:pt idx="22">
                    <c:v>33.192830475605078</c:v>
                  </c:pt>
                  <c:pt idx="23">
                    <c:v>27.853354170341145</c:v>
                  </c:pt>
                  <c:pt idx="24">
                    <c:v>24.694064140380611</c:v>
                  </c:pt>
                  <c:pt idx="25">
                    <c:v>23.688681283030363</c:v>
                  </c:pt>
                  <c:pt idx="26">
                    <c:v>21.678528033203449</c:v>
                  </c:pt>
                  <c:pt idx="27">
                    <c:v>29.679136746505129</c:v>
                  </c:pt>
                  <c:pt idx="28">
                    <c:v>39.870102718095374</c:v>
                  </c:pt>
                  <c:pt idx="29">
                    <c:v>44.567891322176273</c:v>
                  </c:pt>
                  <c:pt idx="30">
                    <c:v>43.13039735506635</c:v>
                  </c:pt>
                  <c:pt idx="31">
                    <c:v>39.219037066909628</c:v>
                  </c:pt>
                  <c:pt idx="32">
                    <c:v>34.36259912227051</c:v>
                  </c:pt>
                  <c:pt idx="33">
                    <c:v>30.134213010715051</c:v>
                  </c:pt>
                  <c:pt idx="34">
                    <c:v>27.663897019860396</c:v>
                  </c:pt>
                  <c:pt idx="35">
                    <c:v>25.870730582109022</c:v>
                  </c:pt>
                  <c:pt idx="36">
                    <c:v>25.409363121662899</c:v>
                  </c:pt>
                  <c:pt idx="37">
                    <c:v>28.676629868094995</c:v>
                  </c:pt>
                  <c:pt idx="38">
                    <c:v>33.250145398534265</c:v>
                  </c:pt>
                  <c:pt idx="39">
                    <c:v>34.988842246852798</c:v>
                  </c:pt>
                  <c:pt idx="40">
                    <c:v>34.574646980531845</c:v>
                  </c:pt>
                  <c:pt idx="41">
                    <c:v>32.73595897679153</c:v>
                  </c:pt>
                  <c:pt idx="42">
                    <c:v>29.694692724557985</c:v>
                  </c:pt>
                  <c:pt idx="43">
                    <c:v>26.444962220994334</c:v>
                  </c:pt>
                  <c:pt idx="44">
                    <c:v>23.624098550285705</c:v>
                  </c:pt>
                  <c:pt idx="45">
                    <c:v>22.482607548447717</c:v>
                  </c:pt>
                  <c:pt idx="46">
                    <c:v>23.619624194360917</c:v>
                  </c:pt>
                  <c:pt idx="47">
                    <c:v>26.413994046997004</c:v>
                  </c:pt>
                  <c:pt idx="48">
                    <c:v>28.499954675039213</c:v>
                  </c:pt>
                  <c:pt idx="49">
                    <c:v>29.41888143079278</c:v>
                  </c:pt>
                  <c:pt idx="50">
                    <c:v>29.748126288665564</c:v>
                  </c:pt>
                  <c:pt idx="51">
                    <c:v>28.070452546401111</c:v>
                  </c:pt>
                  <c:pt idx="52">
                    <c:v>26.006389451247284</c:v>
                  </c:pt>
                  <c:pt idx="53">
                    <c:v>24.443678692530387</c:v>
                  </c:pt>
                  <c:pt idx="54">
                    <c:v>23.085871621933361</c:v>
                  </c:pt>
                  <c:pt idx="55">
                    <c:v>22.445415950991467</c:v>
                  </c:pt>
                  <c:pt idx="56">
                    <c:v>24.478493936079953</c:v>
                  </c:pt>
                  <c:pt idx="57">
                    <c:v>26.51590783487703</c:v>
                  </c:pt>
                  <c:pt idx="58">
                    <c:v>28.380317865311021</c:v>
                  </c:pt>
                  <c:pt idx="59">
                    <c:v>29.366313256889732</c:v>
                  </c:pt>
                  <c:pt idx="60">
                    <c:v>30.024879035076921</c:v>
                  </c:pt>
                </c:numCache>
              </c:numRef>
            </c:plus>
            <c:minus>
              <c:numRef>
                <c:f>'20211213WW30UMOL22_1xls'!$FL$21:$FL$81</c:f>
                <c:numCache>
                  <c:formatCode>General</c:formatCode>
                  <c:ptCount val="61"/>
                  <c:pt idx="0">
                    <c:v>58.239839779928282</c:v>
                  </c:pt>
                  <c:pt idx="1">
                    <c:v>45.363856420146817</c:v>
                  </c:pt>
                  <c:pt idx="2">
                    <c:v>30.698828718477081</c:v>
                  </c:pt>
                  <c:pt idx="3">
                    <c:v>23.099168231266038</c:v>
                  </c:pt>
                  <c:pt idx="4">
                    <c:v>22.618328988995685</c:v>
                  </c:pt>
                  <c:pt idx="5">
                    <c:v>22.401202838584041</c:v>
                  </c:pt>
                  <c:pt idx="6">
                    <c:v>18.971326420518078</c:v>
                  </c:pt>
                  <c:pt idx="7">
                    <c:v>19.748060760160325</c:v>
                  </c:pt>
                  <c:pt idx="8">
                    <c:v>37.295963952523472</c:v>
                  </c:pt>
                  <c:pt idx="9">
                    <c:v>49.665120870693421</c:v>
                  </c:pt>
                  <c:pt idx="10">
                    <c:v>48.725396826798594</c:v>
                  </c:pt>
                  <c:pt idx="11">
                    <c:v>39.774946314551428</c:v>
                  </c:pt>
                  <c:pt idx="12">
                    <c:v>30.597842096245149</c:v>
                  </c:pt>
                  <c:pt idx="13">
                    <c:v>23.818477967460279</c:v>
                  </c:pt>
                  <c:pt idx="14">
                    <c:v>22.899102381312364</c:v>
                  </c:pt>
                  <c:pt idx="15">
                    <c:v>21.322126321495734</c:v>
                  </c:pt>
                  <c:pt idx="16">
                    <c:v>19.246546002276705</c:v>
                  </c:pt>
                  <c:pt idx="17">
                    <c:v>27.987503084401975</c:v>
                  </c:pt>
                  <c:pt idx="18">
                    <c:v>45.553592007253549</c:v>
                  </c:pt>
                  <c:pt idx="19">
                    <c:v>54.227530858248123</c:v>
                  </c:pt>
                  <c:pt idx="20">
                    <c:v>51.166365089339955</c:v>
                  </c:pt>
                  <c:pt idx="21">
                    <c:v>42.409673681266092</c:v>
                  </c:pt>
                  <c:pt idx="22">
                    <c:v>33.192830475605078</c:v>
                  </c:pt>
                  <c:pt idx="23">
                    <c:v>27.853354170341145</c:v>
                  </c:pt>
                  <c:pt idx="24">
                    <c:v>24.694064140380611</c:v>
                  </c:pt>
                  <c:pt idx="25">
                    <c:v>23.688681283030363</c:v>
                  </c:pt>
                  <c:pt idx="26">
                    <c:v>21.678528033203449</c:v>
                  </c:pt>
                  <c:pt idx="27">
                    <c:v>29.679136746505129</c:v>
                  </c:pt>
                  <c:pt idx="28">
                    <c:v>39.870102718095374</c:v>
                  </c:pt>
                  <c:pt idx="29">
                    <c:v>44.567891322176273</c:v>
                  </c:pt>
                  <c:pt idx="30">
                    <c:v>43.13039735506635</c:v>
                  </c:pt>
                  <c:pt idx="31">
                    <c:v>39.219037066909628</c:v>
                  </c:pt>
                  <c:pt idx="32">
                    <c:v>34.36259912227051</c:v>
                  </c:pt>
                  <c:pt idx="33">
                    <c:v>30.134213010715051</c:v>
                  </c:pt>
                  <c:pt idx="34">
                    <c:v>27.663897019860396</c:v>
                  </c:pt>
                  <c:pt idx="35">
                    <c:v>25.870730582109022</c:v>
                  </c:pt>
                  <c:pt idx="36">
                    <c:v>25.409363121662899</c:v>
                  </c:pt>
                  <c:pt idx="37">
                    <c:v>28.676629868094995</c:v>
                  </c:pt>
                  <c:pt idx="38">
                    <c:v>33.250145398534265</c:v>
                  </c:pt>
                  <c:pt idx="39">
                    <c:v>34.988842246852798</c:v>
                  </c:pt>
                  <c:pt idx="40">
                    <c:v>34.574646980531845</c:v>
                  </c:pt>
                  <c:pt idx="41">
                    <c:v>32.73595897679153</c:v>
                  </c:pt>
                  <c:pt idx="42">
                    <c:v>29.694692724557985</c:v>
                  </c:pt>
                  <c:pt idx="43">
                    <c:v>26.444962220994334</c:v>
                  </c:pt>
                  <c:pt idx="44">
                    <c:v>23.624098550285705</c:v>
                  </c:pt>
                  <c:pt idx="45">
                    <c:v>22.482607548447717</c:v>
                  </c:pt>
                  <c:pt idx="46">
                    <c:v>23.619624194360917</c:v>
                  </c:pt>
                  <c:pt idx="47">
                    <c:v>26.413994046997004</c:v>
                  </c:pt>
                  <c:pt idx="48">
                    <c:v>28.499954675039213</c:v>
                  </c:pt>
                  <c:pt idx="49">
                    <c:v>29.41888143079278</c:v>
                  </c:pt>
                  <c:pt idx="50">
                    <c:v>29.748126288665564</c:v>
                  </c:pt>
                  <c:pt idx="51">
                    <c:v>28.070452546401111</c:v>
                  </c:pt>
                  <c:pt idx="52">
                    <c:v>26.006389451247284</c:v>
                  </c:pt>
                  <c:pt idx="53">
                    <c:v>24.443678692530387</c:v>
                  </c:pt>
                  <c:pt idx="54">
                    <c:v>23.085871621933361</c:v>
                  </c:pt>
                  <c:pt idx="55">
                    <c:v>22.445415950991467</c:v>
                  </c:pt>
                  <c:pt idx="56">
                    <c:v>24.478493936079953</c:v>
                  </c:pt>
                  <c:pt idx="57">
                    <c:v>26.51590783487703</c:v>
                  </c:pt>
                  <c:pt idx="58">
                    <c:v>28.380317865311021</c:v>
                  </c:pt>
                  <c:pt idx="59">
                    <c:v>29.366313256889732</c:v>
                  </c:pt>
                  <c:pt idx="60">
                    <c:v>30.024879035076921</c:v>
                  </c:pt>
                </c:numCache>
              </c:numRef>
            </c:minus>
            <c:spPr>
              <a:ln w="12700">
                <a:solidFill>
                  <a:srgbClr val="FF781D"/>
                </a:solidFill>
              </a:ln>
            </c:spPr>
          </c:errBars>
          <c:val>
            <c:numRef>
              <c:f>'20211213WW30UMOL22_1xls'!$FK$21:$FK$81</c:f>
              <c:numCache>
                <c:formatCode>General</c:formatCode>
                <c:ptCount val="61"/>
                <c:pt idx="0">
                  <c:v>873.45423076923078</c:v>
                </c:pt>
                <c:pt idx="1">
                  <c:v>858.245</c:v>
                </c:pt>
                <c:pt idx="2">
                  <c:v>726.99461538461537</c:v>
                </c:pt>
                <c:pt idx="3">
                  <c:v>571.35423076923075</c:v>
                </c:pt>
                <c:pt idx="4">
                  <c:v>474.99115384615379</c:v>
                </c:pt>
                <c:pt idx="5">
                  <c:v>403.84999999999997</c:v>
                </c:pt>
                <c:pt idx="6">
                  <c:v>371.71999999999997</c:v>
                </c:pt>
                <c:pt idx="7">
                  <c:v>424.97769230769222</c:v>
                </c:pt>
                <c:pt idx="8">
                  <c:v>566.43538461538458</c:v>
                </c:pt>
                <c:pt idx="9">
                  <c:v>725.52384615384631</c:v>
                </c:pt>
                <c:pt idx="10">
                  <c:v>807.62307692307695</c:v>
                </c:pt>
                <c:pt idx="11">
                  <c:v>814.90730769230765</c:v>
                </c:pt>
                <c:pt idx="12">
                  <c:v>739.72615384615369</c:v>
                </c:pt>
                <c:pt idx="13">
                  <c:v>628.14538461538461</c:v>
                </c:pt>
                <c:pt idx="14">
                  <c:v>536.05615384615385</c:v>
                </c:pt>
                <c:pt idx="15">
                  <c:v>468.45115384615389</c:v>
                </c:pt>
                <c:pt idx="16">
                  <c:v>452.48769230769227</c:v>
                </c:pt>
                <c:pt idx="17">
                  <c:v>510.75923076923078</c:v>
                </c:pt>
                <c:pt idx="18">
                  <c:v>626.55038461538447</c:v>
                </c:pt>
                <c:pt idx="19">
                  <c:v>749.47153846153844</c:v>
                </c:pt>
                <c:pt idx="20">
                  <c:v>808.9496153846153</c:v>
                </c:pt>
                <c:pt idx="21">
                  <c:v>804.4215384615386</c:v>
                </c:pt>
                <c:pt idx="22">
                  <c:v>744.70153846153835</c:v>
                </c:pt>
                <c:pt idx="23">
                  <c:v>666.91500000000008</c:v>
                </c:pt>
                <c:pt idx="24">
                  <c:v>593.82500000000005</c:v>
                </c:pt>
                <c:pt idx="25">
                  <c:v>569.20807692307699</c:v>
                </c:pt>
                <c:pt idx="26">
                  <c:v>576.77961538461545</c:v>
                </c:pt>
                <c:pt idx="27">
                  <c:v>615.67730769230775</c:v>
                </c:pt>
                <c:pt idx="28">
                  <c:v>657.4265384615386</c:v>
                </c:pt>
                <c:pt idx="29">
                  <c:v>699.94346153846175</c:v>
                </c:pt>
                <c:pt idx="30">
                  <c:v>731.34192307692319</c:v>
                </c:pt>
                <c:pt idx="31">
                  <c:v>745.08961538461529</c:v>
                </c:pt>
                <c:pt idx="32">
                  <c:v>726.02076923076925</c:v>
                </c:pt>
                <c:pt idx="33">
                  <c:v>676.02307692307704</c:v>
                </c:pt>
                <c:pt idx="34">
                  <c:v>619.81269230769226</c:v>
                </c:pt>
                <c:pt idx="35">
                  <c:v>596.68692307692299</c:v>
                </c:pt>
                <c:pt idx="36">
                  <c:v>631.69230769230774</c:v>
                </c:pt>
                <c:pt idx="37">
                  <c:v>681.11076923076917</c:v>
                </c:pt>
                <c:pt idx="38">
                  <c:v>699.21115384615382</c:v>
                </c:pt>
                <c:pt idx="39">
                  <c:v>695.92692307692312</c:v>
                </c:pt>
                <c:pt idx="40">
                  <c:v>694.81346153846164</c:v>
                </c:pt>
                <c:pt idx="41">
                  <c:v>687.91923076923081</c:v>
                </c:pt>
                <c:pt idx="42">
                  <c:v>674.801923076923</c:v>
                </c:pt>
                <c:pt idx="43">
                  <c:v>649.32884615384614</c:v>
                </c:pt>
                <c:pt idx="44">
                  <c:v>622.84807692307686</c:v>
                </c:pt>
                <c:pt idx="45">
                  <c:v>616.54384615384618</c:v>
                </c:pt>
                <c:pt idx="46">
                  <c:v>632.31807692307689</c:v>
                </c:pt>
                <c:pt idx="47">
                  <c:v>663.3407692307693</c:v>
                </c:pt>
                <c:pt idx="48">
                  <c:v>689.38730769230767</c:v>
                </c:pt>
                <c:pt idx="49">
                  <c:v>700.85384615384635</c:v>
                </c:pt>
                <c:pt idx="50">
                  <c:v>698.83961538461529</c:v>
                </c:pt>
                <c:pt idx="51">
                  <c:v>683.28192307692314</c:v>
                </c:pt>
                <c:pt idx="52">
                  <c:v>661.11653846153843</c:v>
                </c:pt>
                <c:pt idx="53">
                  <c:v>634.92615384615397</c:v>
                </c:pt>
                <c:pt idx="54">
                  <c:v>608.93692307692299</c:v>
                </c:pt>
                <c:pt idx="55">
                  <c:v>605.70653846153846</c:v>
                </c:pt>
                <c:pt idx="56">
                  <c:v>625.47038461538455</c:v>
                </c:pt>
                <c:pt idx="57">
                  <c:v>649.48</c:v>
                </c:pt>
                <c:pt idx="58">
                  <c:v>672.20346153846162</c:v>
                </c:pt>
                <c:pt idx="59">
                  <c:v>681.58961538461529</c:v>
                </c:pt>
                <c:pt idx="60">
                  <c:v>679.4003846153847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0408-47AD-93AE-EC8B73D8B0AA}"/>
            </c:ext>
          </c:extLst>
        </c:ser>
        <c:ser>
          <c:idx val="2"/>
          <c:order val="2"/>
          <c:tx>
            <c:strRef>
              <c:f>'20211213WW30UMOL22_1xls'!$FO$7</c:f>
              <c:strCache>
                <c:ptCount val="1"/>
                <c:pt idx="0">
                  <c:v>pTOC1:TOC1-GFP/t1 #2</c:v>
                </c:pt>
              </c:strCache>
            </c:strRef>
          </c:tx>
          <c:spPr>
            <a:ln w="9525" cap="rnd">
              <a:solidFill>
                <a:srgbClr val="A5A5A5"/>
              </a:solidFill>
              <a:round/>
            </a:ln>
            <a:effectLst/>
          </c:spPr>
          <c:marker>
            <c:symbol val="square"/>
            <c:size val="5"/>
            <c:spPr>
              <a:noFill/>
              <a:ln w="12700">
                <a:solidFill>
                  <a:srgbClr val="FF99CC"/>
                </a:solidFill>
              </a:ln>
            </c:spPr>
          </c:marker>
          <c:errBars>
            <c:errDir val="y"/>
            <c:errBarType val="both"/>
            <c:errValType val="cust"/>
            <c:noEndCap val="1"/>
            <c:plus>
              <c:numRef>
                <c:f>'20211213WW30UMOL22_1xls'!$FP$21:$FP$81</c:f>
                <c:numCache>
                  <c:formatCode>General</c:formatCode>
                  <c:ptCount val="61"/>
                  <c:pt idx="0">
                    <c:v>49.848112001953886</c:v>
                  </c:pt>
                  <c:pt idx="1">
                    <c:v>67.718457570491893</c:v>
                  </c:pt>
                  <c:pt idx="2">
                    <c:v>71.278756761934758</c:v>
                  </c:pt>
                  <c:pt idx="3">
                    <c:v>65.466132812836733</c:v>
                  </c:pt>
                  <c:pt idx="4">
                    <c:v>52.722392709099026</c:v>
                  </c:pt>
                  <c:pt idx="5">
                    <c:v>40.376531064205246</c:v>
                  </c:pt>
                  <c:pt idx="6">
                    <c:v>35.436220988273107</c:v>
                  </c:pt>
                  <c:pt idx="7">
                    <c:v>31.820221455032243</c:v>
                  </c:pt>
                  <c:pt idx="8">
                    <c:v>28.276750179938155</c:v>
                  </c:pt>
                  <c:pt idx="9">
                    <c:v>23.953692695339228</c:v>
                  </c:pt>
                  <c:pt idx="10">
                    <c:v>25.819431008049051</c:v>
                  </c:pt>
                  <c:pt idx="11">
                    <c:v>41.998696934066267</c:v>
                  </c:pt>
                  <c:pt idx="12">
                    <c:v>61.488388516184003</c:v>
                  </c:pt>
                  <c:pt idx="13">
                    <c:v>69.872570351064041</c:v>
                  </c:pt>
                  <c:pt idx="14">
                    <c:v>69.874902267997015</c:v>
                  </c:pt>
                  <c:pt idx="15">
                    <c:v>64.252557449401635</c:v>
                  </c:pt>
                  <c:pt idx="16">
                    <c:v>55.146724639565782</c:v>
                  </c:pt>
                  <c:pt idx="17">
                    <c:v>45.408504731399574</c:v>
                  </c:pt>
                  <c:pt idx="18">
                    <c:v>40.245718253155246</c:v>
                  </c:pt>
                  <c:pt idx="19">
                    <c:v>37.649548626456031</c:v>
                  </c:pt>
                  <c:pt idx="20">
                    <c:v>33.742946910932943</c:v>
                  </c:pt>
                  <c:pt idx="21">
                    <c:v>31.577689161835806</c:v>
                  </c:pt>
                  <c:pt idx="22">
                    <c:v>34.058470464061934</c:v>
                  </c:pt>
                  <c:pt idx="23">
                    <c:v>44.319131665356196</c:v>
                  </c:pt>
                  <c:pt idx="24">
                    <c:v>54.446646719805813</c:v>
                  </c:pt>
                  <c:pt idx="25">
                    <c:v>61.412463614400188</c:v>
                  </c:pt>
                  <c:pt idx="26">
                    <c:v>62.490480832622829</c:v>
                  </c:pt>
                  <c:pt idx="27">
                    <c:v>59.369992310665253</c:v>
                  </c:pt>
                  <c:pt idx="28">
                    <c:v>53.556186356043597</c:v>
                  </c:pt>
                  <c:pt idx="29">
                    <c:v>47.475995143964951</c:v>
                  </c:pt>
                  <c:pt idx="30">
                    <c:v>42.392674358472412</c:v>
                  </c:pt>
                  <c:pt idx="31">
                    <c:v>39.835954872205001</c:v>
                  </c:pt>
                  <c:pt idx="32">
                    <c:v>37.723759543184137</c:v>
                  </c:pt>
                  <c:pt idx="33">
                    <c:v>36.766113991404012</c:v>
                  </c:pt>
                  <c:pt idx="34">
                    <c:v>37.654403038224189</c:v>
                  </c:pt>
                  <c:pt idx="35">
                    <c:v>40.883673128775733</c:v>
                  </c:pt>
                  <c:pt idx="36">
                    <c:v>46.425905966650852</c:v>
                  </c:pt>
                  <c:pt idx="37">
                    <c:v>52.677673104311587</c:v>
                  </c:pt>
                  <c:pt idx="38">
                    <c:v>55.713638708817548</c:v>
                  </c:pt>
                  <c:pt idx="39">
                    <c:v>55.60976823044934</c:v>
                  </c:pt>
                  <c:pt idx="40">
                    <c:v>53.355161187414815</c:v>
                  </c:pt>
                  <c:pt idx="41">
                    <c:v>50.600704737090958</c:v>
                  </c:pt>
                  <c:pt idx="42">
                    <c:v>47.47789852264993</c:v>
                  </c:pt>
                  <c:pt idx="43">
                    <c:v>45.216108062283467</c:v>
                  </c:pt>
                  <c:pt idx="44">
                    <c:v>43.881392304692149</c:v>
                  </c:pt>
                  <c:pt idx="45">
                    <c:v>42.484111805890691</c:v>
                  </c:pt>
                  <c:pt idx="46">
                    <c:v>40.910684613599862</c:v>
                  </c:pt>
                  <c:pt idx="47">
                    <c:v>40.593731604572191</c:v>
                  </c:pt>
                  <c:pt idx="48">
                    <c:v>42.496880361579407</c:v>
                  </c:pt>
                  <c:pt idx="49">
                    <c:v>45.626727628492219</c:v>
                  </c:pt>
                  <c:pt idx="50">
                    <c:v>50.722477148047425</c:v>
                  </c:pt>
                  <c:pt idx="51">
                    <c:v>55.160340513153663</c:v>
                  </c:pt>
                  <c:pt idx="52">
                    <c:v>57.844918230145588</c:v>
                  </c:pt>
                  <c:pt idx="53">
                    <c:v>56.744732257528248</c:v>
                  </c:pt>
                  <c:pt idx="54">
                    <c:v>53.789224080297906</c:v>
                  </c:pt>
                  <c:pt idx="55">
                    <c:v>51.679037667722667</c:v>
                  </c:pt>
                  <c:pt idx="56">
                    <c:v>48.214483881251198</c:v>
                  </c:pt>
                  <c:pt idx="57">
                    <c:v>45.275645999955692</c:v>
                  </c:pt>
                  <c:pt idx="58">
                    <c:v>43.734959955591442</c:v>
                  </c:pt>
                  <c:pt idx="59">
                    <c:v>43.494104623926248</c:v>
                  </c:pt>
                  <c:pt idx="60">
                    <c:v>44.104690363506414</c:v>
                  </c:pt>
                </c:numCache>
              </c:numRef>
            </c:plus>
            <c:minus>
              <c:numRef>
                <c:f>'20211213WW30UMOL22_1xls'!$FP$21:$FP$81</c:f>
                <c:numCache>
                  <c:formatCode>General</c:formatCode>
                  <c:ptCount val="61"/>
                  <c:pt idx="0">
                    <c:v>49.848112001953886</c:v>
                  </c:pt>
                  <c:pt idx="1">
                    <c:v>67.718457570491893</c:v>
                  </c:pt>
                  <c:pt idx="2">
                    <c:v>71.278756761934758</c:v>
                  </c:pt>
                  <c:pt idx="3">
                    <c:v>65.466132812836733</c:v>
                  </c:pt>
                  <c:pt idx="4">
                    <c:v>52.722392709099026</c:v>
                  </c:pt>
                  <c:pt idx="5">
                    <c:v>40.376531064205246</c:v>
                  </c:pt>
                  <c:pt idx="6">
                    <c:v>35.436220988273107</c:v>
                  </c:pt>
                  <c:pt idx="7">
                    <c:v>31.820221455032243</c:v>
                  </c:pt>
                  <c:pt idx="8">
                    <c:v>28.276750179938155</c:v>
                  </c:pt>
                  <c:pt idx="9">
                    <c:v>23.953692695339228</c:v>
                  </c:pt>
                  <c:pt idx="10">
                    <c:v>25.819431008049051</c:v>
                  </c:pt>
                  <c:pt idx="11">
                    <c:v>41.998696934066267</c:v>
                  </c:pt>
                  <c:pt idx="12">
                    <c:v>61.488388516184003</c:v>
                  </c:pt>
                  <c:pt idx="13">
                    <c:v>69.872570351064041</c:v>
                  </c:pt>
                  <c:pt idx="14">
                    <c:v>69.874902267997015</c:v>
                  </c:pt>
                  <c:pt idx="15">
                    <c:v>64.252557449401635</c:v>
                  </c:pt>
                  <c:pt idx="16">
                    <c:v>55.146724639565782</c:v>
                  </c:pt>
                  <c:pt idx="17">
                    <c:v>45.408504731399574</c:v>
                  </c:pt>
                  <c:pt idx="18">
                    <c:v>40.245718253155246</c:v>
                  </c:pt>
                  <c:pt idx="19">
                    <c:v>37.649548626456031</c:v>
                  </c:pt>
                  <c:pt idx="20">
                    <c:v>33.742946910932943</c:v>
                  </c:pt>
                  <c:pt idx="21">
                    <c:v>31.577689161835806</c:v>
                  </c:pt>
                  <c:pt idx="22">
                    <c:v>34.058470464061934</c:v>
                  </c:pt>
                  <c:pt idx="23">
                    <c:v>44.319131665356196</c:v>
                  </c:pt>
                  <c:pt idx="24">
                    <c:v>54.446646719805813</c:v>
                  </c:pt>
                  <c:pt idx="25">
                    <c:v>61.412463614400188</c:v>
                  </c:pt>
                  <c:pt idx="26">
                    <c:v>62.490480832622829</c:v>
                  </c:pt>
                  <c:pt idx="27">
                    <c:v>59.369992310665253</c:v>
                  </c:pt>
                  <c:pt idx="28">
                    <c:v>53.556186356043597</c:v>
                  </c:pt>
                  <c:pt idx="29">
                    <c:v>47.475995143964951</c:v>
                  </c:pt>
                  <c:pt idx="30">
                    <c:v>42.392674358472412</c:v>
                  </c:pt>
                  <c:pt idx="31">
                    <c:v>39.835954872205001</c:v>
                  </c:pt>
                  <c:pt idx="32">
                    <c:v>37.723759543184137</c:v>
                  </c:pt>
                  <c:pt idx="33">
                    <c:v>36.766113991404012</c:v>
                  </c:pt>
                  <c:pt idx="34">
                    <c:v>37.654403038224189</c:v>
                  </c:pt>
                  <c:pt idx="35">
                    <c:v>40.883673128775733</c:v>
                  </c:pt>
                  <c:pt idx="36">
                    <c:v>46.425905966650852</c:v>
                  </c:pt>
                  <c:pt idx="37">
                    <c:v>52.677673104311587</c:v>
                  </c:pt>
                  <c:pt idx="38">
                    <c:v>55.713638708817548</c:v>
                  </c:pt>
                  <c:pt idx="39">
                    <c:v>55.60976823044934</c:v>
                  </c:pt>
                  <c:pt idx="40">
                    <c:v>53.355161187414815</c:v>
                  </c:pt>
                  <c:pt idx="41">
                    <c:v>50.600704737090958</c:v>
                  </c:pt>
                  <c:pt idx="42">
                    <c:v>47.47789852264993</c:v>
                  </c:pt>
                  <c:pt idx="43">
                    <c:v>45.216108062283467</c:v>
                  </c:pt>
                  <c:pt idx="44">
                    <c:v>43.881392304692149</c:v>
                  </c:pt>
                  <c:pt idx="45">
                    <c:v>42.484111805890691</c:v>
                  </c:pt>
                  <c:pt idx="46">
                    <c:v>40.910684613599862</c:v>
                  </c:pt>
                  <c:pt idx="47">
                    <c:v>40.593731604572191</c:v>
                  </c:pt>
                  <c:pt idx="48">
                    <c:v>42.496880361579407</c:v>
                  </c:pt>
                  <c:pt idx="49">
                    <c:v>45.626727628492219</c:v>
                  </c:pt>
                  <c:pt idx="50">
                    <c:v>50.722477148047425</c:v>
                  </c:pt>
                  <c:pt idx="51">
                    <c:v>55.160340513153663</c:v>
                  </c:pt>
                  <c:pt idx="52">
                    <c:v>57.844918230145588</c:v>
                  </c:pt>
                  <c:pt idx="53">
                    <c:v>56.744732257528248</c:v>
                  </c:pt>
                  <c:pt idx="54">
                    <c:v>53.789224080297906</c:v>
                  </c:pt>
                  <c:pt idx="55">
                    <c:v>51.679037667722667</c:v>
                  </c:pt>
                  <c:pt idx="56">
                    <c:v>48.214483881251198</c:v>
                  </c:pt>
                  <c:pt idx="57">
                    <c:v>45.275645999955692</c:v>
                  </c:pt>
                  <c:pt idx="58">
                    <c:v>43.734959955591442</c:v>
                  </c:pt>
                  <c:pt idx="59">
                    <c:v>43.494104623926248</c:v>
                  </c:pt>
                  <c:pt idx="60">
                    <c:v>44.104690363506414</c:v>
                  </c:pt>
                </c:numCache>
              </c:numRef>
            </c:minus>
            <c:spPr>
              <a:ln w="12700">
                <a:solidFill>
                  <a:srgbClr val="FF99CC"/>
                </a:solidFill>
              </a:ln>
            </c:spPr>
          </c:errBars>
          <c:val>
            <c:numRef>
              <c:f>'20211213WW30UMOL22_1xls'!$FO$21:$FO$81</c:f>
              <c:numCache>
                <c:formatCode>General</c:formatCode>
                <c:ptCount val="61"/>
                <c:pt idx="0">
                  <c:v>731.83407407407401</c:v>
                </c:pt>
                <c:pt idx="1">
                  <c:v>994.63333333333298</c:v>
                </c:pt>
                <c:pt idx="2">
                  <c:v>1103.5166666666667</c:v>
                </c:pt>
                <c:pt idx="3">
                  <c:v>1034.4525925925925</c:v>
                </c:pt>
                <c:pt idx="4">
                  <c:v>842.52111111111105</c:v>
                </c:pt>
                <c:pt idx="5">
                  <c:v>655.22222222222206</c:v>
                </c:pt>
                <c:pt idx="6">
                  <c:v>564.87444444444429</c:v>
                </c:pt>
                <c:pt idx="7">
                  <c:v>475.53333333333325</c:v>
                </c:pt>
                <c:pt idx="8">
                  <c:v>406.23740740740732</c:v>
                </c:pt>
                <c:pt idx="9">
                  <c:v>390.99185185185183</c:v>
                </c:pt>
                <c:pt idx="10">
                  <c:v>471.08851851851841</c:v>
                </c:pt>
                <c:pt idx="11">
                  <c:v>669.21666666666658</c:v>
                </c:pt>
                <c:pt idx="12">
                  <c:v>904.69777777777779</c:v>
                </c:pt>
                <c:pt idx="13">
                  <c:v>1060.53</c:v>
                </c:pt>
                <c:pt idx="14">
                  <c:v>1092.2181481481477</c:v>
                </c:pt>
                <c:pt idx="15">
                  <c:v>1016.6862962962963</c:v>
                </c:pt>
                <c:pt idx="16">
                  <c:v>883.83814814814821</c:v>
                </c:pt>
                <c:pt idx="17">
                  <c:v>744.89703703703708</c:v>
                </c:pt>
                <c:pt idx="18">
                  <c:v>655.86518518518517</c:v>
                </c:pt>
                <c:pt idx="19">
                  <c:v>600.54111111111115</c:v>
                </c:pt>
                <c:pt idx="20">
                  <c:v>552.01037037037031</c:v>
                </c:pt>
                <c:pt idx="21">
                  <c:v>545.09888888888884</c:v>
                </c:pt>
                <c:pt idx="22">
                  <c:v>591.03555555555556</c:v>
                </c:pt>
                <c:pt idx="23">
                  <c:v>698.1229629629629</c:v>
                </c:pt>
                <c:pt idx="24">
                  <c:v>819.90333333333331</c:v>
                </c:pt>
                <c:pt idx="25">
                  <c:v>918.85185185185196</c:v>
                </c:pt>
                <c:pt idx="26">
                  <c:v>953.5548148148149</c:v>
                </c:pt>
                <c:pt idx="27">
                  <c:v>926.48592592592593</c:v>
                </c:pt>
                <c:pt idx="28">
                  <c:v>848.31962962962962</c:v>
                </c:pt>
                <c:pt idx="29">
                  <c:v>764.91222222222223</c:v>
                </c:pt>
                <c:pt idx="30">
                  <c:v>691.65296296296287</c:v>
                </c:pt>
                <c:pt idx="31">
                  <c:v>664.31185185185177</c:v>
                </c:pt>
                <c:pt idx="32">
                  <c:v>654.15259259259244</c:v>
                </c:pt>
                <c:pt idx="33">
                  <c:v>654.10037037037034</c:v>
                </c:pt>
                <c:pt idx="34">
                  <c:v>661.16592592592588</c:v>
                </c:pt>
                <c:pt idx="35">
                  <c:v>688.46185185185186</c:v>
                </c:pt>
                <c:pt idx="36">
                  <c:v>743.71555555555562</c:v>
                </c:pt>
                <c:pt idx="37">
                  <c:v>800.46222222222218</c:v>
                </c:pt>
                <c:pt idx="38">
                  <c:v>827.8066666666665</c:v>
                </c:pt>
                <c:pt idx="39">
                  <c:v>835.10962962962969</c:v>
                </c:pt>
                <c:pt idx="40">
                  <c:v>819.35925925925926</c:v>
                </c:pt>
                <c:pt idx="41">
                  <c:v>784.47703703703712</c:v>
                </c:pt>
                <c:pt idx="42">
                  <c:v>751.94925925925918</c:v>
                </c:pt>
                <c:pt idx="43">
                  <c:v>736.11222222222216</c:v>
                </c:pt>
                <c:pt idx="44">
                  <c:v>725.04333333333329</c:v>
                </c:pt>
                <c:pt idx="45">
                  <c:v>707.71888888888907</c:v>
                </c:pt>
                <c:pt idx="46">
                  <c:v>685.43740740740759</c:v>
                </c:pt>
                <c:pt idx="47">
                  <c:v>671.96333333333337</c:v>
                </c:pt>
                <c:pt idx="48">
                  <c:v>672.19185185185188</c:v>
                </c:pt>
                <c:pt idx="49">
                  <c:v>691.71814814814832</c:v>
                </c:pt>
                <c:pt idx="50">
                  <c:v>734.20333333333326</c:v>
                </c:pt>
                <c:pt idx="51">
                  <c:v>779.3366666666667</c:v>
                </c:pt>
                <c:pt idx="52">
                  <c:v>813.80111111111103</c:v>
                </c:pt>
                <c:pt idx="53">
                  <c:v>829.88703703703732</c:v>
                </c:pt>
                <c:pt idx="54">
                  <c:v>813.53222222222223</c:v>
                </c:pt>
                <c:pt idx="55">
                  <c:v>792.11407407407398</c:v>
                </c:pt>
                <c:pt idx="56">
                  <c:v>755.12222222222204</c:v>
                </c:pt>
                <c:pt idx="57">
                  <c:v>723.47851851851863</c:v>
                </c:pt>
                <c:pt idx="58">
                  <c:v>698.84222222222229</c:v>
                </c:pt>
                <c:pt idx="59">
                  <c:v>691.00999999999988</c:v>
                </c:pt>
                <c:pt idx="60">
                  <c:v>686.9944444444445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0408-47AD-93AE-EC8B73D8B0AA}"/>
            </c:ext>
          </c:extLst>
        </c:ser>
        <c:ser>
          <c:idx val="3"/>
          <c:order val="3"/>
          <c:tx>
            <c:strRef>
              <c:f>'20211213WW30UMOL22_1xls'!$FS$7</c:f>
              <c:strCache>
                <c:ptCount val="1"/>
                <c:pt idx="0">
                  <c:v>pTOC1:5X-GFP/t1 #2</c:v>
                </c:pt>
              </c:strCache>
            </c:strRef>
          </c:tx>
          <c:spPr>
            <a:ln w="9525" cap="rnd">
              <a:solidFill>
                <a:srgbClr val="A5A5A5"/>
              </a:solidFill>
              <a:round/>
            </a:ln>
            <a:effectLst/>
          </c:spPr>
          <c:marker>
            <c:symbol val="triangle"/>
            <c:size val="5"/>
            <c:spPr>
              <a:noFill/>
              <a:ln w="12700">
                <a:solidFill>
                  <a:srgbClr val="C0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1"/>
            <c:plus>
              <c:numRef>
                <c:f>'20211213WW30UMOL22_1xls'!$FT$21:$FT$81</c:f>
                <c:numCache>
                  <c:formatCode>General</c:formatCode>
                  <c:ptCount val="61"/>
                  <c:pt idx="0">
                    <c:v>25.446824173572402</c:v>
                  </c:pt>
                  <c:pt idx="1">
                    <c:v>30.97223853826198</c:v>
                  </c:pt>
                  <c:pt idx="2">
                    <c:v>23.83531319294805</c:v>
                  </c:pt>
                  <c:pt idx="3">
                    <c:v>15.260135599489018</c:v>
                  </c:pt>
                  <c:pt idx="4">
                    <c:v>10.513332693839812</c:v>
                  </c:pt>
                  <c:pt idx="5">
                    <c:v>9.1231656111916823</c:v>
                  </c:pt>
                  <c:pt idx="6">
                    <c:v>10.14971676004663</c:v>
                  </c:pt>
                  <c:pt idx="7">
                    <c:v>9.4457094708806366</c:v>
                  </c:pt>
                  <c:pt idx="8">
                    <c:v>7.609280784965037</c:v>
                  </c:pt>
                  <c:pt idx="9">
                    <c:v>8.2383737235857204</c:v>
                  </c:pt>
                  <c:pt idx="10">
                    <c:v>19.334230438089204</c:v>
                  </c:pt>
                  <c:pt idx="11">
                    <c:v>27.500899802062417</c:v>
                  </c:pt>
                  <c:pt idx="12">
                    <c:v>26.486969256754769</c:v>
                  </c:pt>
                  <c:pt idx="13">
                    <c:v>20.308235676297087</c:v>
                  </c:pt>
                  <c:pt idx="14">
                    <c:v>14.718950370990111</c:v>
                  </c:pt>
                  <c:pt idx="15">
                    <c:v>11.26655048934655</c:v>
                  </c:pt>
                  <c:pt idx="16">
                    <c:v>9.6264796627961111</c:v>
                  </c:pt>
                  <c:pt idx="17">
                    <c:v>9.6811692750692497</c:v>
                  </c:pt>
                  <c:pt idx="18">
                    <c:v>8.5076824526998003</c:v>
                  </c:pt>
                  <c:pt idx="19">
                    <c:v>7.6473126919385015</c:v>
                  </c:pt>
                  <c:pt idx="20">
                    <c:v>13.238878873545298</c:v>
                  </c:pt>
                  <c:pt idx="21">
                    <c:v>21.863202683907801</c:v>
                  </c:pt>
                  <c:pt idx="22">
                    <c:v>26.032987617897728</c:v>
                  </c:pt>
                  <c:pt idx="23">
                    <c:v>23.828758701130255</c:v>
                  </c:pt>
                  <c:pt idx="24">
                    <c:v>19.740399506907359</c:v>
                  </c:pt>
                  <c:pt idx="25">
                    <c:v>15.948958485963308</c:v>
                  </c:pt>
                  <c:pt idx="26">
                    <c:v>12.500602344777194</c:v>
                  </c:pt>
                  <c:pt idx="27">
                    <c:v>10.242628178353531</c:v>
                  </c:pt>
                  <c:pt idx="28">
                    <c:v>9.4112450465091371</c:v>
                  </c:pt>
                  <c:pt idx="29">
                    <c:v>8.1317247138897102</c:v>
                  </c:pt>
                  <c:pt idx="30">
                    <c:v>7.7091388236537988</c:v>
                  </c:pt>
                  <c:pt idx="31">
                    <c:v>12.531482473208538</c:v>
                  </c:pt>
                  <c:pt idx="32">
                    <c:v>17.427079917974073</c:v>
                  </c:pt>
                  <c:pt idx="33">
                    <c:v>19.761881089942349</c:v>
                  </c:pt>
                  <c:pt idx="34">
                    <c:v>18.734457398541196</c:v>
                  </c:pt>
                  <c:pt idx="35">
                    <c:v>19.575824444917373</c:v>
                  </c:pt>
                  <c:pt idx="36">
                    <c:v>17.776004209018705</c:v>
                  </c:pt>
                  <c:pt idx="37">
                    <c:v>15.392572693678437</c:v>
                  </c:pt>
                  <c:pt idx="38">
                    <c:v>12.99370997146255</c:v>
                  </c:pt>
                  <c:pt idx="39">
                    <c:v>10.97056327676329</c:v>
                  </c:pt>
                  <c:pt idx="40">
                    <c:v>8.8001535825758168</c:v>
                  </c:pt>
                  <c:pt idx="41">
                    <c:v>8.3804526081327744</c:v>
                  </c:pt>
                  <c:pt idx="42">
                    <c:v>10.384008242365415</c:v>
                  </c:pt>
                  <c:pt idx="43">
                    <c:v>13.666744600754255</c:v>
                  </c:pt>
                  <c:pt idx="44">
                    <c:v>16.393598293055724</c:v>
                  </c:pt>
                  <c:pt idx="45">
                    <c:v>18.687552313912196</c:v>
                  </c:pt>
                  <c:pt idx="46">
                    <c:v>19.679473157816787</c:v>
                  </c:pt>
                  <c:pt idx="47">
                    <c:v>19.212335155729807</c:v>
                  </c:pt>
                  <c:pt idx="48">
                    <c:v>16.936867530670416</c:v>
                  </c:pt>
                  <c:pt idx="49">
                    <c:v>13.410632280166542</c:v>
                  </c:pt>
                  <c:pt idx="50">
                    <c:v>10.162846991972652</c:v>
                  </c:pt>
                  <c:pt idx="51">
                    <c:v>8.3736891154594666</c:v>
                  </c:pt>
                  <c:pt idx="52">
                    <c:v>8.1395688558894488</c:v>
                  </c:pt>
                  <c:pt idx="53">
                    <c:v>9.0774793235689852</c:v>
                  </c:pt>
                  <c:pt idx="54">
                    <c:v>10.194428466731994</c:v>
                  </c:pt>
                  <c:pt idx="55">
                    <c:v>12.580527856019945</c:v>
                  </c:pt>
                  <c:pt idx="56">
                    <c:v>15.547268124532172</c:v>
                  </c:pt>
                  <c:pt idx="57">
                    <c:v>16.902026790688065</c:v>
                  </c:pt>
                  <c:pt idx="58">
                    <c:v>18.138365357120914</c:v>
                  </c:pt>
                  <c:pt idx="59">
                    <c:v>17.119893296548604</c:v>
                  </c:pt>
                  <c:pt idx="60">
                    <c:v>14.716298652098317</c:v>
                  </c:pt>
                </c:numCache>
              </c:numRef>
            </c:plus>
            <c:minus>
              <c:numRef>
                <c:f>'20211213WW30UMOL22_1xls'!$FT$21:$FT$81</c:f>
                <c:numCache>
                  <c:formatCode>General</c:formatCode>
                  <c:ptCount val="61"/>
                  <c:pt idx="0">
                    <c:v>25.446824173572402</c:v>
                  </c:pt>
                  <c:pt idx="1">
                    <c:v>30.97223853826198</c:v>
                  </c:pt>
                  <c:pt idx="2">
                    <c:v>23.83531319294805</c:v>
                  </c:pt>
                  <c:pt idx="3">
                    <c:v>15.260135599489018</c:v>
                  </c:pt>
                  <c:pt idx="4">
                    <c:v>10.513332693839812</c:v>
                  </c:pt>
                  <c:pt idx="5">
                    <c:v>9.1231656111916823</c:v>
                  </c:pt>
                  <c:pt idx="6">
                    <c:v>10.14971676004663</c:v>
                  </c:pt>
                  <c:pt idx="7">
                    <c:v>9.4457094708806366</c:v>
                  </c:pt>
                  <c:pt idx="8">
                    <c:v>7.609280784965037</c:v>
                  </c:pt>
                  <c:pt idx="9">
                    <c:v>8.2383737235857204</c:v>
                  </c:pt>
                  <c:pt idx="10">
                    <c:v>19.334230438089204</c:v>
                  </c:pt>
                  <c:pt idx="11">
                    <c:v>27.500899802062417</c:v>
                  </c:pt>
                  <c:pt idx="12">
                    <c:v>26.486969256754769</c:v>
                  </c:pt>
                  <c:pt idx="13">
                    <c:v>20.308235676297087</c:v>
                  </c:pt>
                  <c:pt idx="14">
                    <c:v>14.718950370990111</c:v>
                  </c:pt>
                  <c:pt idx="15">
                    <c:v>11.26655048934655</c:v>
                  </c:pt>
                  <c:pt idx="16">
                    <c:v>9.6264796627961111</c:v>
                  </c:pt>
                  <c:pt idx="17">
                    <c:v>9.6811692750692497</c:v>
                  </c:pt>
                  <c:pt idx="18">
                    <c:v>8.5076824526998003</c:v>
                  </c:pt>
                  <c:pt idx="19">
                    <c:v>7.6473126919385015</c:v>
                  </c:pt>
                  <c:pt idx="20">
                    <c:v>13.238878873545298</c:v>
                  </c:pt>
                  <c:pt idx="21">
                    <c:v>21.863202683907801</c:v>
                  </c:pt>
                  <c:pt idx="22">
                    <c:v>26.032987617897728</c:v>
                  </c:pt>
                  <c:pt idx="23">
                    <c:v>23.828758701130255</c:v>
                  </c:pt>
                  <c:pt idx="24">
                    <c:v>19.740399506907359</c:v>
                  </c:pt>
                  <c:pt idx="25">
                    <c:v>15.948958485963308</c:v>
                  </c:pt>
                  <c:pt idx="26">
                    <c:v>12.500602344777194</c:v>
                  </c:pt>
                  <c:pt idx="27">
                    <c:v>10.242628178353531</c:v>
                  </c:pt>
                  <c:pt idx="28">
                    <c:v>9.4112450465091371</c:v>
                  </c:pt>
                  <c:pt idx="29">
                    <c:v>8.1317247138897102</c:v>
                  </c:pt>
                  <c:pt idx="30">
                    <c:v>7.7091388236537988</c:v>
                  </c:pt>
                  <c:pt idx="31">
                    <c:v>12.531482473208538</c:v>
                  </c:pt>
                  <c:pt idx="32">
                    <c:v>17.427079917974073</c:v>
                  </c:pt>
                  <c:pt idx="33">
                    <c:v>19.761881089942349</c:v>
                  </c:pt>
                  <c:pt idx="34">
                    <c:v>18.734457398541196</c:v>
                  </c:pt>
                  <c:pt idx="35">
                    <c:v>19.575824444917373</c:v>
                  </c:pt>
                  <c:pt idx="36">
                    <c:v>17.776004209018705</c:v>
                  </c:pt>
                  <c:pt idx="37">
                    <c:v>15.392572693678437</c:v>
                  </c:pt>
                  <c:pt idx="38">
                    <c:v>12.99370997146255</c:v>
                  </c:pt>
                  <c:pt idx="39">
                    <c:v>10.97056327676329</c:v>
                  </c:pt>
                  <c:pt idx="40">
                    <c:v>8.8001535825758168</c:v>
                  </c:pt>
                  <c:pt idx="41">
                    <c:v>8.3804526081327744</c:v>
                  </c:pt>
                  <c:pt idx="42">
                    <c:v>10.384008242365415</c:v>
                  </c:pt>
                  <c:pt idx="43">
                    <c:v>13.666744600754255</c:v>
                  </c:pt>
                  <c:pt idx="44">
                    <c:v>16.393598293055724</c:v>
                  </c:pt>
                  <c:pt idx="45">
                    <c:v>18.687552313912196</c:v>
                  </c:pt>
                  <c:pt idx="46">
                    <c:v>19.679473157816787</c:v>
                  </c:pt>
                  <c:pt idx="47">
                    <c:v>19.212335155729807</c:v>
                  </c:pt>
                  <c:pt idx="48">
                    <c:v>16.936867530670416</c:v>
                  </c:pt>
                  <c:pt idx="49">
                    <c:v>13.410632280166542</c:v>
                  </c:pt>
                  <c:pt idx="50">
                    <c:v>10.162846991972652</c:v>
                  </c:pt>
                  <c:pt idx="51">
                    <c:v>8.3736891154594666</c:v>
                  </c:pt>
                  <c:pt idx="52">
                    <c:v>8.1395688558894488</c:v>
                  </c:pt>
                  <c:pt idx="53">
                    <c:v>9.0774793235689852</c:v>
                  </c:pt>
                  <c:pt idx="54">
                    <c:v>10.194428466731994</c:v>
                  </c:pt>
                  <c:pt idx="55">
                    <c:v>12.580527856019945</c:v>
                  </c:pt>
                  <c:pt idx="56">
                    <c:v>15.547268124532172</c:v>
                  </c:pt>
                  <c:pt idx="57">
                    <c:v>16.902026790688065</c:v>
                  </c:pt>
                  <c:pt idx="58">
                    <c:v>18.138365357120914</c:v>
                  </c:pt>
                  <c:pt idx="59">
                    <c:v>17.119893296548604</c:v>
                  </c:pt>
                  <c:pt idx="60">
                    <c:v>14.716298652098317</c:v>
                  </c:pt>
                </c:numCache>
              </c:numRef>
            </c:minus>
            <c:spPr>
              <a:ln w="12700">
                <a:solidFill>
                  <a:srgbClr val="C00000"/>
                </a:solidFill>
              </a:ln>
            </c:spPr>
          </c:errBars>
          <c:val>
            <c:numRef>
              <c:f>'20211213WW30UMOL22_1xls'!$FS$21:$FS$81</c:f>
              <c:numCache>
                <c:formatCode>General</c:formatCode>
                <c:ptCount val="61"/>
                <c:pt idx="0">
                  <c:v>484.26846153846157</c:v>
                </c:pt>
                <c:pt idx="1">
                  <c:v>580.86538461538464</c:v>
                </c:pt>
                <c:pt idx="2">
                  <c:v>515.25692307692304</c:v>
                </c:pt>
                <c:pt idx="3">
                  <c:v>389.35423076923081</c:v>
                </c:pt>
                <c:pt idx="4">
                  <c:v>282.05615384615379</c:v>
                </c:pt>
                <c:pt idx="5">
                  <c:v>228.71</c:v>
                </c:pt>
                <c:pt idx="6">
                  <c:v>196.84403846153845</c:v>
                </c:pt>
                <c:pt idx="7">
                  <c:v>160.35815384615384</c:v>
                </c:pt>
                <c:pt idx="8">
                  <c:v>147.79134615384615</c:v>
                </c:pt>
                <c:pt idx="9">
                  <c:v>215.30461538461537</c:v>
                </c:pt>
                <c:pt idx="10">
                  <c:v>371.61730769230775</c:v>
                </c:pt>
                <c:pt idx="11">
                  <c:v>523.89499999999998</c:v>
                </c:pt>
                <c:pt idx="12">
                  <c:v>558.77115384615411</c:v>
                </c:pt>
                <c:pt idx="13">
                  <c:v>499.94076923076921</c:v>
                </c:pt>
                <c:pt idx="14">
                  <c:v>403.50615384615384</c:v>
                </c:pt>
                <c:pt idx="15">
                  <c:v>325.50307692307695</c:v>
                </c:pt>
                <c:pt idx="16">
                  <c:v>272.29307692307685</c:v>
                </c:pt>
                <c:pt idx="17">
                  <c:v>234.37538461538458</c:v>
                </c:pt>
                <c:pt idx="18">
                  <c:v>204.25115384615387</c:v>
                </c:pt>
                <c:pt idx="19">
                  <c:v>212.3161538461539</c:v>
                </c:pt>
                <c:pt idx="20">
                  <c:v>287.87653846153842</c:v>
                </c:pt>
                <c:pt idx="21">
                  <c:v>410.3384615384615</c:v>
                </c:pt>
                <c:pt idx="22">
                  <c:v>501.15807692307681</c:v>
                </c:pt>
                <c:pt idx="23">
                  <c:v>517.12192307692305</c:v>
                </c:pt>
                <c:pt idx="24">
                  <c:v>475.565</c:v>
                </c:pt>
                <c:pt idx="25">
                  <c:v>417.43730769230774</c:v>
                </c:pt>
                <c:pt idx="26">
                  <c:v>358.15846153846149</c:v>
                </c:pt>
                <c:pt idx="27">
                  <c:v>313.64999999999998</c:v>
                </c:pt>
                <c:pt idx="28">
                  <c:v>280.70769230769235</c:v>
                </c:pt>
                <c:pt idx="29">
                  <c:v>264.4242307692308</c:v>
                </c:pt>
                <c:pt idx="30">
                  <c:v>276.27730769230772</c:v>
                </c:pt>
                <c:pt idx="31">
                  <c:v>331.30423076923068</c:v>
                </c:pt>
                <c:pt idx="32">
                  <c:v>403.77192307692309</c:v>
                </c:pt>
                <c:pt idx="33">
                  <c:v>457.18153846153837</c:v>
                </c:pt>
                <c:pt idx="34">
                  <c:v>472.18269230769226</c:v>
                </c:pt>
                <c:pt idx="35">
                  <c:v>464.16692307692307</c:v>
                </c:pt>
                <c:pt idx="36">
                  <c:v>433.01115384615395</c:v>
                </c:pt>
                <c:pt idx="37">
                  <c:v>399.57923076923083</c:v>
                </c:pt>
                <c:pt idx="38">
                  <c:v>361.87423076923073</c:v>
                </c:pt>
                <c:pt idx="39">
                  <c:v>335.93961538461542</c:v>
                </c:pt>
                <c:pt idx="40">
                  <c:v>322.86</c:v>
                </c:pt>
                <c:pt idx="41">
                  <c:v>324.7853846153846</c:v>
                </c:pt>
                <c:pt idx="42">
                  <c:v>344.27884615384625</c:v>
                </c:pt>
                <c:pt idx="43">
                  <c:v>382.10653846153855</c:v>
                </c:pt>
                <c:pt idx="44">
                  <c:v>423.27461538461546</c:v>
                </c:pt>
                <c:pt idx="45">
                  <c:v>452.24115384615385</c:v>
                </c:pt>
                <c:pt idx="46">
                  <c:v>455.18500000000006</c:v>
                </c:pt>
                <c:pt idx="47">
                  <c:v>435.20346153846157</c:v>
                </c:pt>
                <c:pt idx="48">
                  <c:v>405.25153846153842</c:v>
                </c:pt>
                <c:pt idx="49">
                  <c:v>373.41000000000008</c:v>
                </c:pt>
                <c:pt idx="50">
                  <c:v>351.60153846153844</c:v>
                </c:pt>
                <c:pt idx="51">
                  <c:v>340.46730769230777</c:v>
                </c:pt>
                <c:pt idx="52">
                  <c:v>336.29692307692301</c:v>
                </c:pt>
                <c:pt idx="53">
                  <c:v>340.74115384615385</c:v>
                </c:pt>
                <c:pt idx="54">
                  <c:v>355.51538461538462</c:v>
                </c:pt>
                <c:pt idx="55">
                  <c:v>387.39153846153846</c:v>
                </c:pt>
                <c:pt idx="56">
                  <c:v>418.02653846153851</c:v>
                </c:pt>
                <c:pt idx="57">
                  <c:v>432.3276923076923</c:v>
                </c:pt>
                <c:pt idx="58">
                  <c:v>428.75653846153841</c:v>
                </c:pt>
                <c:pt idx="59">
                  <c:v>406.02384615384614</c:v>
                </c:pt>
                <c:pt idx="60">
                  <c:v>381.4126923076923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0408-47AD-93AE-EC8B73D8B0A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330722320"/>
        <c:axId val="1"/>
      </c:lineChart>
      <c:catAx>
        <c:axId val="330722320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1"/>
        <c:crosses val="autoZero"/>
        <c:auto val="1"/>
        <c:lblAlgn val="ctr"/>
        <c:lblOffset val="100"/>
        <c:noMultiLvlLbl val="0"/>
      </c:catAx>
      <c:valAx>
        <c:axId val="1"/>
        <c:scaling>
          <c:orientation val="minMax"/>
          <c:max val="1200"/>
        </c:scaling>
        <c:delete val="0"/>
        <c:axPos val="l"/>
        <c:title>
          <c:tx>
            <c:rich>
              <a:bodyPr/>
              <a:lstStyle/>
              <a:p>
                <a:pPr>
                  <a:defRPr b="0"/>
                </a:pPr>
                <a:r>
                  <a:rPr lang="en-US" b="0"/>
                  <a:t>Average trace</a:t>
                </a:r>
              </a:p>
            </c:rich>
          </c:tx>
          <c:layout>
            <c:manualLayout>
              <c:xMode val="edge"/>
              <c:yMode val="edge"/>
              <c:x val="9.5233136634695677E-3"/>
              <c:y val="0.28332978408643328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>
                <a:lumMod val="65000"/>
                <a:lumOff val="35000"/>
              </a:schemeClr>
            </a:solidFill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330722320"/>
        <c:crosses val="autoZero"/>
        <c:crossBetween val="between"/>
      </c:valAx>
      <c:spPr>
        <a:noFill/>
        <a:ln w="25400">
          <a:noFill/>
        </a:ln>
      </c:spPr>
    </c:plotArea>
    <c:legend>
      <c:legendPos val="r"/>
      <c:legendEntry>
        <c:idx val="0"/>
        <c:txPr>
          <a:bodyPr rot="0" vert="horz"/>
          <a:lstStyle/>
          <a:p>
            <a:pPr>
              <a:defRPr sz="900" i="0"/>
            </a:pPr>
            <a:endParaRPr lang="en-US"/>
          </a:p>
        </c:txPr>
      </c:legendEntry>
      <c:layout>
        <c:manualLayout>
          <c:xMode val="edge"/>
          <c:yMode val="edge"/>
          <c:x val="0.72819650534429703"/>
          <c:y val="0.28408512605244463"/>
          <c:w val="0.26964077734368691"/>
          <c:h val="0.28057166713396386"/>
        </c:manualLayout>
      </c:layout>
      <c:overlay val="0"/>
      <c:spPr>
        <a:noFill/>
        <a:ln>
          <a:noFill/>
        </a:ln>
        <a:effectLst/>
      </c:spPr>
      <c:txPr>
        <a:bodyPr rot="0" vert="horz"/>
        <a:lstStyle/>
        <a:p>
          <a:pPr>
            <a:defRPr sz="900" i="1"/>
          </a:pPr>
          <a:endParaRPr lang="en-US"/>
        </a:p>
      </c:txPr>
    </c:legend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>
          <a:solidFill>
            <a:sysClr val="windowText" lastClr="000000"/>
          </a:solidFill>
        </a:defRPr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1311412706577506"/>
          <c:y val="5.1067780872794802E-2"/>
          <c:w val="0.82202398295462054"/>
          <c:h val="0.81802104124171104"/>
        </c:manualLayout>
      </c:layout>
      <c:lineChart>
        <c:grouping val="standard"/>
        <c:varyColors val="0"/>
        <c:ser>
          <c:idx val="0"/>
          <c:order val="0"/>
          <c:tx>
            <c:strRef>
              <c:f>Sheet1!$B$4</c:f>
              <c:strCache>
                <c:ptCount val="1"/>
                <c:pt idx="0">
                  <c:v>pTOC1:TOC1-GFP/t1 </c:v>
                </c:pt>
              </c:strCache>
            </c:strRef>
          </c:tx>
          <c:spPr>
            <a:ln w="1270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noFill/>
              <a:ln w="12700">
                <a:solidFill>
                  <a:schemeClr val="accent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(Sheet1!$F$21,Sheet1!$F$25,Sheet1!$F$29,Sheet1!$F$33,Sheet1!$F$37,Sheet1!$F$41,Sheet1!$F$46,Sheet1!$F$50)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1.8578933387161892E-2</c:v>
                  </c:pt>
                  <c:pt idx="2">
                    <c:v>1.7562165781999452E-2</c:v>
                  </c:pt>
                  <c:pt idx="3">
                    <c:v>1.42748578285528</c:v>
                  </c:pt>
                  <c:pt idx="4">
                    <c:v>3.2851528931488851</c:v>
                  </c:pt>
                  <c:pt idx="5">
                    <c:v>1.9243746103099806</c:v>
                  </c:pt>
                  <c:pt idx="6">
                    <c:v>2.1238104478518132E-2</c:v>
                  </c:pt>
                  <c:pt idx="7">
                    <c:v>5.2212743012741779E-2</c:v>
                  </c:pt>
                </c:numCache>
              </c:numRef>
            </c:plus>
            <c:minus>
              <c:numRef>
                <c:f>(Sheet1!$F$21,Sheet1!$F$25,Sheet1!$F$29,Sheet1!$F$33,Sheet1!$F$37,Sheet1!$F$41,Sheet1!$F$46,Sheet1!$F$50)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1.8578933387161892E-2</c:v>
                  </c:pt>
                  <c:pt idx="2">
                    <c:v>1.7562165781999452E-2</c:v>
                  </c:pt>
                  <c:pt idx="3">
                    <c:v>1.42748578285528</c:v>
                  </c:pt>
                  <c:pt idx="4">
                    <c:v>3.2851528931488851</c:v>
                  </c:pt>
                  <c:pt idx="5">
                    <c:v>1.9243746103099806</c:v>
                  </c:pt>
                  <c:pt idx="6">
                    <c:v>2.1238104478518132E-2</c:v>
                  </c:pt>
                  <c:pt idx="7">
                    <c:v>5.2212743012741779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accent5"/>
                </a:solidFill>
                <a:round/>
              </a:ln>
              <a:effectLst/>
            </c:spPr>
          </c:errBars>
          <c:cat>
            <c:numRef>
              <c:f>(Sheet1!$A$4,Sheet1!$A$8,Sheet1!$A$12,Sheet1!$H$4,Sheet1!$H$8,Sheet1!$H$12,Sheet1!$O$4,Sheet1!$O$8)</c:f>
              <c:numCache>
                <c:formatCode>General</c:formatCode>
                <c:ptCount val="8"/>
                <c:pt idx="0">
                  <c:v>1</c:v>
                </c:pt>
                <c:pt idx="1">
                  <c:v>4</c:v>
                </c:pt>
                <c:pt idx="2">
                  <c:v>7</c:v>
                </c:pt>
                <c:pt idx="3">
                  <c:v>10</c:v>
                </c:pt>
                <c:pt idx="4">
                  <c:v>13</c:v>
                </c:pt>
                <c:pt idx="5">
                  <c:v>16</c:v>
                </c:pt>
                <c:pt idx="6">
                  <c:v>19</c:v>
                </c:pt>
                <c:pt idx="7">
                  <c:v>22</c:v>
                </c:pt>
              </c:numCache>
            </c:numRef>
          </c:cat>
          <c:val>
            <c:numRef>
              <c:f>(Sheet1!$F$4,Sheet1!$F$8,Sheet1!$F$12,Sheet1!$M$4,Sheet1!$M$8,Sheet1!$M$12,Sheet1!$T$4,Sheet1!$T$8)</c:f>
              <c:numCache>
                <c:formatCode>General</c:formatCode>
                <c:ptCount val="8"/>
                <c:pt idx="0">
                  <c:v>1</c:v>
                </c:pt>
                <c:pt idx="1">
                  <c:v>0.51889405095405217</c:v>
                </c:pt>
                <c:pt idx="2">
                  <c:v>1.4535928346995277</c:v>
                </c:pt>
                <c:pt idx="3">
                  <c:v>5.1723709426496072</c:v>
                </c:pt>
                <c:pt idx="4">
                  <c:v>9.2252941808954567</c:v>
                </c:pt>
                <c:pt idx="5">
                  <c:v>8.6145881604504382</c:v>
                </c:pt>
                <c:pt idx="6">
                  <c:v>6.1997367708572551</c:v>
                </c:pt>
                <c:pt idx="7">
                  <c:v>2.205540284315896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D4F0-4C6A-AF0D-21E2D9645255}"/>
            </c:ext>
          </c:extLst>
        </c:ser>
        <c:ser>
          <c:idx val="1"/>
          <c:order val="1"/>
          <c:tx>
            <c:strRef>
              <c:f>Sheet1!$B$5</c:f>
              <c:strCache>
                <c:ptCount val="1"/>
                <c:pt idx="0">
                  <c:v>pTOC1:5X-GFP/t1 </c:v>
                </c:pt>
              </c:strCache>
            </c:strRef>
          </c:tx>
          <c:spPr>
            <a:ln w="1270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noFill/>
              <a:ln w="12700">
                <a:solidFill>
                  <a:schemeClr val="accent2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(Sheet1!$F$22,Sheet1!$F$26,Sheet1!$F$30,Sheet1!$F$34,Sheet1!$F$38,Sheet1!$F$42,Sheet1!$F$47,Sheet1!$F$51)</c:f>
                <c:numCache>
                  <c:formatCode>General</c:formatCode>
                  <c:ptCount val="8"/>
                  <c:pt idx="0">
                    <c:v>0.69210341168325373</c:v>
                  </c:pt>
                  <c:pt idx="1">
                    <c:v>0.88433334510441564</c:v>
                  </c:pt>
                  <c:pt idx="2">
                    <c:v>1.0309379436263546</c:v>
                  </c:pt>
                  <c:pt idx="3">
                    <c:v>2.6111271380012835</c:v>
                  </c:pt>
                  <c:pt idx="4">
                    <c:v>3.6589458944589248</c:v>
                  </c:pt>
                  <c:pt idx="5">
                    <c:v>2.1132575753725438</c:v>
                  </c:pt>
                  <c:pt idx="6">
                    <c:v>5.1129493962195544E-2</c:v>
                  </c:pt>
                  <c:pt idx="7">
                    <c:v>4.203155125747135E-2</c:v>
                  </c:pt>
                </c:numCache>
              </c:numRef>
            </c:plus>
            <c:minus>
              <c:numRef>
                <c:f>(Sheet1!$F$22,Sheet1!$F$26,Sheet1!$F$30,Sheet1!$F$34,Sheet1!$F$38,Sheet1!$F$42,Sheet1!$F$47,Sheet1!$F$51)</c:f>
                <c:numCache>
                  <c:formatCode>General</c:formatCode>
                  <c:ptCount val="8"/>
                  <c:pt idx="0">
                    <c:v>0.69210341168325373</c:v>
                  </c:pt>
                  <c:pt idx="1">
                    <c:v>0.88433334510441564</c:v>
                  </c:pt>
                  <c:pt idx="2">
                    <c:v>1.0309379436263546</c:v>
                  </c:pt>
                  <c:pt idx="3">
                    <c:v>2.6111271380012835</c:v>
                  </c:pt>
                  <c:pt idx="4">
                    <c:v>3.6589458944589248</c:v>
                  </c:pt>
                  <c:pt idx="5">
                    <c:v>2.1132575753725438</c:v>
                  </c:pt>
                  <c:pt idx="6">
                    <c:v>5.1129493962195544E-2</c:v>
                  </c:pt>
                  <c:pt idx="7">
                    <c:v>4.203155125747135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accent2"/>
                </a:solidFill>
                <a:round/>
              </a:ln>
              <a:effectLst/>
            </c:spPr>
          </c:errBars>
          <c:cat>
            <c:numRef>
              <c:f>(Sheet1!$A$4,Sheet1!$A$8,Sheet1!$A$12,Sheet1!$H$4,Sheet1!$H$8,Sheet1!$H$12,Sheet1!$O$4,Sheet1!$O$8)</c:f>
              <c:numCache>
                <c:formatCode>General</c:formatCode>
                <c:ptCount val="8"/>
                <c:pt idx="0">
                  <c:v>1</c:v>
                </c:pt>
                <c:pt idx="1">
                  <c:v>4</c:v>
                </c:pt>
                <c:pt idx="2">
                  <c:v>7</c:v>
                </c:pt>
                <c:pt idx="3">
                  <c:v>10</c:v>
                </c:pt>
                <c:pt idx="4">
                  <c:v>13</c:v>
                </c:pt>
                <c:pt idx="5">
                  <c:v>16</c:v>
                </c:pt>
                <c:pt idx="6">
                  <c:v>19</c:v>
                </c:pt>
                <c:pt idx="7">
                  <c:v>22</c:v>
                </c:pt>
              </c:numCache>
            </c:numRef>
          </c:cat>
          <c:val>
            <c:numRef>
              <c:f>(Sheet1!$F$5,Sheet1!$F$9,Sheet1!$F$13,Sheet1!$M$5,Sheet1!$M$9,Sheet1!$M$13,Sheet1!$T$5,Sheet1!$T$9)</c:f>
              <c:numCache>
                <c:formatCode>General</c:formatCode>
                <c:ptCount val="8"/>
                <c:pt idx="0">
                  <c:v>2.3666030353971981</c:v>
                </c:pt>
                <c:pt idx="1">
                  <c:v>2.4612300539462848</c:v>
                </c:pt>
                <c:pt idx="2">
                  <c:v>4.5182835794224339</c:v>
                </c:pt>
                <c:pt idx="3">
                  <c:v>8.3016745866488151</c:v>
                </c:pt>
                <c:pt idx="4">
                  <c:v>11.462719377252721</c:v>
                </c:pt>
                <c:pt idx="5">
                  <c:v>8.2929204960102876</c:v>
                </c:pt>
                <c:pt idx="6">
                  <c:v>2.5264957572966362</c:v>
                </c:pt>
                <c:pt idx="7">
                  <c:v>0.719292028522146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D4F0-4C6A-AF0D-21E2D9645255}"/>
            </c:ext>
          </c:extLst>
        </c:ser>
        <c:ser>
          <c:idx val="2"/>
          <c:order val="2"/>
          <c:tx>
            <c:strRef>
              <c:f>Sheet1!$B$6</c:f>
              <c:strCache>
                <c:ptCount val="1"/>
                <c:pt idx="0">
                  <c:v>pTOC1:T135A-GFP/t1 </c:v>
                </c:pt>
              </c:strCache>
            </c:strRef>
          </c:tx>
          <c:spPr>
            <a:ln w="12700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noFill/>
              <a:ln w="12700">
                <a:solidFill>
                  <a:schemeClr val="accent3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(Sheet1!$F$23,Sheet1!$F$27,Sheet1!$F$31,Sheet1!$F$35,Sheet1!$F$39,Sheet1!$F$43,Sheet1!$F$48,Sheet1!$F$52)</c:f>
                <c:numCache>
                  <c:formatCode>General</c:formatCode>
                  <c:ptCount val="8"/>
                  <c:pt idx="0">
                    <c:v>9.9746176972948936E-2</c:v>
                  </c:pt>
                  <c:pt idx="1">
                    <c:v>7.3323647871483322E-2</c:v>
                  </c:pt>
                  <c:pt idx="2">
                    <c:v>0.23262834787516642</c:v>
                  </c:pt>
                  <c:pt idx="3">
                    <c:v>1.345642765641436</c:v>
                  </c:pt>
                  <c:pt idx="4">
                    <c:v>3.8475537013196646</c:v>
                  </c:pt>
                  <c:pt idx="5">
                    <c:v>2.6973709988319521</c:v>
                  </c:pt>
                  <c:pt idx="6">
                    <c:v>0.12964774948864083</c:v>
                  </c:pt>
                  <c:pt idx="7">
                    <c:v>4.6318377641382524E-2</c:v>
                  </c:pt>
                </c:numCache>
              </c:numRef>
            </c:plus>
            <c:minus>
              <c:numRef>
                <c:f>(Sheet1!$F$23,Sheet1!$F$27,Sheet1!$F$31,Sheet1!$F$35,Sheet1!$F$39,Sheet1!$F$43,Sheet1!$F$48,Sheet1!$F$52)</c:f>
                <c:numCache>
                  <c:formatCode>General</c:formatCode>
                  <c:ptCount val="8"/>
                  <c:pt idx="0">
                    <c:v>9.9746176972948936E-2</c:v>
                  </c:pt>
                  <c:pt idx="1">
                    <c:v>7.3323647871483322E-2</c:v>
                  </c:pt>
                  <c:pt idx="2">
                    <c:v>0.23262834787516642</c:v>
                  </c:pt>
                  <c:pt idx="3">
                    <c:v>1.345642765641436</c:v>
                  </c:pt>
                  <c:pt idx="4">
                    <c:v>3.8475537013196646</c:v>
                  </c:pt>
                  <c:pt idx="5">
                    <c:v>2.6973709988319521</c:v>
                  </c:pt>
                  <c:pt idx="6">
                    <c:v>0.12964774948864083</c:v>
                  </c:pt>
                  <c:pt idx="7">
                    <c:v>4.6318377641382524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accent3"/>
                </a:solidFill>
                <a:round/>
              </a:ln>
              <a:effectLst/>
            </c:spPr>
          </c:errBars>
          <c:cat>
            <c:numRef>
              <c:f>(Sheet1!$A$4,Sheet1!$A$8,Sheet1!$A$12,Sheet1!$H$4,Sheet1!$H$8,Sheet1!$H$12,Sheet1!$O$4,Sheet1!$O$8)</c:f>
              <c:numCache>
                <c:formatCode>General</c:formatCode>
                <c:ptCount val="8"/>
                <c:pt idx="0">
                  <c:v>1</c:v>
                </c:pt>
                <c:pt idx="1">
                  <c:v>4</c:v>
                </c:pt>
                <c:pt idx="2">
                  <c:v>7</c:v>
                </c:pt>
                <c:pt idx="3">
                  <c:v>10</c:v>
                </c:pt>
                <c:pt idx="4">
                  <c:v>13</c:v>
                </c:pt>
                <c:pt idx="5">
                  <c:v>16</c:v>
                </c:pt>
                <c:pt idx="6">
                  <c:v>19</c:v>
                </c:pt>
                <c:pt idx="7">
                  <c:v>22</c:v>
                </c:pt>
              </c:numCache>
            </c:numRef>
          </c:cat>
          <c:val>
            <c:numRef>
              <c:f>(Sheet1!$F$6,Sheet1!$F$10,Sheet1!$F$14,Sheet1!$M$6,Sheet1!$M$10,Sheet1!$M$14,Sheet1!$T$6,Sheet1!$T$10)</c:f>
              <c:numCache>
                <c:formatCode>General</c:formatCode>
                <c:ptCount val="8"/>
                <c:pt idx="0">
                  <c:v>0.92662934604375025</c:v>
                </c:pt>
                <c:pt idx="1">
                  <c:v>0.81481071723891318</c:v>
                </c:pt>
                <c:pt idx="2">
                  <c:v>1.8119859761249439</c:v>
                </c:pt>
                <c:pt idx="3">
                  <c:v>4.8886229631535008</c:v>
                </c:pt>
                <c:pt idx="4">
                  <c:v>10.695486581291817</c:v>
                </c:pt>
                <c:pt idx="5">
                  <c:v>10.358277961644397</c:v>
                </c:pt>
                <c:pt idx="6">
                  <c:v>7.5753468468091807</c:v>
                </c:pt>
                <c:pt idx="7">
                  <c:v>2.226725678358838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D4F0-4C6A-AF0D-21E2D9645255}"/>
            </c:ext>
          </c:extLst>
        </c:ser>
        <c:ser>
          <c:idx val="3"/>
          <c:order val="3"/>
          <c:tx>
            <c:strRef>
              <c:f>Sheet1!$B$7</c:f>
              <c:strCache>
                <c:ptCount val="1"/>
                <c:pt idx="0">
                  <c:v>pTOC1:S175A-GFP/t1 </c:v>
                </c:pt>
              </c:strCache>
            </c:strRef>
          </c:tx>
          <c:spPr>
            <a:ln w="1270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noFill/>
              <a:ln w="12700">
                <a:solidFill>
                  <a:schemeClr val="accent4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(Sheet1!$F$24,Sheet1!$F$28,Sheet1!$F$32,Sheet1!$F$36,Sheet1!$F$40,Sheet1!$F$44,Sheet1!$F$49,Sheet1!$F$53)</c:f>
                <c:numCache>
                  <c:formatCode>General</c:formatCode>
                  <c:ptCount val="8"/>
                  <c:pt idx="0">
                    <c:v>7.3974773288567067E-2</c:v>
                  </c:pt>
                  <c:pt idx="1">
                    <c:v>7.4034000498166261E-2</c:v>
                  </c:pt>
                  <c:pt idx="2">
                    <c:v>0.47424203990637598</c:v>
                  </c:pt>
                  <c:pt idx="3">
                    <c:v>2.1646274485540009</c:v>
                  </c:pt>
                  <c:pt idx="4">
                    <c:v>3.0121394590560135</c:v>
                  </c:pt>
                  <c:pt idx="5">
                    <c:v>1.5859610388790721</c:v>
                  </c:pt>
                  <c:pt idx="6">
                    <c:v>2.7085196936034033E-4</c:v>
                  </c:pt>
                  <c:pt idx="7">
                    <c:v>3.5493980293359526E-2</c:v>
                  </c:pt>
                </c:numCache>
              </c:numRef>
            </c:plus>
            <c:minus>
              <c:numRef>
                <c:f>(Sheet1!$F$24,Sheet1!$F$28,Sheet1!$F$32,Sheet1!$F$36,Sheet1!$F$40,Sheet1!$F$44,Sheet1!$F$49,Sheet1!$F$53)</c:f>
                <c:numCache>
                  <c:formatCode>General</c:formatCode>
                  <c:ptCount val="8"/>
                  <c:pt idx="0">
                    <c:v>7.3974773288567067E-2</c:v>
                  </c:pt>
                  <c:pt idx="1">
                    <c:v>7.4034000498166261E-2</c:v>
                  </c:pt>
                  <c:pt idx="2">
                    <c:v>0.47424203990637598</c:v>
                  </c:pt>
                  <c:pt idx="3">
                    <c:v>2.1646274485540009</c:v>
                  </c:pt>
                  <c:pt idx="4">
                    <c:v>3.0121394590560135</c:v>
                  </c:pt>
                  <c:pt idx="5">
                    <c:v>1.5859610388790721</c:v>
                  </c:pt>
                  <c:pt idx="6">
                    <c:v>2.7085196936034033E-4</c:v>
                  </c:pt>
                  <c:pt idx="7">
                    <c:v>3.5493980293359526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accent4"/>
                </a:solidFill>
                <a:round/>
              </a:ln>
              <a:effectLst/>
            </c:spPr>
          </c:errBars>
          <c:cat>
            <c:numRef>
              <c:f>(Sheet1!$A$4,Sheet1!$A$8,Sheet1!$A$12,Sheet1!$H$4,Sheet1!$H$8,Sheet1!$H$12,Sheet1!$O$4,Sheet1!$O$8)</c:f>
              <c:numCache>
                <c:formatCode>General</c:formatCode>
                <c:ptCount val="8"/>
                <c:pt idx="0">
                  <c:v>1</c:v>
                </c:pt>
                <c:pt idx="1">
                  <c:v>4</c:v>
                </c:pt>
                <c:pt idx="2">
                  <c:v>7</c:v>
                </c:pt>
                <c:pt idx="3">
                  <c:v>10</c:v>
                </c:pt>
                <c:pt idx="4">
                  <c:v>13</c:v>
                </c:pt>
                <c:pt idx="5">
                  <c:v>16</c:v>
                </c:pt>
                <c:pt idx="6">
                  <c:v>19</c:v>
                </c:pt>
                <c:pt idx="7">
                  <c:v>22</c:v>
                </c:pt>
              </c:numCache>
            </c:numRef>
          </c:cat>
          <c:val>
            <c:numRef>
              <c:f>(Sheet1!$F$7,Sheet1!$F$11,Sheet1!$F$15,Sheet1!$M$7,Sheet1!$M$11,Sheet1!$M$15,Sheet1!$T$7,Sheet1!$T$11)</c:f>
              <c:numCache>
                <c:formatCode>General</c:formatCode>
                <c:ptCount val="8"/>
                <c:pt idx="0">
                  <c:v>0.71216994780208265</c:v>
                </c:pt>
                <c:pt idx="1">
                  <c:v>0.57074295268590747</c:v>
                </c:pt>
                <c:pt idx="2">
                  <c:v>2.757328610761653</c:v>
                </c:pt>
                <c:pt idx="3">
                  <c:v>7.0226333205129023</c:v>
                </c:pt>
                <c:pt idx="4">
                  <c:v>9.4122923432782173</c:v>
                </c:pt>
                <c:pt idx="5">
                  <c:v>6.9149051789596987</c:v>
                </c:pt>
                <c:pt idx="6">
                  <c:v>2.8278980067713091</c:v>
                </c:pt>
                <c:pt idx="7">
                  <c:v>0.4916723807360713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D4F0-4C6A-AF0D-21E2D964525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094576160"/>
        <c:axId val="2094579488"/>
      </c:lineChart>
      <c:catAx>
        <c:axId val="209457616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ZT Time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094579488"/>
        <c:crosses val="autoZero"/>
        <c:auto val="1"/>
        <c:lblAlgn val="ctr"/>
        <c:lblOffset val="100"/>
        <c:noMultiLvlLbl val="0"/>
      </c:catAx>
      <c:valAx>
        <c:axId val="2094579488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TOC1-GFP/ADK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09457616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9.0423122029874056E-2"/>
          <c:y val="6.1529705195690315E-2"/>
          <c:w val="0.40275572582181218"/>
          <c:h val="0.35751097872154025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1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>
          <a:solidFill>
            <a:sysClr val="windowText" lastClr="000000"/>
          </a:solidFill>
        </a:defRPr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1311412706577506"/>
          <c:y val="5.1067780872794802E-2"/>
          <c:w val="0.80917279379812612"/>
          <c:h val="0.81802104124171104"/>
        </c:manualLayout>
      </c:layout>
      <c:lineChart>
        <c:grouping val="standard"/>
        <c:varyColors val="0"/>
        <c:ser>
          <c:idx val="0"/>
          <c:order val="0"/>
          <c:tx>
            <c:strRef>
              <c:f>Sheet1!$B$4</c:f>
              <c:strCache>
                <c:ptCount val="1"/>
                <c:pt idx="0">
                  <c:v>pTOC1:TOC1-GFP/t1 </c:v>
                </c:pt>
              </c:strCache>
            </c:strRef>
          </c:tx>
          <c:spPr>
            <a:ln w="1270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noFill/>
              <a:ln w="12700">
                <a:solidFill>
                  <a:schemeClr val="accent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(Sheet1!$F$21,Sheet1!$F$25,Sheet1!$F$29,Sheet1!$F$33,Sheet1!$F$37,Sheet1!$F$41,Sheet1!$F$46,Sheet1!$F$50)</c:f>
                <c:numCache>
                  <c:formatCode>General</c:formatCode>
                  <c:ptCount val="5"/>
                  <c:pt idx="0">
                    <c:v>3.9383508280072324E-2</c:v>
                  </c:pt>
                  <c:pt idx="1">
                    <c:v>0</c:v>
                  </c:pt>
                  <c:pt idx="2">
                    <c:v>0.10688015473191238</c:v>
                  </c:pt>
                  <c:pt idx="3">
                    <c:v>0.11419578516764572</c:v>
                  </c:pt>
                  <c:pt idx="4">
                    <c:v>8.3727362759831558E-2</c:v>
                  </c:pt>
                </c:numCache>
              </c:numRef>
            </c:plus>
            <c:minus>
              <c:numRef>
                <c:f>(Sheet1!$F$21,Sheet1!$F$25,Sheet1!$F$29,Sheet1!$F$33,Sheet1!$F$37,Sheet1!$F$41,Sheet1!$F$46,Sheet1!$F$50)</c:f>
                <c:numCache>
                  <c:formatCode>General</c:formatCode>
                  <c:ptCount val="5"/>
                  <c:pt idx="0">
                    <c:v>3.9383508280072324E-2</c:v>
                  </c:pt>
                  <c:pt idx="1">
                    <c:v>0</c:v>
                  </c:pt>
                  <c:pt idx="2">
                    <c:v>0.10688015473191238</c:v>
                  </c:pt>
                  <c:pt idx="3">
                    <c:v>0.11419578516764572</c:v>
                  </c:pt>
                  <c:pt idx="4">
                    <c:v>8.3727362759831558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accent5"/>
                </a:solidFill>
                <a:round/>
              </a:ln>
              <a:effectLst/>
            </c:spPr>
          </c:errBars>
          <c:cat>
            <c:numRef>
              <c:f>(Sheet1!$A$4,Sheet1!$A$8,Sheet1!$A$12,Sheet1!$H$4,Sheet1!$H$8,Sheet1!$H$12,Sheet1!$O$4,Sheet1!$O$8)</c:f>
              <c:numCache>
                <c:formatCode>General</c:formatCode>
                <c:ptCount val="5"/>
                <c:pt idx="0">
                  <c:v>12</c:v>
                </c:pt>
                <c:pt idx="1">
                  <c:v>13</c:v>
                </c:pt>
                <c:pt idx="2">
                  <c:v>14</c:v>
                </c:pt>
                <c:pt idx="3">
                  <c:v>15</c:v>
                </c:pt>
                <c:pt idx="4">
                  <c:v>16</c:v>
                </c:pt>
              </c:numCache>
            </c:numRef>
          </c:cat>
          <c:val>
            <c:numRef>
              <c:f>(Sheet1!$F$4,Sheet1!$F$8,Sheet1!$F$12,Sheet1!$M$4,Sheet1!$M$8,Sheet1!$M$12,Sheet1!$T$4,Sheet1!$T$8)</c:f>
              <c:numCache>
                <c:formatCode>General</c:formatCode>
                <c:ptCount val="5"/>
                <c:pt idx="0">
                  <c:v>0.77433973911558263</c:v>
                </c:pt>
                <c:pt idx="1">
                  <c:v>1</c:v>
                </c:pt>
                <c:pt idx="2">
                  <c:v>1.3158309070233787</c:v>
                </c:pt>
                <c:pt idx="3">
                  <c:v>1.4058956403299867</c:v>
                </c:pt>
                <c:pt idx="4">
                  <c:v>1.030790533184461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809A-4DEA-B370-AA75A07ED1A3}"/>
            </c:ext>
          </c:extLst>
        </c:ser>
        <c:ser>
          <c:idx val="1"/>
          <c:order val="1"/>
          <c:tx>
            <c:strRef>
              <c:f>Sheet1!$B$5</c:f>
              <c:strCache>
                <c:ptCount val="1"/>
                <c:pt idx="0">
                  <c:v>pTOC1:5X-GFP/t1 </c:v>
                </c:pt>
              </c:strCache>
            </c:strRef>
          </c:tx>
          <c:spPr>
            <a:ln w="1270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noFill/>
              <a:ln w="12700">
                <a:solidFill>
                  <a:schemeClr val="accent2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(Sheet1!$F$22,Sheet1!$F$26,Sheet1!$F$30,Sheet1!$F$34,Sheet1!$F$38,Sheet1!$F$42,Sheet1!$F$47,Sheet1!$F$51)</c:f>
                <c:numCache>
                  <c:formatCode>General</c:formatCode>
                  <c:ptCount val="5"/>
                  <c:pt idx="0">
                    <c:v>8.2749143902263317E-2</c:v>
                  </c:pt>
                  <c:pt idx="1">
                    <c:v>6.3768272580882968E-2</c:v>
                  </c:pt>
                  <c:pt idx="2">
                    <c:v>8.4934168576315958E-2</c:v>
                  </c:pt>
                  <c:pt idx="3">
                    <c:v>8.5780593323395812E-2</c:v>
                  </c:pt>
                  <c:pt idx="4">
                    <c:v>7.803808780390277E-2</c:v>
                  </c:pt>
                </c:numCache>
              </c:numRef>
            </c:plus>
            <c:minus>
              <c:numRef>
                <c:f>(Sheet1!$F$22,Sheet1!$F$26,Sheet1!$F$30,Sheet1!$F$34,Sheet1!$F$38,Sheet1!$F$42,Sheet1!$F$47,Sheet1!$F$51)</c:f>
                <c:numCache>
                  <c:formatCode>General</c:formatCode>
                  <c:ptCount val="5"/>
                  <c:pt idx="0">
                    <c:v>8.2749143902263317E-2</c:v>
                  </c:pt>
                  <c:pt idx="1">
                    <c:v>6.3768272580882968E-2</c:v>
                  </c:pt>
                  <c:pt idx="2">
                    <c:v>8.4934168576315958E-2</c:v>
                  </c:pt>
                  <c:pt idx="3">
                    <c:v>8.5780593323395812E-2</c:v>
                  </c:pt>
                  <c:pt idx="4">
                    <c:v>7.803808780390277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accent2"/>
                </a:solidFill>
                <a:round/>
              </a:ln>
              <a:effectLst/>
            </c:spPr>
          </c:errBars>
          <c:cat>
            <c:numRef>
              <c:f>(Sheet1!$A$4,Sheet1!$A$8,Sheet1!$A$12,Sheet1!$H$4,Sheet1!$H$8,Sheet1!$H$12,Sheet1!$O$4,Sheet1!$O$8)</c:f>
              <c:numCache>
                <c:formatCode>General</c:formatCode>
                <c:ptCount val="5"/>
                <c:pt idx="0">
                  <c:v>12</c:v>
                </c:pt>
                <c:pt idx="1">
                  <c:v>13</c:v>
                </c:pt>
                <c:pt idx="2">
                  <c:v>14</c:v>
                </c:pt>
                <c:pt idx="3">
                  <c:v>15</c:v>
                </c:pt>
                <c:pt idx="4">
                  <c:v>16</c:v>
                </c:pt>
              </c:numCache>
            </c:numRef>
          </c:cat>
          <c:val>
            <c:numRef>
              <c:f>(Sheet1!$F$5,Sheet1!$F$9,Sheet1!$F$13,Sheet1!$M$5,Sheet1!$M$9,Sheet1!$M$13,Sheet1!$T$5,Sheet1!$T$9)</c:f>
              <c:numCache>
                <c:formatCode>General</c:formatCode>
                <c:ptCount val="5"/>
                <c:pt idx="0">
                  <c:v>0.87062365287507881</c:v>
                </c:pt>
                <c:pt idx="1">
                  <c:v>1.2904998430790804</c:v>
                </c:pt>
                <c:pt idx="2">
                  <c:v>1.1783764797043859</c:v>
                </c:pt>
                <c:pt idx="3">
                  <c:v>1.0560684179476256</c:v>
                </c:pt>
                <c:pt idx="4">
                  <c:v>0.9607483083734669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809A-4DEA-B370-AA75A07ED1A3}"/>
            </c:ext>
          </c:extLst>
        </c:ser>
        <c:ser>
          <c:idx val="2"/>
          <c:order val="2"/>
          <c:tx>
            <c:strRef>
              <c:f>Sheet1!$B$6</c:f>
              <c:strCache>
                <c:ptCount val="1"/>
                <c:pt idx="0">
                  <c:v>pTOC1:TOC1-GFP/c349t1 </c:v>
                </c:pt>
              </c:strCache>
            </c:strRef>
          </c:tx>
          <c:spPr>
            <a:ln w="12700" cap="rnd">
              <a:solidFill>
                <a:srgbClr val="996633"/>
              </a:solidFill>
              <a:round/>
            </a:ln>
            <a:effectLst/>
          </c:spPr>
          <c:marker>
            <c:symbol val="circle"/>
            <c:size val="5"/>
            <c:spPr>
              <a:noFill/>
              <a:ln w="12700">
                <a:solidFill>
                  <a:srgbClr val="996633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(Sheet1!$F$23,Sheet1!$F$27,Sheet1!$F$31,Sheet1!$F$35,Sheet1!$F$39,Sheet1!$F$43,Sheet1!$F$48,Sheet1!$F$52)</c:f>
                <c:numCache>
                  <c:formatCode>General</c:formatCode>
                  <c:ptCount val="5"/>
                  <c:pt idx="0">
                    <c:v>5.1163743216865454E-2</c:v>
                  </c:pt>
                  <c:pt idx="1">
                    <c:v>1.294329269820356E-2</c:v>
                  </c:pt>
                  <c:pt idx="2">
                    <c:v>0.11697108426250671</c:v>
                  </c:pt>
                  <c:pt idx="3">
                    <c:v>6.3695142616337241E-2</c:v>
                  </c:pt>
                  <c:pt idx="4">
                    <c:v>0.10487070757388778</c:v>
                  </c:pt>
                </c:numCache>
              </c:numRef>
            </c:plus>
            <c:minus>
              <c:numRef>
                <c:f>(Sheet1!$F$23,Sheet1!$F$27,Sheet1!$F$31,Sheet1!$F$35,Sheet1!$F$39,Sheet1!$F$43,Sheet1!$F$48,Sheet1!$F$52)</c:f>
                <c:numCache>
                  <c:formatCode>General</c:formatCode>
                  <c:ptCount val="5"/>
                  <c:pt idx="0">
                    <c:v>5.1163743216865454E-2</c:v>
                  </c:pt>
                  <c:pt idx="1">
                    <c:v>1.294329269820356E-2</c:v>
                  </c:pt>
                  <c:pt idx="2">
                    <c:v>0.11697108426250671</c:v>
                  </c:pt>
                  <c:pt idx="3">
                    <c:v>6.3695142616337241E-2</c:v>
                  </c:pt>
                  <c:pt idx="4">
                    <c:v>0.10487070757388778</c:v>
                  </c:pt>
                </c:numCache>
              </c:numRef>
            </c:minus>
            <c:spPr>
              <a:noFill/>
              <a:ln w="9525" cap="flat" cmpd="sng" algn="ctr">
                <a:solidFill>
                  <a:srgbClr val="996633"/>
                </a:solidFill>
                <a:round/>
              </a:ln>
              <a:effectLst/>
            </c:spPr>
          </c:errBars>
          <c:cat>
            <c:numRef>
              <c:f>(Sheet1!$A$4,Sheet1!$A$8,Sheet1!$A$12,Sheet1!$H$4,Sheet1!$H$8,Sheet1!$H$12,Sheet1!$O$4,Sheet1!$O$8)</c:f>
              <c:numCache>
                <c:formatCode>General</c:formatCode>
                <c:ptCount val="5"/>
                <c:pt idx="0">
                  <c:v>12</c:v>
                </c:pt>
                <c:pt idx="1">
                  <c:v>13</c:v>
                </c:pt>
                <c:pt idx="2">
                  <c:v>14</c:v>
                </c:pt>
                <c:pt idx="3">
                  <c:v>15</c:v>
                </c:pt>
                <c:pt idx="4">
                  <c:v>16</c:v>
                </c:pt>
              </c:numCache>
            </c:numRef>
          </c:cat>
          <c:val>
            <c:numRef>
              <c:f>(Sheet1!$F$6,Sheet1!$F$10,Sheet1!$F$14,Sheet1!$M$6,Sheet1!$M$10,Sheet1!$M$14,Sheet1!$T$6,Sheet1!$T$10)</c:f>
              <c:numCache>
                <c:formatCode>General</c:formatCode>
                <c:ptCount val="5"/>
                <c:pt idx="0">
                  <c:v>0.7078838497094001</c:v>
                </c:pt>
                <c:pt idx="1">
                  <c:v>0.90609748904267473</c:v>
                </c:pt>
                <c:pt idx="2">
                  <c:v>0.90277116426868975</c:v>
                </c:pt>
                <c:pt idx="3">
                  <c:v>0.78416837524294003</c:v>
                </c:pt>
                <c:pt idx="4">
                  <c:v>0.811227978986722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809A-4DEA-B370-AA75A07ED1A3}"/>
            </c:ext>
          </c:extLst>
        </c:ser>
        <c:ser>
          <c:idx val="3"/>
          <c:order val="3"/>
          <c:tx>
            <c:strRef>
              <c:f>Sheet1!$B$7</c:f>
              <c:strCache>
                <c:ptCount val="1"/>
                <c:pt idx="0">
                  <c:v>pTOC1:5X-GFP/c349t1 </c:v>
                </c:pt>
              </c:strCache>
            </c:strRef>
          </c:tx>
          <c:spPr>
            <a:ln w="12700" cap="rnd">
              <a:solidFill>
                <a:schemeClr val="tx2"/>
              </a:solidFill>
              <a:round/>
            </a:ln>
            <a:effectLst/>
          </c:spPr>
          <c:marker>
            <c:symbol val="circle"/>
            <c:size val="5"/>
            <c:spPr>
              <a:noFill/>
              <a:ln w="12700">
                <a:solidFill>
                  <a:schemeClr val="tx2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(Sheet1!$F$24,Sheet1!$F$28,Sheet1!$F$32,Sheet1!$F$36,Sheet1!$F$40,Sheet1!$F$44,Sheet1!$F$49,Sheet1!$F$53)</c:f>
                <c:numCache>
                  <c:formatCode>General</c:formatCode>
                  <c:ptCount val="5"/>
                  <c:pt idx="0">
                    <c:v>1.7654242612644231E-3</c:v>
                  </c:pt>
                  <c:pt idx="1">
                    <c:v>2.0139941625865958E-2</c:v>
                  </c:pt>
                  <c:pt idx="2">
                    <c:v>0.20444519868325067</c:v>
                  </c:pt>
                  <c:pt idx="3">
                    <c:v>5.7935289659313258E-2</c:v>
                  </c:pt>
                  <c:pt idx="4">
                    <c:v>5.2812989359447907E-2</c:v>
                  </c:pt>
                </c:numCache>
              </c:numRef>
            </c:plus>
            <c:minus>
              <c:numRef>
                <c:f>(Sheet1!$F$24,Sheet1!$F$28,Sheet1!$F$32,Sheet1!$F$36,Sheet1!$F$40,Sheet1!$F$44,Sheet1!$F$49,Sheet1!$F$53)</c:f>
                <c:numCache>
                  <c:formatCode>General</c:formatCode>
                  <c:ptCount val="5"/>
                  <c:pt idx="0">
                    <c:v>1.7654242612644231E-3</c:v>
                  </c:pt>
                  <c:pt idx="1">
                    <c:v>2.0139941625865958E-2</c:v>
                  </c:pt>
                  <c:pt idx="2">
                    <c:v>0.20444519868325067</c:v>
                  </c:pt>
                  <c:pt idx="3">
                    <c:v>5.7935289659313258E-2</c:v>
                  </c:pt>
                  <c:pt idx="4">
                    <c:v>5.2812989359447907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2"/>
                </a:solidFill>
                <a:round/>
              </a:ln>
              <a:effectLst/>
            </c:spPr>
          </c:errBars>
          <c:cat>
            <c:numRef>
              <c:f>(Sheet1!$A$4,Sheet1!$A$8,Sheet1!$A$12,Sheet1!$H$4,Sheet1!$H$8,Sheet1!$H$12,Sheet1!$O$4,Sheet1!$O$8)</c:f>
              <c:numCache>
                <c:formatCode>General</c:formatCode>
                <c:ptCount val="5"/>
                <c:pt idx="0">
                  <c:v>12</c:v>
                </c:pt>
                <c:pt idx="1">
                  <c:v>13</c:v>
                </c:pt>
                <c:pt idx="2">
                  <c:v>14</c:v>
                </c:pt>
                <c:pt idx="3">
                  <c:v>15</c:v>
                </c:pt>
                <c:pt idx="4">
                  <c:v>16</c:v>
                </c:pt>
              </c:numCache>
            </c:numRef>
          </c:cat>
          <c:val>
            <c:numRef>
              <c:f>(Sheet1!$F$7,Sheet1!$F$11,Sheet1!$F$15,Sheet1!$M$7,Sheet1!$M$11,Sheet1!$M$15,Sheet1!$T$7,Sheet1!$T$11)</c:f>
              <c:numCache>
                <c:formatCode>General</c:formatCode>
                <c:ptCount val="5"/>
                <c:pt idx="0">
                  <c:v>0.61725538732620899</c:v>
                </c:pt>
                <c:pt idx="1">
                  <c:v>0.87965387349670543</c:v>
                </c:pt>
                <c:pt idx="2">
                  <c:v>0.60296781091062779</c:v>
                </c:pt>
                <c:pt idx="3">
                  <c:v>0.71325724529769929</c:v>
                </c:pt>
                <c:pt idx="4">
                  <c:v>0.6501952010246200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809A-4DEA-B370-AA75A07ED1A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094576160"/>
        <c:axId val="2094579488"/>
      </c:lineChart>
      <c:catAx>
        <c:axId val="209457616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ZT Time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094579488"/>
        <c:crosses val="autoZero"/>
        <c:auto val="1"/>
        <c:lblAlgn val="ctr"/>
        <c:lblOffset val="100"/>
        <c:noMultiLvlLbl val="0"/>
      </c:catAx>
      <c:valAx>
        <c:axId val="2094579488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TOC1-GFP/ADK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09457616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t"/>
      <c:layout>
        <c:manualLayout>
          <c:xMode val="edge"/>
          <c:yMode val="edge"/>
          <c:x val="0.13120237271007473"/>
          <c:y val="0.69521178637200731"/>
          <c:w val="0.76865136924472588"/>
          <c:h val="0.1484817505546613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1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000">
          <a:solidFill>
            <a:sysClr val="windowText" lastClr="000000"/>
          </a:solidFill>
        </a:defRPr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3920803725691758"/>
          <c:y val="7.7877886136621333E-2"/>
          <c:w val="0.68859143857864713"/>
          <c:h val="0.68011086867569681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noFill/>
              <a:ln w="12700">
                <a:solidFill>
                  <a:schemeClr val="accent5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5BBD-4A8B-BAE8-DC10D8527F83}"/>
              </c:ext>
            </c:extLst>
          </c:dPt>
          <c:dPt>
            <c:idx val="1"/>
            <c:invertIfNegative val="0"/>
            <c:bubble3D val="0"/>
            <c:spPr>
              <a:noFill/>
              <a:ln w="12700">
                <a:solidFill>
                  <a:schemeClr val="accent2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5BBD-4A8B-BAE8-DC10D8527F83}"/>
              </c:ext>
            </c:extLst>
          </c:dPt>
          <c:dPt>
            <c:idx val="2"/>
            <c:invertIfNegative val="0"/>
            <c:bubble3D val="0"/>
            <c:spPr>
              <a:noFill/>
              <a:ln>
                <a:solidFill>
                  <a:schemeClr val="accent5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8-1471-45AD-85A8-278F0FDEA41E}"/>
              </c:ext>
            </c:extLst>
          </c:dPt>
          <c:dPt>
            <c:idx val="3"/>
            <c:invertIfNegative val="0"/>
            <c:bubble3D val="0"/>
            <c:spPr>
              <a:noFill/>
              <a:ln>
                <a:solidFill>
                  <a:schemeClr val="accent2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1471-45AD-85A8-278F0FDEA41E}"/>
              </c:ext>
            </c:extLst>
          </c:dPt>
          <c:cat>
            <c:strRef>
              <c:f>Sheet1!$A$2:$A$7</c:f>
              <c:strCache>
                <c:ptCount val="4"/>
                <c:pt idx="0">
                  <c:v>TOC1</c:v>
                </c:pt>
                <c:pt idx="1">
                  <c:v>5X</c:v>
                </c:pt>
                <c:pt idx="2">
                  <c:v>TOC1</c:v>
                </c:pt>
                <c:pt idx="3">
                  <c:v>5X</c:v>
                </c:pt>
              </c:strCache>
              <c:extLst/>
            </c:strRef>
          </c:cat>
          <c:val>
            <c:numRef>
              <c:f>Sheet1!$F$2:$F$7</c:f>
              <c:numCache>
                <c:formatCode>General</c:formatCode>
                <c:ptCount val="4"/>
                <c:pt idx="0">
                  <c:v>1</c:v>
                </c:pt>
                <c:pt idx="1">
                  <c:v>0.88622762580911396</c:v>
                </c:pt>
                <c:pt idx="2">
                  <c:v>1</c:v>
                </c:pt>
                <c:pt idx="3">
                  <c:v>0.88601482622658312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8-5BBD-4A8B-BAE8-DC10D8527F8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20"/>
        <c:overlap val="-27"/>
        <c:axId val="1297439615"/>
        <c:axId val="1297440031"/>
      </c:barChart>
      <c:catAx>
        <c:axId val="1297439615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97440031"/>
        <c:crosses val="autoZero"/>
        <c:auto val="1"/>
        <c:lblAlgn val="ctr"/>
        <c:lblOffset val="100"/>
        <c:noMultiLvlLbl val="0"/>
      </c:catAx>
      <c:valAx>
        <c:axId val="1297440031"/>
        <c:scaling>
          <c:orientation val="minMax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/>
                  <a:t>CoIP/IP/Input</a:t>
                </a:r>
              </a:p>
            </c:rich>
          </c:tx>
          <c:layout>
            <c:manualLayout>
              <c:xMode val="edge"/>
              <c:yMode val="edge"/>
              <c:x val="4.6715858118992872E-3"/>
              <c:y val="0.21752291460636827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97439615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en-U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8696877171906062"/>
          <c:y val="7.7198438815018672E-2"/>
          <c:w val="0.77427159212765984"/>
          <c:h val="0.66956197781921856"/>
        </c:manualLayout>
      </c:layout>
      <c:barChart>
        <c:barDir val="col"/>
        <c:grouping val="clustered"/>
        <c:varyColors val="0"/>
        <c:ser>
          <c:idx val="0"/>
          <c:order val="0"/>
          <c:spPr>
            <a:noFill/>
            <a:ln w="12700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noFill/>
              <a:ln w="12700">
                <a:solidFill>
                  <a:schemeClr val="bg1">
                    <a:lumMod val="50000"/>
                  </a:schemeClr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A576-4538-999A-B59A26492718}"/>
              </c:ext>
            </c:extLst>
          </c:dPt>
          <c:dPt>
            <c:idx val="1"/>
            <c:invertIfNegative val="0"/>
            <c:bubble3D val="0"/>
            <c:spPr>
              <a:noFill/>
              <a:ln w="12700">
                <a:solidFill>
                  <a:schemeClr val="accent4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A576-4538-999A-B59A26492718}"/>
              </c:ext>
            </c:extLst>
          </c:dPt>
          <c:dPt>
            <c:idx val="2"/>
            <c:invertIfNegative val="0"/>
            <c:bubble3D val="0"/>
            <c:spPr>
              <a:noFill/>
              <a:ln w="12700">
                <a:solidFill>
                  <a:schemeClr val="accent6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A576-4538-999A-B59A26492718}"/>
              </c:ext>
            </c:extLst>
          </c:dPt>
          <c:dPt>
            <c:idx val="3"/>
            <c:invertIfNegative val="0"/>
            <c:bubble3D val="0"/>
            <c:spPr>
              <a:noFill/>
              <a:ln w="12700">
                <a:solidFill>
                  <a:srgbClr val="934BC9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A576-4538-999A-B59A26492718}"/>
              </c:ext>
            </c:extLst>
          </c:dPt>
          <c:dPt>
            <c:idx val="4"/>
            <c:invertIfNegative val="0"/>
            <c:bubble3D val="0"/>
            <c:spPr>
              <a:noFill/>
              <a:ln w="12700">
                <a:solidFill>
                  <a:schemeClr val="bg1">
                    <a:lumMod val="50000"/>
                  </a:schemeClr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A576-4538-999A-B59A26492718}"/>
              </c:ext>
            </c:extLst>
          </c:dPt>
          <c:dPt>
            <c:idx val="5"/>
            <c:invertIfNegative val="0"/>
            <c:bubble3D val="0"/>
            <c:spPr>
              <a:noFill/>
              <a:ln w="12700">
                <a:solidFill>
                  <a:schemeClr val="accent4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A576-4538-999A-B59A26492718}"/>
              </c:ext>
            </c:extLst>
          </c:dPt>
          <c:dPt>
            <c:idx val="6"/>
            <c:invertIfNegative val="0"/>
            <c:bubble3D val="0"/>
            <c:spPr>
              <a:noFill/>
              <a:ln w="12700">
                <a:solidFill>
                  <a:schemeClr val="accent6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A576-4538-999A-B59A26492718}"/>
              </c:ext>
            </c:extLst>
          </c:dPt>
          <c:dPt>
            <c:idx val="7"/>
            <c:invertIfNegative val="0"/>
            <c:bubble3D val="0"/>
            <c:spPr>
              <a:noFill/>
              <a:ln w="12700">
                <a:solidFill>
                  <a:srgbClr val="934BC9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A576-4538-999A-B59A26492718}"/>
              </c:ext>
            </c:extLst>
          </c:dPt>
          <c:dPt>
            <c:idx val="8"/>
            <c:invertIfNegative val="0"/>
            <c:bubble3D val="0"/>
            <c:spPr>
              <a:noFill/>
              <a:ln w="12700">
                <a:solidFill>
                  <a:schemeClr val="bg1">
                    <a:lumMod val="50000"/>
                  </a:schemeClr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1-A576-4538-999A-B59A26492718}"/>
              </c:ext>
            </c:extLst>
          </c:dPt>
          <c:dPt>
            <c:idx val="9"/>
            <c:invertIfNegative val="0"/>
            <c:bubble3D val="0"/>
            <c:spPr>
              <a:noFill/>
              <a:ln w="12700">
                <a:solidFill>
                  <a:schemeClr val="accent4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3-A576-4538-999A-B59A26492718}"/>
              </c:ext>
            </c:extLst>
          </c:dPt>
          <c:dPt>
            <c:idx val="10"/>
            <c:invertIfNegative val="0"/>
            <c:bubble3D val="0"/>
            <c:spPr>
              <a:noFill/>
              <a:ln w="12700">
                <a:solidFill>
                  <a:schemeClr val="accent6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5-A576-4538-999A-B59A26492718}"/>
              </c:ext>
            </c:extLst>
          </c:dPt>
          <c:dPt>
            <c:idx val="11"/>
            <c:invertIfNegative val="0"/>
            <c:bubble3D val="0"/>
            <c:spPr>
              <a:noFill/>
              <a:ln w="12700">
                <a:solidFill>
                  <a:srgbClr val="934BC9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7-A576-4538-999A-B59A26492718}"/>
              </c:ext>
            </c:extLst>
          </c:dPt>
          <c:cat>
            <c:strRef>
              <c:f>Sheet1!$A$2:$A$13</c:f>
              <c:strCache>
                <c:ptCount val="12"/>
                <c:pt idx="0">
                  <c:v>TOC1</c:v>
                </c:pt>
                <c:pt idx="1">
                  <c:v>5X</c:v>
                </c:pt>
                <c:pt idx="2">
                  <c:v>T135A</c:v>
                </c:pt>
                <c:pt idx="3">
                  <c:v>S175A</c:v>
                </c:pt>
                <c:pt idx="4">
                  <c:v>TOC1</c:v>
                </c:pt>
                <c:pt idx="5">
                  <c:v>5X</c:v>
                </c:pt>
                <c:pt idx="6">
                  <c:v>T135A</c:v>
                </c:pt>
                <c:pt idx="7">
                  <c:v>S175A</c:v>
                </c:pt>
                <c:pt idx="8">
                  <c:v>TOC1</c:v>
                </c:pt>
                <c:pt idx="9">
                  <c:v>5X</c:v>
                </c:pt>
                <c:pt idx="10">
                  <c:v>T135A</c:v>
                </c:pt>
                <c:pt idx="11">
                  <c:v>S175A</c:v>
                </c:pt>
              </c:strCache>
            </c:strRef>
          </c:cat>
          <c:val>
            <c:numRef>
              <c:f>Sheet1!$F$2:$F$13</c:f>
              <c:numCache>
                <c:formatCode>General</c:formatCode>
                <c:ptCount val="12"/>
                <c:pt idx="0">
                  <c:v>1</c:v>
                </c:pt>
                <c:pt idx="1">
                  <c:v>0.82233690932901393</c:v>
                </c:pt>
                <c:pt idx="2">
                  <c:v>0.93025006696861745</c:v>
                </c:pt>
                <c:pt idx="3">
                  <c:v>0.79694720762500104</c:v>
                </c:pt>
                <c:pt idx="4">
                  <c:v>1</c:v>
                </c:pt>
                <c:pt idx="5">
                  <c:v>1.0212508449531199</c:v>
                </c:pt>
                <c:pt idx="6">
                  <c:v>0.94478750654364807</c:v>
                </c:pt>
                <c:pt idx="7">
                  <c:v>1.0612303594910284</c:v>
                </c:pt>
                <c:pt idx="8">
                  <c:v>1</c:v>
                </c:pt>
                <c:pt idx="9">
                  <c:v>1.0406863750572373</c:v>
                </c:pt>
                <c:pt idx="10">
                  <c:v>0.75638074926706977</c:v>
                </c:pt>
                <c:pt idx="11">
                  <c:v>0.771745629426380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8-A576-4538-999A-B59A2649271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overlap val="-27"/>
        <c:axId val="1297439615"/>
        <c:axId val="1297440031"/>
      </c:barChart>
      <c:catAx>
        <c:axId val="1297439615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97440031"/>
        <c:crosses val="autoZero"/>
        <c:auto val="1"/>
        <c:lblAlgn val="ctr"/>
        <c:lblOffset val="100"/>
        <c:noMultiLvlLbl val="0"/>
      </c:catAx>
      <c:valAx>
        <c:axId val="1297440031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000"/>
                  <a:t>CoIP/IP/Input</a:t>
                </a:r>
              </a:p>
            </c:rich>
          </c:tx>
          <c:layout>
            <c:manualLayout>
              <c:xMode val="edge"/>
              <c:yMode val="edge"/>
              <c:x val="5.3769908705380988E-2"/>
              <c:y val="0.1727727637353457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97439615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100">
          <a:solidFill>
            <a:schemeClr val="tx1"/>
          </a:solidFill>
        </a:defRPr>
      </a:pPr>
      <a:endParaRPr lang="en-US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sz="1200" dirty="0"/>
              <a:t>TOC1-GFP </a:t>
            </a:r>
            <a:r>
              <a:rPr lang="en-US" sz="1200" dirty="0" err="1"/>
              <a:t>ChIP</a:t>
            </a:r>
            <a:r>
              <a:rPr lang="en-US" sz="1200" dirty="0"/>
              <a:t>: </a:t>
            </a:r>
            <a:r>
              <a:rPr lang="el-GR" sz="1200" dirty="0"/>
              <a:t>α</a:t>
            </a:r>
            <a:r>
              <a:rPr lang="en-US" sz="1200" dirty="0"/>
              <a:t>-GFP</a:t>
            </a:r>
          </a:p>
        </c:rich>
      </c:tx>
      <c:layout>
        <c:manualLayout>
          <c:xMode val="edge"/>
          <c:yMode val="edge"/>
          <c:x val="0.35180668967305012"/>
          <c:y val="7.91765637371338E-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7.3330417031204437E-2"/>
          <c:y val="0.14043649236314343"/>
          <c:w val="0.89580538543793142"/>
          <c:h val="0.6458685209524888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B$2</c:f>
              <c:strCache>
                <c:ptCount val="1"/>
                <c:pt idx="0">
                  <c:v>Col-0</c:v>
                </c:pt>
              </c:strCache>
            </c:strRef>
          </c:tx>
          <c:spPr>
            <a:noFill/>
            <a:ln w="12700">
              <a:solidFill>
                <a:schemeClr val="accent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Sheet1!$B$11,Sheet1!$F$11,Sheet1!$J$11,Sheet1!$N$11,Sheet1!$R$11,Sheet1!$V$11,Sheet1!$Z$11)</c:f>
                <c:numCache>
                  <c:formatCode>General</c:formatCode>
                  <c:ptCount val="7"/>
                  <c:pt idx="0">
                    <c:v>2.6385377423760099E-4</c:v>
                  </c:pt>
                  <c:pt idx="1">
                    <c:v>1.755419716638291E-4</c:v>
                  </c:pt>
                  <c:pt idx="2">
                    <c:v>8.5197282144820166E-5</c:v>
                  </c:pt>
                  <c:pt idx="3">
                    <c:v>2.026666802564752E-4</c:v>
                  </c:pt>
                  <c:pt idx="4">
                    <c:v>4.6285305448084323E-4</c:v>
                  </c:pt>
                  <c:pt idx="5">
                    <c:v>3.0252993821671775E-4</c:v>
                  </c:pt>
                  <c:pt idx="6">
                    <c:v>9.6506947071823391E-5</c:v>
                  </c:pt>
                </c:numCache>
              </c:numRef>
            </c:plus>
            <c:minus>
              <c:numRef>
                <c:f>(Sheet1!$B$11,Sheet1!$F$11,Sheet1!$J$11,Sheet1!$N$11,Sheet1!$R$11,Sheet1!$V$11,Sheet1!$Z$11)</c:f>
                <c:numCache>
                  <c:formatCode>General</c:formatCode>
                  <c:ptCount val="7"/>
                  <c:pt idx="0">
                    <c:v>2.6385377423760099E-4</c:v>
                  </c:pt>
                  <c:pt idx="1">
                    <c:v>1.755419716638291E-4</c:v>
                  </c:pt>
                  <c:pt idx="2">
                    <c:v>8.5197282144820166E-5</c:v>
                  </c:pt>
                  <c:pt idx="3">
                    <c:v>2.026666802564752E-4</c:v>
                  </c:pt>
                  <c:pt idx="4">
                    <c:v>4.6285305448084323E-4</c:v>
                  </c:pt>
                  <c:pt idx="5">
                    <c:v>3.0252993821671775E-4</c:v>
                  </c:pt>
                  <c:pt idx="6">
                    <c:v>9.6506947071823391E-5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accent1"/>
                </a:solidFill>
                <a:round/>
              </a:ln>
              <a:effectLst/>
            </c:spPr>
          </c:errBars>
          <c:cat>
            <c:strRef>
              <c:f>(Sheet1!$B$1,Sheet1!$F$1,Sheet1!$J$1,Sheet1!$N$1,Sheet1!$R$1,Sheet1!$V$1,Sheet1!$Z$1)</c:f>
              <c:strCache>
                <c:ptCount val="7"/>
                <c:pt idx="0">
                  <c:v>CCA1                                                   CDS</c:v>
                </c:pt>
                <c:pt idx="1">
                  <c:v>CCA1                                         FBS</c:v>
                </c:pt>
                <c:pt idx="2">
                  <c:v>CCA1                                       G-box</c:v>
                </c:pt>
                <c:pt idx="3">
                  <c:v>CCA1                                  TBS</c:v>
                </c:pt>
                <c:pt idx="4">
                  <c:v>CCA1                                    T1ME</c:v>
                </c:pt>
                <c:pt idx="5">
                  <c:v>LHY                                 G-box</c:v>
                </c:pt>
                <c:pt idx="6">
                  <c:v>LHY                                         G-box like</c:v>
                </c:pt>
              </c:strCache>
            </c:strRef>
          </c:cat>
          <c:val>
            <c:numRef>
              <c:f>(Sheet1!$B$10,Sheet1!$F$10,Sheet1!$J$10,Sheet1!$N$10,Sheet1!$R$10,Sheet1!$V$10,Sheet1!$Z$10)</c:f>
              <c:numCache>
                <c:formatCode>General</c:formatCode>
                <c:ptCount val="7"/>
                <c:pt idx="0">
                  <c:v>2.9731832664745624E-3</c:v>
                </c:pt>
                <c:pt idx="1">
                  <c:v>1.4788673600884827E-3</c:v>
                </c:pt>
                <c:pt idx="2">
                  <c:v>1.1932608729416868E-3</c:v>
                </c:pt>
                <c:pt idx="3">
                  <c:v>1.3494302049800767E-3</c:v>
                </c:pt>
                <c:pt idx="4">
                  <c:v>1.4939819322496511E-3</c:v>
                </c:pt>
                <c:pt idx="5">
                  <c:v>1.3400554094004109E-3</c:v>
                </c:pt>
                <c:pt idx="6">
                  <c:v>1.1359523863209884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F67-412C-A578-E27237ED9416}"/>
            </c:ext>
          </c:extLst>
        </c:ser>
        <c:ser>
          <c:idx val="1"/>
          <c:order val="1"/>
          <c:tx>
            <c:strRef>
              <c:f>Sheet1!$C$2</c:f>
              <c:strCache>
                <c:ptCount val="1"/>
                <c:pt idx="0">
                  <c:v>pTOC1:TOC1-GFP/t1 </c:v>
                </c:pt>
              </c:strCache>
            </c:strRef>
          </c:tx>
          <c:spPr>
            <a:noFill/>
            <a:ln w="12700">
              <a:solidFill>
                <a:srgbClr val="8C8C8C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Sheet1!$C$11,Sheet1!$G$11,Sheet1!$K$11,Sheet1!$O$11,Sheet1!$S$11,Sheet1!$W$11,Sheet1!$AA$11)</c:f>
                <c:numCache>
                  <c:formatCode>General</c:formatCode>
                  <c:ptCount val="7"/>
                  <c:pt idx="0">
                    <c:v>3.6824167784258024E-4</c:v>
                  </c:pt>
                  <c:pt idx="1">
                    <c:v>3.5765159010105411E-3</c:v>
                  </c:pt>
                  <c:pt idx="2">
                    <c:v>2.0970679424235166E-3</c:v>
                  </c:pt>
                  <c:pt idx="3">
                    <c:v>2.7656292939689806E-3</c:v>
                  </c:pt>
                  <c:pt idx="4">
                    <c:v>9.7947471342210517E-4</c:v>
                  </c:pt>
                  <c:pt idx="5">
                    <c:v>3.5503580524490312E-3</c:v>
                  </c:pt>
                  <c:pt idx="6">
                    <c:v>3.307062496581051E-3</c:v>
                  </c:pt>
                </c:numCache>
              </c:numRef>
            </c:plus>
            <c:minus>
              <c:numRef>
                <c:f>(Sheet1!$C$11,Sheet1!$G$11,Sheet1!$K$11,Sheet1!$O$11,Sheet1!$S$11,Sheet1!$W$11,Sheet1!$AA$11)</c:f>
                <c:numCache>
                  <c:formatCode>General</c:formatCode>
                  <c:ptCount val="7"/>
                  <c:pt idx="0">
                    <c:v>3.6824167784258024E-4</c:v>
                  </c:pt>
                  <c:pt idx="1">
                    <c:v>3.5765159010105411E-3</c:v>
                  </c:pt>
                  <c:pt idx="2">
                    <c:v>2.0970679424235166E-3</c:v>
                  </c:pt>
                  <c:pt idx="3">
                    <c:v>2.7656292939689806E-3</c:v>
                  </c:pt>
                  <c:pt idx="4">
                    <c:v>9.7947471342210517E-4</c:v>
                  </c:pt>
                  <c:pt idx="5">
                    <c:v>3.5503580524490312E-3</c:v>
                  </c:pt>
                  <c:pt idx="6">
                    <c:v>3.307062496581051E-3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>
                    <a:lumMod val="50000"/>
                    <a:lumOff val="50000"/>
                  </a:schemeClr>
                </a:solidFill>
                <a:round/>
              </a:ln>
              <a:effectLst/>
            </c:spPr>
          </c:errBars>
          <c:cat>
            <c:strRef>
              <c:f>(Sheet1!$B$1,Sheet1!$F$1,Sheet1!$J$1,Sheet1!$N$1,Sheet1!$R$1,Sheet1!$V$1,Sheet1!$Z$1)</c:f>
              <c:strCache>
                <c:ptCount val="7"/>
                <c:pt idx="0">
                  <c:v>CCA1                                                   CDS</c:v>
                </c:pt>
                <c:pt idx="1">
                  <c:v>CCA1                                         FBS</c:v>
                </c:pt>
                <c:pt idx="2">
                  <c:v>CCA1                                       G-box</c:v>
                </c:pt>
                <c:pt idx="3">
                  <c:v>CCA1                                  TBS</c:v>
                </c:pt>
                <c:pt idx="4">
                  <c:v>CCA1                                    T1ME</c:v>
                </c:pt>
                <c:pt idx="5">
                  <c:v>LHY                                 G-box</c:v>
                </c:pt>
                <c:pt idx="6">
                  <c:v>LHY                                         G-box like</c:v>
                </c:pt>
              </c:strCache>
            </c:strRef>
          </c:cat>
          <c:val>
            <c:numRef>
              <c:f>(Sheet1!$C$10,Sheet1!$G$10,Sheet1!$K$10,Sheet1!$O$10,Sheet1!$S$10,Sheet1!$W$10,Sheet1!$AA$10)</c:f>
              <c:numCache>
                <c:formatCode>General</c:formatCode>
                <c:ptCount val="7"/>
                <c:pt idx="0">
                  <c:v>1.9493135015736373E-3</c:v>
                </c:pt>
                <c:pt idx="1">
                  <c:v>5.2091067175736451E-2</c:v>
                </c:pt>
                <c:pt idx="2">
                  <c:v>5.6025370014436339E-2</c:v>
                </c:pt>
                <c:pt idx="3">
                  <c:v>6.0548976601833497E-2</c:v>
                </c:pt>
                <c:pt idx="4">
                  <c:v>7.0322138370161767E-3</c:v>
                </c:pt>
                <c:pt idx="5">
                  <c:v>5.6244950415597315E-2</c:v>
                </c:pt>
                <c:pt idx="6">
                  <c:v>5.373148094988859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4F67-412C-A578-E27237ED9416}"/>
            </c:ext>
          </c:extLst>
        </c:ser>
        <c:ser>
          <c:idx val="2"/>
          <c:order val="2"/>
          <c:tx>
            <c:strRef>
              <c:f>Sheet1!$D$2</c:f>
              <c:strCache>
                <c:ptCount val="1"/>
                <c:pt idx="0">
                  <c:v>pTOC1:5X-GFP/t1 </c:v>
                </c:pt>
              </c:strCache>
            </c:strRef>
          </c:tx>
          <c:spPr>
            <a:noFill/>
            <a:ln w="12700">
              <a:solidFill>
                <a:schemeClr val="accent4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Sheet1!$D$11,Sheet1!$H$11,Sheet1!$L$11,Sheet1!$P$11,Sheet1!$T$11,Sheet1!$X$11,Sheet1!$AB$11)</c:f>
                <c:numCache>
                  <c:formatCode>General</c:formatCode>
                  <c:ptCount val="7"/>
                  <c:pt idx="0">
                    <c:v>4.7413400968526813E-4</c:v>
                  </c:pt>
                  <c:pt idx="1">
                    <c:v>4.3579347460198528E-4</c:v>
                  </c:pt>
                  <c:pt idx="2">
                    <c:v>5.9728588745531456E-4</c:v>
                  </c:pt>
                  <c:pt idx="3">
                    <c:v>7.1756115694135154E-4</c:v>
                  </c:pt>
                  <c:pt idx="4">
                    <c:v>3.288239932032905E-4</c:v>
                  </c:pt>
                  <c:pt idx="5">
                    <c:v>2.7306421236607077E-3</c:v>
                  </c:pt>
                  <c:pt idx="6">
                    <c:v>1.4659845594877539E-3</c:v>
                  </c:pt>
                </c:numCache>
              </c:numRef>
            </c:plus>
            <c:minus>
              <c:numRef>
                <c:f>(Sheet1!$D$11,Sheet1!$H$11,Sheet1!$L$11,Sheet1!$P$11,Sheet1!$T$11,Sheet1!$X$11,Sheet1!$AB$11)</c:f>
                <c:numCache>
                  <c:formatCode>General</c:formatCode>
                  <c:ptCount val="7"/>
                  <c:pt idx="0">
                    <c:v>4.7413400968526813E-4</c:v>
                  </c:pt>
                  <c:pt idx="1">
                    <c:v>4.3579347460198528E-4</c:v>
                  </c:pt>
                  <c:pt idx="2">
                    <c:v>5.9728588745531456E-4</c:v>
                  </c:pt>
                  <c:pt idx="3">
                    <c:v>7.1756115694135154E-4</c:v>
                  </c:pt>
                  <c:pt idx="4">
                    <c:v>3.288239932032905E-4</c:v>
                  </c:pt>
                  <c:pt idx="5">
                    <c:v>2.7306421236607077E-3</c:v>
                  </c:pt>
                  <c:pt idx="6">
                    <c:v>1.4659845594877539E-3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accent4"/>
                </a:solidFill>
                <a:round/>
              </a:ln>
              <a:effectLst/>
            </c:spPr>
          </c:errBars>
          <c:cat>
            <c:strRef>
              <c:f>(Sheet1!$B$1,Sheet1!$F$1,Sheet1!$J$1,Sheet1!$N$1,Sheet1!$R$1,Sheet1!$V$1,Sheet1!$Z$1)</c:f>
              <c:strCache>
                <c:ptCount val="7"/>
                <c:pt idx="0">
                  <c:v>CCA1                                                   CDS</c:v>
                </c:pt>
                <c:pt idx="1">
                  <c:v>CCA1                                         FBS</c:v>
                </c:pt>
                <c:pt idx="2">
                  <c:v>CCA1                                       G-box</c:v>
                </c:pt>
                <c:pt idx="3">
                  <c:v>CCA1                                  TBS</c:v>
                </c:pt>
                <c:pt idx="4">
                  <c:v>CCA1                                    T1ME</c:v>
                </c:pt>
                <c:pt idx="5">
                  <c:v>LHY                                 G-box</c:v>
                </c:pt>
                <c:pt idx="6">
                  <c:v>LHY                                         G-box like</c:v>
                </c:pt>
              </c:strCache>
            </c:strRef>
          </c:cat>
          <c:val>
            <c:numRef>
              <c:f>(Sheet1!$D$10,Sheet1!$H$10,Sheet1!$L$10,Sheet1!$P$10,Sheet1!$T$10,Sheet1!$X$10,Sheet1!$AB$10)</c:f>
              <c:numCache>
                <c:formatCode>General</c:formatCode>
                <c:ptCount val="7"/>
                <c:pt idx="0">
                  <c:v>2.1325141028074937E-3</c:v>
                </c:pt>
                <c:pt idx="1">
                  <c:v>5.3644070268319835E-3</c:v>
                </c:pt>
                <c:pt idx="2">
                  <c:v>5.4823758884667258E-3</c:v>
                </c:pt>
                <c:pt idx="3">
                  <c:v>5.1679630354223771E-3</c:v>
                </c:pt>
                <c:pt idx="4">
                  <c:v>4.0207516964060608E-3</c:v>
                </c:pt>
                <c:pt idx="5">
                  <c:v>5.4156008469177404E-2</c:v>
                </c:pt>
                <c:pt idx="6">
                  <c:v>4.6452274563008635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4F67-412C-A578-E27237ED941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136359951"/>
        <c:axId val="261743247"/>
      </c:barChart>
      <c:catAx>
        <c:axId val="136359951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1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61743247"/>
        <c:crosses val="autoZero"/>
        <c:auto val="1"/>
        <c:lblAlgn val="ctr"/>
        <c:lblOffset val="100"/>
        <c:noMultiLvlLbl val="0"/>
      </c:catAx>
      <c:valAx>
        <c:axId val="261743247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36359951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t"/>
      <c:legendEntry>
        <c:idx val="0"/>
        <c:txPr>
          <a:bodyPr rot="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</c:legendEntry>
      <c:layout>
        <c:manualLayout>
          <c:xMode val="edge"/>
          <c:yMode val="edge"/>
          <c:x val="0.17223882281412736"/>
          <c:y val="7.4679560078913618E-2"/>
          <c:w val="0.72976724490273148"/>
          <c:h val="7.1587147212299182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1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000">
          <a:solidFill>
            <a:sysClr val="windowText" lastClr="000000"/>
          </a:solidFill>
        </a:defRPr>
      </a:pPr>
      <a:endParaRPr lang="en-US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1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sz="1100" b="0" i="0" baseline="0" dirty="0">
                <a:effectLst/>
              </a:rPr>
              <a:t>TOC1-GFP </a:t>
            </a:r>
            <a:r>
              <a:rPr lang="en-US" sz="1100" b="0" i="0" baseline="0" dirty="0" err="1">
                <a:effectLst/>
              </a:rPr>
              <a:t>ChIP</a:t>
            </a:r>
            <a:r>
              <a:rPr lang="en-US" sz="1100" b="0" i="0" baseline="0" dirty="0">
                <a:effectLst/>
              </a:rPr>
              <a:t>: </a:t>
            </a:r>
            <a:r>
              <a:rPr lang="el-GR" sz="1100" b="0" i="0" baseline="0" dirty="0">
                <a:effectLst/>
              </a:rPr>
              <a:t>α</a:t>
            </a:r>
            <a:r>
              <a:rPr lang="en-US" sz="1100" b="0" i="0" baseline="0" dirty="0">
                <a:effectLst/>
              </a:rPr>
              <a:t>-GFP</a:t>
            </a:r>
            <a:endParaRPr lang="en-US" sz="1100" dirty="0">
              <a:effectLst/>
            </a:endParaRPr>
          </a:p>
        </c:rich>
      </c:tx>
      <c:layout>
        <c:manualLayout>
          <c:xMode val="edge"/>
          <c:yMode val="edge"/>
          <c:x val="0.35498872260866504"/>
          <c:y val="7.7463371272430304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6005682469455373"/>
          <c:y val="0.177897641663668"/>
          <c:w val="0.80355677821310878"/>
          <c:h val="0.6816997668446138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A$4</c:f>
              <c:strCache>
                <c:ptCount val="1"/>
                <c:pt idx="0">
                  <c:v>Col-0</c:v>
                </c:pt>
              </c:strCache>
            </c:strRef>
          </c:tx>
          <c:spPr>
            <a:noFill/>
            <a:ln w="12700">
              <a:solidFill>
                <a:schemeClr val="accent5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Sheet1!$H$9,Sheet1!$H$15,Sheet1!$H$21)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3.4659410342904412E-4</c:v>
                  </c:pt>
                  <c:pt idx="2">
                    <c:v>1.3896426548482176E-4</c:v>
                  </c:pt>
                </c:numCache>
                <c:extLst/>
              </c:numRef>
            </c:plus>
            <c:minus>
              <c:numRef>
                <c:f>(Sheet1!$H$9,Sheet1!$H$15,Sheet1!$H$21)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3.4659410342904412E-4</c:v>
                  </c:pt>
                  <c:pt idx="2">
                    <c:v>1.3896426548482176E-4</c:v>
                  </c:pt>
                </c:numCache>
                <c:extLst/>
              </c:numRef>
            </c:minus>
            <c:spPr>
              <a:noFill/>
              <a:ln w="12700" cap="flat" cmpd="sng" algn="ctr">
                <a:solidFill>
                  <a:schemeClr val="accent5"/>
                </a:solidFill>
                <a:round/>
              </a:ln>
              <a:effectLst/>
            </c:spPr>
          </c:errBars>
          <c:cat>
            <c:strRef>
              <c:f>(Sheet1!$A$5,Sheet1!$A$11,Sheet1!$A$17)</c:f>
              <c:strCache>
                <c:ptCount val="3"/>
                <c:pt idx="0">
                  <c:v>CCA1 CDS</c:v>
                </c:pt>
                <c:pt idx="1">
                  <c:v>CCA1 FBS</c:v>
                </c:pt>
                <c:pt idx="2">
                  <c:v>LHY G-box</c:v>
                </c:pt>
              </c:strCache>
              <c:extLst/>
            </c:strRef>
          </c:cat>
          <c:val>
            <c:numRef>
              <c:f>(Sheet1!$H$8,Sheet1!$H$14,Sheet1!$H$20)</c:f>
              <c:numCache>
                <c:formatCode>General</c:formatCode>
                <c:ptCount val="3"/>
                <c:pt idx="0">
                  <c:v>1.450342437121264E-3</c:v>
                </c:pt>
                <c:pt idx="1">
                  <c:v>1.2801052295336017E-3</c:v>
                </c:pt>
                <c:pt idx="2">
                  <c:v>6.6405028098045766E-4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0-C986-443B-8373-B63BE7FCD687}"/>
            </c:ext>
          </c:extLst>
        </c:ser>
        <c:ser>
          <c:idx val="1"/>
          <c:order val="1"/>
          <c:tx>
            <c:strRef>
              <c:f>Sheet1!$K$4</c:f>
              <c:strCache>
                <c:ptCount val="1"/>
                <c:pt idx="0">
                  <c:v>pTOC1:TOC1-GFP/t1</c:v>
                </c:pt>
              </c:strCache>
            </c:strRef>
          </c:tx>
          <c:spPr>
            <a:noFill/>
            <a:ln w="12700">
              <a:solidFill>
                <a:schemeClr val="bg1">
                  <a:lumMod val="50000"/>
                </a:schemeClr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Sheet1!$R$9,Sheet1!$R$15,Sheet1!$R$21)</c:f>
                <c:numCache>
                  <c:formatCode>General</c:formatCode>
                  <c:ptCount val="3"/>
                  <c:pt idx="0">
                    <c:v>1.1453173809455111E-3</c:v>
                  </c:pt>
                  <c:pt idx="1">
                    <c:v>2.2846281950356451E-3</c:v>
                  </c:pt>
                  <c:pt idx="2">
                    <c:v>5.2548672646508914E-3</c:v>
                  </c:pt>
                </c:numCache>
                <c:extLst/>
              </c:numRef>
            </c:plus>
            <c:minus>
              <c:numRef>
                <c:f>(Sheet1!$R$9,Sheet1!$R$15,Sheet1!$R$21)</c:f>
                <c:numCache>
                  <c:formatCode>General</c:formatCode>
                  <c:ptCount val="3"/>
                  <c:pt idx="0">
                    <c:v>1.1453173809455111E-3</c:v>
                  </c:pt>
                  <c:pt idx="1">
                    <c:v>2.2846281950356451E-3</c:v>
                  </c:pt>
                  <c:pt idx="2">
                    <c:v>5.2548672646508914E-3</c:v>
                  </c:pt>
                </c:numCache>
                <c:extLst/>
              </c:numRef>
            </c:minus>
            <c:spPr>
              <a:noFill/>
              <a:ln w="12700" cap="flat" cmpd="sng" algn="ctr">
                <a:solidFill>
                  <a:schemeClr val="bg1">
                    <a:lumMod val="50000"/>
                  </a:schemeClr>
                </a:solidFill>
                <a:round/>
              </a:ln>
              <a:effectLst/>
            </c:spPr>
          </c:errBars>
          <c:cat>
            <c:strRef>
              <c:f>(Sheet1!$A$5,Sheet1!$A$11,Sheet1!$A$17)</c:f>
              <c:strCache>
                <c:ptCount val="3"/>
                <c:pt idx="0">
                  <c:v>CCA1 CDS</c:v>
                </c:pt>
                <c:pt idx="1">
                  <c:v>CCA1 FBS</c:v>
                </c:pt>
                <c:pt idx="2">
                  <c:v>LHY G-box</c:v>
                </c:pt>
              </c:strCache>
              <c:extLst/>
            </c:strRef>
          </c:cat>
          <c:val>
            <c:numRef>
              <c:f>(Sheet1!$R$8,Sheet1!$R$14,Sheet1!$R$20)</c:f>
              <c:numCache>
                <c:formatCode>General</c:formatCode>
                <c:ptCount val="3"/>
                <c:pt idx="0">
                  <c:v>4.0991286593657509E-3</c:v>
                </c:pt>
                <c:pt idx="1">
                  <c:v>5.7772965788641488E-2</c:v>
                </c:pt>
                <c:pt idx="2">
                  <c:v>6.6512777713021748E-2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1-C986-443B-8373-B63BE7FCD687}"/>
            </c:ext>
          </c:extLst>
        </c:ser>
        <c:ser>
          <c:idx val="3"/>
          <c:order val="2"/>
          <c:tx>
            <c:strRef>
              <c:f>Sheet1!$U$4</c:f>
              <c:strCache>
                <c:ptCount val="1"/>
                <c:pt idx="0">
                  <c:v>pTOC1:TOC1-GFP/pif345t1</c:v>
                </c:pt>
              </c:strCache>
            </c:strRef>
          </c:tx>
          <c:spPr>
            <a:noFill/>
            <a:ln w="12700">
              <a:solidFill>
                <a:srgbClr val="FF99CC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Sheet1!$AB$9,Sheet1!$AB$15,Sheet1!$AB$21)</c:f>
                <c:numCache>
                  <c:formatCode>General</c:formatCode>
                  <c:ptCount val="3"/>
                  <c:pt idx="0">
                    <c:v>9.5968079271797218E-4</c:v>
                  </c:pt>
                  <c:pt idx="1">
                    <c:v>1.5966445233867607E-3</c:v>
                  </c:pt>
                  <c:pt idx="2">
                    <c:v>5.0907896730870593E-3</c:v>
                  </c:pt>
                </c:numCache>
                <c:extLst/>
              </c:numRef>
            </c:plus>
            <c:minus>
              <c:numRef>
                <c:f>(Sheet1!$AB$9,Sheet1!$AB$15,Sheet1!$AB$21)</c:f>
                <c:numCache>
                  <c:formatCode>General</c:formatCode>
                  <c:ptCount val="3"/>
                  <c:pt idx="0">
                    <c:v>9.5968079271797218E-4</c:v>
                  </c:pt>
                  <c:pt idx="1">
                    <c:v>1.5966445233867607E-3</c:v>
                  </c:pt>
                  <c:pt idx="2">
                    <c:v>5.0907896730870593E-3</c:v>
                  </c:pt>
                </c:numCache>
                <c:extLst/>
              </c:numRef>
            </c:minus>
            <c:spPr>
              <a:noFill/>
              <a:ln w="12700" cap="flat" cmpd="sng" algn="ctr">
                <a:solidFill>
                  <a:srgbClr val="FF99CC"/>
                </a:solidFill>
                <a:round/>
              </a:ln>
              <a:effectLst/>
            </c:spPr>
          </c:errBars>
          <c:cat>
            <c:strRef>
              <c:f>(Sheet1!$A$5,Sheet1!$A$11,Sheet1!$A$17)</c:f>
              <c:strCache>
                <c:ptCount val="3"/>
                <c:pt idx="0">
                  <c:v>CCA1 CDS</c:v>
                </c:pt>
                <c:pt idx="1">
                  <c:v>CCA1 FBS</c:v>
                </c:pt>
                <c:pt idx="2">
                  <c:v>LHY G-box</c:v>
                </c:pt>
              </c:strCache>
              <c:extLst/>
            </c:strRef>
          </c:cat>
          <c:val>
            <c:numRef>
              <c:f>(Sheet1!$AB$8,Sheet1!$AB$14,Sheet1!$AB$20)</c:f>
              <c:numCache>
                <c:formatCode>General</c:formatCode>
                <c:ptCount val="3"/>
                <c:pt idx="0">
                  <c:v>3.702706300195111E-3</c:v>
                </c:pt>
                <c:pt idx="1">
                  <c:v>5.5584119700084755E-2</c:v>
                </c:pt>
                <c:pt idx="2">
                  <c:v>6.5728660984267037E-2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2-C986-443B-8373-B63BE7FCD68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78798511"/>
        <c:axId val="276526639"/>
      </c:barChart>
      <c:catAx>
        <c:axId val="278798511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1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76526639"/>
        <c:crosses val="autoZero"/>
        <c:auto val="1"/>
        <c:lblAlgn val="ctr"/>
        <c:lblOffset val="100"/>
        <c:noMultiLvlLbl val="0"/>
      </c:catAx>
      <c:valAx>
        <c:axId val="276526639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000">
                    <a:solidFill>
                      <a:schemeClr val="tx1"/>
                    </a:solidFill>
                  </a:rPr>
                  <a:t>%</a:t>
                </a:r>
                <a:r>
                  <a:rPr lang="en-US" sz="1000" baseline="0">
                    <a:solidFill>
                      <a:schemeClr val="tx1"/>
                    </a:solidFill>
                  </a:rPr>
                  <a:t> Input</a:t>
                </a:r>
                <a:endParaRPr lang="en-US" sz="1000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78798511"/>
        <c:crosses val="autoZero"/>
        <c:crossBetween val="between"/>
        <c:majorUnit val="1.0000000000000002E-2"/>
      </c:valAx>
      <c:spPr>
        <a:noFill/>
        <a:ln>
          <a:noFill/>
        </a:ln>
        <a:effectLst/>
      </c:spPr>
    </c:plotArea>
    <c:legend>
      <c:legendPos val="t"/>
      <c:legendEntry>
        <c:idx val="0"/>
        <c:txPr>
          <a:bodyPr rot="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</c:legendEntry>
      <c:layout>
        <c:manualLayout>
          <c:xMode val="edge"/>
          <c:yMode val="edge"/>
          <c:x val="0.14509183018658464"/>
          <c:y val="0.16550746212251913"/>
          <c:w val="0.38054346869173805"/>
          <c:h val="0.25933730634054486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1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9618326704169934"/>
          <c:y val="6.0004041484848156E-2"/>
          <c:w val="0.64386243041095093"/>
          <c:h val="0.43070716874938408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5"/>
            </a:solidFill>
            <a:ln w="19050">
              <a:solidFill>
                <a:schemeClr val="accent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noFill/>
              <a:ln w="19050">
                <a:solidFill>
                  <a:schemeClr val="accent2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1441-4D3B-BCA3-BF0C1426628C}"/>
              </c:ext>
            </c:extLst>
          </c:dPt>
          <c:dPt>
            <c:idx val="1"/>
            <c:invertIfNegative val="0"/>
            <c:bubble3D val="0"/>
            <c:spPr>
              <a:noFill/>
              <a:ln w="19050">
                <a:solidFill>
                  <a:schemeClr val="accent3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1441-4D3B-BCA3-BF0C1426628C}"/>
              </c:ext>
            </c:extLst>
          </c:dPt>
          <c:dPt>
            <c:idx val="2"/>
            <c:invertIfNegative val="0"/>
            <c:bubble3D val="0"/>
            <c:spPr>
              <a:noFill/>
              <a:ln w="19050">
                <a:solidFill>
                  <a:schemeClr val="accent4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1441-4D3B-BCA3-BF0C1426628C}"/>
              </c:ext>
            </c:extLst>
          </c:dPt>
          <c:dPt>
            <c:idx val="3"/>
            <c:invertIfNegative val="0"/>
            <c:bubble3D val="0"/>
            <c:spPr>
              <a:noFill/>
              <a:ln w="19050">
                <a:solidFill>
                  <a:schemeClr val="accent6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1441-4D3B-BCA3-BF0C1426628C}"/>
              </c:ext>
            </c:extLst>
          </c:dPt>
          <c:errBars>
            <c:errBarType val="both"/>
            <c:errValType val="cust"/>
            <c:noEndCap val="0"/>
            <c:plus>
              <c:numRef>
                <c:f>Sheet1!$R$3:$R$6</c:f>
                <c:numCache>
                  <c:formatCode>General</c:formatCode>
                  <c:ptCount val="4"/>
                  <c:pt idx="0">
                    <c:v>0.14034602107969746</c:v>
                  </c:pt>
                  <c:pt idx="1">
                    <c:v>0.21349513168369025</c:v>
                  </c:pt>
                  <c:pt idx="2">
                    <c:v>0.15206691113634974</c:v>
                  </c:pt>
                  <c:pt idx="3">
                    <c:v>0.10783048869891024</c:v>
                  </c:pt>
                </c:numCache>
              </c:numRef>
            </c:plus>
            <c:minus>
              <c:numRef>
                <c:f>Sheet1!$R$3:$R$6</c:f>
                <c:numCache>
                  <c:formatCode>General</c:formatCode>
                  <c:ptCount val="4"/>
                  <c:pt idx="0">
                    <c:v>0.14034602107969746</c:v>
                  </c:pt>
                  <c:pt idx="1">
                    <c:v>0.21349513168369025</c:v>
                  </c:pt>
                  <c:pt idx="2">
                    <c:v>0.15206691113634974</c:v>
                  </c:pt>
                  <c:pt idx="3">
                    <c:v>0.1078304886989102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S$3:$S$6</c:f>
              <c:strCache>
                <c:ptCount val="4"/>
                <c:pt idx="0">
                  <c:v>pTOC1:TOC1-GFP/toc1</c:v>
                </c:pt>
                <c:pt idx="1">
                  <c:v>pTOC1:5X-GFP/toc1</c:v>
                </c:pt>
                <c:pt idx="2">
                  <c:v>pTOC1:TOC1-GFP/fhy3toc1</c:v>
                </c:pt>
                <c:pt idx="3">
                  <c:v>pTOC1:5X-GFP/fhy3toc1</c:v>
                </c:pt>
              </c:strCache>
            </c:strRef>
          </c:cat>
          <c:val>
            <c:numRef>
              <c:f>Sheet1!$Q$3:$Q$6</c:f>
              <c:numCache>
                <c:formatCode>General</c:formatCode>
                <c:ptCount val="4"/>
                <c:pt idx="0">
                  <c:v>1</c:v>
                </c:pt>
                <c:pt idx="1">
                  <c:v>1.1154933527566466</c:v>
                </c:pt>
                <c:pt idx="2">
                  <c:v>1.0569273319574803</c:v>
                </c:pt>
                <c:pt idx="3">
                  <c:v>0.719714564886022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1441-4D3B-BCA3-BF0C1426628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1496559424"/>
        <c:axId val="1496560672"/>
      </c:barChart>
      <c:catAx>
        <c:axId val="149655942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1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96560672"/>
        <c:crosses val="autoZero"/>
        <c:auto val="1"/>
        <c:lblAlgn val="ctr"/>
        <c:lblOffset val="100"/>
        <c:noMultiLvlLbl val="0"/>
      </c:catAx>
      <c:valAx>
        <c:axId val="149656067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TOC1-GFP/ADK</a:t>
                </a:r>
              </a:p>
            </c:rich>
          </c:tx>
          <c:layout>
            <c:manualLayout>
              <c:xMode val="edge"/>
              <c:yMode val="edge"/>
              <c:x val="4.3603129125345266E-2"/>
              <c:y val="8.9318313882146547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96559424"/>
        <c:crosses val="autoZero"/>
        <c:crossBetween val="between"/>
      </c:valAx>
      <c:spPr>
        <a:noFill/>
        <a:ln w="19050"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solidFill>
            <a:sysClr val="windowText" lastClr="000000"/>
          </a:solidFill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43343" cy="467072"/>
          </a:xfrm>
          <a:prstGeom prst="rect">
            <a:avLst/>
          </a:prstGeom>
        </p:spPr>
        <p:txBody>
          <a:bodyPr vert="horz" lIns="93324" tIns="46662" rIns="93324" bIns="46662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8132" y="0"/>
            <a:ext cx="3043343" cy="467072"/>
          </a:xfrm>
          <a:prstGeom prst="rect">
            <a:avLst/>
          </a:prstGeom>
        </p:spPr>
        <p:txBody>
          <a:bodyPr vert="horz" lIns="93324" tIns="46662" rIns="93324" bIns="46662" rtlCol="0"/>
          <a:lstStyle>
            <a:lvl1pPr algn="r">
              <a:defRPr sz="1200"/>
            </a:lvl1pPr>
          </a:lstStyle>
          <a:p>
            <a:fld id="{FD48559D-6E24-4311-8FC0-33BDD43A3255}" type="datetimeFigureOut">
              <a:rPr lang="en-US" smtClean="0"/>
              <a:t>3/25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424113" y="1163638"/>
            <a:ext cx="2174875" cy="314166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324" tIns="46662" rIns="93324" bIns="46662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2310" y="4480004"/>
            <a:ext cx="5618480" cy="3665458"/>
          </a:xfrm>
          <a:prstGeom prst="rect">
            <a:avLst/>
          </a:prstGeom>
        </p:spPr>
        <p:txBody>
          <a:bodyPr vert="horz" lIns="93324" tIns="46662" rIns="93324" bIns="46662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42030"/>
            <a:ext cx="3043343" cy="467071"/>
          </a:xfrm>
          <a:prstGeom prst="rect">
            <a:avLst/>
          </a:prstGeom>
        </p:spPr>
        <p:txBody>
          <a:bodyPr vert="horz" lIns="93324" tIns="46662" rIns="93324" bIns="46662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8132" y="8842030"/>
            <a:ext cx="3043343" cy="467071"/>
          </a:xfrm>
          <a:prstGeom prst="rect">
            <a:avLst/>
          </a:prstGeom>
        </p:spPr>
        <p:txBody>
          <a:bodyPr vert="horz" lIns="93324" tIns="46662" rIns="93324" bIns="46662" rtlCol="0" anchor="b"/>
          <a:lstStyle>
            <a:lvl1pPr algn="r">
              <a:defRPr sz="1200"/>
            </a:lvl1pPr>
          </a:lstStyle>
          <a:p>
            <a:fld id="{819F8956-CCA9-4AF7-81B8-2E62C4EF20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921792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19F8956-CCA9-4AF7-81B8-2E62C4EF20C9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543908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591B462B-B399-7D5A-7C46-E7FCE70398EF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>
            <a:extLst>
              <a:ext uri="{FF2B5EF4-FFF2-40B4-BE49-F238E27FC236}">
                <a16:creationId xmlns:a16="http://schemas.microsoft.com/office/drawing/2014/main" id="{C3D16739-B11A-C486-90CC-99E3360DD808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>
            <a:extLst>
              <a:ext uri="{FF2B5EF4-FFF2-40B4-BE49-F238E27FC236}">
                <a16:creationId xmlns:a16="http://schemas.microsoft.com/office/drawing/2014/main" id="{94C98BD0-4304-9571-B93E-12C322CD67F4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zh-CN" altLang="en-US" dirty="0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23EE0C90-FC4A-EC5E-7B7B-5F8CC5C5C5F9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19F8956-CCA9-4AF7-81B8-2E62C4EF20C9}" type="slidenum">
              <a:rPr lang="en-US" smtClean="0"/>
              <a:t>1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654510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19F8956-CCA9-4AF7-81B8-2E62C4EF20C9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5591859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19F8956-CCA9-4AF7-81B8-2E62C4EF20C9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5837183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19F8956-CCA9-4AF7-81B8-2E62C4EF20C9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044558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19F8956-CCA9-4AF7-81B8-2E62C4EF20C9}" type="slidenum">
              <a:rPr lang="en-US" smtClean="0"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9570142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19F8956-CCA9-4AF7-81B8-2E62C4EF20C9}" type="slidenum">
              <a:rPr lang="en-US" smtClean="0"/>
              <a:t>1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6220552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19F8956-CCA9-4AF7-81B8-2E62C4EF20C9}" type="slidenum">
              <a:rPr lang="en-US" smtClean="0"/>
              <a:t>1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9222204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19F8956-CCA9-4AF7-81B8-2E62C4EF20C9}" type="slidenum">
              <a:rPr lang="en-US" smtClean="0"/>
              <a:t>1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2947778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19F8956-CCA9-4AF7-81B8-2E62C4EF20C9}" type="slidenum">
              <a:rPr lang="en-US" smtClean="0"/>
              <a:t>1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566324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F340A7-550F-4E23-9F6D-A912A3F7D209}" type="datetimeFigureOut">
              <a:rPr lang="en-US" smtClean="0"/>
              <a:t>3/2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D0B7DA-25DA-45BF-8BD1-5E578FA068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74198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F340A7-550F-4E23-9F6D-A912A3F7D209}" type="datetimeFigureOut">
              <a:rPr lang="en-US" smtClean="0"/>
              <a:t>3/2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D0B7DA-25DA-45BF-8BD1-5E578FA068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28381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F340A7-550F-4E23-9F6D-A912A3F7D209}" type="datetimeFigureOut">
              <a:rPr lang="en-US" smtClean="0"/>
              <a:t>3/2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D0B7DA-25DA-45BF-8BD1-5E578FA068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8500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F340A7-550F-4E23-9F6D-A912A3F7D209}" type="datetimeFigureOut">
              <a:rPr lang="en-US" smtClean="0"/>
              <a:t>3/2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D0B7DA-25DA-45BF-8BD1-5E578FA068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02120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F340A7-550F-4E23-9F6D-A912A3F7D209}" type="datetimeFigureOut">
              <a:rPr lang="en-US" smtClean="0"/>
              <a:t>3/2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D0B7DA-25DA-45BF-8BD1-5E578FA068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15159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F340A7-550F-4E23-9F6D-A912A3F7D209}" type="datetimeFigureOut">
              <a:rPr lang="en-US" smtClean="0"/>
              <a:t>3/25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D0B7DA-25DA-45BF-8BD1-5E578FA068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78805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F340A7-550F-4E23-9F6D-A912A3F7D209}" type="datetimeFigureOut">
              <a:rPr lang="en-US" smtClean="0"/>
              <a:t>3/25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D0B7DA-25DA-45BF-8BD1-5E578FA068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37525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F340A7-550F-4E23-9F6D-A912A3F7D209}" type="datetimeFigureOut">
              <a:rPr lang="en-US" smtClean="0"/>
              <a:t>3/25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D0B7DA-25DA-45BF-8BD1-5E578FA068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50662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F340A7-550F-4E23-9F6D-A912A3F7D209}" type="datetimeFigureOut">
              <a:rPr lang="en-US" smtClean="0"/>
              <a:t>3/25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D0B7DA-25DA-45BF-8BD1-5E578FA068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52132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F340A7-550F-4E23-9F6D-A912A3F7D209}" type="datetimeFigureOut">
              <a:rPr lang="en-US" smtClean="0"/>
              <a:t>3/25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D0B7DA-25DA-45BF-8BD1-5E578FA068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05790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F340A7-550F-4E23-9F6D-A912A3F7D209}" type="datetimeFigureOut">
              <a:rPr lang="en-US" smtClean="0"/>
              <a:t>3/25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D0B7DA-25DA-45BF-8BD1-5E578FA068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67472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F340A7-550F-4E23-9F6D-A912A3F7D209}" type="datetimeFigureOut">
              <a:rPr lang="en-US" smtClean="0"/>
              <a:t>3/2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D0B7DA-25DA-45BF-8BD1-5E578FA068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39764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.png"/><Relationship Id="rId4" Type="http://schemas.openxmlformats.org/officeDocument/2006/relationships/chart" Target="../charts/chart2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chart" Target="../charts/chart4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7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chart" Target="../charts/chart5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6.xml"/><Relationship Id="rId4" Type="http://schemas.openxmlformats.org/officeDocument/2006/relationships/image" Target="../media/image9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3.png"/><Relationship Id="rId4" Type="http://schemas.openxmlformats.org/officeDocument/2006/relationships/image" Target="../media/image12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chart" Target="../charts/chart7.xml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8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ti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9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0.xml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13.xml"/><Relationship Id="rId5" Type="http://schemas.openxmlformats.org/officeDocument/2006/relationships/chart" Target="../charts/chart12.xml"/><Relationship Id="rId4" Type="http://schemas.openxmlformats.org/officeDocument/2006/relationships/chart" Target="../charts/chart11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>
            <a:extLst>
              <a:ext uri="{FF2B5EF4-FFF2-40B4-BE49-F238E27FC236}">
                <a16:creationId xmlns:a16="http://schemas.microsoft.com/office/drawing/2014/main" id="{19B0BA2C-A799-445F-8040-E2F2CCC62AE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21669024"/>
              </p:ext>
            </p:extLst>
          </p:nvPr>
        </p:nvGraphicFramePr>
        <p:xfrm>
          <a:off x="1085407" y="457051"/>
          <a:ext cx="4903997" cy="2476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CE86FCFF-E228-49E6-ADA3-581469F25B37}"/>
              </a:ext>
            </a:extLst>
          </p:cNvPr>
          <p:cNvSpPr txBox="1"/>
          <p:nvPr/>
        </p:nvSpPr>
        <p:spPr>
          <a:xfrm>
            <a:off x="596808" y="8244480"/>
            <a:ext cx="5581872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1. Circadian phenotype of the 2</a:t>
            </a:r>
            <a:r>
              <a:rPr lang="en-US" sz="12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d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dependent native promoter lines of wild-type </a:t>
            </a:r>
            <a:r>
              <a:rPr lang="en-US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C1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5X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riod vs RAE scatter plot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average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CA1:LUC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ioluminescence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of indicated plant lines. Shown are results of 45 seedlings from 3 independent trials. Free-running period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of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c1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and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f-yc3/4/9 toc1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349t1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using first 4 days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CA1:LUC 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ioluminescence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hown are results of 74 seedlings from 3 independent trials.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edlings were entrained in 12-h/12-h light/dark cycles for 7 days and then transferred to constant white light at ZT2 for image acquisition at 2-h intervals for 1 week. 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54B7E539-88EE-4F5A-BE27-6330609B8DF6}"/>
              </a:ext>
            </a:extLst>
          </p:cNvPr>
          <p:cNvSpPr txBox="1"/>
          <p:nvPr/>
        </p:nvSpPr>
        <p:spPr>
          <a:xfrm>
            <a:off x="938572" y="303161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A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0FAE341C-2C20-4522-A5E2-44E49AD7EC64}"/>
              </a:ext>
            </a:extLst>
          </p:cNvPr>
          <p:cNvSpPr txBox="1"/>
          <p:nvPr/>
        </p:nvSpPr>
        <p:spPr>
          <a:xfrm>
            <a:off x="938572" y="2933652"/>
            <a:ext cx="2856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B</a:t>
            </a:r>
          </a:p>
        </p:txBody>
      </p:sp>
      <p:grpSp>
        <p:nvGrpSpPr>
          <p:cNvPr id="27" name="组合 26">
            <a:extLst>
              <a:ext uri="{FF2B5EF4-FFF2-40B4-BE49-F238E27FC236}">
                <a16:creationId xmlns:a16="http://schemas.microsoft.com/office/drawing/2014/main" id="{1D7721E2-407C-52C8-7C8B-CC8BBFAE26F2}"/>
              </a:ext>
            </a:extLst>
          </p:cNvPr>
          <p:cNvGrpSpPr/>
          <p:nvPr/>
        </p:nvGrpSpPr>
        <p:grpSpPr>
          <a:xfrm>
            <a:off x="960345" y="3087541"/>
            <a:ext cx="5301352" cy="2742687"/>
            <a:chOff x="814635" y="3505202"/>
            <a:chExt cx="5572310" cy="2953525"/>
          </a:xfrm>
        </p:grpSpPr>
        <p:graphicFrame>
          <p:nvGraphicFramePr>
            <p:cNvPr id="6" name="Chart 5">
              <a:extLst>
                <a:ext uri="{FF2B5EF4-FFF2-40B4-BE49-F238E27FC236}">
                  <a16:creationId xmlns:a16="http://schemas.microsoft.com/office/drawing/2014/main" id="{AA2D5F33-BCFC-4AB1-BD40-5F5361485FCF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089702615"/>
                </p:ext>
              </p:extLst>
            </p:nvPr>
          </p:nvGraphicFramePr>
          <p:xfrm>
            <a:off x="814635" y="3505202"/>
            <a:ext cx="5572310" cy="286089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pSp>
          <p:nvGrpSpPr>
            <p:cNvPr id="8" name="Group 68">
              <a:extLst>
                <a:ext uri="{FF2B5EF4-FFF2-40B4-BE49-F238E27FC236}">
                  <a16:creationId xmlns:a16="http://schemas.microsoft.com/office/drawing/2014/main" id="{A16B9A44-D51F-F101-7B61-28D610547FAA}"/>
                </a:ext>
              </a:extLst>
            </p:cNvPr>
            <p:cNvGrpSpPr/>
            <p:nvPr/>
          </p:nvGrpSpPr>
          <p:grpSpPr>
            <a:xfrm>
              <a:off x="1410215" y="5851858"/>
              <a:ext cx="3535076" cy="67190"/>
              <a:chOff x="1170660" y="7554918"/>
              <a:chExt cx="2163158" cy="42665"/>
            </a:xfrm>
          </p:grpSpPr>
          <p:sp>
            <p:nvSpPr>
              <p:cNvPr id="21" name="Rectangle 69">
                <a:extLst>
                  <a:ext uri="{FF2B5EF4-FFF2-40B4-BE49-F238E27FC236}">
                    <a16:creationId xmlns:a16="http://schemas.microsoft.com/office/drawing/2014/main" id="{CE8B90B4-CD77-3634-71EC-BDD0CA3C3A82}"/>
                  </a:ext>
                </a:extLst>
              </p:cNvPr>
              <p:cNvSpPr/>
              <p:nvPr/>
            </p:nvSpPr>
            <p:spPr>
              <a:xfrm>
                <a:off x="1170660" y="7554919"/>
                <a:ext cx="2152782" cy="38398"/>
              </a:xfrm>
              <a:prstGeom prst="rect">
                <a:avLst/>
              </a:prstGeom>
              <a:solidFill>
                <a:schemeClr val="bg1"/>
              </a:solidFill>
              <a:ln w="6350">
                <a:solidFill>
                  <a:schemeClr val="bg1">
                    <a:lumMod val="6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2" name="Rectangle 70">
                <a:extLst>
                  <a:ext uri="{FF2B5EF4-FFF2-40B4-BE49-F238E27FC236}">
                    <a16:creationId xmlns:a16="http://schemas.microsoft.com/office/drawing/2014/main" id="{87B5912B-65CA-D754-FBA6-C934B36635CF}"/>
                  </a:ext>
                </a:extLst>
              </p:cNvPr>
              <p:cNvSpPr/>
              <p:nvPr/>
            </p:nvSpPr>
            <p:spPr>
              <a:xfrm>
                <a:off x="1408101" y="7554918"/>
                <a:ext cx="219672" cy="38398"/>
              </a:xfrm>
              <a:prstGeom prst="rect">
                <a:avLst/>
              </a:prstGeom>
              <a:solidFill>
                <a:schemeClr val="bg1">
                  <a:lumMod val="6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3" name="Rectangle 71">
                <a:extLst>
                  <a:ext uri="{FF2B5EF4-FFF2-40B4-BE49-F238E27FC236}">
                    <a16:creationId xmlns:a16="http://schemas.microsoft.com/office/drawing/2014/main" id="{071451EA-4E08-4F4F-55FD-A599EC462DEA}"/>
                  </a:ext>
                </a:extLst>
              </p:cNvPr>
              <p:cNvSpPr/>
              <p:nvPr/>
            </p:nvSpPr>
            <p:spPr>
              <a:xfrm>
                <a:off x="1834185" y="7554918"/>
                <a:ext cx="219672" cy="38398"/>
              </a:xfrm>
              <a:prstGeom prst="rect">
                <a:avLst/>
              </a:prstGeom>
              <a:solidFill>
                <a:schemeClr val="bg1">
                  <a:lumMod val="6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4" name="Rectangle 72">
                <a:extLst>
                  <a:ext uri="{FF2B5EF4-FFF2-40B4-BE49-F238E27FC236}">
                    <a16:creationId xmlns:a16="http://schemas.microsoft.com/office/drawing/2014/main" id="{420E0785-6941-374E-D106-AE05601F72C3}"/>
                  </a:ext>
                </a:extLst>
              </p:cNvPr>
              <p:cNvSpPr/>
              <p:nvPr/>
            </p:nvSpPr>
            <p:spPr>
              <a:xfrm>
                <a:off x="2257656" y="7554918"/>
                <a:ext cx="219672" cy="38398"/>
              </a:xfrm>
              <a:prstGeom prst="rect">
                <a:avLst/>
              </a:prstGeom>
              <a:solidFill>
                <a:schemeClr val="bg1">
                  <a:lumMod val="6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5" name="Rectangle 73">
                <a:extLst>
                  <a:ext uri="{FF2B5EF4-FFF2-40B4-BE49-F238E27FC236}">
                    <a16:creationId xmlns:a16="http://schemas.microsoft.com/office/drawing/2014/main" id="{711F7164-87D4-4E8C-667B-CA4879B71F01}"/>
                  </a:ext>
                </a:extLst>
              </p:cNvPr>
              <p:cNvSpPr/>
              <p:nvPr/>
            </p:nvSpPr>
            <p:spPr>
              <a:xfrm>
                <a:off x="2685407" y="7554918"/>
                <a:ext cx="219672" cy="38398"/>
              </a:xfrm>
              <a:prstGeom prst="rect">
                <a:avLst/>
              </a:prstGeom>
              <a:solidFill>
                <a:schemeClr val="bg1">
                  <a:lumMod val="6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6" name="Rectangle 74">
                <a:extLst>
                  <a:ext uri="{FF2B5EF4-FFF2-40B4-BE49-F238E27FC236}">
                    <a16:creationId xmlns:a16="http://schemas.microsoft.com/office/drawing/2014/main" id="{A5A23B24-97FA-1930-B18E-684892DE3C75}"/>
                  </a:ext>
                </a:extLst>
              </p:cNvPr>
              <p:cNvSpPr/>
              <p:nvPr/>
            </p:nvSpPr>
            <p:spPr>
              <a:xfrm>
                <a:off x="3114146" y="7559185"/>
                <a:ext cx="219672" cy="38398"/>
              </a:xfrm>
              <a:prstGeom prst="rect">
                <a:avLst/>
              </a:prstGeom>
              <a:solidFill>
                <a:schemeClr val="bg1">
                  <a:lumMod val="6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9" name="文本框 8">
              <a:extLst>
                <a:ext uri="{FF2B5EF4-FFF2-40B4-BE49-F238E27FC236}">
                  <a16:creationId xmlns:a16="http://schemas.microsoft.com/office/drawing/2014/main" id="{2B89B541-8045-CC0C-01CA-04A4AA2D7B69}"/>
                </a:ext>
              </a:extLst>
            </p:cNvPr>
            <p:cNvSpPr txBox="1"/>
            <p:nvPr/>
          </p:nvSpPr>
          <p:spPr>
            <a:xfrm rot="16200000">
              <a:off x="1293883" y="5803110"/>
              <a:ext cx="418118" cy="37773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/>
                <a:t>24</a:t>
              </a:r>
              <a:endParaRPr kumimoji="1" lang="zh-CN" altLang="en-US" sz="1000" dirty="0"/>
            </a:p>
          </p:txBody>
        </p:sp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6836B8B1-BC8B-987B-3F2C-0357D5C23499}"/>
                </a:ext>
              </a:extLst>
            </p:cNvPr>
            <p:cNvSpPr txBox="1"/>
            <p:nvPr/>
          </p:nvSpPr>
          <p:spPr>
            <a:xfrm rot="16200000">
              <a:off x="1655760" y="5803110"/>
              <a:ext cx="418118" cy="37773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/>
                <a:t>36</a:t>
              </a:r>
              <a:endParaRPr kumimoji="1" lang="zh-CN" altLang="en-US" sz="1000" dirty="0"/>
            </a:p>
          </p:txBody>
        </p:sp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id="{D9E69FF5-BF1E-A156-965B-503926B1B91A}"/>
                </a:ext>
              </a:extLst>
            </p:cNvPr>
            <p:cNvSpPr txBox="1"/>
            <p:nvPr/>
          </p:nvSpPr>
          <p:spPr>
            <a:xfrm rot="16200000">
              <a:off x="2017637" y="5803110"/>
              <a:ext cx="418118" cy="37773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/>
                <a:t>48</a:t>
              </a:r>
              <a:endParaRPr kumimoji="1" lang="zh-CN" altLang="en-US" sz="1000" dirty="0"/>
            </a:p>
          </p:txBody>
        </p:sp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F3403C1E-5360-BB38-B603-AA963A6FFCA1}"/>
                </a:ext>
              </a:extLst>
            </p:cNvPr>
            <p:cNvSpPr txBox="1"/>
            <p:nvPr/>
          </p:nvSpPr>
          <p:spPr>
            <a:xfrm rot="16200000">
              <a:off x="2361930" y="5803110"/>
              <a:ext cx="418118" cy="37773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/>
                <a:t>60</a:t>
              </a:r>
              <a:endParaRPr kumimoji="1" lang="zh-CN" altLang="en-US" sz="1000" dirty="0"/>
            </a:p>
          </p:txBody>
        </p:sp>
        <p:sp>
          <p:nvSpPr>
            <p:cNvPr id="13" name="文本框 12">
              <a:extLst>
                <a:ext uri="{FF2B5EF4-FFF2-40B4-BE49-F238E27FC236}">
                  <a16:creationId xmlns:a16="http://schemas.microsoft.com/office/drawing/2014/main" id="{601EAF62-9B17-4C72-876C-8B56A1C85A9E}"/>
                </a:ext>
              </a:extLst>
            </p:cNvPr>
            <p:cNvSpPr txBox="1"/>
            <p:nvPr/>
          </p:nvSpPr>
          <p:spPr>
            <a:xfrm rot="16200000">
              <a:off x="2706223" y="5803110"/>
              <a:ext cx="418118" cy="37773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/>
                <a:t>72</a:t>
              </a:r>
              <a:endParaRPr kumimoji="1" lang="zh-CN" altLang="en-US" sz="1000" dirty="0"/>
            </a:p>
          </p:txBody>
        </p:sp>
        <p:sp>
          <p:nvSpPr>
            <p:cNvPr id="14" name="文本框 13">
              <a:extLst>
                <a:ext uri="{FF2B5EF4-FFF2-40B4-BE49-F238E27FC236}">
                  <a16:creationId xmlns:a16="http://schemas.microsoft.com/office/drawing/2014/main" id="{3C4626C0-E7A3-68E2-1E27-67FDB5297417}"/>
                </a:ext>
              </a:extLst>
            </p:cNvPr>
            <p:cNvSpPr txBox="1"/>
            <p:nvPr/>
          </p:nvSpPr>
          <p:spPr>
            <a:xfrm rot="16200000">
              <a:off x="3068100" y="5803110"/>
              <a:ext cx="418118" cy="37773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/>
                <a:t>84</a:t>
              </a:r>
              <a:endParaRPr kumimoji="1" lang="zh-CN" altLang="en-US" sz="1000" dirty="0"/>
            </a:p>
          </p:txBody>
        </p:sp>
        <p:sp>
          <p:nvSpPr>
            <p:cNvPr id="15" name="文本框 14">
              <a:extLst>
                <a:ext uri="{FF2B5EF4-FFF2-40B4-BE49-F238E27FC236}">
                  <a16:creationId xmlns:a16="http://schemas.microsoft.com/office/drawing/2014/main" id="{FDA6D080-29EF-FFAC-E745-B4FA7A92A905}"/>
                </a:ext>
              </a:extLst>
            </p:cNvPr>
            <p:cNvSpPr txBox="1"/>
            <p:nvPr/>
          </p:nvSpPr>
          <p:spPr>
            <a:xfrm rot="16200000">
              <a:off x="3412393" y="5803110"/>
              <a:ext cx="418118" cy="37773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/>
                <a:t>96</a:t>
              </a:r>
              <a:endParaRPr kumimoji="1" lang="zh-CN" altLang="en-US" sz="1000" dirty="0"/>
            </a:p>
          </p:txBody>
        </p:sp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1CE5F339-8A99-8174-517B-CF88FAC06129}"/>
                </a:ext>
              </a:extLst>
            </p:cNvPr>
            <p:cNvSpPr txBox="1"/>
            <p:nvPr/>
          </p:nvSpPr>
          <p:spPr>
            <a:xfrm rot="16200000">
              <a:off x="3721692" y="5799582"/>
              <a:ext cx="505051" cy="37773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/>
                <a:t>108</a:t>
              </a:r>
              <a:endParaRPr kumimoji="1" lang="zh-CN" altLang="en-US" sz="1000" dirty="0"/>
            </a:p>
          </p:txBody>
        </p:sp>
        <p:sp>
          <p:nvSpPr>
            <p:cNvPr id="17" name="文本框 16">
              <a:extLst>
                <a:ext uri="{FF2B5EF4-FFF2-40B4-BE49-F238E27FC236}">
                  <a16:creationId xmlns:a16="http://schemas.microsoft.com/office/drawing/2014/main" id="{3D2AF5CA-B34C-123E-2AB7-7E55FD0FBBDF}"/>
                </a:ext>
              </a:extLst>
            </p:cNvPr>
            <p:cNvSpPr txBox="1"/>
            <p:nvPr/>
          </p:nvSpPr>
          <p:spPr>
            <a:xfrm rot="16200000">
              <a:off x="4065985" y="5799582"/>
              <a:ext cx="505051" cy="37773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/>
                <a:t>120</a:t>
              </a:r>
              <a:endParaRPr kumimoji="1" lang="zh-CN" altLang="en-US" sz="1000" dirty="0"/>
            </a:p>
          </p:txBody>
        </p:sp>
        <p:sp>
          <p:nvSpPr>
            <p:cNvPr id="18" name="文本框 17">
              <a:extLst>
                <a:ext uri="{FF2B5EF4-FFF2-40B4-BE49-F238E27FC236}">
                  <a16:creationId xmlns:a16="http://schemas.microsoft.com/office/drawing/2014/main" id="{2C047D56-0D21-E96E-1C7B-9D00DA01A43E}"/>
                </a:ext>
              </a:extLst>
            </p:cNvPr>
            <p:cNvSpPr txBox="1"/>
            <p:nvPr/>
          </p:nvSpPr>
          <p:spPr>
            <a:xfrm rot="16200000">
              <a:off x="4335729" y="5865339"/>
              <a:ext cx="50505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1000" dirty="0"/>
                <a:t>132</a:t>
              </a:r>
              <a:endParaRPr kumimoji="1" lang="zh-CN" altLang="en-US" sz="1000" dirty="0"/>
            </a:p>
          </p:txBody>
        </p:sp>
        <p:sp>
          <p:nvSpPr>
            <p:cNvPr id="19" name="文本框 18">
              <a:extLst>
                <a:ext uri="{FF2B5EF4-FFF2-40B4-BE49-F238E27FC236}">
                  <a16:creationId xmlns:a16="http://schemas.microsoft.com/office/drawing/2014/main" id="{12907BED-7E52-9FF1-48A9-44DC781504BB}"/>
                </a:ext>
              </a:extLst>
            </p:cNvPr>
            <p:cNvSpPr txBox="1"/>
            <p:nvPr/>
          </p:nvSpPr>
          <p:spPr>
            <a:xfrm rot="16200000">
              <a:off x="4763042" y="5799581"/>
              <a:ext cx="505051" cy="37773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/>
                <a:t>144</a:t>
              </a:r>
              <a:endParaRPr kumimoji="1" lang="zh-CN" altLang="en-US" sz="1000" dirty="0"/>
            </a:p>
          </p:txBody>
        </p:sp>
        <p:sp>
          <p:nvSpPr>
            <p:cNvPr id="20" name="文本框 19">
              <a:extLst>
                <a:ext uri="{FF2B5EF4-FFF2-40B4-BE49-F238E27FC236}">
                  <a16:creationId xmlns:a16="http://schemas.microsoft.com/office/drawing/2014/main" id="{891401C1-1035-0F7B-48A8-EAACD6D19C56}"/>
                </a:ext>
              </a:extLst>
            </p:cNvPr>
            <p:cNvSpPr txBox="1"/>
            <p:nvPr/>
          </p:nvSpPr>
          <p:spPr>
            <a:xfrm>
              <a:off x="2815946" y="6133053"/>
              <a:ext cx="784982" cy="32567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/>
                <a:t>LL (</a:t>
              </a:r>
              <a:r>
                <a:rPr kumimoji="1" lang="en-US" altLang="zh-CN" sz="1000" dirty="0" err="1"/>
                <a:t>hr</a:t>
              </a:r>
              <a:r>
                <a:rPr kumimoji="1" lang="en-US" altLang="zh-CN" sz="1000" dirty="0"/>
                <a:t>)</a:t>
              </a:r>
              <a:endParaRPr kumimoji="1" lang="zh-CN" altLang="en-US" sz="1000" dirty="0"/>
            </a:p>
          </p:txBody>
        </p:sp>
      </p:grpSp>
      <p:pic>
        <p:nvPicPr>
          <p:cNvPr id="7" name="图片 6">
            <a:extLst>
              <a:ext uri="{FF2B5EF4-FFF2-40B4-BE49-F238E27FC236}">
                <a16:creationId xmlns:a16="http://schemas.microsoft.com/office/drawing/2014/main" id="{B78CB931-E93A-E049-E654-EDCE67A4EF49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l="3716" t="13124" b="8559"/>
          <a:stretch/>
        </p:blipFill>
        <p:spPr>
          <a:xfrm>
            <a:off x="1334128" y="5930231"/>
            <a:ext cx="2575871" cy="2072977"/>
          </a:xfrm>
          <a:prstGeom prst="rect">
            <a:avLst/>
          </a:prstGeom>
        </p:spPr>
      </p:pic>
      <p:sp>
        <p:nvSpPr>
          <p:cNvPr id="28" name="文本框 27">
            <a:extLst>
              <a:ext uri="{FF2B5EF4-FFF2-40B4-BE49-F238E27FC236}">
                <a16:creationId xmlns:a16="http://schemas.microsoft.com/office/drawing/2014/main" id="{C470EAAE-822D-714B-88BB-D6FFE4603429}"/>
              </a:ext>
            </a:extLst>
          </p:cNvPr>
          <p:cNvSpPr txBox="1"/>
          <p:nvPr/>
        </p:nvSpPr>
        <p:spPr>
          <a:xfrm>
            <a:off x="1896127" y="7964711"/>
            <a:ext cx="6142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i="1" dirty="0"/>
              <a:t>c349t1</a:t>
            </a:r>
            <a:endParaRPr kumimoji="1" lang="zh-CN" altLang="en-US" sz="1200" i="1" dirty="0"/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9826D667-1EA9-D333-0363-FFB9BA3C41E7}"/>
              </a:ext>
            </a:extLst>
          </p:cNvPr>
          <p:cNvSpPr txBox="1"/>
          <p:nvPr/>
        </p:nvSpPr>
        <p:spPr>
          <a:xfrm>
            <a:off x="3010088" y="7956752"/>
            <a:ext cx="4553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i="1" dirty="0"/>
              <a:t>toc1</a:t>
            </a:r>
            <a:endParaRPr kumimoji="1" lang="zh-CN" altLang="en-US" sz="1200" i="1" dirty="0"/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2326A81B-7CEC-2421-19FE-741136B873A5}"/>
              </a:ext>
            </a:extLst>
          </p:cNvPr>
          <p:cNvSpPr txBox="1"/>
          <p:nvPr/>
        </p:nvSpPr>
        <p:spPr>
          <a:xfrm rot="16200000">
            <a:off x="995869" y="6907639"/>
            <a:ext cx="4796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/>
              <a:t>hour</a:t>
            </a:r>
            <a:endParaRPr kumimoji="1" lang="zh-CN" altLang="en-US" sz="1200" dirty="0"/>
          </a:p>
        </p:txBody>
      </p:sp>
      <p:sp>
        <p:nvSpPr>
          <p:cNvPr id="31" name="TextBox 4">
            <a:extLst>
              <a:ext uri="{FF2B5EF4-FFF2-40B4-BE49-F238E27FC236}">
                <a16:creationId xmlns:a16="http://schemas.microsoft.com/office/drawing/2014/main" id="{5924878C-29F0-48A5-321A-2DE0BD1D072F}"/>
              </a:ext>
            </a:extLst>
          </p:cNvPr>
          <p:cNvSpPr txBox="1"/>
          <p:nvPr/>
        </p:nvSpPr>
        <p:spPr>
          <a:xfrm>
            <a:off x="960345" y="5744213"/>
            <a:ext cx="2808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1292894443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179A5B02-DCD7-B201-A95A-2ED0CCCB464E}"/>
              </a:ext>
            </a:extLst>
          </p:cNvPr>
          <p:cNvSpPr txBox="1"/>
          <p:nvPr/>
        </p:nvSpPr>
        <p:spPr>
          <a:xfrm>
            <a:off x="566003" y="3232109"/>
            <a:ext cx="5572664" cy="6924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400" b="1" i="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Supplemental </a:t>
            </a:r>
            <a:r>
              <a:rPr lang="en-US" altLang="zh-CN" sz="14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F</a:t>
            </a:r>
            <a:r>
              <a:rPr lang="en-US" altLang="zh-CN" sz="1400" b="1" i="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igure 10. Heatmap of all rhythmically expressed genes</a:t>
            </a:r>
            <a:r>
              <a:rPr lang="zh-CN" altLang="en-US" sz="1400" b="1" i="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4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in</a:t>
            </a:r>
            <a:r>
              <a:rPr lang="zh-CN" altLang="en-US" sz="14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400" b="1" i="1" kern="100" dirty="0">
                <a:solidFill>
                  <a:srgbClr val="000000"/>
                </a:solidFill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TOC1</a:t>
            </a:r>
            <a:r>
              <a:rPr lang="en-US" altLang="zh-CN" sz="14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or</a:t>
            </a:r>
            <a:r>
              <a:rPr lang="zh-CN" altLang="en-US" sz="14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400" b="1" i="1" kern="100" dirty="0">
                <a:solidFill>
                  <a:srgbClr val="000000"/>
                </a:solidFill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5X</a:t>
            </a:r>
            <a:r>
              <a:rPr lang="en-US" altLang="zh-CN" sz="14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line, respectively,</a:t>
            </a:r>
            <a:r>
              <a:rPr lang="en-US" altLang="zh-CN" sz="1400" b="1" i="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sorted by their oscillation phase.</a:t>
            </a:r>
            <a:endParaRPr lang="en-US" altLang="zh-CN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endParaRPr lang="zh-CN" altLang="zh-CN" sz="1100" kern="100" dirty="0">
              <a:effectLst/>
              <a:latin typeface="Times New Roman" panose="02020603050405020304" pitchFamily="18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36A1D743-ED2C-7607-C764-3773E95B5F1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21939" y="511553"/>
            <a:ext cx="5087122" cy="253289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90008889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07832105-11D4-2A96-4542-6EDF1404759B}"/>
              </a:ext>
            </a:extLst>
          </p:cNvPr>
          <p:cNvSpPr txBox="1"/>
          <p:nvPr/>
        </p:nvSpPr>
        <p:spPr>
          <a:xfrm>
            <a:off x="401128" y="7167611"/>
            <a:ext cx="6055743" cy="106811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</a:pPr>
            <a:r>
              <a:rPr lang="en-US" altLang="zh-CN" sz="1400" b="1" i="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Supplemental </a:t>
            </a:r>
            <a:r>
              <a:rPr lang="en-US" altLang="zh-CN" sz="14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F</a:t>
            </a:r>
            <a:r>
              <a:rPr lang="en-US" altLang="zh-CN" sz="1400" b="1" i="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igure 11. </a:t>
            </a:r>
            <a:r>
              <a:rPr lang="en-US" altLang="zh-CN" sz="1400" i="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The sinusoidal model fitting traces for the diurnal expression patterns of clock genes in </a:t>
            </a:r>
            <a:r>
              <a:rPr lang="en-US" altLang="zh-CN" sz="14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TOC1</a:t>
            </a:r>
            <a:r>
              <a:rPr lang="en-US" altLang="zh-CN" sz="1400" i="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4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vs.</a:t>
            </a:r>
            <a:r>
              <a:rPr lang="en-US" altLang="zh-CN" sz="1400" i="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4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5X</a:t>
            </a:r>
            <a:r>
              <a:rPr lang="en-US" altLang="zh-CN" sz="1400" i="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lines </a:t>
            </a:r>
            <a:r>
              <a:rPr lang="en-US" altLang="zh-CN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that </a:t>
            </a:r>
            <a:r>
              <a:rPr lang="en-US" altLang="zh-CN" sz="1400" i="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was determined by time-series RNA-seq under light dark cycles. The actual data was plotted as mean ± SEM</a:t>
            </a:r>
            <a:r>
              <a:rPr lang="en-US" altLang="zh-CN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, the confidence interval was plotted as the </a:t>
            </a:r>
            <a:r>
              <a:rPr lang="en-US" altLang="zh-CN" sz="1400" i="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shade of each curve.</a:t>
            </a: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BD755939-CE9E-1C9D-4393-B8397A5A767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09107" y="343286"/>
            <a:ext cx="6439786" cy="666069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68214689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5785B6BB-B46C-CBC8-CE95-8E89EE6BA80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88724" y="461596"/>
            <a:ext cx="4280551" cy="919382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92738615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B4A32CA5-12A8-BB06-532E-44ABB81376DF}"/>
              </a:ext>
            </a:extLst>
          </p:cNvPr>
          <p:cNvSpPr txBox="1"/>
          <p:nvPr/>
        </p:nvSpPr>
        <p:spPr>
          <a:xfrm>
            <a:off x="471467" y="396058"/>
            <a:ext cx="6055743" cy="156183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</a:pPr>
            <a:r>
              <a:rPr lang="en-US" altLang="zh-CN" sz="1200" b="1" i="0" kern="100" dirty="0">
                <a:solidFill>
                  <a:srgbClr val="000000"/>
                </a:solidFill>
                <a:effectLst/>
                <a:latin typeface="TimesNewRomanPS-BoldMT"/>
                <a:ea typeface="DengXian" panose="02010600030101010101" pitchFamily="2" charset="-122"/>
                <a:cs typeface="Times New Roman" panose="02020603050405020304" pitchFamily="18" charset="0"/>
              </a:rPr>
              <a:t>Supplemental Figure 12</a:t>
            </a:r>
            <a:r>
              <a:rPr lang="en-US" altLang="zh-CN" sz="1200" i="0" kern="100" dirty="0">
                <a:solidFill>
                  <a:srgbClr val="000000"/>
                </a:solidFill>
                <a:effectLst/>
                <a:latin typeface="TimesNewRomanPS-BoldMT"/>
                <a:ea typeface="DengXian" panose="02010600030101010101" pitchFamily="2" charset="-122"/>
                <a:cs typeface="Times New Roman" panose="02020603050405020304" pitchFamily="18" charset="0"/>
              </a:rPr>
              <a:t>. Venn diagram (A) showing the overlap of TOC1 targets  between </a:t>
            </a:r>
            <a:r>
              <a:rPr lang="en-US" altLang="zh-CN" sz="1200" kern="100" dirty="0">
                <a:solidFill>
                  <a:srgbClr val="000000"/>
                </a:solidFill>
                <a:latin typeface="TimesNewRomanPS-BoldMT"/>
                <a:ea typeface="DengXian" panose="02010600030101010101" pitchFamily="2" charset="-122"/>
                <a:cs typeface="Times New Roman" panose="02020603050405020304" pitchFamily="18" charset="0"/>
              </a:rPr>
              <a:t>our </a:t>
            </a:r>
            <a:r>
              <a:rPr lang="en-US" altLang="zh-CN" sz="1200" kern="100" dirty="0" err="1">
                <a:solidFill>
                  <a:srgbClr val="000000"/>
                </a:solidFill>
                <a:latin typeface="TimesNewRomanPS-BoldMT"/>
                <a:ea typeface="DengXian" panose="02010600030101010101" pitchFamily="2" charset="-122"/>
                <a:cs typeface="Times New Roman" panose="02020603050405020304" pitchFamily="18" charset="0"/>
              </a:rPr>
              <a:t>ChIP</a:t>
            </a:r>
            <a:r>
              <a:rPr lang="en-US" altLang="zh-CN" sz="1200" kern="100" dirty="0">
                <a:solidFill>
                  <a:srgbClr val="000000"/>
                </a:solidFill>
                <a:latin typeface="TimesNewRomanPS-BoldMT"/>
                <a:ea typeface="DengXian" panose="02010600030101010101" pitchFamily="2" charset="-122"/>
                <a:cs typeface="Times New Roman" panose="02020603050405020304" pitchFamily="18" charset="0"/>
              </a:rPr>
              <a:t>-seq</a:t>
            </a:r>
            <a:r>
              <a:rPr lang="zh-CN" altLang="en-US" sz="1200" kern="100" dirty="0">
                <a:solidFill>
                  <a:srgbClr val="000000"/>
                </a:solidFill>
                <a:latin typeface="TimesNewRomanPS-BoldMT"/>
                <a:ea typeface="DengXia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200" kern="100" dirty="0">
                <a:solidFill>
                  <a:srgbClr val="000000"/>
                </a:solidFill>
                <a:latin typeface="TimesNewRomanPS-BoldMT"/>
                <a:ea typeface="DengXian" panose="02010600030101010101" pitchFamily="2" charset="-122"/>
                <a:cs typeface="Times New Roman" panose="02020603050405020304" pitchFamily="18" charset="0"/>
              </a:rPr>
              <a:t>(red) and </a:t>
            </a:r>
            <a:r>
              <a:rPr lang="en-US" altLang="zh-CN" sz="1200" kern="100" dirty="0" err="1">
                <a:solidFill>
                  <a:srgbClr val="000000"/>
                </a:solidFill>
                <a:latin typeface="TimesNewRomanPS-BoldMT"/>
                <a:ea typeface="DengXian" panose="02010600030101010101" pitchFamily="2" charset="-122"/>
                <a:cs typeface="Times New Roman" panose="02020603050405020304" pitchFamily="18" charset="0"/>
              </a:rPr>
              <a:t>ChIP</a:t>
            </a:r>
            <a:r>
              <a:rPr lang="en-US" altLang="zh-CN" sz="1200" kern="100" dirty="0">
                <a:solidFill>
                  <a:srgbClr val="000000"/>
                </a:solidFill>
                <a:latin typeface="TimesNewRomanPS-BoldMT"/>
                <a:ea typeface="DengXian" panose="02010600030101010101" pitchFamily="2" charset="-122"/>
                <a:cs typeface="Times New Roman" panose="02020603050405020304" pitchFamily="18" charset="0"/>
              </a:rPr>
              <a:t>-seq performed by Huang et al 2012 (green), and s</a:t>
            </a:r>
            <a:r>
              <a:rPr lang="en-US" altLang="zh-CN" sz="1200" i="0" kern="100" dirty="0">
                <a:solidFill>
                  <a:srgbClr val="000000"/>
                </a:solidFill>
                <a:effectLst/>
                <a:latin typeface="TimesNewRomanPS-BoldMT"/>
                <a:ea typeface="DengXian" panose="02010600030101010101" pitchFamily="2" charset="-122"/>
                <a:cs typeface="Times New Roman" panose="02020603050405020304" pitchFamily="18" charset="0"/>
              </a:rPr>
              <a:t>ignificantly enriched motifs (B) and GO pathways (C) of the common and specific </a:t>
            </a:r>
            <a:r>
              <a:rPr lang="en-US" altLang="zh-CN" sz="1200" kern="100" dirty="0">
                <a:solidFill>
                  <a:srgbClr val="000000"/>
                </a:solidFill>
                <a:latin typeface="TimesNewRomanPS-BoldMT"/>
                <a:ea typeface="DengXian" panose="02010600030101010101" pitchFamily="2" charset="-122"/>
                <a:cs typeface="Times New Roman" panose="02020603050405020304" pitchFamily="18" charset="0"/>
              </a:rPr>
              <a:t>target </a:t>
            </a:r>
            <a:r>
              <a:rPr lang="en-US" altLang="zh-CN" sz="1200" i="0" kern="100" dirty="0">
                <a:solidFill>
                  <a:srgbClr val="000000"/>
                </a:solidFill>
                <a:effectLst/>
                <a:latin typeface="TimesNewRomanPS-BoldMT"/>
                <a:ea typeface="DengXian" panose="02010600030101010101" pitchFamily="2" charset="-122"/>
                <a:cs typeface="Times New Roman" panose="02020603050405020304" pitchFamily="18" charset="0"/>
              </a:rPr>
              <a:t>genes between </a:t>
            </a:r>
            <a:r>
              <a:rPr lang="en-US" altLang="zh-CN" sz="1200" i="1" kern="100" dirty="0">
                <a:solidFill>
                  <a:srgbClr val="000000"/>
                </a:solidFill>
                <a:effectLst/>
                <a:latin typeface="TimesNewRomanPS-BoldMT"/>
                <a:ea typeface="DengXian" panose="02010600030101010101" pitchFamily="2" charset="-122"/>
                <a:cs typeface="Times New Roman" panose="02020603050405020304" pitchFamily="18" charset="0"/>
              </a:rPr>
              <a:t>TOC1</a:t>
            </a:r>
            <a:r>
              <a:rPr lang="en-US" altLang="zh-CN" sz="1200" i="0" kern="100" dirty="0">
                <a:solidFill>
                  <a:srgbClr val="000000"/>
                </a:solidFill>
                <a:effectLst/>
                <a:latin typeface="TimesNewRomanPS-BoldMT"/>
                <a:ea typeface="DengXian" panose="02010600030101010101" pitchFamily="2" charset="-122"/>
                <a:cs typeface="Times New Roman" panose="02020603050405020304" pitchFamily="18" charset="0"/>
              </a:rPr>
              <a:t> and </a:t>
            </a:r>
            <a:r>
              <a:rPr lang="en-US" altLang="zh-CN" sz="1200" i="1" kern="100" dirty="0">
                <a:solidFill>
                  <a:srgbClr val="000000"/>
                </a:solidFill>
                <a:effectLst/>
                <a:latin typeface="TimesNewRomanPS-BoldMT"/>
                <a:ea typeface="DengXian" panose="02010600030101010101" pitchFamily="2" charset="-122"/>
                <a:cs typeface="Times New Roman" panose="02020603050405020304" pitchFamily="18" charset="0"/>
              </a:rPr>
              <a:t>5X </a:t>
            </a:r>
            <a:r>
              <a:rPr lang="en-US" altLang="zh-CN" sz="1200" kern="100" dirty="0">
                <a:solidFill>
                  <a:srgbClr val="000000"/>
                </a:solidFill>
                <a:effectLst/>
                <a:latin typeface="TimesNewRomanPS-BoldMT"/>
                <a:ea typeface="DengXian" panose="02010600030101010101" pitchFamily="2" charset="-122"/>
                <a:cs typeface="Times New Roman" panose="02020603050405020304" pitchFamily="18" charset="0"/>
              </a:rPr>
              <a:t>in Figure 8A. The enrichment score is the negative natural logarithm of the enrichment P-value derived from the Fisher's exact test. Count indicates the number of genes has been identified in each pathway. </a:t>
            </a:r>
          </a:p>
          <a:p>
            <a:pPr algn="just">
              <a:lnSpc>
                <a:spcPct val="115000"/>
              </a:lnSpc>
            </a:pPr>
            <a:endParaRPr lang="en-US" altLang="zh-C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09176941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22A6E05-CCD1-BE39-ADA8-E4C44B5999B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64BC7169-2FBE-0265-12CB-21415D81DF65}"/>
              </a:ext>
            </a:extLst>
          </p:cNvPr>
          <p:cNvSpPr txBox="1"/>
          <p:nvPr/>
        </p:nvSpPr>
        <p:spPr>
          <a:xfrm>
            <a:off x="405019" y="6416020"/>
            <a:ext cx="6055743" cy="13113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</a:pPr>
            <a:r>
              <a:rPr lang="en-US" altLang="zh-CN" sz="1400" b="1" i="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Supplemental Figure 13</a:t>
            </a:r>
            <a:r>
              <a:rPr lang="en-US" altLang="zh-CN" sz="14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. Phase-based clustering of TOC1 target genes. A, B. </a:t>
            </a:r>
            <a:r>
              <a:rPr lang="en-US" altLang="zh-CN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Traces of the rhythmic (A) and non-rhythmic (B) TOC1 target genes assayed by time-series RNA-seq. The rhythmic target genes were clustered into 6 groups based on their predicted phases by Bio-Cycle . Purple line indicates the average trace of each group. 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F07E785E-D208-4CA7-3716-EC83315BFCB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20896" y="1108430"/>
            <a:ext cx="6546670" cy="47631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58592931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BCEAF069-3732-A84B-3654-D268B18AD3C1}"/>
              </a:ext>
            </a:extLst>
          </p:cNvPr>
          <p:cNvSpPr txBox="1"/>
          <p:nvPr/>
        </p:nvSpPr>
        <p:spPr>
          <a:xfrm>
            <a:off x="490080" y="6032526"/>
            <a:ext cx="6055743" cy="155908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</a:pPr>
            <a:r>
              <a:rPr lang="en-US" altLang="zh-CN" sz="1400" b="1" i="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Supplemental Figure 14. Integrative Genomics Viewer (IGV) view of </a:t>
            </a:r>
            <a:r>
              <a:rPr lang="en-US" altLang="zh-CN" sz="1400" b="1" i="0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ChIP</a:t>
            </a:r>
            <a:r>
              <a:rPr lang="en-US" altLang="zh-CN" sz="1400" b="1" i="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-seq profiles and RNA-seq data at several core </a:t>
            </a:r>
            <a:r>
              <a:rPr lang="en-US" altLang="zh-CN" sz="14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clock gene locus </a:t>
            </a:r>
            <a:r>
              <a:rPr lang="en-US" altLang="zh-CN" sz="1400" b="1" i="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in </a:t>
            </a:r>
            <a:r>
              <a:rPr lang="en-US" altLang="zh-CN" sz="1400" b="1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TOC1</a:t>
            </a:r>
            <a:r>
              <a:rPr lang="en-US" altLang="zh-CN" sz="1400" b="1" i="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and </a:t>
            </a:r>
            <a:r>
              <a:rPr lang="en-US" altLang="zh-CN" sz="1400" b="1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5X</a:t>
            </a:r>
            <a:r>
              <a:rPr lang="en-US" altLang="zh-CN" sz="1400" b="1" i="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lines.</a:t>
            </a:r>
            <a:r>
              <a:rPr lang="en-US" altLang="zh-CN" sz="1400" i="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The yellow and green wiggle plot represents the peak of </a:t>
            </a:r>
            <a:r>
              <a:rPr lang="en-US" altLang="zh-CN" sz="1400" i="0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ChIP</a:t>
            </a:r>
            <a:r>
              <a:rPr lang="en-US" altLang="zh-CN" sz="1400" i="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-seq track. The red and blue wiggle plots represent the peak of RNA-seq track. Up and down trace in RNA-seq track indicate forward- and reverse- strand RNA reads, respectively.</a:t>
            </a: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0FE03CF4-170D-7D5E-8A9B-E87AAA4D109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5828" y="368720"/>
            <a:ext cx="6186343" cy="558581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2851434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CEB54360-FB6E-4A7B-A820-EB309AEFCCC5}"/>
              </a:ext>
            </a:extLst>
          </p:cNvPr>
          <p:cNvGrpSpPr/>
          <p:nvPr/>
        </p:nvGrpSpPr>
        <p:grpSpPr>
          <a:xfrm>
            <a:off x="326072" y="430530"/>
            <a:ext cx="4173855" cy="2758440"/>
            <a:chOff x="580072" y="132080"/>
            <a:chExt cx="4173855" cy="2758440"/>
          </a:xfrm>
        </p:grpSpPr>
        <p:graphicFrame>
          <p:nvGraphicFramePr>
            <p:cNvPr id="5" name="Chart 4">
              <a:extLst>
                <a:ext uri="{FF2B5EF4-FFF2-40B4-BE49-F238E27FC236}">
                  <a16:creationId xmlns:a16="http://schemas.microsoft.com/office/drawing/2014/main" id="{01915682-8073-4492-8B10-51315173D69B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051418522"/>
                </p:ext>
              </p:extLst>
            </p:nvPr>
          </p:nvGraphicFramePr>
          <p:xfrm>
            <a:off x="580072" y="132080"/>
            <a:ext cx="4173855" cy="275844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67" name="Rectangle 66">
              <a:extLst>
                <a:ext uri="{FF2B5EF4-FFF2-40B4-BE49-F238E27FC236}">
                  <a16:creationId xmlns:a16="http://schemas.microsoft.com/office/drawing/2014/main" id="{91753F7E-D1ED-4D83-BC8A-39A47CC8E1CC}"/>
                </a:ext>
              </a:extLst>
            </p:cNvPr>
            <p:cNvSpPr/>
            <p:nvPr/>
          </p:nvSpPr>
          <p:spPr>
            <a:xfrm>
              <a:off x="1049970" y="2528495"/>
              <a:ext cx="3406284" cy="5486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8" name="Rectangle 67">
              <a:extLst>
                <a:ext uri="{FF2B5EF4-FFF2-40B4-BE49-F238E27FC236}">
                  <a16:creationId xmlns:a16="http://schemas.microsoft.com/office/drawing/2014/main" id="{94833CAE-1CB5-4B4A-BAA3-54EBE058FACA}"/>
                </a:ext>
              </a:extLst>
            </p:cNvPr>
            <p:cNvSpPr/>
            <p:nvPr/>
          </p:nvSpPr>
          <p:spPr>
            <a:xfrm>
              <a:off x="2768601" y="2528495"/>
              <a:ext cx="1757794" cy="54864"/>
            </a:xfrm>
            <a:prstGeom prst="rect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10" name="Group 9">
            <a:extLst>
              <a:ext uri="{FF2B5EF4-FFF2-40B4-BE49-F238E27FC236}">
                <a16:creationId xmlns:a16="http://schemas.microsoft.com/office/drawing/2014/main" id="{E26F0FB2-A495-47F6-A080-6F7327489DF9}"/>
              </a:ext>
            </a:extLst>
          </p:cNvPr>
          <p:cNvGrpSpPr/>
          <p:nvPr/>
        </p:nvGrpSpPr>
        <p:grpSpPr>
          <a:xfrm>
            <a:off x="286544" y="3580115"/>
            <a:ext cx="6219036" cy="872537"/>
            <a:chOff x="53398" y="3339854"/>
            <a:chExt cx="6560950" cy="968682"/>
          </a:xfrm>
        </p:grpSpPr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0D2A5A9E-0076-42C4-A482-CF1A50A9D58B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895850" y="3339854"/>
              <a:ext cx="1718498" cy="968682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2E604840-D64B-46AE-B572-776A1EA95123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53398" y="3339854"/>
              <a:ext cx="4886902" cy="968682"/>
            </a:xfrm>
            <a:prstGeom prst="rect">
              <a:avLst/>
            </a:prstGeom>
          </p:spPr>
        </p:pic>
      </p:grpSp>
      <p:sp>
        <p:nvSpPr>
          <p:cNvPr id="12" name="TextBox 11">
            <a:extLst>
              <a:ext uri="{FF2B5EF4-FFF2-40B4-BE49-F238E27FC236}">
                <a16:creationId xmlns:a16="http://schemas.microsoft.com/office/drawing/2014/main" id="{353FC47D-3300-41ED-9268-5C1D9505B152}"/>
              </a:ext>
            </a:extLst>
          </p:cNvPr>
          <p:cNvSpPr txBox="1"/>
          <p:nvPr/>
        </p:nvSpPr>
        <p:spPr>
          <a:xfrm>
            <a:off x="282293" y="279646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A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8D72C189-D6FE-422D-AB19-7AD383A832CC}"/>
              </a:ext>
            </a:extLst>
          </p:cNvPr>
          <p:cNvSpPr txBox="1"/>
          <p:nvPr/>
        </p:nvSpPr>
        <p:spPr>
          <a:xfrm>
            <a:off x="282293" y="3188970"/>
            <a:ext cx="2856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B</a:t>
            </a:r>
          </a:p>
        </p:txBody>
      </p:sp>
      <p:grpSp>
        <p:nvGrpSpPr>
          <p:cNvPr id="14" name="Group 13">
            <a:extLst>
              <a:ext uri="{FF2B5EF4-FFF2-40B4-BE49-F238E27FC236}">
                <a16:creationId xmlns:a16="http://schemas.microsoft.com/office/drawing/2014/main" id="{5F824441-E193-4908-882B-5385BDB8A26E}"/>
              </a:ext>
            </a:extLst>
          </p:cNvPr>
          <p:cNvGrpSpPr/>
          <p:nvPr/>
        </p:nvGrpSpPr>
        <p:grpSpPr>
          <a:xfrm>
            <a:off x="281415" y="4853933"/>
            <a:ext cx="6224165" cy="837255"/>
            <a:chOff x="63501" y="4626956"/>
            <a:chExt cx="6593233" cy="822718"/>
          </a:xfrm>
        </p:grpSpPr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5290C45C-1F1C-4577-9F39-3EDA18B0FBA2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63501" y="4626956"/>
              <a:ext cx="4940300" cy="822718"/>
            </a:xfrm>
            <a:prstGeom prst="rect">
              <a:avLst/>
            </a:prstGeom>
          </p:spPr>
        </p:pic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6E403C3A-E683-43B5-B60F-8CDD72617206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4921249" y="4626956"/>
              <a:ext cx="1735485" cy="822718"/>
            </a:xfrm>
            <a:prstGeom prst="rect">
              <a:avLst/>
            </a:prstGeom>
          </p:spPr>
        </p:pic>
      </p:grpSp>
      <p:sp>
        <p:nvSpPr>
          <p:cNvPr id="17" name="TextBox 16">
            <a:extLst>
              <a:ext uri="{FF2B5EF4-FFF2-40B4-BE49-F238E27FC236}">
                <a16:creationId xmlns:a16="http://schemas.microsoft.com/office/drawing/2014/main" id="{24FB3324-277F-4E6D-A592-74B0C46851C5}"/>
              </a:ext>
            </a:extLst>
          </p:cNvPr>
          <p:cNvSpPr txBox="1"/>
          <p:nvPr/>
        </p:nvSpPr>
        <p:spPr>
          <a:xfrm>
            <a:off x="805698" y="5783543"/>
            <a:ext cx="5246604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2. Early-phased protein expression of 5X and S175A. 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tein levels of TOC1 in native promoter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C1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5X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135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175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ines. 10-d-old seedlings grown at 12-h/12-h light/dark conditions were harvested every 3 hours from ZT1 to ZT22. White and black regions indicate light and dark periods. Data from 2 independent trials were averaged; error bars indicate SEM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Two trials of the western blots used for quantitation in A. TOC1-GFP and ADK were immuno-detected by </a:t>
            </a:r>
            <a:r>
              <a:rPr lang="el-G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GFP and </a:t>
            </a:r>
            <a:r>
              <a:rPr lang="el-G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ADK, respectively. ADK is an endogenous constitutively expressed protein that was used as loading control for western blotting.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C6C02EA0-36B9-4475-9FA8-DF28ED23C902}"/>
              </a:ext>
            </a:extLst>
          </p:cNvPr>
          <p:cNvSpPr txBox="1"/>
          <p:nvPr/>
        </p:nvSpPr>
        <p:spPr>
          <a:xfrm>
            <a:off x="575963" y="3313252"/>
            <a:ext cx="6623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1</a:t>
            </a:r>
            <a:r>
              <a:rPr lang="en-US" sz="1200" baseline="30000" dirty="0"/>
              <a:t>st</a:t>
            </a:r>
            <a:r>
              <a:rPr lang="en-US" sz="1200" dirty="0"/>
              <a:t> trial: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1ECD911A-77BB-463A-9BB5-D00B811F4E85}"/>
              </a:ext>
            </a:extLst>
          </p:cNvPr>
          <p:cNvSpPr txBox="1"/>
          <p:nvPr/>
        </p:nvSpPr>
        <p:spPr>
          <a:xfrm>
            <a:off x="540697" y="4651216"/>
            <a:ext cx="6976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2</a:t>
            </a:r>
            <a:r>
              <a:rPr lang="en-US" sz="1200" baseline="30000" dirty="0"/>
              <a:t>nd</a:t>
            </a:r>
            <a:r>
              <a:rPr lang="en-US" sz="1200" dirty="0"/>
              <a:t> trial:</a:t>
            </a:r>
          </a:p>
        </p:txBody>
      </p:sp>
    </p:spTree>
    <p:extLst>
      <p:ext uri="{BB962C8B-B14F-4D97-AF65-F5344CB8AC3E}">
        <p14:creationId xmlns:p14="http://schemas.microsoft.com/office/powerpoint/2010/main" val="74647622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FAF31107-93EB-43DC-A9C7-FB9BA806C68F}"/>
              </a:ext>
            </a:extLst>
          </p:cNvPr>
          <p:cNvSpPr txBox="1"/>
          <p:nvPr/>
        </p:nvSpPr>
        <p:spPr>
          <a:xfrm>
            <a:off x="577449" y="7304807"/>
            <a:ext cx="5246604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3. TOC1 protein levels in native promoter </a:t>
            </a:r>
            <a:r>
              <a:rPr lang="en-US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C1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ines in </a:t>
            </a:r>
            <a:r>
              <a:rPr lang="en-US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c1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f-yc3/4/9 toc1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utant backgrounds.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Quantitation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two trials of western blotting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of TOC1 protein levels in the indicated plant lines. 10-d-old grown at 12-h/12-h light/dark conditions were harvested every hour from ZT12 to ZT16. Data from 2 independent trials were averaged, error bars indicate SEM. TOC1 and ADK were immuno-detected by </a:t>
            </a:r>
            <a:r>
              <a:rPr lang="el-G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GFP and </a:t>
            </a:r>
            <a:r>
              <a:rPr lang="el-G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ADK, respectively. ADK is an endogenous constitutively expressed protein that was used as loading control for western blotting. Proteins were separated by 8% SDS–PAGE special gel (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crylamide:bisacrylamide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50:1) to differentiate TOC1 phosphorylation states.</a:t>
            </a:r>
          </a:p>
        </p:txBody>
      </p:sp>
      <p:graphicFrame>
        <p:nvGraphicFramePr>
          <p:cNvPr id="3" name="Chart 2">
            <a:extLst>
              <a:ext uri="{FF2B5EF4-FFF2-40B4-BE49-F238E27FC236}">
                <a16:creationId xmlns:a16="http://schemas.microsoft.com/office/drawing/2014/main" id="{01915682-8073-4492-8B10-51315173D69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51085179"/>
              </p:ext>
            </p:extLst>
          </p:nvPr>
        </p:nvGraphicFramePr>
        <p:xfrm>
          <a:off x="475720" y="401495"/>
          <a:ext cx="4468814" cy="27584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pic>
        <p:nvPicPr>
          <p:cNvPr id="4" name="Picture 3">
            <a:extLst>
              <a:ext uri="{FF2B5EF4-FFF2-40B4-BE49-F238E27FC236}">
                <a16:creationId xmlns:a16="http://schemas.microsoft.com/office/drawing/2014/main" id="{4B2EDB62-D66F-4C8B-913D-5FD34F9618C5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4429"/>
          <a:stretch/>
        </p:blipFill>
        <p:spPr>
          <a:xfrm>
            <a:off x="679121" y="3422716"/>
            <a:ext cx="5059289" cy="1693654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F16EC46F-5A0C-43C9-94F4-BC538C1A15B6}"/>
              </a:ext>
            </a:extLst>
          </p:cNvPr>
          <p:cNvSpPr txBox="1"/>
          <p:nvPr/>
        </p:nvSpPr>
        <p:spPr>
          <a:xfrm>
            <a:off x="385451" y="3159935"/>
            <a:ext cx="2856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B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1C8D6FDA-EF47-46AB-9438-BF1C12133D86}"/>
              </a:ext>
            </a:extLst>
          </p:cNvPr>
          <p:cNvSpPr txBox="1"/>
          <p:nvPr/>
        </p:nvSpPr>
        <p:spPr>
          <a:xfrm>
            <a:off x="679121" y="3284217"/>
            <a:ext cx="6623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1</a:t>
            </a:r>
            <a:r>
              <a:rPr lang="en-US" sz="1200" baseline="30000" dirty="0"/>
              <a:t>st</a:t>
            </a:r>
            <a:r>
              <a:rPr lang="en-US" sz="1200" dirty="0"/>
              <a:t> trial: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F0EFC55F-4FC7-4067-B96B-F9E3AE2CE038}"/>
              </a:ext>
            </a:extLst>
          </p:cNvPr>
          <p:cNvSpPr txBox="1"/>
          <p:nvPr/>
        </p:nvSpPr>
        <p:spPr>
          <a:xfrm>
            <a:off x="679121" y="5240651"/>
            <a:ext cx="6976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2</a:t>
            </a:r>
            <a:r>
              <a:rPr lang="en-US" sz="1200" baseline="30000" dirty="0"/>
              <a:t>nd</a:t>
            </a:r>
            <a:r>
              <a:rPr lang="en-US" sz="1200" dirty="0"/>
              <a:t> trial: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79B6EE38-4658-42CD-911D-05375D6A346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71107" y="5254869"/>
            <a:ext cx="5059289" cy="1823970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DC441B54-7D85-4606-84E4-9FB38E7EEA90}"/>
              </a:ext>
            </a:extLst>
          </p:cNvPr>
          <p:cNvSpPr txBox="1"/>
          <p:nvPr/>
        </p:nvSpPr>
        <p:spPr>
          <a:xfrm>
            <a:off x="390259" y="344949"/>
            <a:ext cx="2888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A</a:t>
            </a:r>
          </a:p>
        </p:txBody>
      </p:sp>
    </p:spTree>
    <p:extLst>
      <p:ext uri="{BB962C8B-B14F-4D97-AF65-F5344CB8AC3E}">
        <p14:creationId xmlns:p14="http://schemas.microsoft.com/office/powerpoint/2010/main" val="16047158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F84A3322-DCB3-4A54-BCE9-AFF514D4E6E2}"/>
              </a:ext>
            </a:extLst>
          </p:cNvPr>
          <p:cNvSpPr txBox="1"/>
          <p:nvPr/>
        </p:nvSpPr>
        <p:spPr>
          <a:xfrm>
            <a:off x="509186" y="2498793"/>
            <a:ext cx="2856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B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E2870450-9132-4BDF-A391-A79471F0C271}"/>
              </a:ext>
            </a:extLst>
          </p:cNvPr>
          <p:cNvSpPr txBox="1"/>
          <p:nvPr/>
        </p:nvSpPr>
        <p:spPr>
          <a:xfrm>
            <a:off x="509186" y="292191"/>
            <a:ext cx="2888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A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321360AB-49C1-4947-A6A6-87C4B148443D}"/>
              </a:ext>
            </a:extLst>
          </p:cNvPr>
          <p:cNvSpPr txBox="1"/>
          <p:nvPr/>
        </p:nvSpPr>
        <p:spPr>
          <a:xfrm>
            <a:off x="3924289" y="3902992"/>
            <a:ext cx="29527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D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928C2606-C5CD-4ED8-958E-515507ADF5CA}"/>
              </a:ext>
            </a:extLst>
          </p:cNvPr>
          <p:cNvSpPr txBox="1"/>
          <p:nvPr/>
        </p:nvSpPr>
        <p:spPr>
          <a:xfrm>
            <a:off x="513996" y="3900996"/>
            <a:ext cx="2808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8CFA5492-67B5-405B-9CBF-4DFA02F3CBA1}"/>
              </a:ext>
            </a:extLst>
          </p:cNvPr>
          <p:cNvSpPr txBox="1"/>
          <p:nvPr/>
        </p:nvSpPr>
        <p:spPr>
          <a:xfrm>
            <a:off x="509186" y="6105694"/>
            <a:ext cx="5606643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4. TOC1 </a:t>
            </a:r>
            <a:r>
              <a:rPr lang="en-U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hosphovariants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how no difference from WT TOC1 in TCP protein interactions. 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Two additional trials of Co-IP between TAP tagged CHE/TCP and GFP tagged TOC1/5X in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. </a:t>
            </a:r>
            <a:r>
              <a:rPr lang="en-U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enthamian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Protein extracts were immunoprecipitated by IgG resins followed by HRV-3C protease digestion. TAP tagged proteins were detected by anti-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yc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TOC1 was detected by anti-GFP. Asterisks in A indicates TCP22 that was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nspecifically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cognized by the secondary </a:t>
            </a:r>
            <a:r>
              <a:rPr lang="el-G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Rabbit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Quantitation of protein interactions in A and B.</a:t>
            </a:r>
          </a:p>
        </p:txBody>
      </p:sp>
      <p:graphicFrame>
        <p:nvGraphicFramePr>
          <p:cNvPr id="11" name="Chart 10">
            <a:extLst>
              <a:ext uri="{FF2B5EF4-FFF2-40B4-BE49-F238E27FC236}">
                <a16:creationId xmlns:a16="http://schemas.microsoft.com/office/drawing/2014/main" id="{AEFA5506-BBBA-424B-B064-A6CFBB22F09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63994378"/>
              </p:ext>
            </p:extLst>
          </p:nvPr>
        </p:nvGraphicFramePr>
        <p:xfrm>
          <a:off x="3924289" y="4215023"/>
          <a:ext cx="1934889" cy="179383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pic>
        <p:nvPicPr>
          <p:cNvPr id="12" name="Picture 11">
            <a:extLst>
              <a:ext uri="{FF2B5EF4-FFF2-40B4-BE49-F238E27FC236}">
                <a16:creationId xmlns:a16="http://schemas.microsoft.com/office/drawing/2014/main" id="{120B17A8-1AF1-4049-988C-94093E050DD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07761" y="554708"/>
            <a:ext cx="6104380" cy="1782694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996F3EB2-6D48-4D57-B764-0692549D88FE}"/>
              </a:ext>
            </a:extLst>
          </p:cNvPr>
          <p:cNvSpPr txBox="1"/>
          <p:nvPr/>
        </p:nvSpPr>
        <p:spPr>
          <a:xfrm>
            <a:off x="3876636" y="1387866"/>
            <a:ext cx="2487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*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57A6FB0D-2ADB-4D4A-BB83-AF27DEB4CCA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64290" y="2569087"/>
            <a:ext cx="3935639" cy="1404328"/>
          </a:xfrm>
          <a:prstGeom prst="rect">
            <a:avLst/>
          </a:prstGeom>
        </p:spPr>
      </p:pic>
      <p:grpSp>
        <p:nvGrpSpPr>
          <p:cNvPr id="14" name="Group 13">
            <a:extLst>
              <a:ext uri="{FF2B5EF4-FFF2-40B4-BE49-F238E27FC236}">
                <a16:creationId xmlns:a16="http://schemas.microsoft.com/office/drawing/2014/main" id="{22C17153-5FE0-4D89-91A7-6964BC57DE80}"/>
              </a:ext>
            </a:extLst>
          </p:cNvPr>
          <p:cNvGrpSpPr/>
          <p:nvPr/>
        </p:nvGrpSpPr>
        <p:grpSpPr>
          <a:xfrm>
            <a:off x="272371" y="4215023"/>
            <a:ext cx="3604265" cy="1793835"/>
            <a:chOff x="182875" y="5591935"/>
            <a:chExt cx="3604265" cy="1955243"/>
          </a:xfrm>
        </p:grpSpPr>
        <p:graphicFrame>
          <p:nvGraphicFramePr>
            <p:cNvPr id="15" name="Chart 14">
              <a:extLst>
                <a:ext uri="{FF2B5EF4-FFF2-40B4-BE49-F238E27FC236}">
                  <a16:creationId xmlns:a16="http://schemas.microsoft.com/office/drawing/2014/main" id="{B6F03DDD-044D-4F7B-8431-DBED337BE811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673335740"/>
                </p:ext>
              </p:extLst>
            </p:nvPr>
          </p:nvGraphicFramePr>
          <p:xfrm>
            <a:off x="182875" y="5619924"/>
            <a:ext cx="3604265" cy="192725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cxnSp>
          <p:nvCxnSpPr>
            <p:cNvPr id="16" name="Straight Connector 15">
              <a:extLst>
                <a:ext uri="{FF2B5EF4-FFF2-40B4-BE49-F238E27FC236}">
                  <a16:creationId xmlns:a16="http://schemas.microsoft.com/office/drawing/2014/main" id="{64E18CF3-7717-4D9F-B5B1-04B8DAE967A1}"/>
                </a:ext>
              </a:extLst>
            </p:cNvPr>
            <p:cNvCxnSpPr/>
            <p:nvPr/>
          </p:nvCxnSpPr>
          <p:spPr>
            <a:xfrm>
              <a:off x="933353" y="5826460"/>
              <a:ext cx="77724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41945279-62BC-440B-B5E9-FC6E31FE1328}"/>
                </a:ext>
              </a:extLst>
            </p:cNvPr>
            <p:cNvSpPr txBox="1"/>
            <p:nvPr/>
          </p:nvSpPr>
          <p:spPr>
            <a:xfrm>
              <a:off x="1113907" y="5594690"/>
              <a:ext cx="46675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/>
                <a:t>CHE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15CD2683-166E-4633-A247-1F4280500A06}"/>
                </a:ext>
              </a:extLst>
            </p:cNvPr>
            <p:cNvSpPr txBox="1"/>
            <p:nvPr/>
          </p:nvSpPr>
          <p:spPr>
            <a:xfrm>
              <a:off x="1957276" y="5591935"/>
              <a:ext cx="40438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TCP20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E18A8C20-276C-44F7-8C27-6C24458DCA44}"/>
                </a:ext>
              </a:extLst>
            </p:cNvPr>
            <p:cNvSpPr txBox="1"/>
            <p:nvPr/>
          </p:nvSpPr>
          <p:spPr>
            <a:xfrm>
              <a:off x="2906472" y="5596660"/>
              <a:ext cx="40438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TCP22</a:t>
              </a:r>
            </a:p>
          </p:txBody>
        </p:sp>
        <p:cxnSp>
          <p:nvCxnSpPr>
            <p:cNvPr id="21" name="Straight Connector 20">
              <a:extLst>
                <a:ext uri="{FF2B5EF4-FFF2-40B4-BE49-F238E27FC236}">
                  <a16:creationId xmlns:a16="http://schemas.microsoft.com/office/drawing/2014/main" id="{D593878A-29F7-4141-BBB5-F2BF780D4B98}"/>
                </a:ext>
              </a:extLst>
            </p:cNvPr>
            <p:cNvCxnSpPr/>
            <p:nvPr/>
          </p:nvCxnSpPr>
          <p:spPr>
            <a:xfrm>
              <a:off x="1815446" y="5826460"/>
              <a:ext cx="77724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2" name="Straight Connector 21">
              <a:extLst>
                <a:ext uri="{FF2B5EF4-FFF2-40B4-BE49-F238E27FC236}">
                  <a16:creationId xmlns:a16="http://schemas.microsoft.com/office/drawing/2014/main" id="{3A588C92-5116-41BE-BD53-B41772732F3F}"/>
                </a:ext>
              </a:extLst>
            </p:cNvPr>
            <p:cNvCxnSpPr/>
            <p:nvPr/>
          </p:nvCxnSpPr>
          <p:spPr>
            <a:xfrm>
              <a:off x="2794878" y="5826460"/>
              <a:ext cx="77724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23" name="TextBox 22">
            <a:extLst>
              <a:ext uri="{FF2B5EF4-FFF2-40B4-BE49-F238E27FC236}">
                <a16:creationId xmlns:a16="http://schemas.microsoft.com/office/drawing/2014/main" id="{23D28F48-9F19-4EB0-826C-0154024F200C}"/>
              </a:ext>
            </a:extLst>
          </p:cNvPr>
          <p:cNvSpPr txBox="1"/>
          <p:nvPr/>
        </p:nvSpPr>
        <p:spPr>
          <a:xfrm>
            <a:off x="4469101" y="4208773"/>
            <a:ext cx="404384" cy="24001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TCP20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FEF8DA4B-76B8-4CD8-9FC4-969148885B32}"/>
              </a:ext>
            </a:extLst>
          </p:cNvPr>
          <p:cNvSpPr txBox="1"/>
          <p:nvPr/>
        </p:nvSpPr>
        <p:spPr>
          <a:xfrm>
            <a:off x="5099835" y="4209243"/>
            <a:ext cx="56424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TCP22</a:t>
            </a:r>
          </a:p>
        </p:txBody>
      </p:sp>
      <p:cxnSp>
        <p:nvCxnSpPr>
          <p:cNvPr id="25" name="Straight Connector 24">
            <a:extLst>
              <a:ext uri="{FF2B5EF4-FFF2-40B4-BE49-F238E27FC236}">
                <a16:creationId xmlns:a16="http://schemas.microsoft.com/office/drawing/2014/main" id="{A4449267-B1ED-4EBB-9999-D6DEAFE42921}"/>
              </a:ext>
            </a:extLst>
          </p:cNvPr>
          <p:cNvCxnSpPr/>
          <p:nvPr/>
        </p:nvCxnSpPr>
        <p:spPr>
          <a:xfrm>
            <a:off x="4495381" y="4427531"/>
            <a:ext cx="4572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B4A41121-22DC-419F-B807-B0E744E7062A}"/>
              </a:ext>
            </a:extLst>
          </p:cNvPr>
          <p:cNvCxnSpPr/>
          <p:nvPr/>
        </p:nvCxnSpPr>
        <p:spPr>
          <a:xfrm>
            <a:off x="5146569" y="4429600"/>
            <a:ext cx="4572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14129651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9648DA8C-A704-476C-8A43-6BB3315A1EB3}"/>
              </a:ext>
            </a:extLst>
          </p:cNvPr>
          <p:cNvSpPr txBox="1"/>
          <p:nvPr/>
        </p:nvSpPr>
        <p:spPr>
          <a:xfrm>
            <a:off x="356786" y="3821661"/>
            <a:ext cx="2856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B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D2FD7387-4F80-4583-8EA2-11BFFC5C0E27}"/>
              </a:ext>
            </a:extLst>
          </p:cNvPr>
          <p:cNvSpPr txBox="1"/>
          <p:nvPr/>
        </p:nvSpPr>
        <p:spPr>
          <a:xfrm>
            <a:off x="356786" y="292189"/>
            <a:ext cx="2888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99DA2C1D-121E-43F0-9D77-08B7359E6F6A}"/>
              </a:ext>
            </a:extLst>
          </p:cNvPr>
          <p:cNvSpPr txBox="1"/>
          <p:nvPr/>
        </p:nvSpPr>
        <p:spPr>
          <a:xfrm>
            <a:off x="716667" y="413481"/>
            <a:ext cx="6976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2</a:t>
            </a:r>
            <a:r>
              <a:rPr lang="en-US" sz="1200" baseline="30000" dirty="0"/>
              <a:t>nd</a:t>
            </a:r>
            <a:r>
              <a:rPr lang="en-US" sz="1200" dirty="0"/>
              <a:t> trial: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C9ED6C1-48B7-4BCE-8277-88B704453B26}"/>
              </a:ext>
            </a:extLst>
          </p:cNvPr>
          <p:cNvSpPr txBox="1"/>
          <p:nvPr/>
        </p:nvSpPr>
        <p:spPr>
          <a:xfrm>
            <a:off x="708651" y="2076024"/>
            <a:ext cx="6769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3</a:t>
            </a:r>
            <a:r>
              <a:rPr lang="en-US" altLang="zh-CN" sz="1200" baseline="30000" dirty="0"/>
              <a:t>rd</a:t>
            </a:r>
            <a:r>
              <a:rPr lang="en-US" altLang="zh-CN" sz="1200" dirty="0"/>
              <a:t> </a:t>
            </a:r>
            <a:r>
              <a:rPr lang="en-US" sz="1200" dirty="0"/>
              <a:t>trial:</a:t>
            </a:r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id="{B088955A-4E46-488B-810A-4EE3B7065D6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5766" y="524381"/>
            <a:ext cx="6286468" cy="1631423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C86AE5A0-449A-4D92-9D51-3366ACD7A65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85767" y="2155804"/>
            <a:ext cx="6309360" cy="1666696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4C05C9EE-F68A-4BDC-B4CC-9DE6DB8B38F2}"/>
              </a:ext>
            </a:extLst>
          </p:cNvPr>
          <p:cNvSpPr txBox="1"/>
          <p:nvPr/>
        </p:nvSpPr>
        <p:spPr>
          <a:xfrm>
            <a:off x="3361772" y="1643153"/>
            <a:ext cx="2487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*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9B4AFA8B-B9A0-44AD-B14D-3DFF5F25ADC1}"/>
              </a:ext>
            </a:extLst>
          </p:cNvPr>
          <p:cNvSpPr txBox="1"/>
          <p:nvPr/>
        </p:nvSpPr>
        <p:spPr>
          <a:xfrm>
            <a:off x="3382553" y="3274576"/>
            <a:ext cx="2487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*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64C75394-6334-46BD-B085-BADBC3B9AE63}"/>
              </a:ext>
            </a:extLst>
          </p:cNvPr>
          <p:cNvSpPr txBox="1"/>
          <p:nvPr/>
        </p:nvSpPr>
        <p:spPr>
          <a:xfrm>
            <a:off x="716667" y="3857153"/>
            <a:ext cx="6976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2</a:t>
            </a:r>
            <a:r>
              <a:rPr lang="en-US" sz="1200" baseline="30000" dirty="0"/>
              <a:t>nd</a:t>
            </a:r>
            <a:r>
              <a:rPr lang="en-US" sz="1200" dirty="0"/>
              <a:t> trial: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674EDD2F-2E25-4FDA-9A9E-1C59ED8A35B8}"/>
              </a:ext>
            </a:extLst>
          </p:cNvPr>
          <p:cNvSpPr txBox="1"/>
          <p:nvPr/>
        </p:nvSpPr>
        <p:spPr>
          <a:xfrm>
            <a:off x="708651" y="5872986"/>
            <a:ext cx="6769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3</a:t>
            </a:r>
            <a:r>
              <a:rPr lang="en-US" altLang="zh-CN" sz="1200" baseline="30000" dirty="0"/>
              <a:t>rd</a:t>
            </a:r>
            <a:r>
              <a:rPr lang="en-US" altLang="zh-CN" sz="1200" dirty="0"/>
              <a:t> </a:t>
            </a:r>
            <a:r>
              <a:rPr lang="en-US" sz="1200" dirty="0"/>
              <a:t>trial:</a:t>
            </a:r>
          </a:p>
        </p:txBody>
      </p:sp>
      <p:pic>
        <p:nvPicPr>
          <p:cNvPr id="19" name="Picture 18">
            <a:extLst>
              <a:ext uri="{FF2B5EF4-FFF2-40B4-BE49-F238E27FC236}">
                <a16:creationId xmlns:a16="http://schemas.microsoft.com/office/drawing/2014/main" id="{C6E58F0D-C03C-4770-BD59-7E30BCDD09E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02864" y="4092382"/>
            <a:ext cx="4233561" cy="1744083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6FD25203-204F-47CF-8DA7-8B28C0791B0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82356" y="6092011"/>
            <a:ext cx="4274576" cy="1744083"/>
          </a:xfrm>
          <a:prstGeom prst="rect">
            <a:avLst/>
          </a:prstGeom>
        </p:spPr>
      </p:pic>
      <p:sp>
        <p:nvSpPr>
          <p:cNvPr id="6" name="TextBox 1">
            <a:extLst>
              <a:ext uri="{FF2B5EF4-FFF2-40B4-BE49-F238E27FC236}">
                <a16:creationId xmlns:a16="http://schemas.microsoft.com/office/drawing/2014/main" id="{49F2C729-1604-EF32-63D6-70B83B6230C3}"/>
              </a:ext>
            </a:extLst>
          </p:cNvPr>
          <p:cNvSpPr txBox="1"/>
          <p:nvPr/>
        </p:nvSpPr>
        <p:spPr>
          <a:xfrm>
            <a:off x="499614" y="7952501"/>
            <a:ext cx="5606643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5. FHY3 and PIF5 interacts more poorly with 5X compared to wild-type TOC1. </a:t>
            </a:r>
            <a:r>
              <a: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wo additional trials of Co-IP between TAP tagged FHY3/PIF5 and GFP tagged TOC1 carrying varied phospho-site substitutions in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. </a:t>
            </a:r>
            <a:r>
              <a:rPr lang="en-U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enthamian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Protein extracts were immunoprecipitated by IgG resins followed by HRV-3C protease digestion. TAP tagged proteins were detected by anti-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yc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TOC1 was detected by anti-GFP.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sterisks in C indicates PIF5 that was 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nspecifically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cognized by the secondary antibody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6887714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5" name="Group 34">
            <a:extLst>
              <a:ext uri="{FF2B5EF4-FFF2-40B4-BE49-F238E27FC236}">
                <a16:creationId xmlns:a16="http://schemas.microsoft.com/office/drawing/2014/main" id="{05E13ECC-D2CB-4C44-A588-0C22E7C0C93E}"/>
              </a:ext>
            </a:extLst>
          </p:cNvPr>
          <p:cNvGrpSpPr/>
          <p:nvPr/>
        </p:nvGrpSpPr>
        <p:grpSpPr>
          <a:xfrm>
            <a:off x="432545" y="335280"/>
            <a:ext cx="4116008" cy="2642383"/>
            <a:chOff x="432545" y="335280"/>
            <a:chExt cx="4116008" cy="2642383"/>
          </a:xfrm>
        </p:grpSpPr>
        <p:graphicFrame>
          <p:nvGraphicFramePr>
            <p:cNvPr id="4" name="Chart 3">
              <a:extLst>
                <a:ext uri="{FF2B5EF4-FFF2-40B4-BE49-F238E27FC236}">
                  <a16:creationId xmlns:a16="http://schemas.microsoft.com/office/drawing/2014/main" id="{5238ED28-DAC9-4EA1-A42A-CB395A2B2803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438607992"/>
                </p:ext>
              </p:extLst>
            </p:nvPr>
          </p:nvGraphicFramePr>
          <p:xfrm>
            <a:off x="614289" y="335280"/>
            <a:ext cx="3934264" cy="2642383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5ACDCD5C-9A83-4882-9557-8F9FA1554312}"/>
                </a:ext>
              </a:extLst>
            </p:cNvPr>
            <p:cNvSpPr txBox="1"/>
            <p:nvPr/>
          </p:nvSpPr>
          <p:spPr>
            <a:xfrm rot="16200000">
              <a:off x="264550" y="1424354"/>
              <a:ext cx="58221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% Input</a:t>
              </a:r>
            </a:p>
          </p:txBody>
        </p:sp>
        <p:cxnSp>
          <p:nvCxnSpPr>
            <p:cNvPr id="6" name="Straight Connector 5">
              <a:extLst>
                <a:ext uri="{FF2B5EF4-FFF2-40B4-BE49-F238E27FC236}">
                  <a16:creationId xmlns:a16="http://schemas.microsoft.com/office/drawing/2014/main" id="{E502E6D2-5623-47FB-B52A-79F0BA7C0746}"/>
                </a:ext>
              </a:extLst>
            </p:cNvPr>
            <p:cNvCxnSpPr>
              <a:cxnSpLocks/>
            </p:cNvCxnSpPr>
            <p:nvPr/>
          </p:nvCxnSpPr>
          <p:spPr>
            <a:xfrm>
              <a:off x="1727940" y="976678"/>
              <a:ext cx="146304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C0E0F452-175E-4C8B-BBEB-765C0BA0ECA5}"/>
                </a:ext>
              </a:extLst>
            </p:cNvPr>
            <p:cNvSpPr txBox="1"/>
            <p:nvPr/>
          </p:nvSpPr>
          <p:spPr>
            <a:xfrm>
              <a:off x="1612758" y="826480"/>
              <a:ext cx="43433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/>
                <a:t>***</a:t>
              </a:r>
            </a:p>
          </p:txBody>
        </p:sp>
        <p:cxnSp>
          <p:nvCxnSpPr>
            <p:cNvPr id="8" name="Straight Connector 7">
              <a:extLst>
                <a:ext uri="{FF2B5EF4-FFF2-40B4-BE49-F238E27FC236}">
                  <a16:creationId xmlns:a16="http://schemas.microsoft.com/office/drawing/2014/main" id="{7D275407-F578-454B-8ECC-B2A76959B368}"/>
                </a:ext>
              </a:extLst>
            </p:cNvPr>
            <p:cNvCxnSpPr/>
            <p:nvPr/>
          </p:nvCxnSpPr>
          <p:spPr>
            <a:xfrm>
              <a:off x="1873574" y="976878"/>
              <a:ext cx="0" cy="1252728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" name="Straight Connector 8">
              <a:extLst>
                <a:ext uri="{FF2B5EF4-FFF2-40B4-BE49-F238E27FC236}">
                  <a16:creationId xmlns:a16="http://schemas.microsoft.com/office/drawing/2014/main" id="{72243375-AE9E-4462-87DC-B07C2FD06D5A}"/>
                </a:ext>
              </a:extLst>
            </p:cNvPr>
            <p:cNvCxnSpPr/>
            <p:nvPr/>
          </p:nvCxnSpPr>
          <p:spPr>
            <a:xfrm>
              <a:off x="1726604" y="976878"/>
              <a:ext cx="0" cy="4572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" name="Straight Connector 9">
              <a:extLst>
                <a:ext uri="{FF2B5EF4-FFF2-40B4-BE49-F238E27FC236}">
                  <a16:creationId xmlns:a16="http://schemas.microsoft.com/office/drawing/2014/main" id="{5A708AAD-F90C-4E23-9AB9-4964978D18EC}"/>
                </a:ext>
              </a:extLst>
            </p:cNvPr>
            <p:cNvCxnSpPr>
              <a:cxnSpLocks/>
            </p:cNvCxnSpPr>
            <p:nvPr/>
          </p:nvCxnSpPr>
          <p:spPr>
            <a:xfrm>
              <a:off x="2232125" y="914069"/>
              <a:ext cx="146304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03CC2267-80E6-4EDD-AF9B-6BD45FA25267}"/>
                </a:ext>
              </a:extLst>
            </p:cNvPr>
            <p:cNvSpPr txBox="1"/>
            <p:nvPr/>
          </p:nvSpPr>
          <p:spPr>
            <a:xfrm>
              <a:off x="2116943" y="764653"/>
              <a:ext cx="43433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/>
                <a:t>***</a:t>
              </a:r>
            </a:p>
          </p:txBody>
        </p:sp>
        <p:cxnSp>
          <p:nvCxnSpPr>
            <p:cNvPr id="12" name="Straight Connector 11">
              <a:extLst>
                <a:ext uri="{FF2B5EF4-FFF2-40B4-BE49-F238E27FC236}">
                  <a16:creationId xmlns:a16="http://schemas.microsoft.com/office/drawing/2014/main" id="{B44C9846-820A-4DFD-A0B3-7906004EE3FF}"/>
                </a:ext>
              </a:extLst>
            </p:cNvPr>
            <p:cNvCxnSpPr/>
            <p:nvPr/>
          </p:nvCxnSpPr>
          <p:spPr>
            <a:xfrm>
              <a:off x="2376977" y="915051"/>
              <a:ext cx="0" cy="1298448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" name="Straight Connector 12">
              <a:extLst>
                <a:ext uri="{FF2B5EF4-FFF2-40B4-BE49-F238E27FC236}">
                  <a16:creationId xmlns:a16="http://schemas.microsoft.com/office/drawing/2014/main" id="{D9E8FECD-3E64-4521-B4A1-DAC02A63FA5F}"/>
                </a:ext>
              </a:extLst>
            </p:cNvPr>
            <p:cNvCxnSpPr/>
            <p:nvPr/>
          </p:nvCxnSpPr>
          <p:spPr>
            <a:xfrm>
              <a:off x="2230007" y="915051"/>
              <a:ext cx="0" cy="4572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" name="Straight Connector 13">
              <a:extLst>
                <a:ext uri="{FF2B5EF4-FFF2-40B4-BE49-F238E27FC236}">
                  <a16:creationId xmlns:a16="http://schemas.microsoft.com/office/drawing/2014/main" id="{235002C2-D9A2-4C57-9007-8EC7FD6F8086}"/>
                </a:ext>
              </a:extLst>
            </p:cNvPr>
            <p:cNvCxnSpPr>
              <a:cxnSpLocks/>
            </p:cNvCxnSpPr>
            <p:nvPr/>
          </p:nvCxnSpPr>
          <p:spPr>
            <a:xfrm>
              <a:off x="2744117" y="773468"/>
              <a:ext cx="13716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43DE5BEB-6810-4B30-8D93-C584DFB62B68}"/>
                </a:ext>
              </a:extLst>
            </p:cNvPr>
            <p:cNvSpPr txBox="1"/>
            <p:nvPr/>
          </p:nvSpPr>
          <p:spPr>
            <a:xfrm>
              <a:off x="2623855" y="624415"/>
              <a:ext cx="43433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/>
                <a:t>***</a:t>
              </a:r>
            </a:p>
          </p:txBody>
        </p:sp>
        <p:cxnSp>
          <p:nvCxnSpPr>
            <p:cNvPr id="16" name="Straight Connector 15">
              <a:extLst>
                <a:ext uri="{FF2B5EF4-FFF2-40B4-BE49-F238E27FC236}">
                  <a16:creationId xmlns:a16="http://schemas.microsoft.com/office/drawing/2014/main" id="{D37A0310-3962-4FD7-992A-4DEF4342548C}"/>
                </a:ext>
              </a:extLst>
            </p:cNvPr>
            <p:cNvCxnSpPr/>
            <p:nvPr/>
          </p:nvCxnSpPr>
          <p:spPr>
            <a:xfrm>
              <a:off x="2878809" y="774813"/>
              <a:ext cx="0" cy="146304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7" name="Straight Connector 16">
              <a:extLst>
                <a:ext uri="{FF2B5EF4-FFF2-40B4-BE49-F238E27FC236}">
                  <a16:creationId xmlns:a16="http://schemas.microsoft.com/office/drawing/2014/main" id="{4E2E19CC-9929-4268-8D42-C76E153E7366}"/>
                </a:ext>
              </a:extLst>
            </p:cNvPr>
            <p:cNvCxnSpPr/>
            <p:nvPr/>
          </p:nvCxnSpPr>
          <p:spPr>
            <a:xfrm>
              <a:off x="2736919" y="774813"/>
              <a:ext cx="0" cy="4572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8" name="Straight Connector 17">
              <a:extLst>
                <a:ext uri="{FF2B5EF4-FFF2-40B4-BE49-F238E27FC236}">
                  <a16:creationId xmlns:a16="http://schemas.microsoft.com/office/drawing/2014/main" id="{812BB000-8466-4284-89AA-45407CA867D5}"/>
                </a:ext>
              </a:extLst>
            </p:cNvPr>
            <p:cNvCxnSpPr>
              <a:cxnSpLocks/>
            </p:cNvCxnSpPr>
            <p:nvPr/>
          </p:nvCxnSpPr>
          <p:spPr>
            <a:xfrm>
              <a:off x="3240753" y="2137444"/>
              <a:ext cx="146304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89D03D09-9728-4956-9AE5-323C9E2E5C6A}"/>
                </a:ext>
              </a:extLst>
            </p:cNvPr>
            <p:cNvSpPr txBox="1"/>
            <p:nvPr/>
          </p:nvSpPr>
          <p:spPr>
            <a:xfrm>
              <a:off x="3152460" y="1937143"/>
              <a:ext cx="38829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err="1"/>
                <a:t>n.s</a:t>
              </a:r>
              <a:r>
                <a:rPr lang="en-US" sz="1000" dirty="0"/>
                <a:t>.</a:t>
              </a:r>
            </a:p>
          </p:txBody>
        </p:sp>
        <p:cxnSp>
          <p:nvCxnSpPr>
            <p:cNvPr id="20" name="Straight Connector 19">
              <a:extLst>
                <a:ext uri="{FF2B5EF4-FFF2-40B4-BE49-F238E27FC236}">
                  <a16:creationId xmlns:a16="http://schemas.microsoft.com/office/drawing/2014/main" id="{0AE754D9-FDC1-4195-BFDF-373726D2B541}"/>
                </a:ext>
              </a:extLst>
            </p:cNvPr>
            <p:cNvCxnSpPr/>
            <p:nvPr/>
          </p:nvCxnSpPr>
          <p:spPr>
            <a:xfrm>
              <a:off x="3386387" y="2137644"/>
              <a:ext cx="0" cy="118872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1" name="Straight Connector 20">
              <a:extLst>
                <a:ext uri="{FF2B5EF4-FFF2-40B4-BE49-F238E27FC236}">
                  <a16:creationId xmlns:a16="http://schemas.microsoft.com/office/drawing/2014/main" id="{E67A464A-18B3-4284-AED3-1C5F02EF6651}"/>
                </a:ext>
              </a:extLst>
            </p:cNvPr>
            <p:cNvCxnSpPr/>
            <p:nvPr/>
          </p:nvCxnSpPr>
          <p:spPr>
            <a:xfrm>
              <a:off x="3239417" y="2137644"/>
              <a:ext cx="0" cy="4572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2" name="Straight Connector 21">
              <a:extLst>
                <a:ext uri="{FF2B5EF4-FFF2-40B4-BE49-F238E27FC236}">
                  <a16:creationId xmlns:a16="http://schemas.microsoft.com/office/drawing/2014/main" id="{8F4FD8FD-4053-40E9-8B38-0F76B9CDC4C2}"/>
                </a:ext>
              </a:extLst>
            </p:cNvPr>
            <p:cNvCxnSpPr>
              <a:cxnSpLocks/>
            </p:cNvCxnSpPr>
            <p:nvPr/>
          </p:nvCxnSpPr>
          <p:spPr>
            <a:xfrm>
              <a:off x="3745761" y="886866"/>
              <a:ext cx="146304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98ED5995-BAD5-4998-A0B7-BA3630B10D4A}"/>
                </a:ext>
              </a:extLst>
            </p:cNvPr>
            <p:cNvSpPr txBox="1"/>
            <p:nvPr/>
          </p:nvSpPr>
          <p:spPr>
            <a:xfrm>
              <a:off x="3657468" y="686565"/>
              <a:ext cx="38829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err="1"/>
                <a:t>n.s</a:t>
              </a:r>
              <a:r>
                <a:rPr lang="en-US" sz="1000" dirty="0"/>
                <a:t>.</a:t>
              </a:r>
            </a:p>
          </p:txBody>
        </p:sp>
        <p:cxnSp>
          <p:nvCxnSpPr>
            <p:cNvPr id="24" name="Straight Connector 23">
              <a:extLst>
                <a:ext uri="{FF2B5EF4-FFF2-40B4-BE49-F238E27FC236}">
                  <a16:creationId xmlns:a16="http://schemas.microsoft.com/office/drawing/2014/main" id="{70A48FA0-9D60-465C-A65F-BF8D3247F2E1}"/>
                </a:ext>
              </a:extLst>
            </p:cNvPr>
            <p:cNvCxnSpPr/>
            <p:nvPr/>
          </p:nvCxnSpPr>
          <p:spPr>
            <a:xfrm>
              <a:off x="3891395" y="887066"/>
              <a:ext cx="0" cy="109728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5" name="Straight Connector 24">
              <a:extLst>
                <a:ext uri="{FF2B5EF4-FFF2-40B4-BE49-F238E27FC236}">
                  <a16:creationId xmlns:a16="http://schemas.microsoft.com/office/drawing/2014/main" id="{9394612A-BECE-492F-8690-6DBBBFD01047}"/>
                </a:ext>
              </a:extLst>
            </p:cNvPr>
            <p:cNvCxnSpPr/>
            <p:nvPr/>
          </p:nvCxnSpPr>
          <p:spPr>
            <a:xfrm>
              <a:off x="3744425" y="887066"/>
              <a:ext cx="0" cy="4572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6" name="Straight Connector 25">
              <a:extLst>
                <a:ext uri="{FF2B5EF4-FFF2-40B4-BE49-F238E27FC236}">
                  <a16:creationId xmlns:a16="http://schemas.microsoft.com/office/drawing/2014/main" id="{0F2AC28D-DBDA-4D65-B9D1-7B78729E5468}"/>
                </a:ext>
              </a:extLst>
            </p:cNvPr>
            <p:cNvCxnSpPr>
              <a:cxnSpLocks/>
            </p:cNvCxnSpPr>
            <p:nvPr/>
          </p:nvCxnSpPr>
          <p:spPr>
            <a:xfrm>
              <a:off x="4242756" y="939358"/>
              <a:ext cx="146304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64E8B1D4-285C-4A46-B0AB-7F0CF43BD4C5}"/>
                </a:ext>
              </a:extLst>
            </p:cNvPr>
            <p:cNvSpPr txBox="1"/>
            <p:nvPr/>
          </p:nvSpPr>
          <p:spPr>
            <a:xfrm>
              <a:off x="4159906" y="739057"/>
              <a:ext cx="38829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err="1"/>
                <a:t>n.s</a:t>
              </a:r>
              <a:r>
                <a:rPr lang="en-US" sz="1000" dirty="0"/>
                <a:t>.</a:t>
              </a:r>
            </a:p>
          </p:txBody>
        </p:sp>
        <p:cxnSp>
          <p:nvCxnSpPr>
            <p:cNvPr id="28" name="Straight Connector 27">
              <a:extLst>
                <a:ext uri="{FF2B5EF4-FFF2-40B4-BE49-F238E27FC236}">
                  <a16:creationId xmlns:a16="http://schemas.microsoft.com/office/drawing/2014/main" id="{45162B5D-8595-42E2-A8A6-FA49CD553E51}"/>
                </a:ext>
              </a:extLst>
            </p:cNvPr>
            <p:cNvCxnSpPr/>
            <p:nvPr/>
          </p:nvCxnSpPr>
          <p:spPr>
            <a:xfrm>
              <a:off x="4393833" y="939558"/>
              <a:ext cx="0" cy="256032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9" name="Straight Connector 28">
              <a:extLst>
                <a:ext uri="{FF2B5EF4-FFF2-40B4-BE49-F238E27FC236}">
                  <a16:creationId xmlns:a16="http://schemas.microsoft.com/office/drawing/2014/main" id="{78BC4ACE-0E93-4BD4-A436-6C142B67D730}"/>
                </a:ext>
              </a:extLst>
            </p:cNvPr>
            <p:cNvCxnSpPr/>
            <p:nvPr/>
          </p:nvCxnSpPr>
          <p:spPr>
            <a:xfrm>
              <a:off x="4246863" y="939558"/>
              <a:ext cx="0" cy="4572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1" name="Straight Connector 30">
              <a:extLst>
                <a:ext uri="{FF2B5EF4-FFF2-40B4-BE49-F238E27FC236}">
                  <a16:creationId xmlns:a16="http://schemas.microsoft.com/office/drawing/2014/main" id="{BCC66783-AAD7-41BD-9F0C-F10B50B2EEF6}"/>
                </a:ext>
              </a:extLst>
            </p:cNvPr>
            <p:cNvCxnSpPr>
              <a:cxnSpLocks/>
            </p:cNvCxnSpPr>
            <p:nvPr/>
          </p:nvCxnSpPr>
          <p:spPr>
            <a:xfrm>
              <a:off x="1226268" y="2265997"/>
              <a:ext cx="146304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CB330562-5EB9-4243-9E14-E23275AAADA1}"/>
                </a:ext>
              </a:extLst>
            </p:cNvPr>
            <p:cNvSpPr txBox="1"/>
            <p:nvPr/>
          </p:nvSpPr>
          <p:spPr>
            <a:xfrm>
              <a:off x="1137975" y="2065696"/>
              <a:ext cx="38829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err="1"/>
                <a:t>n.s</a:t>
              </a:r>
              <a:r>
                <a:rPr lang="en-US" sz="1000" dirty="0"/>
                <a:t>.</a:t>
              </a:r>
            </a:p>
          </p:txBody>
        </p:sp>
        <p:cxnSp>
          <p:nvCxnSpPr>
            <p:cNvPr id="33" name="Straight Connector 32">
              <a:extLst>
                <a:ext uri="{FF2B5EF4-FFF2-40B4-BE49-F238E27FC236}">
                  <a16:creationId xmlns:a16="http://schemas.microsoft.com/office/drawing/2014/main" id="{515EDF11-7D76-4051-99BA-C4C8EFB8A2DD}"/>
                </a:ext>
              </a:extLst>
            </p:cNvPr>
            <p:cNvCxnSpPr/>
            <p:nvPr/>
          </p:nvCxnSpPr>
          <p:spPr>
            <a:xfrm>
              <a:off x="1371902" y="2266197"/>
              <a:ext cx="0" cy="4572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4" name="Straight Connector 33">
              <a:extLst>
                <a:ext uri="{FF2B5EF4-FFF2-40B4-BE49-F238E27FC236}">
                  <a16:creationId xmlns:a16="http://schemas.microsoft.com/office/drawing/2014/main" id="{7FC43A4F-B608-49BC-9FDB-89A8C8AEF746}"/>
                </a:ext>
              </a:extLst>
            </p:cNvPr>
            <p:cNvCxnSpPr/>
            <p:nvPr/>
          </p:nvCxnSpPr>
          <p:spPr>
            <a:xfrm>
              <a:off x="1224932" y="2266197"/>
              <a:ext cx="0" cy="4572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aphicFrame>
        <p:nvGraphicFramePr>
          <p:cNvPr id="77" name="Chart 76">
            <a:extLst>
              <a:ext uri="{FF2B5EF4-FFF2-40B4-BE49-F238E27FC236}">
                <a16:creationId xmlns:a16="http://schemas.microsoft.com/office/drawing/2014/main" id="{C5EF4528-D6B4-404C-AD6B-2DD2D3DE857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02890001"/>
              </p:ext>
            </p:extLst>
          </p:nvPr>
        </p:nvGraphicFramePr>
        <p:xfrm>
          <a:off x="300138" y="2977663"/>
          <a:ext cx="4431876" cy="243442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79" name="TextBox 78">
            <a:extLst>
              <a:ext uri="{FF2B5EF4-FFF2-40B4-BE49-F238E27FC236}">
                <a16:creationId xmlns:a16="http://schemas.microsoft.com/office/drawing/2014/main" id="{07C2DA55-584F-4498-AD84-602760C9522B}"/>
              </a:ext>
            </a:extLst>
          </p:cNvPr>
          <p:cNvSpPr txBox="1"/>
          <p:nvPr/>
        </p:nvSpPr>
        <p:spPr>
          <a:xfrm>
            <a:off x="385451" y="3159935"/>
            <a:ext cx="2856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B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43703688-C793-45F9-8C96-8308B7A8FEF9}"/>
              </a:ext>
            </a:extLst>
          </p:cNvPr>
          <p:cNvSpPr txBox="1"/>
          <p:nvPr/>
        </p:nvSpPr>
        <p:spPr>
          <a:xfrm>
            <a:off x="390259" y="344949"/>
            <a:ext cx="2888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A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4AF8C040-0C4C-4393-A165-ABE12160C726}"/>
              </a:ext>
            </a:extLst>
          </p:cNvPr>
          <p:cNvSpPr txBox="1"/>
          <p:nvPr/>
        </p:nvSpPr>
        <p:spPr>
          <a:xfrm>
            <a:off x="436095" y="5376460"/>
            <a:ext cx="5606643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6.  5X shows reduced binding to various </a:t>
            </a:r>
            <a:r>
              <a:rPr lang="en-US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is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elements at the </a:t>
            </a:r>
            <a:r>
              <a:rPr lang="en-US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CA1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moter but not at the </a:t>
            </a:r>
            <a:r>
              <a:rPr lang="en-US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HY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romoter, and PIF3/4/5 do not affect TOC1 occupancy at </a:t>
            </a:r>
            <a:r>
              <a:rPr lang="en-US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CA1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IP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qPCR of TOC1 binding to the varied promoter regions of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CA1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HY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t ZT14 in Col-0, wild type TOC1 and 5X lines. Data were averaged from 3 independent trials, each trial with 2 technical repeats. Error bars indicate SEM. Asterisks indicate significant differences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etween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ld-type TOC1 and 5X (*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0.05, **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0.001, ***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 0.0001, Student’s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test)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IP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qPCR of TOC1 binding to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CA1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HY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presence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v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absence of PIF3/4/5. Shown are results from one trial with two technical repeats. Error bars indicate SEM,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.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= not significant.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2586FB75-7D03-44F2-B315-2DB8CBC219E6}"/>
              </a:ext>
            </a:extLst>
          </p:cNvPr>
          <p:cNvSpPr txBox="1"/>
          <p:nvPr/>
        </p:nvSpPr>
        <p:spPr>
          <a:xfrm>
            <a:off x="1558228" y="4642944"/>
            <a:ext cx="3882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err="1"/>
              <a:t>n.s</a:t>
            </a:r>
            <a:r>
              <a:rPr lang="en-US" sz="1000" dirty="0"/>
              <a:t>.</a:t>
            </a:r>
          </a:p>
        </p:txBody>
      </p:sp>
      <p:cxnSp>
        <p:nvCxnSpPr>
          <p:cNvPr id="3" name="Straight Connector 2">
            <a:extLst>
              <a:ext uri="{FF2B5EF4-FFF2-40B4-BE49-F238E27FC236}">
                <a16:creationId xmlns:a16="http://schemas.microsoft.com/office/drawing/2014/main" id="{4EC1386C-FADE-4407-A85D-38784AC75D64}"/>
              </a:ext>
            </a:extLst>
          </p:cNvPr>
          <p:cNvCxnSpPr/>
          <p:nvPr/>
        </p:nvCxnSpPr>
        <p:spPr>
          <a:xfrm>
            <a:off x="1594248" y="4856475"/>
            <a:ext cx="27432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0" name="Straight Connector 39">
            <a:extLst>
              <a:ext uri="{FF2B5EF4-FFF2-40B4-BE49-F238E27FC236}">
                <a16:creationId xmlns:a16="http://schemas.microsoft.com/office/drawing/2014/main" id="{4E188E79-06B7-4B32-8184-5BD96EE98019}"/>
              </a:ext>
            </a:extLst>
          </p:cNvPr>
          <p:cNvCxnSpPr>
            <a:cxnSpLocks/>
          </p:cNvCxnSpPr>
          <p:nvPr/>
        </p:nvCxnSpPr>
        <p:spPr>
          <a:xfrm rot="16200000">
            <a:off x="1570003" y="4880720"/>
            <a:ext cx="4572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1" name="Straight Connector 40">
            <a:extLst>
              <a:ext uri="{FF2B5EF4-FFF2-40B4-BE49-F238E27FC236}">
                <a16:creationId xmlns:a16="http://schemas.microsoft.com/office/drawing/2014/main" id="{273B322A-839C-4CE2-B610-99CB14B6F694}"/>
              </a:ext>
            </a:extLst>
          </p:cNvPr>
          <p:cNvCxnSpPr>
            <a:cxnSpLocks/>
          </p:cNvCxnSpPr>
          <p:nvPr/>
        </p:nvCxnSpPr>
        <p:spPr>
          <a:xfrm rot="16200000">
            <a:off x="1845610" y="4880718"/>
            <a:ext cx="4572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2" name="TextBox 41">
            <a:extLst>
              <a:ext uri="{FF2B5EF4-FFF2-40B4-BE49-F238E27FC236}">
                <a16:creationId xmlns:a16="http://schemas.microsoft.com/office/drawing/2014/main" id="{205074E4-04BF-4102-84BF-11CB1137E954}"/>
              </a:ext>
            </a:extLst>
          </p:cNvPr>
          <p:cNvSpPr txBox="1"/>
          <p:nvPr/>
        </p:nvSpPr>
        <p:spPr>
          <a:xfrm>
            <a:off x="2764163" y="3509460"/>
            <a:ext cx="3882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err="1"/>
              <a:t>n.s</a:t>
            </a:r>
            <a:r>
              <a:rPr lang="en-US" sz="1000" dirty="0"/>
              <a:t>.</a:t>
            </a:r>
          </a:p>
        </p:txBody>
      </p:sp>
      <p:cxnSp>
        <p:nvCxnSpPr>
          <p:cNvPr id="43" name="Straight Connector 42">
            <a:extLst>
              <a:ext uri="{FF2B5EF4-FFF2-40B4-BE49-F238E27FC236}">
                <a16:creationId xmlns:a16="http://schemas.microsoft.com/office/drawing/2014/main" id="{BCC4CE74-AB3F-4EE2-A9B4-7EC0C1BFD707}"/>
              </a:ext>
            </a:extLst>
          </p:cNvPr>
          <p:cNvCxnSpPr/>
          <p:nvPr/>
        </p:nvCxnSpPr>
        <p:spPr>
          <a:xfrm>
            <a:off x="2800183" y="3722991"/>
            <a:ext cx="27432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4" name="Straight Connector 43">
            <a:extLst>
              <a:ext uri="{FF2B5EF4-FFF2-40B4-BE49-F238E27FC236}">
                <a16:creationId xmlns:a16="http://schemas.microsoft.com/office/drawing/2014/main" id="{3E366C32-816A-42E7-AA3A-50E36879E291}"/>
              </a:ext>
            </a:extLst>
          </p:cNvPr>
          <p:cNvCxnSpPr>
            <a:cxnSpLocks/>
          </p:cNvCxnSpPr>
          <p:nvPr/>
        </p:nvCxnSpPr>
        <p:spPr>
          <a:xfrm rot="16200000">
            <a:off x="2775938" y="3747236"/>
            <a:ext cx="4572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5" name="Straight Connector 44">
            <a:extLst>
              <a:ext uri="{FF2B5EF4-FFF2-40B4-BE49-F238E27FC236}">
                <a16:creationId xmlns:a16="http://schemas.microsoft.com/office/drawing/2014/main" id="{491875C9-F649-4842-8292-BF8AAECA3073}"/>
              </a:ext>
            </a:extLst>
          </p:cNvPr>
          <p:cNvCxnSpPr>
            <a:cxnSpLocks/>
          </p:cNvCxnSpPr>
          <p:nvPr/>
        </p:nvCxnSpPr>
        <p:spPr>
          <a:xfrm rot="16200000">
            <a:off x="3050865" y="3747234"/>
            <a:ext cx="4572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6" name="TextBox 45">
            <a:extLst>
              <a:ext uri="{FF2B5EF4-FFF2-40B4-BE49-F238E27FC236}">
                <a16:creationId xmlns:a16="http://schemas.microsoft.com/office/drawing/2014/main" id="{C52C278D-17EB-4156-9EA5-BD352052BE82}"/>
              </a:ext>
            </a:extLst>
          </p:cNvPr>
          <p:cNvSpPr txBox="1"/>
          <p:nvPr/>
        </p:nvSpPr>
        <p:spPr>
          <a:xfrm>
            <a:off x="3931122" y="3281506"/>
            <a:ext cx="3882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err="1"/>
              <a:t>n.s</a:t>
            </a:r>
            <a:r>
              <a:rPr lang="en-US" sz="1000" dirty="0"/>
              <a:t>.</a:t>
            </a:r>
          </a:p>
        </p:txBody>
      </p:sp>
      <p:cxnSp>
        <p:nvCxnSpPr>
          <p:cNvPr id="47" name="Straight Connector 46">
            <a:extLst>
              <a:ext uri="{FF2B5EF4-FFF2-40B4-BE49-F238E27FC236}">
                <a16:creationId xmlns:a16="http://schemas.microsoft.com/office/drawing/2014/main" id="{7606C680-D448-4526-A405-DA8849704729}"/>
              </a:ext>
            </a:extLst>
          </p:cNvPr>
          <p:cNvCxnSpPr/>
          <p:nvPr/>
        </p:nvCxnSpPr>
        <p:spPr>
          <a:xfrm>
            <a:off x="3967142" y="3495037"/>
            <a:ext cx="27432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8" name="Straight Connector 47">
            <a:extLst>
              <a:ext uri="{FF2B5EF4-FFF2-40B4-BE49-F238E27FC236}">
                <a16:creationId xmlns:a16="http://schemas.microsoft.com/office/drawing/2014/main" id="{053167D4-CE10-46AD-8D89-B175B3F9C36B}"/>
              </a:ext>
            </a:extLst>
          </p:cNvPr>
          <p:cNvCxnSpPr>
            <a:cxnSpLocks/>
          </p:cNvCxnSpPr>
          <p:nvPr/>
        </p:nvCxnSpPr>
        <p:spPr>
          <a:xfrm rot="16200000">
            <a:off x="3942897" y="3519282"/>
            <a:ext cx="4572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9" name="Straight Connector 48">
            <a:extLst>
              <a:ext uri="{FF2B5EF4-FFF2-40B4-BE49-F238E27FC236}">
                <a16:creationId xmlns:a16="http://schemas.microsoft.com/office/drawing/2014/main" id="{2BA4A2E3-6BE5-47CE-AA37-A0536495F604}"/>
              </a:ext>
            </a:extLst>
          </p:cNvPr>
          <p:cNvCxnSpPr>
            <a:cxnSpLocks/>
          </p:cNvCxnSpPr>
          <p:nvPr/>
        </p:nvCxnSpPr>
        <p:spPr>
          <a:xfrm rot="16200000">
            <a:off x="4218504" y="3519280"/>
            <a:ext cx="4572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81581112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3" name="Picture 22" descr="A picture containing text&#10;&#10;Description automatically generated">
            <a:extLst>
              <a:ext uri="{FF2B5EF4-FFF2-40B4-BE49-F238E27FC236}">
                <a16:creationId xmlns:a16="http://schemas.microsoft.com/office/drawing/2014/main" id="{B3E1C777-E72F-4BFD-A394-6988006589F5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4403" t="68708" r="33912" b="27758"/>
          <a:stretch/>
        </p:blipFill>
        <p:spPr>
          <a:xfrm>
            <a:off x="1371600" y="923982"/>
            <a:ext cx="1437463" cy="347473"/>
          </a:xfrm>
          <a:prstGeom prst="rect">
            <a:avLst/>
          </a:prstGeom>
          <a:ln>
            <a:solidFill>
              <a:schemeClr val="bg1">
                <a:lumMod val="65000"/>
              </a:schemeClr>
            </a:solidFill>
          </a:ln>
        </p:spPr>
      </p:pic>
      <p:pic>
        <p:nvPicPr>
          <p:cNvPr id="24" name="Picture 23" descr="A picture containing text&#10;&#10;Description automatically generated">
            <a:extLst>
              <a:ext uri="{FF2B5EF4-FFF2-40B4-BE49-F238E27FC236}">
                <a16:creationId xmlns:a16="http://schemas.microsoft.com/office/drawing/2014/main" id="{E416BD29-B050-4C42-AF09-419AADF0BC1C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9789" t="66941" r="18526" b="29525"/>
          <a:stretch/>
        </p:blipFill>
        <p:spPr>
          <a:xfrm>
            <a:off x="1371600" y="1369563"/>
            <a:ext cx="1437463" cy="347473"/>
          </a:xfrm>
          <a:prstGeom prst="rect">
            <a:avLst/>
          </a:prstGeom>
          <a:ln>
            <a:solidFill>
              <a:schemeClr val="bg1">
                <a:lumMod val="65000"/>
              </a:schemeClr>
            </a:solidFill>
          </a:ln>
        </p:spPr>
      </p:pic>
      <p:sp>
        <p:nvSpPr>
          <p:cNvPr id="25" name="TextBox 24">
            <a:extLst>
              <a:ext uri="{FF2B5EF4-FFF2-40B4-BE49-F238E27FC236}">
                <a16:creationId xmlns:a16="http://schemas.microsoft.com/office/drawing/2014/main" id="{49F7D716-208C-485A-A9C3-586890C50809}"/>
              </a:ext>
            </a:extLst>
          </p:cNvPr>
          <p:cNvSpPr txBox="1"/>
          <p:nvPr/>
        </p:nvSpPr>
        <p:spPr>
          <a:xfrm>
            <a:off x="898943" y="962131"/>
            <a:ext cx="5004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000" dirty="0"/>
              <a:t>α</a:t>
            </a:r>
            <a:r>
              <a:rPr lang="en-US" sz="1000" dirty="0"/>
              <a:t>-GFP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3B7740A7-7C07-4A0F-9093-98B5BB444964}"/>
              </a:ext>
            </a:extLst>
          </p:cNvPr>
          <p:cNvSpPr txBox="1"/>
          <p:nvPr/>
        </p:nvSpPr>
        <p:spPr>
          <a:xfrm>
            <a:off x="885065" y="1412494"/>
            <a:ext cx="51488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000" dirty="0"/>
              <a:t>α</a:t>
            </a:r>
            <a:r>
              <a:rPr lang="en-US" sz="1000" dirty="0"/>
              <a:t>-ADK</a:t>
            </a:r>
          </a:p>
        </p:txBody>
      </p:sp>
      <p:graphicFrame>
        <p:nvGraphicFramePr>
          <p:cNvPr id="27" name="Chart 26">
            <a:extLst>
              <a:ext uri="{FF2B5EF4-FFF2-40B4-BE49-F238E27FC236}">
                <a16:creationId xmlns:a16="http://schemas.microsoft.com/office/drawing/2014/main" id="{8AC17938-5EEA-4769-8279-B6C0D3284B3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23562480"/>
              </p:ext>
            </p:extLst>
          </p:nvPr>
        </p:nvGraphicFramePr>
        <p:xfrm>
          <a:off x="2951138" y="451338"/>
          <a:ext cx="2330108" cy="252632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28" name="TextBox 27">
            <a:extLst>
              <a:ext uri="{FF2B5EF4-FFF2-40B4-BE49-F238E27FC236}">
                <a16:creationId xmlns:a16="http://schemas.microsoft.com/office/drawing/2014/main" id="{8F18560C-183E-4F91-BD84-63B7D1FE2E3C}"/>
              </a:ext>
            </a:extLst>
          </p:cNvPr>
          <p:cNvSpPr txBox="1"/>
          <p:nvPr/>
        </p:nvSpPr>
        <p:spPr>
          <a:xfrm rot="19351861">
            <a:off x="506767" y="2025468"/>
            <a:ext cx="13708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pTOC1:TOC1-GFP/</a:t>
            </a:r>
            <a:r>
              <a:rPr lang="en-US" sz="1000" i="1" dirty="0"/>
              <a:t>toc1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7422ED6C-607A-474C-B28B-3E5396922E98}"/>
              </a:ext>
            </a:extLst>
          </p:cNvPr>
          <p:cNvSpPr txBox="1"/>
          <p:nvPr/>
        </p:nvSpPr>
        <p:spPr>
          <a:xfrm rot="19351861">
            <a:off x="937355" y="1980123"/>
            <a:ext cx="122180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pTOC1:5X-GFP/</a:t>
            </a:r>
            <a:r>
              <a:rPr lang="en-US" sz="1000" i="1" dirty="0"/>
              <a:t>toc1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58107C16-65FD-42BE-8720-6D78210817EF}"/>
              </a:ext>
            </a:extLst>
          </p:cNvPr>
          <p:cNvSpPr txBox="1"/>
          <p:nvPr/>
        </p:nvSpPr>
        <p:spPr>
          <a:xfrm rot="19351861">
            <a:off x="948813" y="2094704"/>
            <a:ext cx="159851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pTOC1:TOC1-GFP/</a:t>
            </a:r>
            <a:r>
              <a:rPr lang="en-US" sz="1000" i="1" dirty="0"/>
              <a:t>fhy3toc1</a:t>
            </a:r>
            <a:endParaRPr lang="en-US" sz="1000" dirty="0"/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17124A89-4D6F-4BD3-94B2-E0D33053A827}"/>
              </a:ext>
            </a:extLst>
          </p:cNvPr>
          <p:cNvSpPr txBox="1"/>
          <p:nvPr/>
        </p:nvSpPr>
        <p:spPr>
          <a:xfrm rot="19351861">
            <a:off x="1402057" y="2049360"/>
            <a:ext cx="14494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pTOC1:5X-GFP/</a:t>
            </a:r>
            <a:r>
              <a:rPr lang="en-US" sz="1000" i="1" dirty="0"/>
              <a:t>fhy3toc1</a:t>
            </a:r>
            <a:endParaRPr lang="en-US" sz="1000" dirty="0"/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075DEC3E-34F5-4D9B-AF63-94896389227E}"/>
              </a:ext>
            </a:extLst>
          </p:cNvPr>
          <p:cNvSpPr txBox="1"/>
          <p:nvPr/>
        </p:nvSpPr>
        <p:spPr>
          <a:xfrm>
            <a:off x="281510" y="3215681"/>
            <a:ext cx="601900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7. FHY3 is required for TOC1 binding to the FBS element of </a:t>
            </a:r>
            <a:r>
              <a:rPr lang="en-US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CA1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romoter 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estern blots and quantitation of TOC1 protein levels of native promoter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C1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5X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ines in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c1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hy3 toc1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utant backgrounds. 10-d-old seedlings grown at 12-h/12-h light/dark conditions were harvested at ZT14. Data from 2 independent trials were averaged; error bars indicate SEM</a:t>
            </a:r>
            <a:endParaRPr lang="en-US" sz="1200" b="1" strike="sngStrike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2442671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TextBox 12">
            <a:extLst>
              <a:ext uri="{FF2B5EF4-FFF2-40B4-BE49-F238E27FC236}">
                <a16:creationId xmlns:a16="http://schemas.microsoft.com/office/drawing/2014/main" id="{4DFEA486-3E89-4B10-AAB9-6960900F2841}"/>
              </a:ext>
            </a:extLst>
          </p:cNvPr>
          <p:cNvSpPr txBox="1"/>
          <p:nvPr/>
        </p:nvSpPr>
        <p:spPr>
          <a:xfrm>
            <a:off x="525566" y="3052014"/>
            <a:ext cx="601900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8. </a:t>
            </a:r>
            <a:r>
              <a:rPr lang="en-US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hy3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utant shows dampened </a:t>
            </a:r>
            <a:r>
              <a:rPr lang="en-US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CA1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xpression similar to </a:t>
            </a:r>
            <a:r>
              <a:rPr lang="en-US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5X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ine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trial of time-series expression of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CA1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HY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hown in fig. 6B. Error bars indicate SEM of two technical repeats. 10-d-old seedlings grown at 12-h/12-h light/dark conditions were harvested every 3 hours from ZT1 to ZT22.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pression was normalized to Col-0 at ZT1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3" name="Chart 1">
            <a:extLst>
              <a:ext uri="{FF2B5EF4-FFF2-40B4-BE49-F238E27FC236}">
                <a16:creationId xmlns:a16="http://schemas.microsoft.com/office/drawing/2014/main" id="{92B68A61-2461-2738-4855-FD076F0CA07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68420036"/>
              </p:ext>
            </p:extLst>
          </p:nvPr>
        </p:nvGraphicFramePr>
        <p:xfrm>
          <a:off x="614185" y="386188"/>
          <a:ext cx="2853649" cy="163016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2" name="Chart 1">
            <a:extLst>
              <a:ext uri="{FF2B5EF4-FFF2-40B4-BE49-F238E27FC236}">
                <a16:creationId xmlns:a16="http://schemas.microsoft.com/office/drawing/2014/main" id="{DE78D339-3205-F517-DD67-FC41E4DF143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74059632"/>
              </p:ext>
            </p:extLst>
          </p:nvPr>
        </p:nvGraphicFramePr>
        <p:xfrm>
          <a:off x="614185" y="1528406"/>
          <a:ext cx="2853649" cy="139036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4" name="Rectangle 43">
            <a:extLst>
              <a:ext uri="{FF2B5EF4-FFF2-40B4-BE49-F238E27FC236}">
                <a16:creationId xmlns:a16="http://schemas.microsoft.com/office/drawing/2014/main" id="{A7813888-880E-3BFF-98AB-8B71305DA841}"/>
              </a:ext>
            </a:extLst>
          </p:cNvPr>
          <p:cNvSpPr/>
          <p:nvPr/>
        </p:nvSpPr>
        <p:spPr>
          <a:xfrm>
            <a:off x="611738" y="1656348"/>
            <a:ext cx="328936" cy="13710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72C7D712-58AA-CC4C-0FF3-7A9E475594A0}"/>
              </a:ext>
            </a:extLst>
          </p:cNvPr>
          <p:cNvSpPr txBox="1"/>
          <p:nvPr/>
        </p:nvSpPr>
        <p:spPr>
          <a:xfrm>
            <a:off x="776206" y="1594095"/>
            <a:ext cx="29367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050" dirty="0"/>
              <a:t>//</a:t>
            </a:r>
            <a:endParaRPr kumimoji="1" lang="zh-CN" altLang="en-US" sz="1050" dirty="0"/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8690770E-FC59-E0A9-F724-EED703444F55}"/>
              </a:ext>
            </a:extLst>
          </p:cNvPr>
          <p:cNvSpPr txBox="1"/>
          <p:nvPr/>
        </p:nvSpPr>
        <p:spPr>
          <a:xfrm>
            <a:off x="541328" y="1622193"/>
            <a:ext cx="36420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050" dirty="0"/>
              <a:t>0.4</a:t>
            </a:r>
            <a:endParaRPr kumimoji="1" lang="zh-CN" altLang="en-US" sz="1050" dirty="0"/>
          </a:p>
        </p:txBody>
      </p:sp>
      <p:graphicFrame>
        <p:nvGraphicFramePr>
          <p:cNvPr id="18" name="Chart 4">
            <a:extLst>
              <a:ext uri="{FF2B5EF4-FFF2-40B4-BE49-F238E27FC236}">
                <a16:creationId xmlns:a16="http://schemas.microsoft.com/office/drawing/2014/main" id="{CB27D980-6BAA-F0CD-FDF5-EF33BF65EFC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15002200"/>
              </p:ext>
            </p:extLst>
          </p:nvPr>
        </p:nvGraphicFramePr>
        <p:xfrm>
          <a:off x="3690925" y="359646"/>
          <a:ext cx="2853649" cy="156744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19" name="Chart 4">
            <a:extLst>
              <a:ext uri="{FF2B5EF4-FFF2-40B4-BE49-F238E27FC236}">
                <a16:creationId xmlns:a16="http://schemas.microsoft.com/office/drawing/2014/main" id="{F18654B1-06E1-406B-9EB5-38B2FE9752C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66585113"/>
              </p:ext>
            </p:extLst>
          </p:nvPr>
        </p:nvGraphicFramePr>
        <p:xfrm>
          <a:off x="3690925" y="1587990"/>
          <a:ext cx="2853649" cy="13369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20" name="Rectangle 43">
            <a:extLst>
              <a:ext uri="{FF2B5EF4-FFF2-40B4-BE49-F238E27FC236}">
                <a16:creationId xmlns:a16="http://schemas.microsoft.com/office/drawing/2014/main" id="{CE40B554-A4B2-F1F1-D3A8-B9F64F7D8728}"/>
              </a:ext>
            </a:extLst>
          </p:cNvPr>
          <p:cNvSpPr/>
          <p:nvPr/>
        </p:nvSpPr>
        <p:spPr>
          <a:xfrm>
            <a:off x="3683313" y="1664858"/>
            <a:ext cx="328936" cy="13710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21BB0B10-5593-4B70-FED0-CC360E5B8974}"/>
              </a:ext>
            </a:extLst>
          </p:cNvPr>
          <p:cNvSpPr txBox="1"/>
          <p:nvPr/>
        </p:nvSpPr>
        <p:spPr>
          <a:xfrm>
            <a:off x="3847781" y="1602605"/>
            <a:ext cx="29367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050" dirty="0"/>
              <a:t>//</a:t>
            </a:r>
            <a:endParaRPr kumimoji="1" lang="zh-CN" altLang="en-US" sz="1050" dirty="0"/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E43B2C57-0346-4EAE-3677-4C57D4C9BEDC}"/>
              </a:ext>
            </a:extLst>
          </p:cNvPr>
          <p:cNvSpPr txBox="1"/>
          <p:nvPr/>
        </p:nvSpPr>
        <p:spPr>
          <a:xfrm>
            <a:off x="3617966" y="1651983"/>
            <a:ext cx="36420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050" dirty="0"/>
              <a:t>0.4</a:t>
            </a:r>
            <a:endParaRPr kumimoji="1" lang="zh-CN" altLang="en-US" sz="1050" dirty="0"/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71081A7B-7A64-C1F1-C944-A831FEB91B2C}"/>
              </a:ext>
            </a:extLst>
          </p:cNvPr>
          <p:cNvSpPr txBox="1"/>
          <p:nvPr/>
        </p:nvSpPr>
        <p:spPr>
          <a:xfrm rot="16200000">
            <a:off x="-203427" y="1397601"/>
            <a:ext cx="148951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100" dirty="0"/>
              <a:t>Normalized expression</a:t>
            </a:r>
            <a:endParaRPr kumimoji="1" lang="zh-CN" altLang="en-US" sz="1100" dirty="0"/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CBF098BC-36EE-405C-77D3-C5BDE0B699E3}"/>
              </a:ext>
            </a:extLst>
          </p:cNvPr>
          <p:cNvSpPr txBox="1"/>
          <p:nvPr/>
        </p:nvSpPr>
        <p:spPr>
          <a:xfrm rot="16200000">
            <a:off x="2869405" y="1415473"/>
            <a:ext cx="148951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100" dirty="0"/>
              <a:t>Normalized expression</a:t>
            </a:r>
            <a:endParaRPr kumimoji="1" lang="zh-CN" altLang="en-US" sz="1100" dirty="0"/>
          </a:p>
        </p:txBody>
      </p:sp>
    </p:spTree>
    <p:extLst>
      <p:ext uri="{BB962C8B-B14F-4D97-AF65-F5344CB8AC3E}">
        <p14:creationId xmlns:p14="http://schemas.microsoft.com/office/powerpoint/2010/main" val="232235101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F13FF93B-77C7-B8E2-0EDF-2279199F7FFF}"/>
              </a:ext>
            </a:extLst>
          </p:cNvPr>
          <p:cNvSpPr txBox="1"/>
          <p:nvPr/>
        </p:nvSpPr>
        <p:spPr>
          <a:xfrm>
            <a:off x="401128" y="8135904"/>
            <a:ext cx="6055743" cy="113710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</a:pPr>
            <a:r>
              <a:rPr lang="en-US" altLang="zh-CN" sz="1200" b="1" i="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Supplemental Figure 9. Significantly enriched Gene Ontology (GO) categories of the common and genotype-specific rhythmic genes between </a:t>
            </a:r>
            <a:r>
              <a:rPr lang="en-US" altLang="zh-CN" sz="1200" b="1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TOC1</a:t>
            </a:r>
            <a:r>
              <a:rPr lang="en-US" altLang="zh-CN" sz="1200" b="1" i="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and </a:t>
            </a:r>
            <a:r>
              <a:rPr lang="en-US" altLang="zh-CN" sz="1200" b="1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5X</a:t>
            </a:r>
            <a:r>
              <a:rPr lang="zh-CN" altLang="en-US" sz="12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2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plants in</a:t>
            </a:r>
            <a:r>
              <a:rPr lang="zh-CN" altLang="en-US" sz="12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2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F</a:t>
            </a:r>
            <a:r>
              <a:rPr lang="en-US" altLang="zh-CN" sz="12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igure 7B. </a:t>
            </a:r>
            <a:r>
              <a:rPr lang="en-US" altLang="zh-CN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The enrichment score is the negative natural logarithm of the enrichment P-value derived from the Fisher's exact test. </a:t>
            </a:r>
            <a:r>
              <a:rPr lang="en-US" altLang="zh-CN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Count indicates the number of genes that have been identified in each category. </a:t>
            </a:r>
          </a:p>
        </p:txBody>
      </p:sp>
      <p:pic>
        <p:nvPicPr>
          <p:cNvPr id="2" name="图片 1">
            <a:extLst>
              <a:ext uri="{FF2B5EF4-FFF2-40B4-BE49-F238E27FC236}">
                <a16:creationId xmlns:a16="http://schemas.microsoft.com/office/drawing/2014/main" id="{EE9BF292-30BF-8740-FD16-7714CC9BA7E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42140" y="372338"/>
            <a:ext cx="3780491" cy="754285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169995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7540</TotalTime>
  <Words>1387</Words>
  <Application>Microsoft Office PowerPoint</Application>
  <PresentationFormat>A4 Paper (210x297 mm)</PresentationFormat>
  <Paragraphs>112</Paragraphs>
  <Slides>15</Slides>
  <Notes>1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5</vt:i4>
      </vt:variant>
    </vt:vector>
  </HeadingPairs>
  <TitlesOfParts>
    <vt:vector size="21" baseType="lpstr">
      <vt:lpstr>Arial</vt:lpstr>
      <vt:lpstr>Calibri</vt:lpstr>
      <vt:lpstr>Calibri Light</vt:lpstr>
      <vt:lpstr>Times New Roman</vt:lpstr>
      <vt:lpstr>TimesNewRomanPS-BoldM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iapei Yan</dc:creator>
  <cp:lastModifiedBy>Somers, David</cp:lastModifiedBy>
  <cp:revision>375</cp:revision>
  <cp:lastPrinted>2024-12-29T21:19:12Z</cp:lastPrinted>
  <dcterms:created xsi:type="dcterms:W3CDTF">2023-01-30T05:40:55Z</dcterms:created>
  <dcterms:modified xsi:type="dcterms:W3CDTF">2025-03-25T23:10:35Z</dcterms:modified>
</cp:coreProperties>
</file>